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2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172.21.101.229\Pubblica\UTENTI\RIGHETTO\JACMP%20Secondo%20Invio\DHV%20Meningioma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172.21.101.229\Pubblica\UTENTI\RIGHETTO\JACMP%20Secondo%20Invio\DHV%20Meningioma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00095238095238"/>
          <c:y val="7.7611111111111117E-2"/>
          <c:w val="0.75379047619047623"/>
          <c:h val="0.69686999999999999"/>
        </c:manualLayout>
      </c:layout>
      <c:scatterChart>
        <c:scatterStyle val="lineMarker"/>
        <c:varyColors val="0"/>
        <c:ser>
          <c:idx val="0"/>
          <c:order val="0"/>
          <c:tx>
            <c:strRef>
              <c:f>Foglio6!$A$1</c:f>
              <c:strCache>
                <c:ptCount val="1"/>
                <c:pt idx="0">
                  <c:v>S0,5NA</c:v>
                </c:pt>
              </c:strCache>
            </c:strRef>
          </c:tx>
          <c:spPr>
            <a:ln w="19050" cap="rnd">
              <a:solidFill>
                <a:srgbClr val="9DC3E6"/>
              </a:solidFill>
              <a:round/>
            </a:ln>
            <a:effectLst/>
          </c:spPr>
          <c:marker>
            <c:symbol val="none"/>
          </c:marker>
          <c:dLbls>
            <c:dLbl>
              <c:idx val="401"/>
              <c:dLblPos val="r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C237-45B1-A7AA-312291C8735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Foglio6!$A$424:$A$82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3.0000000000000001E-3</c:v>
                </c:pt>
                <c:pt idx="69">
                  <c:v>2.5000000000000001E-2</c:v>
                </c:pt>
                <c:pt idx="70">
                  <c:v>4.8000000000000001E-2</c:v>
                </c:pt>
                <c:pt idx="71">
                  <c:v>7.0000000000000007E-2</c:v>
                </c:pt>
                <c:pt idx="72">
                  <c:v>9.1999999999999998E-2</c:v>
                </c:pt>
                <c:pt idx="73">
                  <c:v>0.115</c:v>
                </c:pt>
                <c:pt idx="74">
                  <c:v>0.13700000000000001</c:v>
                </c:pt>
                <c:pt idx="75">
                  <c:v>0.159</c:v>
                </c:pt>
                <c:pt idx="76">
                  <c:v>0.182</c:v>
                </c:pt>
                <c:pt idx="77">
                  <c:v>0.20399999999999999</c:v>
                </c:pt>
                <c:pt idx="78">
                  <c:v>0.22600000000000001</c:v>
                </c:pt>
                <c:pt idx="79">
                  <c:v>0.249</c:v>
                </c:pt>
                <c:pt idx="80">
                  <c:v>0.27100000000000002</c:v>
                </c:pt>
                <c:pt idx="81">
                  <c:v>0.29299999999999998</c:v>
                </c:pt>
                <c:pt idx="82">
                  <c:v>0.316</c:v>
                </c:pt>
                <c:pt idx="83">
                  <c:v>0.33800000000000002</c:v>
                </c:pt>
                <c:pt idx="84">
                  <c:v>0.36</c:v>
                </c:pt>
                <c:pt idx="85">
                  <c:v>0.38200000000000001</c:v>
                </c:pt>
                <c:pt idx="86">
                  <c:v>0.40500000000000003</c:v>
                </c:pt>
                <c:pt idx="87">
                  <c:v>0.42699999999999999</c:v>
                </c:pt>
                <c:pt idx="88">
                  <c:v>0.44900000000000001</c:v>
                </c:pt>
                <c:pt idx="89">
                  <c:v>0.47199999999999998</c:v>
                </c:pt>
                <c:pt idx="90">
                  <c:v>0.49399999999999999</c:v>
                </c:pt>
                <c:pt idx="91">
                  <c:v>0.51600000000000001</c:v>
                </c:pt>
                <c:pt idx="92">
                  <c:v>0.53900000000000003</c:v>
                </c:pt>
                <c:pt idx="93">
                  <c:v>0.56100000000000005</c:v>
                </c:pt>
                <c:pt idx="94">
                  <c:v>0.58299999999999996</c:v>
                </c:pt>
                <c:pt idx="95">
                  <c:v>0.60599999999999998</c:v>
                </c:pt>
                <c:pt idx="96">
                  <c:v>0.628</c:v>
                </c:pt>
                <c:pt idx="97">
                  <c:v>0.65</c:v>
                </c:pt>
                <c:pt idx="98">
                  <c:v>0.67300000000000004</c:v>
                </c:pt>
                <c:pt idx="99">
                  <c:v>0.69499999999999995</c:v>
                </c:pt>
                <c:pt idx="100">
                  <c:v>0.71699999999999997</c:v>
                </c:pt>
                <c:pt idx="101">
                  <c:v>0.73899999999999999</c:v>
                </c:pt>
                <c:pt idx="102">
                  <c:v>0.76200000000000001</c:v>
                </c:pt>
                <c:pt idx="103">
                  <c:v>0.78400000000000003</c:v>
                </c:pt>
                <c:pt idx="104">
                  <c:v>0.80600000000000005</c:v>
                </c:pt>
                <c:pt idx="105">
                  <c:v>0.82899999999999996</c:v>
                </c:pt>
                <c:pt idx="106">
                  <c:v>0.85099999999999998</c:v>
                </c:pt>
                <c:pt idx="107">
                  <c:v>0.873</c:v>
                </c:pt>
                <c:pt idx="108">
                  <c:v>0.89600000000000002</c:v>
                </c:pt>
                <c:pt idx="109">
                  <c:v>0.91800000000000004</c:v>
                </c:pt>
                <c:pt idx="110">
                  <c:v>0.94</c:v>
                </c:pt>
                <c:pt idx="111">
                  <c:v>0.96299999999999997</c:v>
                </c:pt>
                <c:pt idx="112">
                  <c:v>0.98499999999999999</c:v>
                </c:pt>
                <c:pt idx="113">
                  <c:v>1.0069999999999999</c:v>
                </c:pt>
                <c:pt idx="114">
                  <c:v>1.03</c:v>
                </c:pt>
                <c:pt idx="115">
                  <c:v>1.052</c:v>
                </c:pt>
                <c:pt idx="116">
                  <c:v>1.0740000000000001</c:v>
                </c:pt>
                <c:pt idx="117">
                  <c:v>1.0960000000000001</c:v>
                </c:pt>
                <c:pt idx="118">
                  <c:v>1.119</c:v>
                </c:pt>
                <c:pt idx="119">
                  <c:v>1.141</c:v>
                </c:pt>
                <c:pt idx="120">
                  <c:v>1.163</c:v>
                </c:pt>
                <c:pt idx="121">
                  <c:v>1.1859999999999999</c:v>
                </c:pt>
                <c:pt idx="122">
                  <c:v>1.208</c:v>
                </c:pt>
                <c:pt idx="123">
                  <c:v>1.23</c:v>
                </c:pt>
                <c:pt idx="124">
                  <c:v>1.2529999999999999</c:v>
                </c:pt>
                <c:pt idx="125">
                  <c:v>1.2749999999999999</c:v>
                </c:pt>
                <c:pt idx="126">
                  <c:v>1.2969999999999999</c:v>
                </c:pt>
                <c:pt idx="127">
                  <c:v>1.32</c:v>
                </c:pt>
                <c:pt idx="128">
                  <c:v>1.3420000000000001</c:v>
                </c:pt>
                <c:pt idx="129">
                  <c:v>1.3640000000000001</c:v>
                </c:pt>
                <c:pt idx="130">
                  <c:v>1.3859999999999999</c:v>
                </c:pt>
                <c:pt idx="131">
                  <c:v>1.409</c:v>
                </c:pt>
                <c:pt idx="132">
                  <c:v>1.431</c:v>
                </c:pt>
                <c:pt idx="133">
                  <c:v>1.4530000000000001</c:v>
                </c:pt>
                <c:pt idx="134">
                  <c:v>1.476</c:v>
                </c:pt>
                <c:pt idx="135">
                  <c:v>1.498</c:v>
                </c:pt>
                <c:pt idx="136">
                  <c:v>1.52</c:v>
                </c:pt>
                <c:pt idx="137">
                  <c:v>1.5429999999999999</c:v>
                </c:pt>
                <c:pt idx="138">
                  <c:v>1.5649999999999999</c:v>
                </c:pt>
                <c:pt idx="139">
                  <c:v>1.587</c:v>
                </c:pt>
                <c:pt idx="140">
                  <c:v>1.7030000000000001</c:v>
                </c:pt>
                <c:pt idx="141">
                  <c:v>1.9259999999999999</c:v>
                </c:pt>
                <c:pt idx="142">
                  <c:v>2.1480000000000001</c:v>
                </c:pt>
                <c:pt idx="143">
                  <c:v>2.371</c:v>
                </c:pt>
                <c:pt idx="144">
                  <c:v>2.593</c:v>
                </c:pt>
                <c:pt idx="145">
                  <c:v>2.8159999999999998</c:v>
                </c:pt>
                <c:pt idx="146">
                  <c:v>3.0379999999999998</c:v>
                </c:pt>
                <c:pt idx="147">
                  <c:v>3.3119999999999998</c:v>
                </c:pt>
                <c:pt idx="148">
                  <c:v>3.7170000000000001</c:v>
                </c:pt>
                <c:pt idx="149">
                  <c:v>4.1219999999999999</c:v>
                </c:pt>
                <c:pt idx="150">
                  <c:v>4.5270000000000001</c:v>
                </c:pt>
                <c:pt idx="151">
                  <c:v>4.9939999999999998</c:v>
                </c:pt>
                <c:pt idx="152">
                  <c:v>5.5860000000000003</c:v>
                </c:pt>
                <c:pt idx="153">
                  <c:v>6.1769999999999996</c:v>
                </c:pt>
                <c:pt idx="154">
                  <c:v>6.8959999999999999</c:v>
                </c:pt>
                <c:pt idx="155">
                  <c:v>7.6909999999999998</c:v>
                </c:pt>
                <c:pt idx="156">
                  <c:v>7.9960000000000004</c:v>
                </c:pt>
                <c:pt idx="157">
                  <c:v>8.6150000000000002</c:v>
                </c:pt>
                <c:pt idx="158">
                  <c:v>9.6240000000000006</c:v>
                </c:pt>
                <c:pt idx="159">
                  <c:v>10.868</c:v>
                </c:pt>
                <c:pt idx="160">
                  <c:v>12.247</c:v>
                </c:pt>
                <c:pt idx="161">
                  <c:v>13.76</c:v>
                </c:pt>
                <c:pt idx="162">
                  <c:v>15.464</c:v>
                </c:pt>
                <c:pt idx="163">
                  <c:v>15.992000000000001</c:v>
                </c:pt>
                <c:pt idx="164">
                  <c:v>17.440999999999999</c:v>
                </c:pt>
                <c:pt idx="165">
                  <c:v>19.664000000000001</c:v>
                </c:pt>
                <c:pt idx="166">
                  <c:v>22.164999999999999</c:v>
                </c:pt>
                <c:pt idx="167">
                  <c:v>23.988</c:v>
                </c:pt>
                <c:pt idx="168">
                  <c:v>25.006</c:v>
                </c:pt>
                <c:pt idx="169">
                  <c:v>28.126000000000001</c:v>
                </c:pt>
                <c:pt idx="170">
                  <c:v>31.585999999999999</c:v>
                </c:pt>
                <c:pt idx="171">
                  <c:v>31.984000000000002</c:v>
                </c:pt>
                <c:pt idx="172">
                  <c:v>35.345999999999997</c:v>
                </c:pt>
                <c:pt idx="173">
                  <c:v>39.545000000000002</c:v>
                </c:pt>
                <c:pt idx="174">
                  <c:v>39.979999999999997</c:v>
                </c:pt>
                <c:pt idx="175">
                  <c:v>44.256</c:v>
                </c:pt>
                <c:pt idx="176">
                  <c:v>47.975999999999999</c:v>
                </c:pt>
                <c:pt idx="177">
                  <c:v>49.2</c:v>
                </c:pt>
                <c:pt idx="178">
                  <c:v>54.631999999999998</c:v>
                </c:pt>
                <c:pt idx="179">
                  <c:v>55.972000000000001</c:v>
                </c:pt>
                <c:pt idx="180">
                  <c:v>60.722000000000001</c:v>
                </c:pt>
                <c:pt idx="181">
                  <c:v>63.968000000000004</c:v>
                </c:pt>
                <c:pt idx="182">
                  <c:v>67.203000000000003</c:v>
                </c:pt>
                <c:pt idx="183">
                  <c:v>71.963999999999999</c:v>
                </c:pt>
                <c:pt idx="184">
                  <c:v>74.164000000000001</c:v>
                </c:pt>
                <c:pt idx="185">
                  <c:v>79.959999999999994</c:v>
                </c:pt>
                <c:pt idx="186">
                  <c:v>81.804000000000002</c:v>
                </c:pt>
                <c:pt idx="187">
                  <c:v>87.956000000000003</c:v>
                </c:pt>
                <c:pt idx="188">
                  <c:v>90.644000000000005</c:v>
                </c:pt>
                <c:pt idx="189">
                  <c:v>95.951999999999998</c:v>
                </c:pt>
                <c:pt idx="190">
                  <c:v>100.185</c:v>
                </c:pt>
                <c:pt idx="191">
                  <c:v>103.94799999999999</c:v>
                </c:pt>
                <c:pt idx="192">
                  <c:v>110.36499999999999</c:v>
                </c:pt>
                <c:pt idx="193">
                  <c:v>111.943</c:v>
                </c:pt>
                <c:pt idx="194">
                  <c:v>119.93899999999999</c:v>
                </c:pt>
                <c:pt idx="195">
                  <c:v>121.721</c:v>
                </c:pt>
                <c:pt idx="196">
                  <c:v>127.935</c:v>
                </c:pt>
                <c:pt idx="197">
                  <c:v>135.23099999999999</c:v>
                </c:pt>
                <c:pt idx="198">
                  <c:v>135.93100000000001</c:v>
                </c:pt>
                <c:pt idx="199">
                  <c:v>143.92699999999999</c:v>
                </c:pt>
                <c:pt idx="200">
                  <c:v>149.363</c:v>
                </c:pt>
                <c:pt idx="201">
                  <c:v>151.923</c:v>
                </c:pt>
                <c:pt idx="202">
                  <c:v>159.91900000000001</c:v>
                </c:pt>
                <c:pt idx="203">
                  <c:v>165.95699999999999</c:v>
                </c:pt>
                <c:pt idx="204">
                  <c:v>167.91499999999999</c:v>
                </c:pt>
                <c:pt idx="205">
                  <c:v>175.911</c:v>
                </c:pt>
                <c:pt idx="206">
                  <c:v>183.90700000000001</c:v>
                </c:pt>
                <c:pt idx="207">
                  <c:v>184.55600000000001</c:v>
                </c:pt>
                <c:pt idx="208">
                  <c:v>191.90299999999999</c:v>
                </c:pt>
                <c:pt idx="209">
                  <c:v>199.899</c:v>
                </c:pt>
                <c:pt idx="210">
                  <c:v>204.50800000000001</c:v>
                </c:pt>
                <c:pt idx="211">
                  <c:v>207.89500000000001</c:v>
                </c:pt>
                <c:pt idx="212">
                  <c:v>215.89099999999999</c:v>
                </c:pt>
                <c:pt idx="213">
                  <c:v>223.887</c:v>
                </c:pt>
                <c:pt idx="214">
                  <c:v>228.78100000000001</c:v>
                </c:pt>
                <c:pt idx="215">
                  <c:v>231.88300000000001</c:v>
                </c:pt>
                <c:pt idx="216">
                  <c:v>239.87899999999999</c:v>
                </c:pt>
                <c:pt idx="217">
                  <c:v>247.875</c:v>
                </c:pt>
                <c:pt idx="218">
                  <c:v>254.648</c:v>
                </c:pt>
                <c:pt idx="219">
                  <c:v>255.87100000000001</c:v>
                </c:pt>
                <c:pt idx="220">
                  <c:v>263.86700000000002</c:v>
                </c:pt>
                <c:pt idx="221">
                  <c:v>271.863</c:v>
                </c:pt>
                <c:pt idx="222">
                  <c:v>279.85899999999998</c:v>
                </c:pt>
                <c:pt idx="223">
                  <c:v>285.613</c:v>
                </c:pt>
                <c:pt idx="224">
                  <c:v>287.85500000000002</c:v>
                </c:pt>
                <c:pt idx="225">
                  <c:v>295.851</c:v>
                </c:pt>
                <c:pt idx="226">
                  <c:v>303.84699999999998</c:v>
                </c:pt>
                <c:pt idx="227">
                  <c:v>311.84300000000002</c:v>
                </c:pt>
                <c:pt idx="228">
                  <c:v>319.83800000000002</c:v>
                </c:pt>
                <c:pt idx="229">
                  <c:v>320.68599999999998</c:v>
                </c:pt>
                <c:pt idx="230">
                  <c:v>327.834</c:v>
                </c:pt>
                <c:pt idx="231">
                  <c:v>335.83</c:v>
                </c:pt>
                <c:pt idx="232">
                  <c:v>343.82600000000002</c:v>
                </c:pt>
                <c:pt idx="233">
                  <c:v>351.822</c:v>
                </c:pt>
                <c:pt idx="234">
                  <c:v>359.81799999999998</c:v>
                </c:pt>
                <c:pt idx="235">
                  <c:v>362.09500000000003</c:v>
                </c:pt>
                <c:pt idx="236">
                  <c:v>367.81400000000002</c:v>
                </c:pt>
                <c:pt idx="237">
                  <c:v>375.81</c:v>
                </c:pt>
                <c:pt idx="238">
                  <c:v>383.80599999999998</c:v>
                </c:pt>
                <c:pt idx="239">
                  <c:v>391.80200000000002</c:v>
                </c:pt>
                <c:pt idx="240">
                  <c:v>399.798</c:v>
                </c:pt>
                <c:pt idx="241">
                  <c:v>407.53399999999999</c:v>
                </c:pt>
                <c:pt idx="242">
                  <c:v>407.79399999999998</c:v>
                </c:pt>
                <c:pt idx="243">
                  <c:v>415.79</c:v>
                </c:pt>
                <c:pt idx="244">
                  <c:v>423.786</c:v>
                </c:pt>
                <c:pt idx="245">
                  <c:v>431.78199999999998</c:v>
                </c:pt>
                <c:pt idx="246">
                  <c:v>439.77800000000002</c:v>
                </c:pt>
                <c:pt idx="247">
                  <c:v>447.774</c:v>
                </c:pt>
                <c:pt idx="248">
                  <c:v>455.77</c:v>
                </c:pt>
                <c:pt idx="249">
                  <c:v>463.76600000000002</c:v>
                </c:pt>
                <c:pt idx="250">
                  <c:v>464.60399999999998</c:v>
                </c:pt>
                <c:pt idx="251">
                  <c:v>471.762</c:v>
                </c:pt>
                <c:pt idx="252">
                  <c:v>479.75799999999998</c:v>
                </c:pt>
                <c:pt idx="253">
                  <c:v>487.75400000000002</c:v>
                </c:pt>
                <c:pt idx="254">
                  <c:v>495.75</c:v>
                </c:pt>
                <c:pt idx="255">
                  <c:v>503.74599999999998</c:v>
                </c:pt>
                <c:pt idx="256">
                  <c:v>511.74200000000002</c:v>
                </c:pt>
                <c:pt idx="257">
                  <c:v>519.73800000000006</c:v>
                </c:pt>
                <c:pt idx="258">
                  <c:v>527.73299999999995</c:v>
                </c:pt>
                <c:pt idx="259">
                  <c:v>529.197</c:v>
                </c:pt>
                <c:pt idx="260">
                  <c:v>535.72900000000004</c:v>
                </c:pt>
                <c:pt idx="261">
                  <c:v>543.72500000000002</c:v>
                </c:pt>
                <c:pt idx="262">
                  <c:v>551.721</c:v>
                </c:pt>
                <c:pt idx="263">
                  <c:v>559.71699999999998</c:v>
                </c:pt>
                <c:pt idx="264">
                  <c:v>567.71299999999997</c:v>
                </c:pt>
                <c:pt idx="265">
                  <c:v>575.70899999999995</c:v>
                </c:pt>
                <c:pt idx="266">
                  <c:v>583.70500000000004</c:v>
                </c:pt>
                <c:pt idx="267">
                  <c:v>591.70100000000002</c:v>
                </c:pt>
                <c:pt idx="268">
                  <c:v>599.697</c:v>
                </c:pt>
                <c:pt idx="269">
                  <c:v>605.29100000000005</c:v>
                </c:pt>
                <c:pt idx="270">
                  <c:v>607.69299999999998</c:v>
                </c:pt>
                <c:pt idx="271">
                  <c:v>615.68899999999996</c:v>
                </c:pt>
                <c:pt idx="272">
                  <c:v>623.68499999999995</c:v>
                </c:pt>
                <c:pt idx="273">
                  <c:v>631.68100000000004</c:v>
                </c:pt>
                <c:pt idx="274">
                  <c:v>639.67700000000002</c:v>
                </c:pt>
                <c:pt idx="275">
                  <c:v>647.673</c:v>
                </c:pt>
                <c:pt idx="276">
                  <c:v>655.66899999999998</c:v>
                </c:pt>
                <c:pt idx="277">
                  <c:v>663.66499999999996</c:v>
                </c:pt>
                <c:pt idx="278">
                  <c:v>671.66099999999994</c:v>
                </c:pt>
                <c:pt idx="279">
                  <c:v>679.65700000000004</c:v>
                </c:pt>
                <c:pt idx="280">
                  <c:v>687.65300000000002</c:v>
                </c:pt>
                <c:pt idx="281">
                  <c:v>695.649</c:v>
                </c:pt>
                <c:pt idx="282">
                  <c:v>695.66899999999998</c:v>
                </c:pt>
                <c:pt idx="283">
                  <c:v>703.64499999999998</c:v>
                </c:pt>
                <c:pt idx="284">
                  <c:v>711.64099999999996</c:v>
                </c:pt>
                <c:pt idx="285">
                  <c:v>719.63699999999994</c:v>
                </c:pt>
                <c:pt idx="286">
                  <c:v>727.63300000000004</c:v>
                </c:pt>
                <c:pt idx="287">
                  <c:v>735.62800000000004</c:v>
                </c:pt>
                <c:pt idx="288">
                  <c:v>743.62400000000002</c:v>
                </c:pt>
                <c:pt idx="289">
                  <c:v>751.62</c:v>
                </c:pt>
                <c:pt idx="290">
                  <c:v>759.61599999999999</c:v>
                </c:pt>
                <c:pt idx="291">
                  <c:v>767.61199999999997</c:v>
                </c:pt>
                <c:pt idx="292">
                  <c:v>775.60799999999995</c:v>
                </c:pt>
                <c:pt idx="293">
                  <c:v>783.60400000000004</c:v>
                </c:pt>
                <c:pt idx="294">
                  <c:v>791.6</c:v>
                </c:pt>
                <c:pt idx="295">
                  <c:v>799.49599999999998</c:v>
                </c:pt>
                <c:pt idx="296">
                  <c:v>799.596</c:v>
                </c:pt>
                <c:pt idx="297">
                  <c:v>807.59199999999998</c:v>
                </c:pt>
                <c:pt idx="298">
                  <c:v>815.58799999999997</c:v>
                </c:pt>
                <c:pt idx="299">
                  <c:v>823.58399999999995</c:v>
                </c:pt>
                <c:pt idx="300">
                  <c:v>831.58</c:v>
                </c:pt>
                <c:pt idx="301">
                  <c:v>839.57600000000002</c:v>
                </c:pt>
                <c:pt idx="302">
                  <c:v>847.572</c:v>
                </c:pt>
                <c:pt idx="303">
                  <c:v>855.56799999999998</c:v>
                </c:pt>
                <c:pt idx="304">
                  <c:v>863.56399999999996</c:v>
                </c:pt>
                <c:pt idx="305">
                  <c:v>871.56</c:v>
                </c:pt>
                <c:pt idx="306">
                  <c:v>879.55600000000004</c:v>
                </c:pt>
                <c:pt idx="307">
                  <c:v>887.55200000000002</c:v>
                </c:pt>
                <c:pt idx="308">
                  <c:v>895.548</c:v>
                </c:pt>
                <c:pt idx="309">
                  <c:v>903.54399999999998</c:v>
                </c:pt>
                <c:pt idx="310">
                  <c:v>911.54</c:v>
                </c:pt>
                <c:pt idx="311">
                  <c:v>916.91899999999998</c:v>
                </c:pt>
                <c:pt idx="312">
                  <c:v>919.53599999999994</c:v>
                </c:pt>
                <c:pt idx="313">
                  <c:v>927.53200000000004</c:v>
                </c:pt>
                <c:pt idx="314">
                  <c:v>935.52800000000002</c:v>
                </c:pt>
                <c:pt idx="315">
                  <c:v>943.524</c:v>
                </c:pt>
                <c:pt idx="316">
                  <c:v>951.51900000000001</c:v>
                </c:pt>
                <c:pt idx="317">
                  <c:v>959.51499999999999</c:v>
                </c:pt>
                <c:pt idx="318">
                  <c:v>967.51099999999997</c:v>
                </c:pt>
                <c:pt idx="319">
                  <c:v>975.50699999999995</c:v>
                </c:pt>
                <c:pt idx="320">
                  <c:v>983.50300000000004</c:v>
                </c:pt>
                <c:pt idx="321">
                  <c:v>991.49900000000002</c:v>
                </c:pt>
                <c:pt idx="322">
                  <c:v>999.495</c:v>
                </c:pt>
                <c:pt idx="323">
                  <c:v>1007.491</c:v>
                </c:pt>
                <c:pt idx="324">
                  <c:v>1015.487</c:v>
                </c:pt>
                <c:pt idx="325">
                  <c:v>1023.4829999999999</c:v>
                </c:pt>
                <c:pt idx="326">
                  <c:v>1031.479</c:v>
                </c:pt>
                <c:pt idx="327">
                  <c:v>1039.4749999999999</c:v>
                </c:pt>
                <c:pt idx="328">
                  <c:v>1047.471</c:v>
                </c:pt>
                <c:pt idx="329">
                  <c:v>1048.538</c:v>
                </c:pt>
                <c:pt idx="330">
                  <c:v>1055.4670000000001</c:v>
                </c:pt>
                <c:pt idx="331">
                  <c:v>1063.463</c:v>
                </c:pt>
                <c:pt idx="332">
                  <c:v>1071.4590000000001</c:v>
                </c:pt>
                <c:pt idx="333">
                  <c:v>1079.4549999999999</c:v>
                </c:pt>
                <c:pt idx="334">
                  <c:v>1087.451</c:v>
                </c:pt>
                <c:pt idx="335">
                  <c:v>1095.4469999999999</c:v>
                </c:pt>
                <c:pt idx="336">
                  <c:v>1103.443</c:v>
                </c:pt>
                <c:pt idx="337">
                  <c:v>1111.4390000000001</c:v>
                </c:pt>
                <c:pt idx="338">
                  <c:v>1119.4349999999999</c:v>
                </c:pt>
                <c:pt idx="339">
                  <c:v>1127.431</c:v>
                </c:pt>
                <c:pt idx="340">
                  <c:v>1135.4269999999999</c:v>
                </c:pt>
                <c:pt idx="341">
                  <c:v>1143.423</c:v>
                </c:pt>
                <c:pt idx="342">
                  <c:v>1151.4190000000001</c:v>
                </c:pt>
                <c:pt idx="343">
                  <c:v>1159.414</c:v>
                </c:pt>
                <c:pt idx="344">
                  <c:v>1167.4100000000001</c:v>
                </c:pt>
                <c:pt idx="345">
                  <c:v>1175.4059999999999</c:v>
                </c:pt>
                <c:pt idx="346">
                  <c:v>1183.402</c:v>
                </c:pt>
                <c:pt idx="347">
                  <c:v>1191.3979999999999</c:v>
                </c:pt>
                <c:pt idx="348">
                  <c:v>1199.394</c:v>
                </c:pt>
                <c:pt idx="349">
                  <c:v>1199.4159999999999</c:v>
                </c:pt>
                <c:pt idx="350">
                  <c:v>1207.3900000000001</c:v>
                </c:pt>
                <c:pt idx="351">
                  <c:v>1215.386</c:v>
                </c:pt>
                <c:pt idx="352">
                  <c:v>1223.3820000000001</c:v>
                </c:pt>
                <c:pt idx="353">
                  <c:v>1231.3779999999999</c:v>
                </c:pt>
                <c:pt idx="354">
                  <c:v>1239.374</c:v>
                </c:pt>
                <c:pt idx="355">
                  <c:v>1247.3699999999999</c:v>
                </c:pt>
                <c:pt idx="356">
                  <c:v>1255.366</c:v>
                </c:pt>
                <c:pt idx="357">
                  <c:v>1263.3620000000001</c:v>
                </c:pt>
                <c:pt idx="358">
                  <c:v>1271.3579999999999</c:v>
                </c:pt>
                <c:pt idx="359">
                  <c:v>1279.354</c:v>
                </c:pt>
                <c:pt idx="360">
                  <c:v>1287.3499999999999</c:v>
                </c:pt>
                <c:pt idx="361">
                  <c:v>1295.346</c:v>
                </c:pt>
                <c:pt idx="362">
                  <c:v>1303.3420000000001</c:v>
                </c:pt>
                <c:pt idx="363">
                  <c:v>1311.338</c:v>
                </c:pt>
                <c:pt idx="364">
                  <c:v>1319.3340000000001</c:v>
                </c:pt>
                <c:pt idx="365">
                  <c:v>1327.33</c:v>
                </c:pt>
                <c:pt idx="366">
                  <c:v>1335.326</c:v>
                </c:pt>
                <c:pt idx="367">
                  <c:v>1343.3219999999999</c:v>
                </c:pt>
                <c:pt idx="368">
                  <c:v>1351.318</c:v>
                </c:pt>
                <c:pt idx="369">
                  <c:v>1359.3140000000001</c:v>
                </c:pt>
                <c:pt idx="370">
                  <c:v>1361.702</c:v>
                </c:pt>
                <c:pt idx="371">
                  <c:v>1367.309</c:v>
                </c:pt>
                <c:pt idx="372">
                  <c:v>1375.3050000000001</c:v>
                </c:pt>
                <c:pt idx="373">
                  <c:v>1383.3009999999999</c:v>
                </c:pt>
                <c:pt idx="374">
                  <c:v>1391.297</c:v>
                </c:pt>
                <c:pt idx="375">
                  <c:v>1399.2929999999999</c:v>
                </c:pt>
                <c:pt idx="376">
                  <c:v>1407.289</c:v>
                </c:pt>
                <c:pt idx="377">
                  <c:v>1415.2850000000001</c:v>
                </c:pt>
                <c:pt idx="378">
                  <c:v>1423.2809999999999</c:v>
                </c:pt>
                <c:pt idx="379">
                  <c:v>1431.277</c:v>
                </c:pt>
                <c:pt idx="380">
                  <c:v>1439.2729999999999</c:v>
                </c:pt>
                <c:pt idx="381">
                  <c:v>1447.269</c:v>
                </c:pt>
                <c:pt idx="382">
                  <c:v>1455.2650000000001</c:v>
                </c:pt>
                <c:pt idx="383">
                  <c:v>1463.261</c:v>
                </c:pt>
                <c:pt idx="384">
                  <c:v>1471.2570000000001</c:v>
                </c:pt>
                <c:pt idx="385">
                  <c:v>1479.2529999999999</c:v>
                </c:pt>
                <c:pt idx="386">
                  <c:v>1487.249</c:v>
                </c:pt>
                <c:pt idx="387">
                  <c:v>1495.2449999999999</c:v>
                </c:pt>
                <c:pt idx="388">
                  <c:v>1503.241</c:v>
                </c:pt>
                <c:pt idx="389">
                  <c:v>1511.2370000000001</c:v>
                </c:pt>
                <c:pt idx="390">
                  <c:v>1519.2329999999999</c:v>
                </c:pt>
                <c:pt idx="391">
                  <c:v>1527.229</c:v>
                </c:pt>
                <c:pt idx="392">
                  <c:v>1535.2249999999999</c:v>
                </c:pt>
                <c:pt idx="393">
                  <c:v>1543.221</c:v>
                </c:pt>
                <c:pt idx="394">
                  <c:v>1551.2170000000001</c:v>
                </c:pt>
                <c:pt idx="395">
                  <c:v>1559.213</c:v>
                </c:pt>
                <c:pt idx="396">
                  <c:v>1567.2090000000001</c:v>
                </c:pt>
                <c:pt idx="397">
                  <c:v>1575.204</c:v>
                </c:pt>
                <c:pt idx="398">
                  <c:v>1583.2</c:v>
                </c:pt>
                <c:pt idx="399">
                  <c:v>1591.1959999999999</c:v>
                </c:pt>
                <c:pt idx="400">
                  <c:v>1599.192</c:v>
                </c:pt>
                <c:pt idx="401">
                  <c:v>1599.192</c:v>
                </c:pt>
              </c:numCache>
            </c:numRef>
          </c:xVal>
          <c:yVal>
            <c:numRef>
              <c:f>Foglio6!$B$424:$B$82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808</c:v>
                </c:pt>
                <c:pt idx="157">
                  <c:v>22.5</c:v>
                </c:pt>
                <c:pt idx="158">
                  <c:v>22</c:v>
                </c:pt>
                <c:pt idx="159">
                  <c:v>21.5</c:v>
                </c:pt>
                <c:pt idx="160">
                  <c:v>21</c:v>
                </c:pt>
                <c:pt idx="161">
                  <c:v>20.5</c:v>
                </c:pt>
                <c:pt idx="162">
                  <c:v>20</c:v>
                </c:pt>
                <c:pt idx="163">
                  <c:v>19.853000000000002</c:v>
                </c:pt>
                <c:pt idx="164">
                  <c:v>19.5</c:v>
                </c:pt>
                <c:pt idx="165">
                  <c:v>19</c:v>
                </c:pt>
                <c:pt idx="166">
                  <c:v>18.5</c:v>
                </c:pt>
                <c:pt idx="167">
                  <c:v>18.169</c:v>
                </c:pt>
                <c:pt idx="168">
                  <c:v>18</c:v>
                </c:pt>
                <c:pt idx="169">
                  <c:v>17.5</c:v>
                </c:pt>
                <c:pt idx="170">
                  <c:v>17</c:v>
                </c:pt>
                <c:pt idx="171">
                  <c:v>16.943999999999999</c:v>
                </c:pt>
                <c:pt idx="172">
                  <c:v>16.5</c:v>
                </c:pt>
                <c:pt idx="173">
                  <c:v>16</c:v>
                </c:pt>
                <c:pt idx="174">
                  <c:v>15.949</c:v>
                </c:pt>
                <c:pt idx="175">
                  <c:v>15.5</c:v>
                </c:pt>
                <c:pt idx="176">
                  <c:v>15.12</c:v>
                </c:pt>
                <c:pt idx="177">
                  <c:v>15</c:v>
                </c:pt>
                <c:pt idx="178">
                  <c:v>14.5</c:v>
                </c:pt>
                <c:pt idx="179">
                  <c:v>14.391999999999999</c:v>
                </c:pt>
                <c:pt idx="180">
                  <c:v>14</c:v>
                </c:pt>
                <c:pt idx="181">
                  <c:v>13.749000000000001</c:v>
                </c:pt>
                <c:pt idx="182">
                  <c:v>13.5</c:v>
                </c:pt>
                <c:pt idx="183">
                  <c:v>13.154</c:v>
                </c:pt>
                <c:pt idx="184">
                  <c:v>13</c:v>
                </c:pt>
                <c:pt idx="185">
                  <c:v>12.615</c:v>
                </c:pt>
                <c:pt idx="186">
                  <c:v>12.5</c:v>
                </c:pt>
                <c:pt idx="187">
                  <c:v>12.148</c:v>
                </c:pt>
                <c:pt idx="188">
                  <c:v>12</c:v>
                </c:pt>
                <c:pt idx="189">
                  <c:v>11.722</c:v>
                </c:pt>
                <c:pt idx="190">
                  <c:v>11.5</c:v>
                </c:pt>
                <c:pt idx="191">
                  <c:v>11.313000000000001</c:v>
                </c:pt>
                <c:pt idx="192">
                  <c:v>11</c:v>
                </c:pt>
                <c:pt idx="193">
                  <c:v>10.929</c:v>
                </c:pt>
                <c:pt idx="194">
                  <c:v>10.574999999999999</c:v>
                </c:pt>
                <c:pt idx="195">
                  <c:v>10.5</c:v>
                </c:pt>
                <c:pt idx="196">
                  <c:v>10.273999999999999</c:v>
                </c:pt>
                <c:pt idx="197">
                  <c:v>10</c:v>
                </c:pt>
                <c:pt idx="198">
                  <c:v>9.9730000000000008</c:v>
                </c:pt>
                <c:pt idx="199">
                  <c:v>9.6959999999999997</c:v>
                </c:pt>
                <c:pt idx="200">
                  <c:v>9.5</c:v>
                </c:pt>
                <c:pt idx="201">
                  <c:v>9.4179999999999993</c:v>
                </c:pt>
                <c:pt idx="202">
                  <c:v>9.1750000000000007</c:v>
                </c:pt>
                <c:pt idx="203">
                  <c:v>9</c:v>
                </c:pt>
                <c:pt idx="204">
                  <c:v>8.9410000000000007</c:v>
                </c:pt>
                <c:pt idx="205">
                  <c:v>8.7170000000000005</c:v>
                </c:pt>
                <c:pt idx="206">
                  <c:v>8.5169999999999995</c:v>
                </c:pt>
                <c:pt idx="207">
                  <c:v>8.5</c:v>
                </c:pt>
                <c:pt idx="208">
                  <c:v>8.3040000000000003</c:v>
                </c:pt>
                <c:pt idx="209">
                  <c:v>8.1059999999999999</c:v>
                </c:pt>
                <c:pt idx="210">
                  <c:v>8</c:v>
                </c:pt>
                <c:pt idx="211">
                  <c:v>7.9290000000000003</c:v>
                </c:pt>
                <c:pt idx="212">
                  <c:v>7.7610000000000001</c:v>
                </c:pt>
                <c:pt idx="213">
                  <c:v>7.5970000000000004</c:v>
                </c:pt>
                <c:pt idx="214">
                  <c:v>7.5</c:v>
                </c:pt>
                <c:pt idx="215">
                  <c:v>7.444</c:v>
                </c:pt>
                <c:pt idx="216">
                  <c:v>7.2839999999999998</c:v>
                </c:pt>
                <c:pt idx="217">
                  <c:v>7.1369999999999996</c:v>
                </c:pt>
                <c:pt idx="218">
                  <c:v>7</c:v>
                </c:pt>
                <c:pt idx="219">
                  <c:v>6.9749999999999996</c:v>
                </c:pt>
                <c:pt idx="220">
                  <c:v>6.8390000000000004</c:v>
                </c:pt>
                <c:pt idx="221">
                  <c:v>6.7140000000000004</c:v>
                </c:pt>
                <c:pt idx="222">
                  <c:v>6.5839999999999996</c:v>
                </c:pt>
                <c:pt idx="223">
                  <c:v>6.5</c:v>
                </c:pt>
                <c:pt idx="224">
                  <c:v>6.4690000000000003</c:v>
                </c:pt>
                <c:pt idx="225">
                  <c:v>6.3460000000000001</c:v>
                </c:pt>
                <c:pt idx="226">
                  <c:v>6.2249999999999996</c:v>
                </c:pt>
                <c:pt idx="227">
                  <c:v>6.125</c:v>
                </c:pt>
                <c:pt idx="228">
                  <c:v>6.01</c:v>
                </c:pt>
                <c:pt idx="229">
                  <c:v>6</c:v>
                </c:pt>
                <c:pt idx="230">
                  <c:v>5.9119999999999999</c:v>
                </c:pt>
                <c:pt idx="231">
                  <c:v>5.8159999999999998</c:v>
                </c:pt>
                <c:pt idx="232">
                  <c:v>5.7050000000000001</c:v>
                </c:pt>
                <c:pt idx="233">
                  <c:v>5.6159999999999997</c:v>
                </c:pt>
                <c:pt idx="234">
                  <c:v>5.5279999999999996</c:v>
                </c:pt>
                <c:pt idx="235">
                  <c:v>5.5</c:v>
                </c:pt>
                <c:pt idx="236">
                  <c:v>5.4349999999999996</c:v>
                </c:pt>
                <c:pt idx="237">
                  <c:v>5.3460000000000001</c:v>
                </c:pt>
                <c:pt idx="238">
                  <c:v>5.258</c:v>
                </c:pt>
                <c:pt idx="239">
                  <c:v>5.1669999999999998</c:v>
                </c:pt>
                <c:pt idx="240">
                  <c:v>5.0830000000000002</c:v>
                </c:pt>
                <c:pt idx="241">
                  <c:v>5</c:v>
                </c:pt>
                <c:pt idx="242">
                  <c:v>4.9980000000000002</c:v>
                </c:pt>
                <c:pt idx="243">
                  <c:v>4.9160000000000004</c:v>
                </c:pt>
                <c:pt idx="244">
                  <c:v>4.851</c:v>
                </c:pt>
                <c:pt idx="245">
                  <c:v>4.7720000000000002</c:v>
                </c:pt>
                <c:pt idx="246">
                  <c:v>4.7050000000000001</c:v>
                </c:pt>
                <c:pt idx="247">
                  <c:v>4.6449999999999996</c:v>
                </c:pt>
                <c:pt idx="248">
                  <c:v>4.5739999999999998</c:v>
                </c:pt>
                <c:pt idx="249">
                  <c:v>4.5069999999999997</c:v>
                </c:pt>
                <c:pt idx="250">
                  <c:v>4.5</c:v>
                </c:pt>
                <c:pt idx="251">
                  <c:v>4.4359999999999999</c:v>
                </c:pt>
                <c:pt idx="252">
                  <c:v>4.3780000000000001</c:v>
                </c:pt>
                <c:pt idx="253">
                  <c:v>4.319</c:v>
                </c:pt>
                <c:pt idx="254">
                  <c:v>4.2530000000000001</c:v>
                </c:pt>
                <c:pt idx="255">
                  <c:v>4.1909999999999998</c:v>
                </c:pt>
                <c:pt idx="256">
                  <c:v>4.13</c:v>
                </c:pt>
                <c:pt idx="257">
                  <c:v>4.0730000000000004</c:v>
                </c:pt>
                <c:pt idx="258">
                  <c:v>4.01</c:v>
                </c:pt>
                <c:pt idx="259">
                  <c:v>4</c:v>
                </c:pt>
                <c:pt idx="260">
                  <c:v>3.956</c:v>
                </c:pt>
                <c:pt idx="261">
                  <c:v>3.9009999999999998</c:v>
                </c:pt>
                <c:pt idx="262">
                  <c:v>3.8530000000000002</c:v>
                </c:pt>
                <c:pt idx="263">
                  <c:v>3.7890000000000001</c:v>
                </c:pt>
                <c:pt idx="264">
                  <c:v>3.734</c:v>
                </c:pt>
                <c:pt idx="265">
                  <c:v>3.6859999999999999</c:v>
                </c:pt>
                <c:pt idx="266">
                  <c:v>3.6339999999999999</c:v>
                </c:pt>
                <c:pt idx="267">
                  <c:v>3.59</c:v>
                </c:pt>
                <c:pt idx="268">
                  <c:v>3.5350000000000001</c:v>
                </c:pt>
                <c:pt idx="269">
                  <c:v>3.5</c:v>
                </c:pt>
                <c:pt idx="270">
                  <c:v>3.4870000000000001</c:v>
                </c:pt>
                <c:pt idx="271">
                  <c:v>3.444</c:v>
                </c:pt>
                <c:pt idx="272">
                  <c:v>3.3969999999999998</c:v>
                </c:pt>
                <c:pt idx="273">
                  <c:v>3.3479999999999999</c:v>
                </c:pt>
                <c:pt idx="274">
                  <c:v>3.2970000000000002</c:v>
                </c:pt>
                <c:pt idx="275">
                  <c:v>3.254</c:v>
                </c:pt>
                <c:pt idx="276">
                  <c:v>3.214</c:v>
                </c:pt>
                <c:pt idx="277">
                  <c:v>3.17</c:v>
                </c:pt>
                <c:pt idx="278">
                  <c:v>3.1259999999999999</c:v>
                </c:pt>
                <c:pt idx="279">
                  <c:v>3.0819999999999999</c:v>
                </c:pt>
                <c:pt idx="280">
                  <c:v>3.0379999999999998</c:v>
                </c:pt>
                <c:pt idx="281">
                  <c:v>3</c:v>
                </c:pt>
                <c:pt idx="282">
                  <c:v>3</c:v>
                </c:pt>
                <c:pt idx="283">
                  <c:v>2.9550000000000001</c:v>
                </c:pt>
                <c:pt idx="284">
                  <c:v>2.9169999999999998</c:v>
                </c:pt>
                <c:pt idx="285">
                  <c:v>2.8809999999999998</c:v>
                </c:pt>
                <c:pt idx="286">
                  <c:v>2.8420000000000001</c:v>
                </c:pt>
                <c:pt idx="287">
                  <c:v>2.7949999999999999</c:v>
                </c:pt>
                <c:pt idx="288">
                  <c:v>2.7519999999999998</c:v>
                </c:pt>
                <c:pt idx="289">
                  <c:v>2.7069999999999999</c:v>
                </c:pt>
                <c:pt idx="290">
                  <c:v>2.6720000000000002</c:v>
                </c:pt>
                <c:pt idx="291">
                  <c:v>2.6360000000000001</c:v>
                </c:pt>
                <c:pt idx="292">
                  <c:v>2.6</c:v>
                </c:pt>
                <c:pt idx="293">
                  <c:v>2.5649999999999999</c:v>
                </c:pt>
                <c:pt idx="294">
                  <c:v>2.5350000000000001</c:v>
                </c:pt>
                <c:pt idx="295">
                  <c:v>2.5</c:v>
                </c:pt>
                <c:pt idx="296">
                  <c:v>2.4990000000000001</c:v>
                </c:pt>
                <c:pt idx="297">
                  <c:v>2.464</c:v>
                </c:pt>
                <c:pt idx="298">
                  <c:v>2.4220000000000002</c:v>
                </c:pt>
                <c:pt idx="299">
                  <c:v>2.3860000000000001</c:v>
                </c:pt>
                <c:pt idx="300">
                  <c:v>2.3460000000000001</c:v>
                </c:pt>
                <c:pt idx="301">
                  <c:v>2.3159999999999998</c:v>
                </c:pt>
                <c:pt idx="302">
                  <c:v>2.282</c:v>
                </c:pt>
                <c:pt idx="303">
                  <c:v>2.2450000000000001</c:v>
                </c:pt>
                <c:pt idx="304">
                  <c:v>2.2109999999999999</c:v>
                </c:pt>
                <c:pt idx="305">
                  <c:v>2.177</c:v>
                </c:pt>
                <c:pt idx="306">
                  <c:v>2.1379999999999999</c:v>
                </c:pt>
                <c:pt idx="307">
                  <c:v>2.1120000000000001</c:v>
                </c:pt>
                <c:pt idx="308">
                  <c:v>2.0790000000000002</c:v>
                </c:pt>
                <c:pt idx="309">
                  <c:v>2.0489999999999999</c:v>
                </c:pt>
                <c:pt idx="310">
                  <c:v>2.02</c:v>
                </c:pt>
                <c:pt idx="311">
                  <c:v>2</c:v>
                </c:pt>
                <c:pt idx="312">
                  <c:v>1.986</c:v>
                </c:pt>
                <c:pt idx="313">
                  <c:v>1.9570000000000001</c:v>
                </c:pt>
                <c:pt idx="314">
                  <c:v>1.923</c:v>
                </c:pt>
                <c:pt idx="315">
                  <c:v>1.889</c:v>
                </c:pt>
                <c:pt idx="316">
                  <c:v>1.861</c:v>
                </c:pt>
                <c:pt idx="317">
                  <c:v>1.827</c:v>
                </c:pt>
                <c:pt idx="318">
                  <c:v>1.794</c:v>
                </c:pt>
                <c:pt idx="319">
                  <c:v>1.766</c:v>
                </c:pt>
                <c:pt idx="320">
                  <c:v>1.734</c:v>
                </c:pt>
                <c:pt idx="321">
                  <c:v>1.7010000000000001</c:v>
                </c:pt>
                <c:pt idx="322">
                  <c:v>1.669</c:v>
                </c:pt>
                <c:pt idx="323">
                  <c:v>1.6359999999999999</c:v>
                </c:pt>
                <c:pt idx="324">
                  <c:v>1.609</c:v>
                </c:pt>
                <c:pt idx="325">
                  <c:v>1.579</c:v>
                </c:pt>
                <c:pt idx="326">
                  <c:v>1.554</c:v>
                </c:pt>
                <c:pt idx="327">
                  <c:v>1.526</c:v>
                </c:pt>
                <c:pt idx="328">
                  <c:v>1.5029999999999999</c:v>
                </c:pt>
                <c:pt idx="329">
                  <c:v>1.5</c:v>
                </c:pt>
                <c:pt idx="330">
                  <c:v>1.4790000000000001</c:v>
                </c:pt>
                <c:pt idx="331">
                  <c:v>1.4510000000000001</c:v>
                </c:pt>
                <c:pt idx="332">
                  <c:v>1.423</c:v>
                </c:pt>
                <c:pt idx="333">
                  <c:v>1.387</c:v>
                </c:pt>
                <c:pt idx="334">
                  <c:v>1.3620000000000001</c:v>
                </c:pt>
                <c:pt idx="335">
                  <c:v>1.339</c:v>
                </c:pt>
                <c:pt idx="336">
                  <c:v>1.3160000000000001</c:v>
                </c:pt>
                <c:pt idx="337">
                  <c:v>1.2889999999999999</c:v>
                </c:pt>
                <c:pt idx="338">
                  <c:v>1.262</c:v>
                </c:pt>
                <c:pt idx="339">
                  <c:v>1.2330000000000001</c:v>
                </c:pt>
                <c:pt idx="340">
                  <c:v>1.206</c:v>
                </c:pt>
                <c:pt idx="341">
                  <c:v>1.173</c:v>
                </c:pt>
                <c:pt idx="342">
                  <c:v>1.1459999999999999</c:v>
                </c:pt>
                <c:pt idx="343">
                  <c:v>1.1200000000000001</c:v>
                </c:pt>
                <c:pt idx="344">
                  <c:v>1.0920000000000001</c:v>
                </c:pt>
                <c:pt idx="345">
                  <c:v>1.0669999999999999</c:v>
                </c:pt>
                <c:pt idx="346">
                  <c:v>1.0449999999999999</c:v>
                </c:pt>
                <c:pt idx="347">
                  <c:v>1.0229999999999999</c:v>
                </c:pt>
                <c:pt idx="348">
                  <c:v>1</c:v>
                </c:pt>
                <c:pt idx="349">
                  <c:v>1</c:v>
                </c:pt>
                <c:pt idx="350">
                  <c:v>0.97299999999999998</c:v>
                </c:pt>
                <c:pt idx="351">
                  <c:v>0.94799999999999995</c:v>
                </c:pt>
                <c:pt idx="352">
                  <c:v>0.92</c:v>
                </c:pt>
                <c:pt idx="353">
                  <c:v>0.89600000000000002</c:v>
                </c:pt>
                <c:pt idx="354">
                  <c:v>0.873</c:v>
                </c:pt>
                <c:pt idx="355">
                  <c:v>0.84499999999999997</c:v>
                </c:pt>
                <c:pt idx="356">
                  <c:v>0.82</c:v>
                </c:pt>
                <c:pt idx="357">
                  <c:v>0.79300000000000004</c:v>
                </c:pt>
                <c:pt idx="358">
                  <c:v>0.76600000000000001</c:v>
                </c:pt>
                <c:pt idx="359">
                  <c:v>0.74199999999999999</c:v>
                </c:pt>
                <c:pt idx="360">
                  <c:v>0.71299999999999997</c:v>
                </c:pt>
                <c:pt idx="361">
                  <c:v>0.69199999999999995</c:v>
                </c:pt>
                <c:pt idx="362">
                  <c:v>0.66200000000000003</c:v>
                </c:pt>
                <c:pt idx="363">
                  <c:v>0.64400000000000002</c:v>
                </c:pt>
                <c:pt idx="364">
                  <c:v>0.624</c:v>
                </c:pt>
                <c:pt idx="365">
                  <c:v>0.60099999999999998</c:v>
                </c:pt>
                <c:pt idx="366">
                  <c:v>0.57699999999999996</c:v>
                </c:pt>
                <c:pt idx="367">
                  <c:v>0.55900000000000005</c:v>
                </c:pt>
                <c:pt idx="368">
                  <c:v>0.53200000000000003</c:v>
                </c:pt>
                <c:pt idx="369">
                  <c:v>0.50700000000000001</c:v>
                </c:pt>
                <c:pt idx="370">
                  <c:v>0.5</c:v>
                </c:pt>
                <c:pt idx="371">
                  <c:v>0.47799999999999998</c:v>
                </c:pt>
                <c:pt idx="372">
                  <c:v>0.46</c:v>
                </c:pt>
                <c:pt idx="373">
                  <c:v>0.435</c:v>
                </c:pt>
                <c:pt idx="374">
                  <c:v>0.41099999999999998</c:v>
                </c:pt>
                <c:pt idx="375">
                  <c:v>0.38900000000000001</c:v>
                </c:pt>
                <c:pt idx="376">
                  <c:v>0.371</c:v>
                </c:pt>
                <c:pt idx="377">
                  <c:v>0.35</c:v>
                </c:pt>
                <c:pt idx="378">
                  <c:v>0.32700000000000001</c:v>
                </c:pt>
                <c:pt idx="379">
                  <c:v>0.30599999999999999</c:v>
                </c:pt>
                <c:pt idx="380">
                  <c:v>0.28199999999999997</c:v>
                </c:pt>
                <c:pt idx="381">
                  <c:v>0.254</c:v>
                </c:pt>
                <c:pt idx="382">
                  <c:v>0.23499999999999999</c:v>
                </c:pt>
                <c:pt idx="383">
                  <c:v>0.21299999999999999</c:v>
                </c:pt>
                <c:pt idx="384">
                  <c:v>0.193</c:v>
                </c:pt>
                <c:pt idx="385">
                  <c:v>0.17</c:v>
                </c:pt>
                <c:pt idx="386">
                  <c:v>0.14899999999999999</c:v>
                </c:pt>
                <c:pt idx="387">
                  <c:v>0.128</c:v>
                </c:pt>
                <c:pt idx="388">
                  <c:v>0.105</c:v>
                </c:pt>
                <c:pt idx="389">
                  <c:v>8.7999999999999995E-2</c:v>
                </c:pt>
                <c:pt idx="390">
                  <c:v>7.0999999999999994E-2</c:v>
                </c:pt>
                <c:pt idx="391">
                  <c:v>5.6000000000000001E-2</c:v>
                </c:pt>
                <c:pt idx="392">
                  <c:v>3.9E-2</c:v>
                </c:pt>
                <c:pt idx="393">
                  <c:v>2.5999999999999999E-2</c:v>
                </c:pt>
                <c:pt idx="394">
                  <c:v>1.6E-2</c:v>
                </c:pt>
                <c:pt idx="395">
                  <c:v>8.9999999999999993E-3</c:v>
                </c:pt>
                <c:pt idx="396">
                  <c:v>4.0000000000000001E-3</c:v>
                </c:pt>
                <c:pt idx="397">
                  <c:v>3.0000000000000001E-3</c:v>
                </c:pt>
                <c:pt idx="398">
                  <c:v>2E-3</c:v>
                </c:pt>
                <c:pt idx="399">
                  <c:v>1E-3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237-45B1-A7AA-312291C87353}"/>
            </c:ext>
          </c:extLst>
        </c:ser>
        <c:ser>
          <c:idx val="3"/>
          <c:order val="1"/>
          <c:tx>
            <c:strRef>
              <c:f>Foglio6!$C$1</c:f>
              <c:strCache>
                <c:ptCount val="1"/>
                <c:pt idx="0">
                  <c:v>S1,0NA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dLbls>
            <c:dLbl>
              <c:idx val="401"/>
              <c:dLblPos val="r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C237-45B1-A7AA-312291C8735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Foglio6!$C$424:$C$82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1.4999999999999999E-2</c:v>
                </c:pt>
                <c:pt idx="70">
                  <c:v>3.6999999999999998E-2</c:v>
                </c:pt>
                <c:pt idx="71">
                  <c:v>5.8999999999999997E-2</c:v>
                </c:pt>
                <c:pt idx="72">
                  <c:v>8.1000000000000003E-2</c:v>
                </c:pt>
                <c:pt idx="73">
                  <c:v>0.10299999999999999</c:v>
                </c:pt>
                <c:pt idx="74">
                  <c:v>0.125</c:v>
                </c:pt>
                <c:pt idx="75">
                  <c:v>0.14699999999999999</c:v>
                </c:pt>
                <c:pt idx="76">
                  <c:v>0.16900000000000001</c:v>
                </c:pt>
                <c:pt idx="77">
                  <c:v>0.191</c:v>
                </c:pt>
                <c:pt idx="78">
                  <c:v>0.21299999999999999</c:v>
                </c:pt>
                <c:pt idx="79">
                  <c:v>0.23499999999999999</c:v>
                </c:pt>
                <c:pt idx="80">
                  <c:v>0.25700000000000001</c:v>
                </c:pt>
                <c:pt idx="81">
                  <c:v>0.27900000000000003</c:v>
                </c:pt>
                <c:pt idx="82">
                  <c:v>0.30099999999999999</c:v>
                </c:pt>
                <c:pt idx="83">
                  <c:v>0.32300000000000001</c:v>
                </c:pt>
                <c:pt idx="84">
                  <c:v>0.34599999999999997</c:v>
                </c:pt>
                <c:pt idx="85">
                  <c:v>0.36799999999999999</c:v>
                </c:pt>
                <c:pt idx="86">
                  <c:v>0.39</c:v>
                </c:pt>
                <c:pt idx="87">
                  <c:v>0.41199999999999998</c:v>
                </c:pt>
                <c:pt idx="88">
                  <c:v>0.434</c:v>
                </c:pt>
                <c:pt idx="89">
                  <c:v>0.45600000000000002</c:v>
                </c:pt>
                <c:pt idx="90">
                  <c:v>0.47799999999999998</c:v>
                </c:pt>
                <c:pt idx="91">
                  <c:v>0.5</c:v>
                </c:pt>
                <c:pt idx="92">
                  <c:v>0.52200000000000002</c:v>
                </c:pt>
                <c:pt idx="93">
                  <c:v>0.54400000000000004</c:v>
                </c:pt>
                <c:pt idx="94">
                  <c:v>0.56599999999999995</c:v>
                </c:pt>
                <c:pt idx="95">
                  <c:v>0.58799999999999997</c:v>
                </c:pt>
                <c:pt idx="96">
                  <c:v>0.61</c:v>
                </c:pt>
                <c:pt idx="97">
                  <c:v>0.63200000000000001</c:v>
                </c:pt>
                <c:pt idx="98">
                  <c:v>0.65400000000000003</c:v>
                </c:pt>
                <c:pt idx="99">
                  <c:v>0.67600000000000005</c:v>
                </c:pt>
                <c:pt idx="100">
                  <c:v>0.69799999999999995</c:v>
                </c:pt>
                <c:pt idx="101">
                  <c:v>0.72099999999999997</c:v>
                </c:pt>
                <c:pt idx="102">
                  <c:v>0.74299999999999999</c:v>
                </c:pt>
                <c:pt idx="103">
                  <c:v>0.76500000000000001</c:v>
                </c:pt>
                <c:pt idx="104">
                  <c:v>0.78700000000000003</c:v>
                </c:pt>
                <c:pt idx="105">
                  <c:v>0.80900000000000005</c:v>
                </c:pt>
                <c:pt idx="106">
                  <c:v>0.83099999999999996</c:v>
                </c:pt>
                <c:pt idx="107">
                  <c:v>0.85299999999999998</c:v>
                </c:pt>
                <c:pt idx="108">
                  <c:v>0.875</c:v>
                </c:pt>
                <c:pt idx="109">
                  <c:v>0.89700000000000002</c:v>
                </c:pt>
                <c:pt idx="110">
                  <c:v>0.91900000000000004</c:v>
                </c:pt>
                <c:pt idx="111">
                  <c:v>0.94099999999999995</c:v>
                </c:pt>
                <c:pt idx="112">
                  <c:v>0.96299999999999997</c:v>
                </c:pt>
                <c:pt idx="113">
                  <c:v>0.98499999999999999</c:v>
                </c:pt>
                <c:pt idx="114">
                  <c:v>1.0069999999999999</c:v>
                </c:pt>
                <c:pt idx="115">
                  <c:v>1.0289999999999999</c:v>
                </c:pt>
                <c:pt idx="116">
                  <c:v>1.0509999999999999</c:v>
                </c:pt>
                <c:pt idx="117">
                  <c:v>1.073</c:v>
                </c:pt>
                <c:pt idx="118">
                  <c:v>1.095</c:v>
                </c:pt>
                <c:pt idx="119">
                  <c:v>1.1180000000000001</c:v>
                </c:pt>
                <c:pt idx="120">
                  <c:v>1.1399999999999999</c:v>
                </c:pt>
                <c:pt idx="121">
                  <c:v>1.1619999999999999</c:v>
                </c:pt>
                <c:pt idx="122">
                  <c:v>1.1839999999999999</c:v>
                </c:pt>
                <c:pt idx="123">
                  <c:v>1.206</c:v>
                </c:pt>
                <c:pt idx="124">
                  <c:v>1.228</c:v>
                </c:pt>
                <c:pt idx="125">
                  <c:v>1.25</c:v>
                </c:pt>
                <c:pt idx="126">
                  <c:v>1.272</c:v>
                </c:pt>
                <c:pt idx="127">
                  <c:v>1.294</c:v>
                </c:pt>
                <c:pt idx="128">
                  <c:v>1.3160000000000001</c:v>
                </c:pt>
                <c:pt idx="129">
                  <c:v>1.3380000000000001</c:v>
                </c:pt>
                <c:pt idx="130">
                  <c:v>1.36</c:v>
                </c:pt>
                <c:pt idx="131">
                  <c:v>1.3819999999999999</c:v>
                </c:pt>
                <c:pt idx="132">
                  <c:v>1.4039999999999999</c:v>
                </c:pt>
                <c:pt idx="133">
                  <c:v>1.4259999999999999</c:v>
                </c:pt>
                <c:pt idx="134">
                  <c:v>1.448</c:v>
                </c:pt>
                <c:pt idx="135">
                  <c:v>1.47</c:v>
                </c:pt>
                <c:pt idx="136">
                  <c:v>1.492</c:v>
                </c:pt>
                <c:pt idx="137">
                  <c:v>1.5149999999999999</c:v>
                </c:pt>
                <c:pt idx="138">
                  <c:v>1.5369999999999999</c:v>
                </c:pt>
                <c:pt idx="139">
                  <c:v>1.5589999999999999</c:v>
                </c:pt>
                <c:pt idx="140">
                  <c:v>1.581</c:v>
                </c:pt>
                <c:pt idx="141">
                  <c:v>1.605</c:v>
                </c:pt>
                <c:pt idx="142">
                  <c:v>1.8080000000000001</c:v>
                </c:pt>
                <c:pt idx="143">
                  <c:v>2.012</c:v>
                </c:pt>
                <c:pt idx="144">
                  <c:v>2.2149999999999999</c:v>
                </c:pt>
                <c:pt idx="145">
                  <c:v>2.419</c:v>
                </c:pt>
                <c:pt idx="146">
                  <c:v>2.6219999999999999</c:v>
                </c:pt>
                <c:pt idx="147">
                  <c:v>2.8260000000000001</c:v>
                </c:pt>
                <c:pt idx="148">
                  <c:v>3.0289999999999999</c:v>
                </c:pt>
                <c:pt idx="149">
                  <c:v>3.258</c:v>
                </c:pt>
                <c:pt idx="150">
                  <c:v>3.645</c:v>
                </c:pt>
                <c:pt idx="151">
                  <c:v>4.032</c:v>
                </c:pt>
                <c:pt idx="152">
                  <c:v>4.4189999999999996</c:v>
                </c:pt>
                <c:pt idx="153">
                  <c:v>4.8070000000000004</c:v>
                </c:pt>
                <c:pt idx="154">
                  <c:v>5.3849999999999998</c:v>
                </c:pt>
                <c:pt idx="155">
                  <c:v>5.9640000000000004</c:v>
                </c:pt>
                <c:pt idx="156">
                  <c:v>6.5869999999999997</c:v>
                </c:pt>
                <c:pt idx="157">
                  <c:v>7.3620000000000001</c:v>
                </c:pt>
                <c:pt idx="158">
                  <c:v>8.0129999999999999</c:v>
                </c:pt>
                <c:pt idx="159">
                  <c:v>8.17</c:v>
                </c:pt>
                <c:pt idx="160">
                  <c:v>9.1560000000000006</c:v>
                </c:pt>
                <c:pt idx="161">
                  <c:v>10.246</c:v>
                </c:pt>
                <c:pt idx="162">
                  <c:v>11.465</c:v>
                </c:pt>
                <c:pt idx="163">
                  <c:v>12.862</c:v>
                </c:pt>
                <c:pt idx="164">
                  <c:v>14.371</c:v>
                </c:pt>
                <c:pt idx="165">
                  <c:v>16.024999999999999</c:v>
                </c:pt>
                <c:pt idx="166">
                  <c:v>16.082000000000001</c:v>
                </c:pt>
                <c:pt idx="167">
                  <c:v>18.093</c:v>
                </c:pt>
                <c:pt idx="168">
                  <c:v>20.347000000000001</c:v>
                </c:pt>
                <c:pt idx="169">
                  <c:v>22.844999999999999</c:v>
                </c:pt>
                <c:pt idx="170">
                  <c:v>24.038</c:v>
                </c:pt>
                <c:pt idx="171">
                  <c:v>25.628</c:v>
                </c:pt>
                <c:pt idx="172">
                  <c:v>28.681000000000001</c:v>
                </c:pt>
                <c:pt idx="173">
                  <c:v>31.960999999999999</c:v>
                </c:pt>
                <c:pt idx="174">
                  <c:v>32.049999999999997</c:v>
                </c:pt>
                <c:pt idx="175">
                  <c:v>35.521999999999998</c:v>
                </c:pt>
                <c:pt idx="176">
                  <c:v>39.518000000000001</c:v>
                </c:pt>
                <c:pt idx="177">
                  <c:v>40.063000000000002</c:v>
                </c:pt>
                <c:pt idx="178">
                  <c:v>43.99</c:v>
                </c:pt>
                <c:pt idx="179">
                  <c:v>48.075000000000003</c:v>
                </c:pt>
                <c:pt idx="180">
                  <c:v>49.052</c:v>
                </c:pt>
                <c:pt idx="181">
                  <c:v>54.442</c:v>
                </c:pt>
                <c:pt idx="182">
                  <c:v>56.088000000000001</c:v>
                </c:pt>
                <c:pt idx="183">
                  <c:v>60.503999999999998</c:v>
                </c:pt>
                <c:pt idx="184">
                  <c:v>64.099999999999994</c:v>
                </c:pt>
                <c:pt idx="185">
                  <c:v>66.679000000000002</c:v>
                </c:pt>
                <c:pt idx="186">
                  <c:v>72.113</c:v>
                </c:pt>
                <c:pt idx="187">
                  <c:v>73.92</c:v>
                </c:pt>
                <c:pt idx="188">
                  <c:v>80.125</c:v>
                </c:pt>
                <c:pt idx="189">
                  <c:v>81.947999999999993</c:v>
                </c:pt>
                <c:pt idx="190">
                  <c:v>88.138000000000005</c:v>
                </c:pt>
                <c:pt idx="191">
                  <c:v>91.37</c:v>
                </c:pt>
                <c:pt idx="192">
                  <c:v>96.15</c:v>
                </c:pt>
                <c:pt idx="193">
                  <c:v>101.873</c:v>
                </c:pt>
                <c:pt idx="194">
                  <c:v>104.163</c:v>
                </c:pt>
                <c:pt idx="195">
                  <c:v>112.175</c:v>
                </c:pt>
                <c:pt idx="196">
                  <c:v>113.398</c:v>
                </c:pt>
                <c:pt idx="197">
                  <c:v>120.188</c:v>
                </c:pt>
                <c:pt idx="198">
                  <c:v>126.83199999999999</c:v>
                </c:pt>
                <c:pt idx="199">
                  <c:v>128.19999999999999</c:v>
                </c:pt>
                <c:pt idx="200">
                  <c:v>136.21299999999999</c:v>
                </c:pt>
                <c:pt idx="201">
                  <c:v>141.803</c:v>
                </c:pt>
                <c:pt idx="202">
                  <c:v>144.22499999999999</c:v>
                </c:pt>
                <c:pt idx="203">
                  <c:v>152.238</c:v>
                </c:pt>
                <c:pt idx="204">
                  <c:v>159.29499999999999</c:v>
                </c:pt>
                <c:pt idx="205">
                  <c:v>160.25</c:v>
                </c:pt>
                <c:pt idx="206">
                  <c:v>168.26300000000001</c:v>
                </c:pt>
                <c:pt idx="207">
                  <c:v>176.27500000000001</c:v>
                </c:pt>
                <c:pt idx="208">
                  <c:v>179.65299999999999</c:v>
                </c:pt>
                <c:pt idx="209">
                  <c:v>184.28800000000001</c:v>
                </c:pt>
                <c:pt idx="210">
                  <c:v>192.3</c:v>
                </c:pt>
                <c:pt idx="211">
                  <c:v>200.31299999999999</c:v>
                </c:pt>
                <c:pt idx="212">
                  <c:v>202.13</c:v>
                </c:pt>
                <c:pt idx="213">
                  <c:v>208.32599999999999</c:v>
                </c:pt>
                <c:pt idx="214">
                  <c:v>216.33799999999999</c:v>
                </c:pt>
                <c:pt idx="215">
                  <c:v>224.351</c:v>
                </c:pt>
                <c:pt idx="216">
                  <c:v>228.22900000000001</c:v>
                </c:pt>
                <c:pt idx="217">
                  <c:v>232.363</c:v>
                </c:pt>
                <c:pt idx="218">
                  <c:v>240.376</c:v>
                </c:pt>
                <c:pt idx="219">
                  <c:v>248.38800000000001</c:v>
                </c:pt>
                <c:pt idx="220">
                  <c:v>256.40100000000001</c:v>
                </c:pt>
                <c:pt idx="221">
                  <c:v>259.67700000000002</c:v>
                </c:pt>
                <c:pt idx="222">
                  <c:v>264.41300000000001</c:v>
                </c:pt>
                <c:pt idx="223">
                  <c:v>272.42599999999999</c:v>
                </c:pt>
                <c:pt idx="224">
                  <c:v>280.43799999999999</c:v>
                </c:pt>
                <c:pt idx="225">
                  <c:v>288.45100000000002</c:v>
                </c:pt>
                <c:pt idx="226">
                  <c:v>293.846</c:v>
                </c:pt>
                <c:pt idx="227">
                  <c:v>296.46300000000002</c:v>
                </c:pt>
                <c:pt idx="228">
                  <c:v>304.476</c:v>
                </c:pt>
                <c:pt idx="229">
                  <c:v>312.488</c:v>
                </c:pt>
                <c:pt idx="230">
                  <c:v>320.50099999999998</c:v>
                </c:pt>
                <c:pt idx="231">
                  <c:v>328.51299999999998</c:v>
                </c:pt>
                <c:pt idx="232">
                  <c:v>335.97699999999998</c:v>
                </c:pt>
                <c:pt idx="233">
                  <c:v>336.52600000000001</c:v>
                </c:pt>
                <c:pt idx="234">
                  <c:v>344.53800000000001</c:v>
                </c:pt>
                <c:pt idx="235">
                  <c:v>352.55099999999999</c:v>
                </c:pt>
                <c:pt idx="236">
                  <c:v>360.56299999999999</c:v>
                </c:pt>
                <c:pt idx="237">
                  <c:v>368.57600000000002</c:v>
                </c:pt>
                <c:pt idx="238">
                  <c:v>376.58800000000002</c:v>
                </c:pt>
                <c:pt idx="239">
                  <c:v>384.601</c:v>
                </c:pt>
                <c:pt idx="240">
                  <c:v>384.91199999999998</c:v>
                </c:pt>
                <c:pt idx="241">
                  <c:v>392.613</c:v>
                </c:pt>
                <c:pt idx="242">
                  <c:v>400.62599999999998</c:v>
                </c:pt>
                <c:pt idx="243">
                  <c:v>408.63799999999998</c:v>
                </c:pt>
                <c:pt idx="244">
                  <c:v>416.65100000000001</c:v>
                </c:pt>
                <c:pt idx="245">
                  <c:v>424.66399999999999</c:v>
                </c:pt>
                <c:pt idx="246">
                  <c:v>432.67599999999999</c:v>
                </c:pt>
                <c:pt idx="247">
                  <c:v>440.68900000000002</c:v>
                </c:pt>
                <c:pt idx="248">
                  <c:v>442.61200000000002</c:v>
                </c:pt>
                <c:pt idx="249">
                  <c:v>448.70100000000002</c:v>
                </c:pt>
                <c:pt idx="250">
                  <c:v>456.714</c:v>
                </c:pt>
                <c:pt idx="251">
                  <c:v>464.726</c:v>
                </c:pt>
                <c:pt idx="252">
                  <c:v>472.73899999999998</c:v>
                </c:pt>
                <c:pt idx="253">
                  <c:v>480.75099999999998</c:v>
                </c:pt>
                <c:pt idx="254">
                  <c:v>488.76400000000001</c:v>
                </c:pt>
                <c:pt idx="255">
                  <c:v>496.77600000000001</c:v>
                </c:pt>
                <c:pt idx="256">
                  <c:v>504.78899999999999</c:v>
                </c:pt>
                <c:pt idx="257">
                  <c:v>512.80100000000004</c:v>
                </c:pt>
                <c:pt idx="258">
                  <c:v>512.84900000000005</c:v>
                </c:pt>
                <c:pt idx="259">
                  <c:v>520.81399999999996</c:v>
                </c:pt>
                <c:pt idx="260">
                  <c:v>528.82600000000002</c:v>
                </c:pt>
                <c:pt idx="261">
                  <c:v>536.83900000000006</c:v>
                </c:pt>
                <c:pt idx="262">
                  <c:v>544.851</c:v>
                </c:pt>
                <c:pt idx="263">
                  <c:v>552.86400000000003</c:v>
                </c:pt>
                <c:pt idx="264">
                  <c:v>560.87599999999998</c:v>
                </c:pt>
                <c:pt idx="265">
                  <c:v>568.88900000000001</c:v>
                </c:pt>
                <c:pt idx="266">
                  <c:v>576.90099999999995</c:v>
                </c:pt>
                <c:pt idx="267">
                  <c:v>584.91399999999999</c:v>
                </c:pt>
                <c:pt idx="268">
                  <c:v>592.92600000000004</c:v>
                </c:pt>
                <c:pt idx="269">
                  <c:v>596.01099999999997</c:v>
                </c:pt>
                <c:pt idx="270">
                  <c:v>600.93899999999996</c:v>
                </c:pt>
                <c:pt idx="271">
                  <c:v>608.95100000000002</c:v>
                </c:pt>
                <c:pt idx="272">
                  <c:v>616.96400000000006</c:v>
                </c:pt>
                <c:pt idx="273">
                  <c:v>624.97699999999998</c:v>
                </c:pt>
                <c:pt idx="274">
                  <c:v>632.98900000000003</c:v>
                </c:pt>
                <c:pt idx="275">
                  <c:v>641.00199999999995</c:v>
                </c:pt>
                <c:pt idx="276">
                  <c:v>649.01400000000001</c:v>
                </c:pt>
                <c:pt idx="277">
                  <c:v>657.02700000000004</c:v>
                </c:pt>
                <c:pt idx="278">
                  <c:v>665.03899999999999</c:v>
                </c:pt>
                <c:pt idx="279">
                  <c:v>673.05200000000002</c:v>
                </c:pt>
                <c:pt idx="280">
                  <c:v>681.06399999999996</c:v>
                </c:pt>
                <c:pt idx="281">
                  <c:v>689.077</c:v>
                </c:pt>
                <c:pt idx="282">
                  <c:v>693.44</c:v>
                </c:pt>
                <c:pt idx="283">
                  <c:v>697.08900000000006</c:v>
                </c:pt>
                <c:pt idx="284">
                  <c:v>705.10199999999998</c:v>
                </c:pt>
                <c:pt idx="285">
                  <c:v>713.11400000000003</c:v>
                </c:pt>
                <c:pt idx="286">
                  <c:v>721.12699999999995</c:v>
                </c:pt>
                <c:pt idx="287">
                  <c:v>729.13900000000001</c:v>
                </c:pt>
                <c:pt idx="288">
                  <c:v>737.15200000000004</c:v>
                </c:pt>
                <c:pt idx="289">
                  <c:v>745.16399999999999</c:v>
                </c:pt>
                <c:pt idx="290">
                  <c:v>753.17700000000002</c:v>
                </c:pt>
                <c:pt idx="291">
                  <c:v>761.18899999999996</c:v>
                </c:pt>
                <c:pt idx="292">
                  <c:v>769.202</c:v>
                </c:pt>
                <c:pt idx="293">
                  <c:v>777.21400000000006</c:v>
                </c:pt>
                <c:pt idx="294">
                  <c:v>785.22699999999998</c:v>
                </c:pt>
                <c:pt idx="295">
                  <c:v>793.23900000000003</c:v>
                </c:pt>
                <c:pt idx="296">
                  <c:v>801.25199999999995</c:v>
                </c:pt>
                <c:pt idx="297">
                  <c:v>806.46199999999999</c:v>
                </c:pt>
                <c:pt idx="298">
                  <c:v>809.26400000000001</c:v>
                </c:pt>
                <c:pt idx="299">
                  <c:v>817.27700000000004</c:v>
                </c:pt>
                <c:pt idx="300">
                  <c:v>825.29</c:v>
                </c:pt>
                <c:pt idx="301">
                  <c:v>833.30200000000002</c:v>
                </c:pt>
                <c:pt idx="302">
                  <c:v>841.31500000000005</c:v>
                </c:pt>
                <c:pt idx="303">
                  <c:v>849.327</c:v>
                </c:pt>
                <c:pt idx="304">
                  <c:v>857.34</c:v>
                </c:pt>
                <c:pt idx="305">
                  <c:v>865.35199999999998</c:v>
                </c:pt>
                <c:pt idx="306">
                  <c:v>873.36500000000001</c:v>
                </c:pt>
                <c:pt idx="307">
                  <c:v>881.37699999999995</c:v>
                </c:pt>
                <c:pt idx="308">
                  <c:v>889.39</c:v>
                </c:pt>
                <c:pt idx="309">
                  <c:v>897.40200000000004</c:v>
                </c:pt>
                <c:pt idx="310">
                  <c:v>905.41499999999996</c:v>
                </c:pt>
                <c:pt idx="311">
                  <c:v>913.42700000000002</c:v>
                </c:pt>
                <c:pt idx="312">
                  <c:v>921.44</c:v>
                </c:pt>
                <c:pt idx="313">
                  <c:v>929.452</c:v>
                </c:pt>
                <c:pt idx="314">
                  <c:v>937.46500000000003</c:v>
                </c:pt>
                <c:pt idx="315">
                  <c:v>942.09199999999998</c:v>
                </c:pt>
                <c:pt idx="316">
                  <c:v>945.47699999999998</c:v>
                </c:pt>
                <c:pt idx="317">
                  <c:v>953.49</c:v>
                </c:pt>
                <c:pt idx="318">
                  <c:v>961.50199999999995</c:v>
                </c:pt>
                <c:pt idx="319">
                  <c:v>969.51499999999999</c:v>
                </c:pt>
                <c:pt idx="320">
                  <c:v>977.52700000000004</c:v>
                </c:pt>
                <c:pt idx="321">
                  <c:v>985.54</c:v>
                </c:pt>
                <c:pt idx="322">
                  <c:v>993.55200000000002</c:v>
                </c:pt>
                <c:pt idx="323">
                  <c:v>1001.5650000000001</c:v>
                </c:pt>
                <c:pt idx="324">
                  <c:v>1009.577</c:v>
                </c:pt>
                <c:pt idx="325">
                  <c:v>1017.59</c:v>
                </c:pt>
                <c:pt idx="326">
                  <c:v>1025.6030000000001</c:v>
                </c:pt>
                <c:pt idx="327">
                  <c:v>1033.615</c:v>
                </c:pt>
                <c:pt idx="328">
                  <c:v>1041.6279999999999</c:v>
                </c:pt>
                <c:pt idx="329">
                  <c:v>1049.6400000000001</c:v>
                </c:pt>
                <c:pt idx="330">
                  <c:v>1057.653</c:v>
                </c:pt>
                <c:pt idx="331">
                  <c:v>1065.665</c:v>
                </c:pt>
                <c:pt idx="332">
                  <c:v>1073.6780000000001</c:v>
                </c:pt>
                <c:pt idx="333">
                  <c:v>1081.69</c:v>
                </c:pt>
                <c:pt idx="334">
                  <c:v>1089.703</c:v>
                </c:pt>
                <c:pt idx="335">
                  <c:v>1097.7149999999999</c:v>
                </c:pt>
                <c:pt idx="336">
                  <c:v>1104.5050000000001</c:v>
                </c:pt>
                <c:pt idx="337">
                  <c:v>1105.7280000000001</c:v>
                </c:pt>
                <c:pt idx="338">
                  <c:v>1113.74</c:v>
                </c:pt>
                <c:pt idx="339">
                  <c:v>1121.7529999999999</c:v>
                </c:pt>
                <c:pt idx="340">
                  <c:v>1129.7650000000001</c:v>
                </c:pt>
                <c:pt idx="341">
                  <c:v>1137.778</c:v>
                </c:pt>
                <c:pt idx="342">
                  <c:v>1145.79</c:v>
                </c:pt>
                <c:pt idx="343">
                  <c:v>1153.8030000000001</c:v>
                </c:pt>
                <c:pt idx="344">
                  <c:v>1161.8150000000001</c:v>
                </c:pt>
                <c:pt idx="345">
                  <c:v>1169.828</c:v>
                </c:pt>
                <c:pt idx="346">
                  <c:v>1177.8399999999999</c:v>
                </c:pt>
                <c:pt idx="347">
                  <c:v>1185.8530000000001</c:v>
                </c:pt>
                <c:pt idx="348">
                  <c:v>1193.865</c:v>
                </c:pt>
                <c:pt idx="349">
                  <c:v>1201.8779999999999</c:v>
                </c:pt>
                <c:pt idx="350">
                  <c:v>1209.8900000000001</c:v>
                </c:pt>
                <c:pt idx="351">
                  <c:v>1217.903</c:v>
                </c:pt>
                <c:pt idx="352">
                  <c:v>1225.915</c:v>
                </c:pt>
                <c:pt idx="353">
                  <c:v>1233.9280000000001</c:v>
                </c:pt>
                <c:pt idx="354">
                  <c:v>1241.941</c:v>
                </c:pt>
                <c:pt idx="355">
                  <c:v>1249.953</c:v>
                </c:pt>
                <c:pt idx="356">
                  <c:v>1257.9659999999999</c:v>
                </c:pt>
                <c:pt idx="357">
                  <c:v>1265.9780000000001</c:v>
                </c:pt>
                <c:pt idx="358">
                  <c:v>1273.991</c:v>
                </c:pt>
                <c:pt idx="359">
                  <c:v>1282.0029999999999</c:v>
                </c:pt>
                <c:pt idx="360">
                  <c:v>1290.0160000000001</c:v>
                </c:pt>
                <c:pt idx="361">
                  <c:v>1298.028</c:v>
                </c:pt>
                <c:pt idx="362">
                  <c:v>1300.319</c:v>
                </c:pt>
                <c:pt idx="363">
                  <c:v>1306.0409999999999</c:v>
                </c:pt>
                <c:pt idx="364">
                  <c:v>1314.0530000000001</c:v>
                </c:pt>
                <c:pt idx="365">
                  <c:v>1322.066</c:v>
                </c:pt>
                <c:pt idx="366">
                  <c:v>1330.078</c:v>
                </c:pt>
                <c:pt idx="367">
                  <c:v>1338.0909999999999</c:v>
                </c:pt>
                <c:pt idx="368">
                  <c:v>1346.1030000000001</c:v>
                </c:pt>
                <c:pt idx="369">
                  <c:v>1354.116</c:v>
                </c:pt>
                <c:pt idx="370">
                  <c:v>1362.1279999999999</c:v>
                </c:pt>
                <c:pt idx="371">
                  <c:v>1370.1410000000001</c:v>
                </c:pt>
                <c:pt idx="372">
                  <c:v>1378.153</c:v>
                </c:pt>
                <c:pt idx="373">
                  <c:v>1386.1659999999999</c:v>
                </c:pt>
                <c:pt idx="374">
                  <c:v>1394.1780000000001</c:v>
                </c:pt>
                <c:pt idx="375">
                  <c:v>1402.191</c:v>
                </c:pt>
                <c:pt idx="376">
                  <c:v>1410.203</c:v>
                </c:pt>
                <c:pt idx="377">
                  <c:v>1418.2159999999999</c:v>
                </c:pt>
                <c:pt idx="378">
                  <c:v>1426.2280000000001</c:v>
                </c:pt>
                <c:pt idx="379">
                  <c:v>1434.241</c:v>
                </c:pt>
                <c:pt idx="380">
                  <c:v>1442.2539999999999</c:v>
                </c:pt>
                <c:pt idx="381">
                  <c:v>1450.2660000000001</c:v>
                </c:pt>
                <c:pt idx="382">
                  <c:v>1458.279</c:v>
                </c:pt>
                <c:pt idx="383">
                  <c:v>1466.2909999999999</c:v>
                </c:pt>
                <c:pt idx="384">
                  <c:v>1474.3040000000001</c:v>
                </c:pt>
                <c:pt idx="385">
                  <c:v>1482.316</c:v>
                </c:pt>
                <c:pt idx="386">
                  <c:v>1490.329</c:v>
                </c:pt>
                <c:pt idx="387">
                  <c:v>1498.3409999999999</c:v>
                </c:pt>
                <c:pt idx="388">
                  <c:v>1506.354</c:v>
                </c:pt>
                <c:pt idx="389">
                  <c:v>1514.366</c:v>
                </c:pt>
                <c:pt idx="390">
                  <c:v>1522.3789999999999</c:v>
                </c:pt>
                <c:pt idx="391">
                  <c:v>1530.3910000000001</c:v>
                </c:pt>
                <c:pt idx="392">
                  <c:v>1538.404</c:v>
                </c:pt>
                <c:pt idx="393">
                  <c:v>1546.4159999999999</c:v>
                </c:pt>
                <c:pt idx="394">
                  <c:v>1554.4290000000001</c:v>
                </c:pt>
                <c:pt idx="395">
                  <c:v>1562.441</c:v>
                </c:pt>
                <c:pt idx="396">
                  <c:v>1570.454</c:v>
                </c:pt>
                <c:pt idx="397">
                  <c:v>1578.4659999999999</c:v>
                </c:pt>
                <c:pt idx="398">
                  <c:v>1586.479</c:v>
                </c:pt>
                <c:pt idx="399">
                  <c:v>1594.491</c:v>
                </c:pt>
                <c:pt idx="400">
                  <c:v>1602.5039999999999</c:v>
                </c:pt>
                <c:pt idx="401">
                  <c:v>1602.5039999999999</c:v>
                </c:pt>
              </c:numCache>
            </c:numRef>
          </c:xVal>
          <c:yVal>
            <c:numRef>
              <c:f>Foglio6!$D$424:$D$82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8</c:v>
                </c:pt>
                <c:pt idx="159">
                  <c:v>21.5</c:v>
                </c:pt>
                <c:pt idx="160">
                  <c:v>21</c:v>
                </c:pt>
                <c:pt idx="161">
                  <c:v>20.5</c:v>
                </c:pt>
                <c:pt idx="162">
                  <c:v>20</c:v>
                </c:pt>
                <c:pt idx="163">
                  <c:v>19.5</c:v>
                </c:pt>
                <c:pt idx="164">
                  <c:v>19</c:v>
                </c:pt>
                <c:pt idx="165">
                  <c:v>18.513999999999999</c:v>
                </c:pt>
                <c:pt idx="166">
                  <c:v>18.5</c:v>
                </c:pt>
                <c:pt idx="167">
                  <c:v>18</c:v>
                </c:pt>
                <c:pt idx="168">
                  <c:v>17.5</c:v>
                </c:pt>
                <c:pt idx="169">
                  <c:v>17</c:v>
                </c:pt>
                <c:pt idx="170">
                  <c:v>16.774000000000001</c:v>
                </c:pt>
                <c:pt idx="171">
                  <c:v>16.5</c:v>
                </c:pt>
                <c:pt idx="172">
                  <c:v>16</c:v>
                </c:pt>
                <c:pt idx="173">
                  <c:v>15.5</c:v>
                </c:pt>
                <c:pt idx="174">
                  <c:v>15.486000000000001</c:v>
                </c:pt>
                <c:pt idx="175">
                  <c:v>15</c:v>
                </c:pt>
                <c:pt idx="176">
                  <c:v>14.5</c:v>
                </c:pt>
                <c:pt idx="177">
                  <c:v>14.433</c:v>
                </c:pt>
                <c:pt idx="178">
                  <c:v>14</c:v>
                </c:pt>
                <c:pt idx="179">
                  <c:v>13.595000000000001</c:v>
                </c:pt>
                <c:pt idx="180">
                  <c:v>13.5</c:v>
                </c:pt>
                <c:pt idx="181">
                  <c:v>13</c:v>
                </c:pt>
                <c:pt idx="182">
                  <c:v>12.864000000000001</c:v>
                </c:pt>
                <c:pt idx="183">
                  <c:v>12.5</c:v>
                </c:pt>
                <c:pt idx="184">
                  <c:v>12.199</c:v>
                </c:pt>
                <c:pt idx="185">
                  <c:v>12</c:v>
                </c:pt>
                <c:pt idx="186">
                  <c:v>11.63</c:v>
                </c:pt>
                <c:pt idx="187">
                  <c:v>11.5</c:v>
                </c:pt>
                <c:pt idx="188">
                  <c:v>11.097</c:v>
                </c:pt>
                <c:pt idx="189">
                  <c:v>11</c:v>
                </c:pt>
                <c:pt idx="190">
                  <c:v>10.666</c:v>
                </c:pt>
                <c:pt idx="191">
                  <c:v>10.5</c:v>
                </c:pt>
                <c:pt idx="192">
                  <c:v>10.27</c:v>
                </c:pt>
                <c:pt idx="193">
                  <c:v>10</c:v>
                </c:pt>
                <c:pt idx="194">
                  <c:v>9.891</c:v>
                </c:pt>
                <c:pt idx="195">
                  <c:v>9.5540000000000003</c:v>
                </c:pt>
                <c:pt idx="196">
                  <c:v>9.5</c:v>
                </c:pt>
                <c:pt idx="197">
                  <c:v>9.2520000000000007</c:v>
                </c:pt>
                <c:pt idx="198">
                  <c:v>9</c:v>
                </c:pt>
                <c:pt idx="199">
                  <c:v>8.9550000000000001</c:v>
                </c:pt>
                <c:pt idx="200">
                  <c:v>8.6880000000000006</c:v>
                </c:pt>
                <c:pt idx="201">
                  <c:v>8.5</c:v>
                </c:pt>
                <c:pt idx="202">
                  <c:v>8.4269999999999996</c:v>
                </c:pt>
                <c:pt idx="203">
                  <c:v>8.1869999999999994</c:v>
                </c:pt>
                <c:pt idx="204">
                  <c:v>8</c:v>
                </c:pt>
                <c:pt idx="205">
                  <c:v>7.976</c:v>
                </c:pt>
                <c:pt idx="206">
                  <c:v>7.78</c:v>
                </c:pt>
                <c:pt idx="207">
                  <c:v>7.5880000000000001</c:v>
                </c:pt>
                <c:pt idx="208">
                  <c:v>7.5</c:v>
                </c:pt>
                <c:pt idx="209">
                  <c:v>7.3890000000000002</c:v>
                </c:pt>
                <c:pt idx="210">
                  <c:v>7.202</c:v>
                </c:pt>
                <c:pt idx="211">
                  <c:v>7.04</c:v>
                </c:pt>
                <c:pt idx="212">
                  <c:v>7</c:v>
                </c:pt>
                <c:pt idx="213">
                  <c:v>6.8739999999999997</c:v>
                </c:pt>
                <c:pt idx="214">
                  <c:v>6.71</c:v>
                </c:pt>
                <c:pt idx="215">
                  <c:v>6.5629999999999997</c:v>
                </c:pt>
                <c:pt idx="216">
                  <c:v>6.5</c:v>
                </c:pt>
                <c:pt idx="217">
                  <c:v>6.4349999999999996</c:v>
                </c:pt>
                <c:pt idx="218">
                  <c:v>6.2949999999999999</c:v>
                </c:pt>
                <c:pt idx="219">
                  <c:v>6.1719999999999997</c:v>
                </c:pt>
                <c:pt idx="220">
                  <c:v>6.0519999999999996</c:v>
                </c:pt>
                <c:pt idx="221">
                  <c:v>6</c:v>
                </c:pt>
                <c:pt idx="222">
                  <c:v>5.9329999999999998</c:v>
                </c:pt>
                <c:pt idx="223">
                  <c:v>5.8010000000000002</c:v>
                </c:pt>
                <c:pt idx="224">
                  <c:v>5.68</c:v>
                </c:pt>
                <c:pt idx="225">
                  <c:v>5.5739999999999998</c:v>
                </c:pt>
                <c:pt idx="226">
                  <c:v>5.5</c:v>
                </c:pt>
                <c:pt idx="227">
                  <c:v>5.468</c:v>
                </c:pt>
                <c:pt idx="228">
                  <c:v>5.3760000000000003</c:v>
                </c:pt>
                <c:pt idx="229">
                  <c:v>5.2649999999999997</c:v>
                </c:pt>
                <c:pt idx="230">
                  <c:v>5.1719999999999997</c:v>
                </c:pt>
                <c:pt idx="231">
                  <c:v>5.0830000000000002</c:v>
                </c:pt>
                <c:pt idx="232">
                  <c:v>5</c:v>
                </c:pt>
                <c:pt idx="233">
                  <c:v>4.9950000000000001</c:v>
                </c:pt>
                <c:pt idx="234">
                  <c:v>4.8959999999999999</c:v>
                </c:pt>
                <c:pt idx="235">
                  <c:v>4.8140000000000001</c:v>
                </c:pt>
                <c:pt idx="236">
                  <c:v>4.7290000000000001</c:v>
                </c:pt>
                <c:pt idx="237">
                  <c:v>4.6509999999999998</c:v>
                </c:pt>
                <c:pt idx="238">
                  <c:v>4.577</c:v>
                </c:pt>
                <c:pt idx="239">
                  <c:v>4.5019999999999998</c:v>
                </c:pt>
                <c:pt idx="240">
                  <c:v>4.5</c:v>
                </c:pt>
                <c:pt idx="241">
                  <c:v>4.4349999999999996</c:v>
                </c:pt>
                <c:pt idx="242">
                  <c:v>4.3650000000000002</c:v>
                </c:pt>
                <c:pt idx="243">
                  <c:v>4.2830000000000004</c:v>
                </c:pt>
                <c:pt idx="244">
                  <c:v>4.2119999999999997</c:v>
                </c:pt>
                <c:pt idx="245">
                  <c:v>4.1470000000000002</c:v>
                </c:pt>
                <c:pt idx="246">
                  <c:v>4.0780000000000003</c:v>
                </c:pt>
                <c:pt idx="247">
                  <c:v>4.016</c:v>
                </c:pt>
                <c:pt idx="248">
                  <c:v>4</c:v>
                </c:pt>
                <c:pt idx="249">
                  <c:v>3.9489999999999998</c:v>
                </c:pt>
                <c:pt idx="250">
                  <c:v>3.887</c:v>
                </c:pt>
                <c:pt idx="251">
                  <c:v>3.8319999999999999</c:v>
                </c:pt>
                <c:pt idx="252">
                  <c:v>3.7650000000000001</c:v>
                </c:pt>
                <c:pt idx="253">
                  <c:v>3.7120000000000002</c:v>
                </c:pt>
                <c:pt idx="254">
                  <c:v>3.6640000000000001</c:v>
                </c:pt>
                <c:pt idx="255">
                  <c:v>3.6110000000000002</c:v>
                </c:pt>
                <c:pt idx="256">
                  <c:v>3.5579999999999998</c:v>
                </c:pt>
                <c:pt idx="257">
                  <c:v>3.5</c:v>
                </c:pt>
                <c:pt idx="258">
                  <c:v>3.5</c:v>
                </c:pt>
                <c:pt idx="259">
                  <c:v>3.4529999999999998</c:v>
                </c:pt>
                <c:pt idx="260">
                  <c:v>3.4</c:v>
                </c:pt>
                <c:pt idx="261">
                  <c:v>3.3450000000000002</c:v>
                </c:pt>
                <c:pt idx="262">
                  <c:v>3.2879999999999998</c:v>
                </c:pt>
                <c:pt idx="263">
                  <c:v>3.2519999999999998</c:v>
                </c:pt>
                <c:pt idx="264">
                  <c:v>3.202</c:v>
                </c:pt>
                <c:pt idx="265">
                  <c:v>3.1539999999999999</c:v>
                </c:pt>
                <c:pt idx="266">
                  <c:v>3.11</c:v>
                </c:pt>
                <c:pt idx="267">
                  <c:v>3.0630000000000002</c:v>
                </c:pt>
                <c:pt idx="268">
                  <c:v>3.0190000000000001</c:v>
                </c:pt>
                <c:pt idx="269">
                  <c:v>3</c:v>
                </c:pt>
                <c:pt idx="270">
                  <c:v>2.976</c:v>
                </c:pt>
                <c:pt idx="271">
                  <c:v>2.931</c:v>
                </c:pt>
                <c:pt idx="272">
                  <c:v>2.8879999999999999</c:v>
                </c:pt>
                <c:pt idx="273">
                  <c:v>2.8420000000000001</c:v>
                </c:pt>
                <c:pt idx="274">
                  <c:v>2.7970000000000002</c:v>
                </c:pt>
                <c:pt idx="275">
                  <c:v>2.7519999999999998</c:v>
                </c:pt>
                <c:pt idx="276">
                  <c:v>2.7069999999999999</c:v>
                </c:pt>
                <c:pt idx="277">
                  <c:v>2.6619999999999999</c:v>
                </c:pt>
                <c:pt idx="278">
                  <c:v>2.6230000000000002</c:v>
                </c:pt>
                <c:pt idx="279">
                  <c:v>2.585</c:v>
                </c:pt>
                <c:pt idx="280">
                  <c:v>2.5510000000000002</c:v>
                </c:pt>
                <c:pt idx="281">
                  <c:v>2.5179999999999998</c:v>
                </c:pt>
                <c:pt idx="282">
                  <c:v>2.5</c:v>
                </c:pt>
                <c:pt idx="283">
                  <c:v>2.4820000000000002</c:v>
                </c:pt>
                <c:pt idx="284">
                  <c:v>2.4529999999999998</c:v>
                </c:pt>
                <c:pt idx="285">
                  <c:v>2.4119999999999999</c:v>
                </c:pt>
                <c:pt idx="286">
                  <c:v>2.37</c:v>
                </c:pt>
                <c:pt idx="287">
                  <c:v>2.3250000000000002</c:v>
                </c:pt>
                <c:pt idx="288">
                  <c:v>2.2839999999999998</c:v>
                </c:pt>
                <c:pt idx="289">
                  <c:v>2.2490000000000001</c:v>
                </c:pt>
                <c:pt idx="290">
                  <c:v>2.214</c:v>
                </c:pt>
                <c:pt idx="291">
                  <c:v>2.1800000000000002</c:v>
                </c:pt>
                <c:pt idx="292">
                  <c:v>2.1459999999999999</c:v>
                </c:pt>
                <c:pt idx="293">
                  <c:v>2.1150000000000002</c:v>
                </c:pt>
                <c:pt idx="294">
                  <c:v>2.0790000000000002</c:v>
                </c:pt>
                <c:pt idx="295">
                  <c:v>2.0470000000000002</c:v>
                </c:pt>
                <c:pt idx="296">
                  <c:v>2.0179999999999998</c:v>
                </c:pt>
                <c:pt idx="297">
                  <c:v>2</c:v>
                </c:pt>
                <c:pt idx="298">
                  <c:v>1.9870000000000001</c:v>
                </c:pt>
                <c:pt idx="299">
                  <c:v>1.9570000000000001</c:v>
                </c:pt>
                <c:pt idx="300">
                  <c:v>1.93</c:v>
                </c:pt>
                <c:pt idx="301">
                  <c:v>1.891</c:v>
                </c:pt>
                <c:pt idx="302">
                  <c:v>1.855</c:v>
                </c:pt>
                <c:pt idx="303">
                  <c:v>1.827</c:v>
                </c:pt>
                <c:pt idx="304">
                  <c:v>1.7949999999999999</c:v>
                </c:pt>
                <c:pt idx="305">
                  <c:v>1.762</c:v>
                </c:pt>
                <c:pt idx="306">
                  <c:v>1.7390000000000001</c:v>
                </c:pt>
                <c:pt idx="307">
                  <c:v>1.71</c:v>
                </c:pt>
                <c:pt idx="308">
                  <c:v>1.6819999999999999</c:v>
                </c:pt>
                <c:pt idx="309">
                  <c:v>1.6559999999999999</c:v>
                </c:pt>
                <c:pt idx="310">
                  <c:v>1.625</c:v>
                </c:pt>
                <c:pt idx="311">
                  <c:v>1.6</c:v>
                </c:pt>
                <c:pt idx="312">
                  <c:v>1.5740000000000001</c:v>
                </c:pt>
                <c:pt idx="313">
                  <c:v>1.546</c:v>
                </c:pt>
                <c:pt idx="314">
                  <c:v>1.5169999999999999</c:v>
                </c:pt>
                <c:pt idx="315">
                  <c:v>1.5</c:v>
                </c:pt>
                <c:pt idx="316">
                  <c:v>1.486</c:v>
                </c:pt>
                <c:pt idx="317">
                  <c:v>1.4630000000000001</c:v>
                </c:pt>
                <c:pt idx="318">
                  <c:v>1.431</c:v>
                </c:pt>
                <c:pt idx="319">
                  <c:v>1.41</c:v>
                </c:pt>
                <c:pt idx="320">
                  <c:v>1.383</c:v>
                </c:pt>
                <c:pt idx="321">
                  <c:v>1.357</c:v>
                </c:pt>
                <c:pt idx="322">
                  <c:v>1.333</c:v>
                </c:pt>
                <c:pt idx="323">
                  <c:v>1.306</c:v>
                </c:pt>
                <c:pt idx="324">
                  <c:v>1.2849999999999999</c:v>
                </c:pt>
                <c:pt idx="325">
                  <c:v>1.26</c:v>
                </c:pt>
                <c:pt idx="326">
                  <c:v>1.232</c:v>
                </c:pt>
                <c:pt idx="327">
                  <c:v>1.21</c:v>
                </c:pt>
                <c:pt idx="328">
                  <c:v>1.1890000000000001</c:v>
                </c:pt>
                <c:pt idx="329">
                  <c:v>1.1619999999999999</c:v>
                </c:pt>
                <c:pt idx="330">
                  <c:v>1.1399999999999999</c:v>
                </c:pt>
                <c:pt idx="331">
                  <c:v>1.1180000000000001</c:v>
                </c:pt>
                <c:pt idx="332">
                  <c:v>1.0900000000000001</c:v>
                </c:pt>
                <c:pt idx="333">
                  <c:v>1.0660000000000001</c:v>
                </c:pt>
                <c:pt idx="334">
                  <c:v>1.0449999999999999</c:v>
                </c:pt>
                <c:pt idx="335">
                  <c:v>1.022</c:v>
                </c:pt>
                <c:pt idx="336">
                  <c:v>1</c:v>
                </c:pt>
                <c:pt idx="337">
                  <c:v>0.997</c:v>
                </c:pt>
                <c:pt idx="338">
                  <c:v>0.97699999999999998</c:v>
                </c:pt>
                <c:pt idx="339">
                  <c:v>0.95599999999999996</c:v>
                </c:pt>
                <c:pt idx="340">
                  <c:v>0.93899999999999995</c:v>
                </c:pt>
                <c:pt idx="341">
                  <c:v>0.91600000000000004</c:v>
                </c:pt>
                <c:pt idx="342">
                  <c:v>0.89</c:v>
                </c:pt>
                <c:pt idx="343">
                  <c:v>0.86699999999999999</c:v>
                </c:pt>
                <c:pt idx="344">
                  <c:v>0.84</c:v>
                </c:pt>
                <c:pt idx="345">
                  <c:v>0.81899999999999995</c:v>
                </c:pt>
                <c:pt idx="346">
                  <c:v>0.79500000000000004</c:v>
                </c:pt>
                <c:pt idx="347">
                  <c:v>0.77500000000000002</c:v>
                </c:pt>
                <c:pt idx="348">
                  <c:v>0.75900000000000001</c:v>
                </c:pt>
                <c:pt idx="349">
                  <c:v>0.73799999999999999</c:v>
                </c:pt>
                <c:pt idx="350">
                  <c:v>0.71899999999999997</c:v>
                </c:pt>
                <c:pt idx="351">
                  <c:v>0.69899999999999995</c:v>
                </c:pt>
                <c:pt idx="352">
                  <c:v>0.68</c:v>
                </c:pt>
                <c:pt idx="353">
                  <c:v>0.66300000000000003</c:v>
                </c:pt>
                <c:pt idx="354">
                  <c:v>0.64200000000000002</c:v>
                </c:pt>
                <c:pt idx="355">
                  <c:v>0.61299999999999999</c:v>
                </c:pt>
                <c:pt idx="356">
                  <c:v>0.59099999999999997</c:v>
                </c:pt>
                <c:pt idx="357">
                  <c:v>0.56899999999999995</c:v>
                </c:pt>
                <c:pt idx="358">
                  <c:v>0.55600000000000005</c:v>
                </c:pt>
                <c:pt idx="359">
                  <c:v>0.54</c:v>
                </c:pt>
                <c:pt idx="360">
                  <c:v>0.52100000000000002</c:v>
                </c:pt>
                <c:pt idx="361">
                  <c:v>0.50600000000000001</c:v>
                </c:pt>
                <c:pt idx="362">
                  <c:v>0.5</c:v>
                </c:pt>
                <c:pt idx="363">
                  <c:v>0.48599999999999999</c:v>
                </c:pt>
                <c:pt idx="364">
                  <c:v>0.47099999999999997</c:v>
                </c:pt>
                <c:pt idx="365">
                  <c:v>0.45100000000000001</c:v>
                </c:pt>
                <c:pt idx="366">
                  <c:v>0.434</c:v>
                </c:pt>
                <c:pt idx="367">
                  <c:v>0.41199999999999998</c:v>
                </c:pt>
                <c:pt idx="368">
                  <c:v>0.39300000000000002</c:v>
                </c:pt>
                <c:pt idx="369">
                  <c:v>0.374</c:v>
                </c:pt>
                <c:pt idx="370">
                  <c:v>0.35699999999999998</c:v>
                </c:pt>
                <c:pt idx="371">
                  <c:v>0.33700000000000002</c:v>
                </c:pt>
                <c:pt idx="372">
                  <c:v>0.318</c:v>
                </c:pt>
                <c:pt idx="373">
                  <c:v>0.29899999999999999</c:v>
                </c:pt>
                <c:pt idx="374">
                  <c:v>0.28299999999999997</c:v>
                </c:pt>
                <c:pt idx="375">
                  <c:v>0.26800000000000002</c:v>
                </c:pt>
                <c:pt idx="376">
                  <c:v>0.252</c:v>
                </c:pt>
                <c:pt idx="377">
                  <c:v>0.23499999999999999</c:v>
                </c:pt>
                <c:pt idx="378">
                  <c:v>0.221</c:v>
                </c:pt>
                <c:pt idx="379">
                  <c:v>0.20499999999999999</c:v>
                </c:pt>
                <c:pt idx="380">
                  <c:v>0.192</c:v>
                </c:pt>
                <c:pt idx="381">
                  <c:v>0.17399999999999999</c:v>
                </c:pt>
                <c:pt idx="382">
                  <c:v>0.153</c:v>
                </c:pt>
                <c:pt idx="383">
                  <c:v>0.14199999999999999</c:v>
                </c:pt>
                <c:pt idx="384">
                  <c:v>0.126</c:v>
                </c:pt>
                <c:pt idx="385">
                  <c:v>0.111</c:v>
                </c:pt>
                <c:pt idx="386">
                  <c:v>0.1</c:v>
                </c:pt>
                <c:pt idx="387">
                  <c:v>8.3000000000000004E-2</c:v>
                </c:pt>
                <c:pt idx="388">
                  <c:v>7.1999999999999995E-2</c:v>
                </c:pt>
                <c:pt idx="389">
                  <c:v>5.8000000000000003E-2</c:v>
                </c:pt>
                <c:pt idx="390">
                  <c:v>4.9000000000000002E-2</c:v>
                </c:pt>
                <c:pt idx="391">
                  <c:v>3.3000000000000002E-2</c:v>
                </c:pt>
                <c:pt idx="392">
                  <c:v>2.4E-2</c:v>
                </c:pt>
                <c:pt idx="393">
                  <c:v>1.7000000000000001E-2</c:v>
                </c:pt>
                <c:pt idx="394">
                  <c:v>1.0999999999999999E-2</c:v>
                </c:pt>
                <c:pt idx="395">
                  <c:v>5.0000000000000001E-3</c:v>
                </c:pt>
                <c:pt idx="396">
                  <c:v>4.0000000000000001E-3</c:v>
                </c:pt>
                <c:pt idx="397">
                  <c:v>2E-3</c:v>
                </c:pt>
                <c:pt idx="398">
                  <c:v>1E-3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237-45B1-A7AA-312291C87353}"/>
            </c:ext>
          </c:extLst>
        </c:ser>
        <c:ser>
          <c:idx val="1"/>
          <c:order val="2"/>
          <c:tx>
            <c:strRef>
              <c:f>Foglio6!$E$1</c:f>
              <c:strCache>
                <c:ptCount val="1"/>
                <c:pt idx="0">
                  <c:v>S0,5M5</c:v>
                </c:pt>
              </c:strCache>
            </c:strRef>
          </c:tx>
          <c:spPr>
            <a:ln w="19050" cap="rnd">
              <a:solidFill>
                <a:srgbClr val="FFCCCC"/>
              </a:solidFill>
              <a:round/>
            </a:ln>
            <a:effectLst/>
          </c:spPr>
          <c:marker>
            <c:symbol val="none"/>
          </c:marker>
          <c:dLbls>
            <c:dLbl>
              <c:idx val="401"/>
              <c:dLblPos val="r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C237-45B1-A7AA-312291C8735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Foglio6!$E$424:$E$82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.02</c:v>
                </c:pt>
                <c:pt idx="75">
                  <c:v>4.2000000000000003E-2</c:v>
                </c:pt>
                <c:pt idx="76">
                  <c:v>6.3E-2</c:v>
                </c:pt>
                <c:pt idx="77">
                  <c:v>8.4000000000000005E-2</c:v>
                </c:pt>
                <c:pt idx="78">
                  <c:v>0.105</c:v>
                </c:pt>
                <c:pt idx="79">
                  <c:v>0.127</c:v>
                </c:pt>
                <c:pt idx="80">
                  <c:v>0.14799999999999999</c:v>
                </c:pt>
                <c:pt idx="81">
                  <c:v>0.16900000000000001</c:v>
                </c:pt>
                <c:pt idx="82">
                  <c:v>0.19</c:v>
                </c:pt>
                <c:pt idx="83">
                  <c:v>0.21099999999999999</c:v>
                </c:pt>
                <c:pt idx="84">
                  <c:v>0.23300000000000001</c:v>
                </c:pt>
                <c:pt idx="85">
                  <c:v>0.254</c:v>
                </c:pt>
                <c:pt idx="86">
                  <c:v>0.27500000000000002</c:v>
                </c:pt>
                <c:pt idx="87">
                  <c:v>0.29599999999999999</c:v>
                </c:pt>
                <c:pt idx="88">
                  <c:v>0.318</c:v>
                </c:pt>
                <c:pt idx="89">
                  <c:v>0.33900000000000002</c:v>
                </c:pt>
                <c:pt idx="90">
                  <c:v>0.36</c:v>
                </c:pt>
                <c:pt idx="91">
                  <c:v>0.38100000000000001</c:v>
                </c:pt>
                <c:pt idx="92">
                  <c:v>0.40300000000000002</c:v>
                </c:pt>
                <c:pt idx="93">
                  <c:v>0.42399999999999999</c:v>
                </c:pt>
                <c:pt idx="94">
                  <c:v>0.44500000000000001</c:v>
                </c:pt>
                <c:pt idx="95">
                  <c:v>0.46600000000000003</c:v>
                </c:pt>
                <c:pt idx="96">
                  <c:v>0.48699999999999999</c:v>
                </c:pt>
                <c:pt idx="97">
                  <c:v>0.50900000000000001</c:v>
                </c:pt>
                <c:pt idx="98">
                  <c:v>0.53</c:v>
                </c:pt>
                <c:pt idx="99">
                  <c:v>0.55100000000000005</c:v>
                </c:pt>
                <c:pt idx="100">
                  <c:v>0.57199999999999995</c:v>
                </c:pt>
                <c:pt idx="101">
                  <c:v>0.59399999999999997</c:v>
                </c:pt>
                <c:pt idx="102">
                  <c:v>0.61499999999999999</c:v>
                </c:pt>
                <c:pt idx="103">
                  <c:v>0.63600000000000001</c:v>
                </c:pt>
                <c:pt idx="104">
                  <c:v>0.65700000000000003</c:v>
                </c:pt>
                <c:pt idx="105">
                  <c:v>0.67800000000000005</c:v>
                </c:pt>
                <c:pt idx="106">
                  <c:v>0.7</c:v>
                </c:pt>
                <c:pt idx="107">
                  <c:v>0.72099999999999997</c:v>
                </c:pt>
                <c:pt idx="108">
                  <c:v>0.74199999999999999</c:v>
                </c:pt>
                <c:pt idx="109">
                  <c:v>0.76300000000000001</c:v>
                </c:pt>
                <c:pt idx="110">
                  <c:v>0.78500000000000003</c:v>
                </c:pt>
                <c:pt idx="111">
                  <c:v>0.80600000000000005</c:v>
                </c:pt>
                <c:pt idx="112">
                  <c:v>0.82699999999999996</c:v>
                </c:pt>
                <c:pt idx="113">
                  <c:v>0.84799999999999998</c:v>
                </c:pt>
                <c:pt idx="114">
                  <c:v>0.87</c:v>
                </c:pt>
                <c:pt idx="115">
                  <c:v>0.89100000000000001</c:v>
                </c:pt>
                <c:pt idx="116">
                  <c:v>0.91200000000000003</c:v>
                </c:pt>
                <c:pt idx="117">
                  <c:v>0.93300000000000005</c:v>
                </c:pt>
                <c:pt idx="118">
                  <c:v>0.95399999999999996</c:v>
                </c:pt>
                <c:pt idx="119">
                  <c:v>0.97599999999999998</c:v>
                </c:pt>
                <c:pt idx="120">
                  <c:v>0.997</c:v>
                </c:pt>
                <c:pt idx="121">
                  <c:v>1.018</c:v>
                </c:pt>
                <c:pt idx="122">
                  <c:v>1.0389999999999999</c:v>
                </c:pt>
                <c:pt idx="123">
                  <c:v>1.0609999999999999</c:v>
                </c:pt>
                <c:pt idx="124">
                  <c:v>1.0820000000000001</c:v>
                </c:pt>
                <c:pt idx="125">
                  <c:v>1.103</c:v>
                </c:pt>
                <c:pt idx="126">
                  <c:v>1.1240000000000001</c:v>
                </c:pt>
                <c:pt idx="127">
                  <c:v>1.1459999999999999</c:v>
                </c:pt>
                <c:pt idx="128">
                  <c:v>1.167</c:v>
                </c:pt>
                <c:pt idx="129">
                  <c:v>1.1879999999999999</c:v>
                </c:pt>
                <c:pt idx="130">
                  <c:v>1.2090000000000001</c:v>
                </c:pt>
                <c:pt idx="131">
                  <c:v>1.23</c:v>
                </c:pt>
                <c:pt idx="132">
                  <c:v>1.252</c:v>
                </c:pt>
                <c:pt idx="133">
                  <c:v>1.2729999999999999</c:v>
                </c:pt>
                <c:pt idx="134">
                  <c:v>1.294</c:v>
                </c:pt>
                <c:pt idx="135">
                  <c:v>1.3149999999999999</c:v>
                </c:pt>
                <c:pt idx="136">
                  <c:v>1.337</c:v>
                </c:pt>
                <c:pt idx="137">
                  <c:v>1.3580000000000001</c:v>
                </c:pt>
                <c:pt idx="138">
                  <c:v>1.379</c:v>
                </c:pt>
                <c:pt idx="139">
                  <c:v>1.4</c:v>
                </c:pt>
                <c:pt idx="140">
                  <c:v>1.421</c:v>
                </c:pt>
                <c:pt idx="141">
                  <c:v>1.4430000000000001</c:v>
                </c:pt>
                <c:pt idx="142">
                  <c:v>1.464</c:v>
                </c:pt>
                <c:pt idx="143">
                  <c:v>1.4850000000000001</c:v>
                </c:pt>
                <c:pt idx="144">
                  <c:v>1.506</c:v>
                </c:pt>
                <c:pt idx="145">
                  <c:v>1.528</c:v>
                </c:pt>
                <c:pt idx="146">
                  <c:v>1.5489999999999999</c:v>
                </c:pt>
                <c:pt idx="147">
                  <c:v>1.57</c:v>
                </c:pt>
                <c:pt idx="148">
                  <c:v>1.591</c:v>
                </c:pt>
                <c:pt idx="149">
                  <c:v>1.613</c:v>
                </c:pt>
                <c:pt idx="150">
                  <c:v>1.6339999999999999</c:v>
                </c:pt>
                <c:pt idx="151">
                  <c:v>1.655</c:v>
                </c:pt>
                <c:pt idx="152">
                  <c:v>1.6759999999999999</c:v>
                </c:pt>
                <c:pt idx="153">
                  <c:v>1.8420000000000001</c:v>
                </c:pt>
                <c:pt idx="154">
                  <c:v>2.0089999999999999</c:v>
                </c:pt>
                <c:pt idx="155">
                  <c:v>2.1760000000000002</c:v>
                </c:pt>
                <c:pt idx="156">
                  <c:v>2.3420000000000001</c:v>
                </c:pt>
                <c:pt idx="157">
                  <c:v>2.5089999999999999</c:v>
                </c:pt>
                <c:pt idx="158">
                  <c:v>2.6760000000000002</c:v>
                </c:pt>
                <c:pt idx="159">
                  <c:v>2.8420000000000001</c:v>
                </c:pt>
                <c:pt idx="160">
                  <c:v>3.0089999999999999</c:v>
                </c:pt>
                <c:pt idx="161">
                  <c:v>3.1760000000000002</c:v>
                </c:pt>
                <c:pt idx="162">
                  <c:v>3.3420000000000001</c:v>
                </c:pt>
                <c:pt idx="163">
                  <c:v>3.6749999999999998</c:v>
                </c:pt>
                <c:pt idx="164">
                  <c:v>4.0190000000000001</c:v>
                </c:pt>
                <c:pt idx="165">
                  <c:v>4.3630000000000004</c:v>
                </c:pt>
                <c:pt idx="166">
                  <c:v>4.7069999999999999</c:v>
                </c:pt>
                <c:pt idx="167">
                  <c:v>5.0659999999999998</c:v>
                </c:pt>
                <c:pt idx="168">
                  <c:v>5.6360000000000001</c:v>
                </c:pt>
                <c:pt idx="169">
                  <c:v>6.2060000000000004</c:v>
                </c:pt>
                <c:pt idx="170">
                  <c:v>6.8040000000000003</c:v>
                </c:pt>
                <c:pt idx="171">
                  <c:v>7.601</c:v>
                </c:pt>
                <c:pt idx="172">
                  <c:v>8.3819999999999997</c:v>
                </c:pt>
                <c:pt idx="173">
                  <c:v>8.4009999999999998</c:v>
                </c:pt>
                <c:pt idx="174">
                  <c:v>9.4079999999999995</c:v>
                </c:pt>
                <c:pt idx="175">
                  <c:v>10.507</c:v>
                </c:pt>
                <c:pt idx="176">
                  <c:v>11.78</c:v>
                </c:pt>
                <c:pt idx="177">
                  <c:v>13.289</c:v>
                </c:pt>
                <c:pt idx="178">
                  <c:v>14.97</c:v>
                </c:pt>
                <c:pt idx="179">
                  <c:v>16.763000000000002</c:v>
                </c:pt>
                <c:pt idx="180">
                  <c:v>17.009</c:v>
                </c:pt>
                <c:pt idx="181">
                  <c:v>19.486000000000001</c:v>
                </c:pt>
                <c:pt idx="182">
                  <c:v>22.510999999999999</c:v>
                </c:pt>
                <c:pt idx="183">
                  <c:v>25.145</c:v>
                </c:pt>
                <c:pt idx="184">
                  <c:v>26.01</c:v>
                </c:pt>
                <c:pt idx="185">
                  <c:v>29.968</c:v>
                </c:pt>
                <c:pt idx="186">
                  <c:v>33.526000000000003</c:v>
                </c:pt>
                <c:pt idx="187">
                  <c:v>34.878999999999998</c:v>
                </c:pt>
                <c:pt idx="188">
                  <c:v>41.337000000000003</c:v>
                </c:pt>
                <c:pt idx="189">
                  <c:v>41.908000000000001</c:v>
                </c:pt>
                <c:pt idx="190">
                  <c:v>48.484000000000002</c:v>
                </c:pt>
                <c:pt idx="191">
                  <c:v>50.29</c:v>
                </c:pt>
                <c:pt idx="192">
                  <c:v>57.735999999999997</c:v>
                </c:pt>
                <c:pt idx="193">
                  <c:v>58.670999999999999</c:v>
                </c:pt>
                <c:pt idx="194">
                  <c:v>67.052999999999997</c:v>
                </c:pt>
                <c:pt idx="195">
                  <c:v>68.7</c:v>
                </c:pt>
                <c:pt idx="196">
                  <c:v>75.433999999999997</c:v>
                </c:pt>
                <c:pt idx="197">
                  <c:v>82.724999999999994</c:v>
                </c:pt>
                <c:pt idx="198">
                  <c:v>83.816000000000003</c:v>
                </c:pt>
                <c:pt idx="199">
                  <c:v>92.197999999999993</c:v>
                </c:pt>
                <c:pt idx="200">
                  <c:v>100.15600000000001</c:v>
                </c:pt>
                <c:pt idx="201">
                  <c:v>100.57899999999999</c:v>
                </c:pt>
                <c:pt idx="202">
                  <c:v>108.961</c:v>
                </c:pt>
                <c:pt idx="203">
                  <c:v>117.343</c:v>
                </c:pt>
                <c:pt idx="204">
                  <c:v>121.206</c:v>
                </c:pt>
                <c:pt idx="205">
                  <c:v>125.724</c:v>
                </c:pt>
                <c:pt idx="206">
                  <c:v>134.10599999999999</c:v>
                </c:pt>
                <c:pt idx="207">
                  <c:v>142.48699999999999</c:v>
                </c:pt>
                <c:pt idx="208">
                  <c:v>148.20599999999999</c:v>
                </c:pt>
                <c:pt idx="209">
                  <c:v>150.869</c:v>
                </c:pt>
                <c:pt idx="210">
                  <c:v>159.251</c:v>
                </c:pt>
                <c:pt idx="211">
                  <c:v>167.63200000000001</c:v>
                </c:pt>
                <c:pt idx="212">
                  <c:v>176.01400000000001</c:v>
                </c:pt>
                <c:pt idx="213">
                  <c:v>183.2</c:v>
                </c:pt>
                <c:pt idx="214">
                  <c:v>184.39500000000001</c:v>
                </c:pt>
                <c:pt idx="215">
                  <c:v>192.77699999999999</c:v>
                </c:pt>
                <c:pt idx="216">
                  <c:v>201.15899999999999</c:v>
                </c:pt>
                <c:pt idx="217">
                  <c:v>209.54</c:v>
                </c:pt>
                <c:pt idx="218">
                  <c:v>217.922</c:v>
                </c:pt>
                <c:pt idx="219">
                  <c:v>226.27699999999999</c:v>
                </c:pt>
                <c:pt idx="220">
                  <c:v>226.303</c:v>
                </c:pt>
                <c:pt idx="221">
                  <c:v>234.685</c:v>
                </c:pt>
                <c:pt idx="222">
                  <c:v>243.06700000000001</c:v>
                </c:pt>
                <c:pt idx="223">
                  <c:v>251.44800000000001</c:v>
                </c:pt>
                <c:pt idx="224">
                  <c:v>259.83</c:v>
                </c:pt>
                <c:pt idx="225">
                  <c:v>268.21199999999999</c:v>
                </c:pt>
                <c:pt idx="226">
                  <c:v>276.59300000000002</c:v>
                </c:pt>
                <c:pt idx="227">
                  <c:v>281.91000000000003</c:v>
                </c:pt>
                <c:pt idx="228">
                  <c:v>284.97500000000002</c:v>
                </c:pt>
                <c:pt idx="229">
                  <c:v>293.35599999999999</c:v>
                </c:pt>
                <c:pt idx="230">
                  <c:v>301.738</c:v>
                </c:pt>
                <c:pt idx="231">
                  <c:v>310.12</c:v>
                </c:pt>
                <c:pt idx="232">
                  <c:v>318.50099999999998</c:v>
                </c:pt>
                <c:pt idx="233">
                  <c:v>326.88299999999998</c:v>
                </c:pt>
                <c:pt idx="234">
                  <c:v>335.26400000000001</c:v>
                </c:pt>
                <c:pt idx="235">
                  <c:v>343.64600000000002</c:v>
                </c:pt>
                <c:pt idx="236">
                  <c:v>350.84</c:v>
                </c:pt>
                <c:pt idx="237">
                  <c:v>352.02800000000002</c:v>
                </c:pt>
                <c:pt idx="238">
                  <c:v>360.40899999999999</c:v>
                </c:pt>
                <c:pt idx="239">
                  <c:v>368.791</c:v>
                </c:pt>
                <c:pt idx="240">
                  <c:v>377.17200000000003</c:v>
                </c:pt>
                <c:pt idx="241">
                  <c:v>385.55399999999997</c:v>
                </c:pt>
                <c:pt idx="242">
                  <c:v>393.93599999999998</c:v>
                </c:pt>
                <c:pt idx="243">
                  <c:v>402.31700000000001</c:v>
                </c:pt>
                <c:pt idx="244">
                  <c:v>410.69900000000001</c:v>
                </c:pt>
                <c:pt idx="245">
                  <c:v>419.08100000000002</c:v>
                </c:pt>
                <c:pt idx="246">
                  <c:v>427.46199999999999</c:v>
                </c:pt>
                <c:pt idx="247">
                  <c:v>435.84399999999999</c:v>
                </c:pt>
                <c:pt idx="248">
                  <c:v>444.22500000000002</c:v>
                </c:pt>
                <c:pt idx="249">
                  <c:v>444.42599999999999</c:v>
                </c:pt>
                <c:pt idx="250">
                  <c:v>452.60700000000003</c:v>
                </c:pt>
                <c:pt idx="251">
                  <c:v>460.98899999999998</c:v>
                </c:pt>
                <c:pt idx="252">
                  <c:v>469.37</c:v>
                </c:pt>
                <c:pt idx="253">
                  <c:v>477.75200000000001</c:v>
                </c:pt>
                <c:pt idx="254">
                  <c:v>486.13299999999998</c:v>
                </c:pt>
                <c:pt idx="255">
                  <c:v>494.51499999999999</c:v>
                </c:pt>
                <c:pt idx="256">
                  <c:v>502.89699999999999</c:v>
                </c:pt>
                <c:pt idx="257">
                  <c:v>511.27800000000002</c:v>
                </c:pt>
                <c:pt idx="258">
                  <c:v>519.66</c:v>
                </c:pt>
                <c:pt idx="259">
                  <c:v>528.04100000000005</c:v>
                </c:pt>
                <c:pt idx="260">
                  <c:v>536.423</c:v>
                </c:pt>
                <c:pt idx="261">
                  <c:v>544.80499999999995</c:v>
                </c:pt>
                <c:pt idx="262">
                  <c:v>553.18600000000004</c:v>
                </c:pt>
                <c:pt idx="263">
                  <c:v>561.56799999999998</c:v>
                </c:pt>
                <c:pt idx="264">
                  <c:v>563.14</c:v>
                </c:pt>
                <c:pt idx="265">
                  <c:v>569.94899999999996</c:v>
                </c:pt>
                <c:pt idx="266">
                  <c:v>578.33100000000002</c:v>
                </c:pt>
                <c:pt idx="267">
                  <c:v>586.71299999999997</c:v>
                </c:pt>
                <c:pt idx="268">
                  <c:v>595.09400000000005</c:v>
                </c:pt>
                <c:pt idx="269">
                  <c:v>603.476</c:v>
                </c:pt>
                <c:pt idx="270">
                  <c:v>611.85799999999995</c:v>
                </c:pt>
                <c:pt idx="271">
                  <c:v>620.23900000000003</c:v>
                </c:pt>
                <c:pt idx="272">
                  <c:v>628.62099999999998</c:v>
                </c:pt>
                <c:pt idx="273">
                  <c:v>637.00199999999995</c:v>
                </c:pt>
                <c:pt idx="274">
                  <c:v>645.38400000000001</c:v>
                </c:pt>
                <c:pt idx="275">
                  <c:v>653.76599999999996</c:v>
                </c:pt>
                <c:pt idx="276">
                  <c:v>662.14700000000005</c:v>
                </c:pt>
                <c:pt idx="277">
                  <c:v>670.529</c:v>
                </c:pt>
                <c:pt idx="278">
                  <c:v>678.91</c:v>
                </c:pt>
                <c:pt idx="279">
                  <c:v>687.29200000000003</c:v>
                </c:pt>
                <c:pt idx="280">
                  <c:v>695.67399999999998</c:v>
                </c:pt>
                <c:pt idx="281">
                  <c:v>704.05499999999995</c:v>
                </c:pt>
                <c:pt idx="282">
                  <c:v>712.43700000000001</c:v>
                </c:pt>
                <c:pt idx="283">
                  <c:v>720.81799999999998</c:v>
                </c:pt>
                <c:pt idx="284">
                  <c:v>723.21199999999999</c:v>
                </c:pt>
                <c:pt idx="285">
                  <c:v>729.2</c:v>
                </c:pt>
                <c:pt idx="286">
                  <c:v>737.58199999999999</c:v>
                </c:pt>
                <c:pt idx="287">
                  <c:v>745.96299999999997</c:v>
                </c:pt>
                <c:pt idx="288">
                  <c:v>754.34500000000003</c:v>
                </c:pt>
                <c:pt idx="289">
                  <c:v>762.72699999999998</c:v>
                </c:pt>
                <c:pt idx="290">
                  <c:v>771.10799999999995</c:v>
                </c:pt>
                <c:pt idx="291">
                  <c:v>779.49</c:v>
                </c:pt>
                <c:pt idx="292">
                  <c:v>787.87099999999998</c:v>
                </c:pt>
                <c:pt idx="293">
                  <c:v>796.25300000000004</c:v>
                </c:pt>
                <c:pt idx="294">
                  <c:v>804.63499999999999</c:v>
                </c:pt>
                <c:pt idx="295">
                  <c:v>813.01599999999996</c:v>
                </c:pt>
                <c:pt idx="296">
                  <c:v>821.39800000000002</c:v>
                </c:pt>
                <c:pt idx="297">
                  <c:v>829.779</c:v>
                </c:pt>
                <c:pt idx="298">
                  <c:v>838.16099999999994</c:v>
                </c:pt>
                <c:pt idx="299">
                  <c:v>846.54300000000001</c:v>
                </c:pt>
                <c:pt idx="300">
                  <c:v>854.92399999999998</c:v>
                </c:pt>
                <c:pt idx="301">
                  <c:v>863.30600000000004</c:v>
                </c:pt>
                <c:pt idx="302">
                  <c:v>871.68700000000001</c:v>
                </c:pt>
                <c:pt idx="303">
                  <c:v>880.06899999999996</c:v>
                </c:pt>
                <c:pt idx="304">
                  <c:v>888.45100000000002</c:v>
                </c:pt>
                <c:pt idx="305">
                  <c:v>896.83199999999999</c:v>
                </c:pt>
                <c:pt idx="306">
                  <c:v>905.21400000000006</c:v>
                </c:pt>
                <c:pt idx="307">
                  <c:v>913.596</c:v>
                </c:pt>
                <c:pt idx="308">
                  <c:v>921.97699999999998</c:v>
                </c:pt>
                <c:pt idx="309">
                  <c:v>925.52700000000004</c:v>
                </c:pt>
                <c:pt idx="310">
                  <c:v>930.35900000000004</c:v>
                </c:pt>
                <c:pt idx="311">
                  <c:v>938.74</c:v>
                </c:pt>
                <c:pt idx="312">
                  <c:v>947.12199999999996</c:v>
                </c:pt>
                <c:pt idx="313">
                  <c:v>955.50400000000002</c:v>
                </c:pt>
                <c:pt idx="314">
                  <c:v>963.88499999999999</c:v>
                </c:pt>
                <c:pt idx="315">
                  <c:v>972.26700000000005</c:v>
                </c:pt>
                <c:pt idx="316">
                  <c:v>980.64800000000002</c:v>
                </c:pt>
                <c:pt idx="317">
                  <c:v>989.03</c:v>
                </c:pt>
                <c:pt idx="318">
                  <c:v>997.41200000000003</c:v>
                </c:pt>
                <c:pt idx="319">
                  <c:v>1005.793</c:v>
                </c:pt>
                <c:pt idx="320">
                  <c:v>1014.175</c:v>
                </c:pt>
                <c:pt idx="321">
                  <c:v>1022.556</c:v>
                </c:pt>
                <c:pt idx="322">
                  <c:v>1030.9380000000001</c:v>
                </c:pt>
                <c:pt idx="323">
                  <c:v>1039.32</c:v>
                </c:pt>
                <c:pt idx="324">
                  <c:v>1047.701</c:v>
                </c:pt>
                <c:pt idx="325">
                  <c:v>1056.0830000000001</c:v>
                </c:pt>
                <c:pt idx="326">
                  <c:v>1064.4639999999999</c:v>
                </c:pt>
                <c:pt idx="327">
                  <c:v>1072.846</c:v>
                </c:pt>
                <c:pt idx="328">
                  <c:v>1081.2280000000001</c:v>
                </c:pt>
                <c:pt idx="329">
                  <c:v>1089.6089999999999</c:v>
                </c:pt>
                <c:pt idx="330">
                  <c:v>1097.991</c:v>
                </c:pt>
                <c:pt idx="331">
                  <c:v>1106.373</c:v>
                </c:pt>
                <c:pt idx="332">
                  <c:v>1114.7539999999999</c:v>
                </c:pt>
                <c:pt idx="333">
                  <c:v>1123.136</c:v>
                </c:pt>
                <c:pt idx="334">
                  <c:v>1131.5170000000001</c:v>
                </c:pt>
                <c:pt idx="335">
                  <c:v>1139.8989999999999</c:v>
                </c:pt>
                <c:pt idx="336">
                  <c:v>1148.2809999999999</c:v>
                </c:pt>
                <c:pt idx="337">
                  <c:v>1156.662</c:v>
                </c:pt>
                <c:pt idx="338">
                  <c:v>1165.0440000000001</c:v>
                </c:pt>
                <c:pt idx="339">
                  <c:v>1173.425</c:v>
                </c:pt>
                <c:pt idx="340">
                  <c:v>1181.807</c:v>
                </c:pt>
                <c:pt idx="341">
                  <c:v>1190.1890000000001</c:v>
                </c:pt>
                <c:pt idx="342">
                  <c:v>1198.57</c:v>
                </c:pt>
                <c:pt idx="343">
                  <c:v>1202.0820000000001</c:v>
                </c:pt>
                <c:pt idx="344">
                  <c:v>1206.952</c:v>
                </c:pt>
                <c:pt idx="345">
                  <c:v>1215.3330000000001</c:v>
                </c:pt>
                <c:pt idx="346">
                  <c:v>1223.7149999999999</c:v>
                </c:pt>
                <c:pt idx="347">
                  <c:v>1232.097</c:v>
                </c:pt>
                <c:pt idx="348">
                  <c:v>1240.4780000000001</c:v>
                </c:pt>
                <c:pt idx="349">
                  <c:v>1248.8599999999999</c:v>
                </c:pt>
                <c:pt idx="350">
                  <c:v>1257.242</c:v>
                </c:pt>
                <c:pt idx="351">
                  <c:v>1265.623</c:v>
                </c:pt>
                <c:pt idx="352">
                  <c:v>1274.0050000000001</c:v>
                </c:pt>
                <c:pt idx="353">
                  <c:v>1282.386</c:v>
                </c:pt>
                <c:pt idx="354">
                  <c:v>1290.768</c:v>
                </c:pt>
                <c:pt idx="355">
                  <c:v>1299.1500000000001</c:v>
                </c:pt>
                <c:pt idx="356">
                  <c:v>1307.5309999999999</c:v>
                </c:pt>
                <c:pt idx="357">
                  <c:v>1315.913</c:v>
                </c:pt>
                <c:pt idx="358">
                  <c:v>1324.2940000000001</c:v>
                </c:pt>
                <c:pt idx="359">
                  <c:v>1332.6759999999999</c:v>
                </c:pt>
                <c:pt idx="360">
                  <c:v>1341.058</c:v>
                </c:pt>
                <c:pt idx="361">
                  <c:v>1349.4390000000001</c:v>
                </c:pt>
                <c:pt idx="362">
                  <c:v>1357.8209999999999</c:v>
                </c:pt>
                <c:pt idx="363">
                  <c:v>1366.202</c:v>
                </c:pt>
                <c:pt idx="364">
                  <c:v>1374.5840000000001</c:v>
                </c:pt>
                <c:pt idx="365">
                  <c:v>1382.9659999999999</c:v>
                </c:pt>
                <c:pt idx="366">
                  <c:v>1391.347</c:v>
                </c:pt>
                <c:pt idx="367">
                  <c:v>1399.729</c:v>
                </c:pt>
                <c:pt idx="368">
                  <c:v>1408.11</c:v>
                </c:pt>
                <c:pt idx="369">
                  <c:v>1416.492</c:v>
                </c:pt>
                <c:pt idx="370">
                  <c:v>1424.874</c:v>
                </c:pt>
                <c:pt idx="371">
                  <c:v>1433.2550000000001</c:v>
                </c:pt>
                <c:pt idx="372">
                  <c:v>1441.6369999999999</c:v>
                </c:pt>
                <c:pt idx="373">
                  <c:v>1450.019</c:v>
                </c:pt>
                <c:pt idx="374">
                  <c:v>1458.4</c:v>
                </c:pt>
                <c:pt idx="375">
                  <c:v>1466.7819999999999</c:v>
                </c:pt>
                <c:pt idx="376">
                  <c:v>1475.163</c:v>
                </c:pt>
                <c:pt idx="377">
                  <c:v>1483.5450000000001</c:v>
                </c:pt>
                <c:pt idx="378">
                  <c:v>1491.9269999999999</c:v>
                </c:pt>
                <c:pt idx="379">
                  <c:v>1500.308</c:v>
                </c:pt>
                <c:pt idx="380">
                  <c:v>1508.69</c:v>
                </c:pt>
                <c:pt idx="381">
                  <c:v>1517.0709999999999</c:v>
                </c:pt>
                <c:pt idx="382">
                  <c:v>1525.453</c:v>
                </c:pt>
                <c:pt idx="383">
                  <c:v>1533.835</c:v>
                </c:pt>
                <c:pt idx="384">
                  <c:v>1542.2159999999999</c:v>
                </c:pt>
                <c:pt idx="385">
                  <c:v>1550.598</c:v>
                </c:pt>
                <c:pt idx="386">
                  <c:v>1558.979</c:v>
                </c:pt>
                <c:pt idx="387">
                  <c:v>1567.3610000000001</c:v>
                </c:pt>
                <c:pt idx="388">
                  <c:v>1575.7429999999999</c:v>
                </c:pt>
                <c:pt idx="389">
                  <c:v>1584.124</c:v>
                </c:pt>
                <c:pt idx="390">
                  <c:v>1592.5060000000001</c:v>
                </c:pt>
                <c:pt idx="391">
                  <c:v>1600.8879999999999</c:v>
                </c:pt>
                <c:pt idx="392">
                  <c:v>1609.269</c:v>
                </c:pt>
                <c:pt idx="393">
                  <c:v>1617.6510000000001</c:v>
                </c:pt>
                <c:pt idx="394">
                  <c:v>1626.0319999999999</c:v>
                </c:pt>
                <c:pt idx="395">
                  <c:v>1634.414</c:v>
                </c:pt>
                <c:pt idx="396">
                  <c:v>1642.796</c:v>
                </c:pt>
                <c:pt idx="397">
                  <c:v>1651.1769999999999</c:v>
                </c:pt>
                <c:pt idx="398">
                  <c:v>1659.559</c:v>
                </c:pt>
                <c:pt idx="399">
                  <c:v>1667.94</c:v>
                </c:pt>
                <c:pt idx="400">
                  <c:v>1676.3219999999999</c:v>
                </c:pt>
                <c:pt idx="401">
                  <c:v>1676.3219999999999</c:v>
                </c:pt>
              </c:numCache>
            </c:numRef>
          </c:xVal>
          <c:yVal>
            <c:numRef>
              <c:f>Foglio6!$F$424:$F$82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</c:v>
                </c:pt>
                <c:pt idx="166">
                  <c:v>17.5</c:v>
                </c:pt>
                <c:pt idx="167">
                  <c:v>17</c:v>
                </c:pt>
                <c:pt idx="168">
                  <c:v>16.5</c:v>
                </c:pt>
                <c:pt idx="169">
                  <c:v>16</c:v>
                </c:pt>
                <c:pt idx="170">
                  <c:v>15.5</c:v>
                </c:pt>
                <c:pt idx="171">
                  <c:v>15</c:v>
                </c:pt>
                <c:pt idx="172">
                  <c:v>14.51</c:v>
                </c:pt>
                <c:pt idx="173">
                  <c:v>14.5</c:v>
                </c:pt>
                <c:pt idx="174">
                  <c:v>14</c:v>
                </c:pt>
                <c:pt idx="175">
                  <c:v>13.5</c:v>
                </c:pt>
                <c:pt idx="176">
                  <c:v>13</c:v>
                </c:pt>
                <c:pt idx="177">
                  <c:v>12.5</c:v>
                </c:pt>
                <c:pt idx="178">
                  <c:v>12</c:v>
                </c:pt>
                <c:pt idx="179">
                  <c:v>11.552</c:v>
                </c:pt>
                <c:pt idx="180">
                  <c:v>11.5</c:v>
                </c:pt>
                <c:pt idx="181">
                  <c:v>11</c:v>
                </c:pt>
                <c:pt idx="182">
                  <c:v>10.5</c:v>
                </c:pt>
                <c:pt idx="183">
                  <c:v>10.119999999999999</c:v>
                </c:pt>
                <c:pt idx="184">
                  <c:v>10</c:v>
                </c:pt>
                <c:pt idx="185">
                  <c:v>9.5</c:v>
                </c:pt>
                <c:pt idx="186">
                  <c:v>9.125</c:v>
                </c:pt>
                <c:pt idx="187">
                  <c:v>9</c:v>
                </c:pt>
                <c:pt idx="188">
                  <c:v>8.5</c:v>
                </c:pt>
                <c:pt idx="189">
                  <c:v>8.4580000000000002</c:v>
                </c:pt>
                <c:pt idx="190">
                  <c:v>8</c:v>
                </c:pt>
                <c:pt idx="191">
                  <c:v>7.891</c:v>
                </c:pt>
                <c:pt idx="192">
                  <c:v>7.5</c:v>
                </c:pt>
                <c:pt idx="193">
                  <c:v>7.4569999999999999</c:v>
                </c:pt>
                <c:pt idx="194">
                  <c:v>7.07</c:v>
                </c:pt>
                <c:pt idx="195">
                  <c:v>7</c:v>
                </c:pt>
                <c:pt idx="196">
                  <c:v>6.7489999999999997</c:v>
                </c:pt>
                <c:pt idx="197">
                  <c:v>6.5</c:v>
                </c:pt>
                <c:pt idx="198">
                  <c:v>6.4640000000000004</c:v>
                </c:pt>
                <c:pt idx="199">
                  <c:v>6.2069999999999999</c:v>
                </c:pt>
                <c:pt idx="200">
                  <c:v>6</c:v>
                </c:pt>
                <c:pt idx="201">
                  <c:v>5.99</c:v>
                </c:pt>
                <c:pt idx="202">
                  <c:v>5.7720000000000002</c:v>
                </c:pt>
                <c:pt idx="203">
                  <c:v>5.5839999999999996</c:v>
                </c:pt>
                <c:pt idx="204">
                  <c:v>5.5</c:v>
                </c:pt>
                <c:pt idx="205">
                  <c:v>5.415</c:v>
                </c:pt>
                <c:pt idx="206">
                  <c:v>5.2539999999999996</c:v>
                </c:pt>
                <c:pt idx="207">
                  <c:v>5.1059999999999999</c:v>
                </c:pt>
                <c:pt idx="208">
                  <c:v>5</c:v>
                </c:pt>
                <c:pt idx="209">
                  <c:v>4.96</c:v>
                </c:pt>
                <c:pt idx="210">
                  <c:v>4.8250000000000002</c:v>
                </c:pt>
                <c:pt idx="211">
                  <c:v>4.7110000000000003</c:v>
                </c:pt>
                <c:pt idx="212">
                  <c:v>4.5890000000000004</c:v>
                </c:pt>
                <c:pt idx="213">
                  <c:v>4.5</c:v>
                </c:pt>
                <c:pt idx="214">
                  <c:v>4.484</c:v>
                </c:pt>
                <c:pt idx="215">
                  <c:v>4.3780000000000001</c:v>
                </c:pt>
                <c:pt idx="216">
                  <c:v>4.2750000000000004</c:v>
                </c:pt>
                <c:pt idx="217">
                  <c:v>4.173</c:v>
                </c:pt>
                <c:pt idx="218">
                  <c:v>4.0830000000000002</c:v>
                </c:pt>
                <c:pt idx="219">
                  <c:v>4</c:v>
                </c:pt>
                <c:pt idx="220">
                  <c:v>4</c:v>
                </c:pt>
                <c:pt idx="221">
                  <c:v>3.9119999999999999</c:v>
                </c:pt>
                <c:pt idx="222">
                  <c:v>3.8319999999999999</c:v>
                </c:pt>
                <c:pt idx="223">
                  <c:v>3.7559999999999998</c:v>
                </c:pt>
                <c:pt idx="224">
                  <c:v>3.6760000000000002</c:v>
                </c:pt>
                <c:pt idx="225">
                  <c:v>3.605</c:v>
                </c:pt>
                <c:pt idx="226">
                  <c:v>3.536</c:v>
                </c:pt>
                <c:pt idx="227">
                  <c:v>3.5</c:v>
                </c:pt>
                <c:pt idx="228">
                  <c:v>3.4769999999999999</c:v>
                </c:pt>
                <c:pt idx="229">
                  <c:v>3.4129999999999998</c:v>
                </c:pt>
                <c:pt idx="230">
                  <c:v>3.3610000000000002</c:v>
                </c:pt>
                <c:pt idx="231">
                  <c:v>3.2930000000000001</c:v>
                </c:pt>
                <c:pt idx="232">
                  <c:v>3.2330000000000001</c:v>
                </c:pt>
                <c:pt idx="233">
                  <c:v>3.1720000000000002</c:v>
                </c:pt>
                <c:pt idx="234">
                  <c:v>3.1110000000000002</c:v>
                </c:pt>
                <c:pt idx="235">
                  <c:v>3.048</c:v>
                </c:pt>
                <c:pt idx="236">
                  <c:v>3</c:v>
                </c:pt>
                <c:pt idx="237">
                  <c:v>2.9910000000000001</c:v>
                </c:pt>
                <c:pt idx="238">
                  <c:v>2.9420000000000002</c:v>
                </c:pt>
                <c:pt idx="239">
                  <c:v>2.8969999999999998</c:v>
                </c:pt>
                <c:pt idx="240">
                  <c:v>2.8580000000000001</c:v>
                </c:pt>
                <c:pt idx="241">
                  <c:v>2.8140000000000001</c:v>
                </c:pt>
                <c:pt idx="242">
                  <c:v>2.7629999999999999</c:v>
                </c:pt>
                <c:pt idx="243">
                  <c:v>2.7160000000000002</c:v>
                </c:pt>
                <c:pt idx="244">
                  <c:v>2.6709999999999998</c:v>
                </c:pt>
                <c:pt idx="245">
                  <c:v>2.6259999999999999</c:v>
                </c:pt>
                <c:pt idx="246">
                  <c:v>2.58</c:v>
                </c:pt>
                <c:pt idx="247">
                  <c:v>2.5419999999999998</c:v>
                </c:pt>
                <c:pt idx="248">
                  <c:v>2.5009999999999999</c:v>
                </c:pt>
                <c:pt idx="249">
                  <c:v>2.5</c:v>
                </c:pt>
                <c:pt idx="250">
                  <c:v>2.4580000000000002</c:v>
                </c:pt>
                <c:pt idx="251">
                  <c:v>2.4169999999999998</c:v>
                </c:pt>
                <c:pt idx="252">
                  <c:v>2.3849999999999998</c:v>
                </c:pt>
                <c:pt idx="253">
                  <c:v>2.3439999999999999</c:v>
                </c:pt>
                <c:pt idx="254">
                  <c:v>2.3010000000000002</c:v>
                </c:pt>
                <c:pt idx="255">
                  <c:v>2.2719999999999998</c:v>
                </c:pt>
                <c:pt idx="256">
                  <c:v>2.2360000000000002</c:v>
                </c:pt>
                <c:pt idx="257">
                  <c:v>2.2029999999999998</c:v>
                </c:pt>
                <c:pt idx="258">
                  <c:v>2.173</c:v>
                </c:pt>
                <c:pt idx="259">
                  <c:v>2.1360000000000001</c:v>
                </c:pt>
                <c:pt idx="260">
                  <c:v>2.0979999999999999</c:v>
                </c:pt>
                <c:pt idx="261">
                  <c:v>2.0680000000000001</c:v>
                </c:pt>
                <c:pt idx="262">
                  <c:v>2.04</c:v>
                </c:pt>
                <c:pt idx="263">
                  <c:v>2.008</c:v>
                </c:pt>
                <c:pt idx="264">
                  <c:v>2</c:v>
                </c:pt>
                <c:pt idx="265">
                  <c:v>1.9790000000000001</c:v>
                </c:pt>
                <c:pt idx="266">
                  <c:v>1.952</c:v>
                </c:pt>
                <c:pt idx="267">
                  <c:v>1.921</c:v>
                </c:pt>
                <c:pt idx="268">
                  <c:v>1.889</c:v>
                </c:pt>
                <c:pt idx="269">
                  <c:v>1.859</c:v>
                </c:pt>
                <c:pt idx="270">
                  <c:v>1.8320000000000001</c:v>
                </c:pt>
                <c:pt idx="271">
                  <c:v>1.8069999999999999</c:v>
                </c:pt>
                <c:pt idx="272">
                  <c:v>1.78</c:v>
                </c:pt>
                <c:pt idx="273">
                  <c:v>1.7529999999999999</c:v>
                </c:pt>
                <c:pt idx="274">
                  <c:v>1.724</c:v>
                </c:pt>
                <c:pt idx="275">
                  <c:v>1.696</c:v>
                </c:pt>
                <c:pt idx="276">
                  <c:v>1.6679999999999999</c:v>
                </c:pt>
                <c:pt idx="277">
                  <c:v>1.6439999999999999</c:v>
                </c:pt>
                <c:pt idx="278">
                  <c:v>1.6160000000000001</c:v>
                </c:pt>
                <c:pt idx="279">
                  <c:v>1.5940000000000001</c:v>
                </c:pt>
                <c:pt idx="280">
                  <c:v>1.569</c:v>
                </c:pt>
                <c:pt idx="281">
                  <c:v>1.546</c:v>
                </c:pt>
                <c:pt idx="282">
                  <c:v>1.5249999999999999</c:v>
                </c:pt>
                <c:pt idx="283">
                  <c:v>1.5049999999999999</c:v>
                </c:pt>
                <c:pt idx="284">
                  <c:v>1.5</c:v>
                </c:pt>
                <c:pt idx="285">
                  <c:v>1.48</c:v>
                </c:pt>
                <c:pt idx="286">
                  <c:v>1.46</c:v>
                </c:pt>
                <c:pt idx="287">
                  <c:v>1.4330000000000001</c:v>
                </c:pt>
                <c:pt idx="288">
                  <c:v>1.413</c:v>
                </c:pt>
                <c:pt idx="289">
                  <c:v>1.3859999999999999</c:v>
                </c:pt>
                <c:pt idx="290">
                  <c:v>1.36</c:v>
                </c:pt>
                <c:pt idx="291">
                  <c:v>1.3360000000000001</c:v>
                </c:pt>
                <c:pt idx="292">
                  <c:v>1.3180000000000001</c:v>
                </c:pt>
                <c:pt idx="293">
                  <c:v>1.2949999999999999</c:v>
                </c:pt>
                <c:pt idx="294">
                  <c:v>1.2669999999999999</c:v>
                </c:pt>
                <c:pt idx="295">
                  <c:v>1.252</c:v>
                </c:pt>
                <c:pt idx="296">
                  <c:v>1.236</c:v>
                </c:pt>
                <c:pt idx="297">
                  <c:v>1.2210000000000001</c:v>
                </c:pt>
                <c:pt idx="298">
                  <c:v>1.2</c:v>
                </c:pt>
                <c:pt idx="299">
                  <c:v>1.177</c:v>
                </c:pt>
                <c:pt idx="300">
                  <c:v>1.161</c:v>
                </c:pt>
                <c:pt idx="301">
                  <c:v>1.143</c:v>
                </c:pt>
                <c:pt idx="302">
                  <c:v>1.127</c:v>
                </c:pt>
                <c:pt idx="303">
                  <c:v>1.111</c:v>
                </c:pt>
                <c:pt idx="304">
                  <c:v>1.0880000000000001</c:v>
                </c:pt>
                <c:pt idx="305">
                  <c:v>1.0620000000000001</c:v>
                </c:pt>
                <c:pt idx="306">
                  <c:v>1.0429999999999999</c:v>
                </c:pt>
                <c:pt idx="307">
                  <c:v>1.024</c:v>
                </c:pt>
                <c:pt idx="308">
                  <c:v>1.0049999999999999</c:v>
                </c:pt>
                <c:pt idx="309">
                  <c:v>1</c:v>
                </c:pt>
                <c:pt idx="310">
                  <c:v>0.99199999999999999</c:v>
                </c:pt>
                <c:pt idx="311">
                  <c:v>0.97599999999999998</c:v>
                </c:pt>
                <c:pt idx="312">
                  <c:v>0.96</c:v>
                </c:pt>
                <c:pt idx="313">
                  <c:v>0.94599999999999995</c:v>
                </c:pt>
                <c:pt idx="314">
                  <c:v>0.93100000000000005</c:v>
                </c:pt>
                <c:pt idx="315">
                  <c:v>0.90900000000000003</c:v>
                </c:pt>
                <c:pt idx="316">
                  <c:v>0.89</c:v>
                </c:pt>
                <c:pt idx="317">
                  <c:v>0.874</c:v>
                </c:pt>
                <c:pt idx="318">
                  <c:v>0.85799999999999998</c:v>
                </c:pt>
                <c:pt idx="319">
                  <c:v>0.84</c:v>
                </c:pt>
                <c:pt idx="320">
                  <c:v>0.82299999999999995</c:v>
                </c:pt>
                <c:pt idx="321">
                  <c:v>0.80300000000000005</c:v>
                </c:pt>
                <c:pt idx="322">
                  <c:v>0.78600000000000003</c:v>
                </c:pt>
                <c:pt idx="323">
                  <c:v>0.77400000000000002</c:v>
                </c:pt>
                <c:pt idx="324">
                  <c:v>0.75900000000000001</c:v>
                </c:pt>
                <c:pt idx="325">
                  <c:v>0.74199999999999999</c:v>
                </c:pt>
                <c:pt idx="326">
                  <c:v>0.72599999999999998</c:v>
                </c:pt>
                <c:pt idx="327">
                  <c:v>0.71499999999999997</c:v>
                </c:pt>
                <c:pt idx="328">
                  <c:v>0.70199999999999996</c:v>
                </c:pt>
                <c:pt idx="329">
                  <c:v>0.68700000000000006</c:v>
                </c:pt>
                <c:pt idx="330">
                  <c:v>0.67400000000000004</c:v>
                </c:pt>
                <c:pt idx="331">
                  <c:v>0.65900000000000003</c:v>
                </c:pt>
                <c:pt idx="332">
                  <c:v>0.64600000000000002</c:v>
                </c:pt>
                <c:pt idx="333">
                  <c:v>0.63300000000000001</c:v>
                </c:pt>
                <c:pt idx="334">
                  <c:v>0.61499999999999999</c:v>
                </c:pt>
                <c:pt idx="335">
                  <c:v>0.60099999999999998</c:v>
                </c:pt>
                <c:pt idx="336">
                  <c:v>0.58799999999999997</c:v>
                </c:pt>
                <c:pt idx="337">
                  <c:v>0.57099999999999995</c:v>
                </c:pt>
                <c:pt idx="338">
                  <c:v>0.55600000000000005</c:v>
                </c:pt>
                <c:pt idx="339">
                  <c:v>0.54500000000000004</c:v>
                </c:pt>
                <c:pt idx="340">
                  <c:v>0.53200000000000003</c:v>
                </c:pt>
                <c:pt idx="341">
                  <c:v>0.51600000000000001</c:v>
                </c:pt>
                <c:pt idx="342">
                  <c:v>0.504</c:v>
                </c:pt>
                <c:pt idx="343">
                  <c:v>0.5</c:v>
                </c:pt>
                <c:pt idx="344">
                  <c:v>0.49299999999999999</c:v>
                </c:pt>
                <c:pt idx="345">
                  <c:v>0.47899999999999998</c:v>
                </c:pt>
                <c:pt idx="346">
                  <c:v>0.46500000000000002</c:v>
                </c:pt>
                <c:pt idx="347">
                  <c:v>0.45400000000000001</c:v>
                </c:pt>
                <c:pt idx="348">
                  <c:v>0.44400000000000001</c:v>
                </c:pt>
                <c:pt idx="349">
                  <c:v>0.432</c:v>
                </c:pt>
                <c:pt idx="350">
                  <c:v>0.41499999999999998</c:v>
                </c:pt>
                <c:pt idx="351">
                  <c:v>0.40400000000000003</c:v>
                </c:pt>
                <c:pt idx="352">
                  <c:v>0.39600000000000002</c:v>
                </c:pt>
                <c:pt idx="353">
                  <c:v>0.38400000000000001</c:v>
                </c:pt>
                <c:pt idx="354">
                  <c:v>0.36799999999999999</c:v>
                </c:pt>
                <c:pt idx="355">
                  <c:v>0.35899999999999999</c:v>
                </c:pt>
                <c:pt idx="356">
                  <c:v>0.34200000000000003</c:v>
                </c:pt>
                <c:pt idx="357">
                  <c:v>0.32800000000000001</c:v>
                </c:pt>
                <c:pt idx="358">
                  <c:v>0.318</c:v>
                </c:pt>
                <c:pt idx="359">
                  <c:v>0.308</c:v>
                </c:pt>
                <c:pt idx="360">
                  <c:v>0.29399999999999998</c:v>
                </c:pt>
                <c:pt idx="361">
                  <c:v>0.28100000000000003</c:v>
                </c:pt>
                <c:pt idx="362">
                  <c:v>0.27100000000000002</c:v>
                </c:pt>
                <c:pt idx="363">
                  <c:v>0.26300000000000001</c:v>
                </c:pt>
                <c:pt idx="364">
                  <c:v>0.249</c:v>
                </c:pt>
                <c:pt idx="365">
                  <c:v>0.23699999999999999</c:v>
                </c:pt>
                <c:pt idx="366">
                  <c:v>0.22700000000000001</c:v>
                </c:pt>
                <c:pt idx="367">
                  <c:v>0.214</c:v>
                </c:pt>
                <c:pt idx="368">
                  <c:v>0.20300000000000001</c:v>
                </c:pt>
                <c:pt idx="369">
                  <c:v>0.19</c:v>
                </c:pt>
                <c:pt idx="370">
                  <c:v>0.17799999999999999</c:v>
                </c:pt>
                <c:pt idx="371">
                  <c:v>0.16800000000000001</c:v>
                </c:pt>
                <c:pt idx="372">
                  <c:v>0.161</c:v>
                </c:pt>
                <c:pt idx="373">
                  <c:v>0.15</c:v>
                </c:pt>
                <c:pt idx="374">
                  <c:v>0.14099999999999999</c:v>
                </c:pt>
                <c:pt idx="375">
                  <c:v>0.13</c:v>
                </c:pt>
                <c:pt idx="376">
                  <c:v>0.11799999999999999</c:v>
                </c:pt>
                <c:pt idx="377">
                  <c:v>0.11</c:v>
                </c:pt>
                <c:pt idx="378">
                  <c:v>0.10100000000000001</c:v>
                </c:pt>
                <c:pt idx="379">
                  <c:v>9.1999999999999998E-2</c:v>
                </c:pt>
                <c:pt idx="380">
                  <c:v>8.1000000000000003E-2</c:v>
                </c:pt>
                <c:pt idx="381">
                  <c:v>7.0999999999999994E-2</c:v>
                </c:pt>
                <c:pt idx="382">
                  <c:v>6.4000000000000001E-2</c:v>
                </c:pt>
                <c:pt idx="383">
                  <c:v>5.8000000000000003E-2</c:v>
                </c:pt>
                <c:pt idx="384">
                  <c:v>4.9000000000000002E-2</c:v>
                </c:pt>
                <c:pt idx="385">
                  <c:v>4.1000000000000002E-2</c:v>
                </c:pt>
                <c:pt idx="386">
                  <c:v>3.4000000000000002E-2</c:v>
                </c:pt>
                <c:pt idx="387">
                  <c:v>2.7E-2</c:v>
                </c:pt>
                <c:pt idx="388">
                  <c:v>2.1000000000000001E-2</c:v>
                </c:pt>
                <c:pt idx="389">
                  <c:v>1.7000000000000001E-2</c:v>
                </c:pt>
                <c:pt idx="390">
                  <c:v>1.4E-2</c:v>
                </c:pt>
                <c:pt idx="391">
                  <c:v>0.01</c:v>
                </c:pt>
                <c:pt idx="392">
                  <c:v>7.0000000000000001E-3</c:v>
                </c:pt>
                <c:pt idx="393">
                  <c:v>5.0000000000000001E-3</c:v>
                </c:pt>
                <c:pt idx="394">
                  <c:v>4.0000000000000001E-3</c:v>
                </c:pt>
                <c:pt idx="395">
                  <c:v>3.0000000000000001E-3</c:v>
                </c:pt>
                <c:pt idx="396">
                  <c:v>3.0000000000000001E-3</c:v>
                </c:pt>
                <c:pt idx="397">
                  <c:v>1E-3</c:v>
                </c:pt>
                <c:pt idx="398">
                  <c:v>1E-3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237-45B1-A7AA-312291C87353}"/>
            </c:ext>
          </c:extLst>
        </c:ser>
        <c:ser>
          <c:idx val="4"/>
          <c:order val="3"/>
          <c:tx>
            <c:strRef>
              <c:f>Foglio6!$G$1</c:f>
              <c:strCache>
                <c:ptCount val="1"/>
                <c:pt idx="0">
                  <c:v>S1,0M5</c:v>
                </c:pt>
              </c:strCache>
            </c:strRef>
          </c:tx>
          <c:spPr>
            <a:ln w="19050" cap="rnd">
              <a:solidFill>
                <a:srgbClr val="990000"/>
              </a:solidFill>
              <a:round/>
            </a:ln>
            <a:effectLst/>
          </c:spPr>
          <c:marker>
            <c:symbol val="none"/>
          </c:marker>
          <c:dLbls>
            <c:dLbl>
              <c:idx val="401"/>
              <c:dLblPos val="r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C237-45B1-A7AA-312291C8735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Foglio6!$G$424:$G$82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3.0000000000000001E-3</c:v>
                </c:pt>
                <c:pt idx="74">
                  <c:v>2.5999999999999999E-2</c:v>
                </c:pt>
                <c:pt idx="75">
                  <c:v>4.8000000000000001E-2</c:v>
                </c:pt>
                <c:pt idx="76">
                  <c:v>7.0000000000000007E-2</c:v>
                </c:pt>
                <c:pt idx="77">
                  <c:v>9.1999999999999998E-2</c:v>
                </c:pt>
                <c:pt idx="78">
                  <c:v>0.115</c:v>
                </c:pt>
                <c:pt idx="79">
                  <c:v>0.13700000000000001</c:v>
                </c:pt>
                <c:pt idx="80">
                  <c:v>0.159</c:v>
                </c:pt>
                <c:pt idx="81">
                  <c:v>0.18099999999999999</c:v>
                </c:pt>
                <c:pt idx="82">
                  <c:v>0.20300000000000001</c:v>
                </c:pt>
                <c:pt idx="83">
                  <c:v>0.22600000000000001</c:v>
                </c:pt>
                <c:pt idx="84">
                  <c:v>0.248</c:v>
                </c:pt>
                <c:pt idx="85">
                  <c:v>0.27</c:v>
                </c:pt>
                <c:pt idx="86">
                  <c:v>0.29199999999999998</c:v>
                </c:pt>
                <c:pt idx="87">
                  <c:v>0.315</c:v>
                </c:pt>
                <c:pt idx="88">
                  <c:v>0.33700000000000002</c:v>
                </c:pt>
                <c:pt idx="89">
                  <c:v>0.35899999999999999</c:v>
                </c:pt>
                <c:pt idx="90">
                  <c:v>0.38100000000000001</c:v>
                </c:pt>
                <c:pt idx="91">
                  <c:v>0.40300000000000002</c:v>
                </c:pt>
                <c:pt idx="92">
                  <c:v>0.42599999999999999</c:v>
                </c:pt>
                <c:pt idx="93">
                  <c:v>0.44800000000000001</c:v>
                </c:pt>
                <c:pt idx="94">
                  <c:v>0.47</c:v>
                </c:pt>
                <c:pt idx="95">
                  <c:v>0.49199999999999999</c:v>
                </c:pt>
                <c:pt idx="96">
                  <c:v>0.51500000000000001</c:v>
                </c:pt>
                <c:pt idx="97">
                  <c:v>0.53700000000000003</c:v>
                </c:pt>
                <c:pt idx="98">
                  <c:v>0.55900000000000005</c:v>
                </c:pt>
                <c:pt idx="99">
                  <c:v>0.58099999999999996</c:v>
                </c:pt>
                <c:pt idx="100">
                  <c:v>0.60399999999999998</c:v>
                </c:pt>
                <c:pt idx="101">
                  <c:v>0.626</c:v>
                </c:pt>
                <c:pt idx="102">
                  <c:v>0.64800000000000002</c:v>
                </c:pt>
                <c:pt idx="103">
                  <c:v>0.67</c:v>
                </c:pt>
                <c:pt idx="104">
                  <c:v>0.69199999999999995</c:v>
                </c:pt>
                <c:pt idx="105">
                  <c:v>0.71499999999999997</c:v>
                </c:pt>
                <c:pt idx="106">
                  <c:v>0.73699999999999999</c:v>
                </c:pt>
                <c:pt idx="107">
                  <c:v>0.75900000000000001</c:v>
                </c:pt>
                <c:pt idx="108">
                  <c:v>0.78100000000000003</c:v>
                </c:pt>
                <c:pt idx="109">
                  <c:v>0.80400000000000005</c:v>
                </c:pt>
                <c:pt idx="110">
                  <c:v>0.82599999999999996</c:v>
                </c:pt>
                <c:pt idx="111">
                  <c:v>0.84799999999999998</c:v>
                </c:pt>
                <c:pt idx="112">
                  <c:v>0.87</c:v>
                </c:pt>
                <c:pt idx="113">
                  <c:v>0.89200000000000002</c:v>
                </c:pt>
                <c:pt idx="114">
                  <c:v>0.91500000000000004</c:v>
                </c:pt>
                <c:pt idx="115">
                  <c:v>0.93700000000000006</c:v>
                </c:pt>
                <c:pt idx="116">
                  <c:v>0.95899999999999996</c:v>
                </c:pt>
                <c:pt idx="117">
                  <c:v>0.98099999999999998</c:v>
                </c:pt>
                <c:pt idx="118">
                  <c:v>1.004</c:v>
                </c:pt>
                <c:pt idx="119">
                  <c:v>1.026</c:v>
                </c:pt>
                <c:pt idx="120">
                  <c:v>1.048</c:v>
                </c:pt>
                <c:pt idx="121">
                  <c:v>1.07</c:v>
                </c:pt>
                <c:pt idx="122">
                  <c:v>1.093</c:v>
                </c:pt>
                <c:pt idx="123">
                  <c:v>1.115</c:v>
                </c:pt>
                <c:pt idx="124">
                  <c:v>1.137</c:v>
                </c:pt>
                <c:pt idx="125">
                  <c:v>1.159</c:v>
                </c:pt>
                <c:pt idx="126">
                  <c:v>1.181</c:v>
                </c:pt>
                <c:pt idx="127">
                  <c:v>1.204</c:v>
                </c:pt>
                <c:pt idx="128">
                  <c:v>1.226</c:v>
                </c:pt>
                <c:pt idx="129">
                  <c:v>1.248</c:v>
                </c:pt>
                <c:pt idx="130">
                  <c:v>1.27</c:v>
                </c:pt>
                <c:pt idx="131">
                  <c:v>1.2929999999999999</c:v>
                </c:pt>
                <c:pt idx="132">
                  <c:v>1.3149999999999999</c:v>
                </c:pt>
                <c:pt idx="133">
                  <c:v>1.337</c:v>
                </c:pt>
                <c:pt idx="134">
                  <c:v>1.359</c:v>
                </c:pt>
                <c:pt idx="135">
                  <c:v>1.381</c:v>
                </c:pt>
                <c:pt idx="136">
                  <c:v>1.4039999999999999</c:v>
                </c:pt>
                <c:pt idx="137">
                  <c:v>1.4259999999999999</c:v>
                </c:pt>
                <c:pt idx="138">
                  <c:v>1.448</c:v>
                </c:pt>
                <c:pt idx="139">
                  <c:v>1.47</c:v>
                </c:pt>
                <c:pt idx="140">
                  <c:v>1.4930000000000001</c:v>
                </c:pt>
                <c:pt idx="141">
                  <c:v>1.5149999999999999</c:v>
                </c:pt>
                <c:pt idx="142">
                  <c:v>1.5369999999999999</c:v>
                </c:pt>
                <c:pt idx="143">
                  <c:v>1.5589999999999999</c:v>
                </c:pt>
                <c:pt idx="144">
                  <c:v>1.581</c:v>
                </c:pt>
                <c:pt idx="145">
                  <c:v>1.6040000000000001</c:v>
                </c:pt>
                <c:pt idx="146">
                  <c:v>1.6259999999999999</c:v>
                </c:pt>
                <c:pt idx="147">
                  <c:v>1.6479999999999999</c:v>
                </c:pt>
                <c:pt idx="148">
                  <c:v>1.67</c:v>
                </c:pt>
                <c:pt idx="149">
                  <c:v>1.6930000000000001</c:v>
                </c:pt>
                <c:pt idx="150">
                  <c:v>1.7150000000000001</c:v>
                </c:pt>
                <c:pt idx="151">
                  <c:v>1.7370000000000001</c:v>
                </c:pt>
                <c:pt idx="152">
                  <c:v>1.788</c:v>
                </c:pt>
                <c:pt idx="153">
                  <c:v>1.962</c:v>
                </c:pt>
                <c:pt idx="154">
                  <c:v>2.1349999999999998</c:v>
                </c:pt>
                <c:pt idx="155">
                  <c:v>2.3090000000000002</c:v>
                </c:pt>
                <c:pt idx="156">
                  <c:v>2.4820000000000002</c:v>
                </c:pt>
                <c:pt idx="157">
                  <c:v>2.6560000000000001</c:v>
                </c:pt>
                <c:pt idx="158">
                  <c:v>2.8290000000000002</c:v>
                </c:pt>
                <c:pt idx="159">
                  <c:v>3.0030000000000001</c:v>
                </c:pt>
                <c:pt idx="160">
                  <c:v>3.1760000000000002</c:v>
                </c:pt>
                <c:pt idx="161">
                  <c:v>3.35</c:v>
                </c:pt>
                <c:pt idx="162">
                  <c:v>3.5379999999999998</c:v>
                </c:pt>
                <c:pt idx="163">
                  <c:v>3.9089999999999998</c:v>
                </c:pt>
                <c:pt idx="164">
                  <c:v>4.2789999999999999</c:v>
                </c:pt>
                <c:pt idx="165">
                  <c:v>4.649</c:v>
                </c:pt>
                <c:pt idx="166">
                  <c:v>5.0190000000000001</c:v>
                </c:pt>
                <c:pt idx="167">
                  <c:v>5.4669999999999996</c:v>
                </c:pt>
                <c:pt idx="168">
                  <c:v>6.0670000000000002</c:v>
                </c:pt>
                <c:pt idx="169">
                  <c:v>6.6680000000000001</c:v>
                </c:pt>
                <c:pt idx="170">
                  <c:v>7.3650000000000002</c:v>
                </c:pt>
                <c:pt idx="171">
                  <c:v>8.1989999999999998</c:v>
                </c:pt>
                <c:pt idx="172">
                  <c:v>8.7750000000000004</c:v>
                </c:pt>
                <c:pt idx="173">
                  <c:v>9.1080000000000005</c:v>
                </c:pt>
                <c:pt idx="174">
                  <c:v>10.182</c:v>
                </c:pt>
                <c:pt idx="175">
                  <c:v>11.430999999999999</c:v>
                </c:pt>
                <c:pt idx="176">
                  <c:v>12.851000000000001</c:v>
                </c:pt>
                <c:pt idx="177">
                  <c:v>14.494</c:v>
                </c:pt>
                <c:pt idx="178">
                  <c:v>16.419</c:v>
                </c:pt>
                <c:pt idx="179">
                  <c:v>17.55</c:v>
                </c:pt>
                <c:pt idx="180">
                  <c:v>18.651</c:v>
                </c:pt>
                <c:pt idx="181">
                  <c:v>21.2</c:v>
                </c:pt>
                <c:pt idx="182">
                  <c:v>24.353999999999999</c:v>
                </c:pt>
                <c:pt idx="183">
                  <c:v>26.326000000000001</c:v>
                </c:pt>
                <c:pt idx="184">
                  <c:v>28.045000000000002</c:v>
                </c:pt>
                <c:pt idx="185">
                  <c:v>32.408999999999999</c:v>
                </c:pt>
                <c:pt idx="186">
                  <c:v>35.100999999999999</c:v>
                </c:pt>
                <c:pt idx="187">
                  <c:v>37.572000000000003</c:v>
                </c:pt>
                <c:pt idx="188">
                  <c:v>43.875999999999998</c:v>
                </c:pt>
                <c:pt idx="189">
                  <c:v>43.948</c:v>
                </c:pt>
                <c:pt idx="190">
                  <c:v>51.552999999999997</c:v>
                </c:pt>
                <c:pt idx="191">
                  <c:v>52.651000000000003</c:v>
                </c:pt>
                <c:pt idx="192">
                  <c:v>60.814</c:v>
                </c:pt>
                <c:pt idx="193">
                  <c:v>61.426000000000002</c:v>
                </c:pt>
                <c:pt idx="194">
                  <c:v>70.201999999999998</c:v>
                </c:pt>
                <c:pt idx="195">
                  <c:v>72.122</c:v>
                </c:pt>
                <c:pt idx="196">
                  <c:v>78.977000000000004</c:v>
                </c:pt>
                <c:pt idx="197">
                  <c:v>85.123999999999995</c:v>
                </c:pt>
                <c:pt idx="198">
                  <c:v>87.751999999999995</c:v>
                </c:pt>
                <c:pt idx="199">
                  <c:v>96.527000000000001</c:v>
                </c:pt>
                <c:pt idx="200">
                  <c:v>102.54600000000001</c:v>
                </c:pt>
                <c:pt idx="201">
                  <c:v>105.30200000000001</c:v>
                </c:pt>
                <c:pt idx="202">
                  <c:v>114.078</c:v>
                </c:pt>
                <c:pt idx="203">
                  <c:v>122.85299999999999</c:v>
                </c:pt>
                <c:pt idx="204">
                  <c:v>123.221</c:v>
                </c:pt>
                <c:pt idx="205">
                  <c:v>131.62799999999999</c:v>
                </c:pt>
                <c:pt idx="206">
                  <c:v>140.40299999999999</c:v>
                </c:pt>
                <c:pt idx="207">
                  <c:v>148.80500000000001</c:v>
                </c:pt>
                <c:pt idx="208">
                  <c:v>149.179</c:v>
                </c:pt>
                <c:pt idx="209">
                  <c:v>157.95400000000001</c:v>
                </c:pt>
                <c:pt idx="210">
                  <c:v>166.72900000000001</c:v>
                </c:pt>
                <c:pt idx="211">
                  <c:v>175.50399999999999</c:v>
                </c:pt>
                <c:pt idx="212">
                  <c:v>180.42</c:v>
                </c:pt>
                <c:pt idx="213">
                  <c:v>184.279</c:v>
                </c:pt>
                <c:pt idx="214">
                  <c:v>193.05500000000001</c:v>
                </c:pt>
                <c:pt idx="215">
                  <c:v>201.83</c:v>
                </c:pt>
                <c:pt idx="216">
                  <c:v>210.60499999999999</c:v>
                </c:pt>
                <c:pt idx="217">
                  <c:v>219.38</c:v>
                </c:pt>
                <c:pt idx="218">
                  <c:v>220.54900000000001</c:v>
                </c:pt>
                <c:pt idx="219">
                  <c:v>228.155</c:v>
                </c:pt>
                <c:pt idx="220">
                  <c:v>236.93100000000001</c:v>
                </c:pt>
                <c:pt idx="221">
                  <c:v>245.70599999999999</c:v>
                </c:pt>
                <c:pt idx="222">
                  <c:v>254.48099999999999</c:v>
                </c:pt>
                <c:pt idx="223">
                  <c:v>263.25599999999997</c:v>
                </c:pt>
                <c:pt idx="224">
                  <c:v>270.10700000000003</c:v>
                </c:pt>
                <c:pt idx="225">
                  <c:v>272.03100000000001</c:v>
                </c:pt>
                <c:pt idx="226">
                  <c:v>280.80700000000002</c:v>
                </c:pt>
                <c:pt idx="227">
                  <c:v>289.58199999999999</c:v>
                </c:pt>
                <c:pt idx="228">
                  <c:v>298.35700000000003</c:v>
                </c:pt>
                <c:pt idx="229">
                  <c:v>307.13200000000001</c:v>
                </c:pt>
                <c:pt idx="230">
                  <c:v>315.90699999999998</c:v>
                </c:pt>
                <c:pt idx="231">
                  <c:v>324.68299999999999</c:v>
                </c:pt>
                <c:pt idx="232">
                  <c:v>333.45800000000003</c:v>
                </c:pt>
                <c:pt idx="233">
                  <c:v>334.95</c:v>
                </c:pt>
                <c:pt idx="234">
                  <c:v>342.233</c:v>
                </c:pt>
                <c:pt idx="235">
                  <c:v>351.00799999999998</c:v>
                </c:pt>
                <c:pt idx="236">
                  <c:v>359.78300000000002</c:v>
                </c:pt>
                <c:pt idx="237">
                  <c:v>368.55900000000003</c:v>
                </c:pt>
                <c:pt idx="238">
                  <c:v>377.334</c:v>
                </c:pt>
                <c:pt idx="239">
                  <c:v>386.10899999999998</c:v>
                </c:pt>
                <c:pt idx="240">
                  <c:v>394.88400000000001</c:v>
                </c:pt>
                <c:pt idx="241">
                  <c:v>403.65899999999999</c:v>
                </c:pt>
                <c:pt idx="242">
                  <c:v>412.435</c:v>
                </c:pt>
                <c:pt idx="243">
                  <c:v>417.27100000000002</c:v>
                </c:pt>
                <c:pt idx="244">
                  <c:v>421.21</c:v>
                </c:pt>
                <c:pt idx="245">
                  <c:v>429.98500000000001</c:v>
                </c:pt>
                <c:pt idx="246">
                  <c:v>438.76</c:v>
                </c:pt>
                <c:pt idx="247">
                  <c:v>447.536</c:v>
                </c:pt>
                <c:pt idx="248">
                  <c:v>456.31099999999998</c:v>
                </c:pt>
                <c:pt idx="249">
                  <c:v>465.08600000000001</c:v>
                </c:pt>
                <c:pt idx="250">
                  <c:v>473.86099999999999</c:v>
                </c:pt>
                <c:pt idx="251">
                  <c:v>482.63600000000002</c:v>
                </c:pt>
                <c:pt idx="252">
                  <c:v>491.41199999999998</c:v>
                </c:pt>
                <c:pt idx="253">
                  <c:v>500.18700000000001</c:v>
                </c:pt>
                <c:pt idx="254">
                  <c:v>508.96199999999999</c:v>
                </c:pt>
                <c:pt idx="255">
                  <c:v>517.73699999999997</c:v>
                </c:pt>
                <c:pt idx="256">
                  <c:v>523.99300000000005</c:v>
                </c:pt>
                <c:pt idx="257">
                  <c:v>526.51199999999994</c:v>
                </c:pt>
                <c:pt idx="258">
                  <c:v>535.28800000000001</c:v>
                </c:pt>
                <c:pt idx="259">
                  <c:v>544.06299999999999</c:v>
                </c:pt>
                <c:pt idx="260">
                  <c:v>552.83799999999997</c:v>
                </c:pt>
                <c:pt idx="261">
                  <c:v>561.61300000000006</c:v>
                </c:pt>
                <c:pt idx="262">
                  <c:v>570.38800000000003</c:v>
                </c:pt>
                <c:pt idx="263">
                  <c:v>579.16399999999999</c:v>
                </c:pt>
                <c:pt idx="264">
                  <c:v>587.93899999999996</c:v>
                </c:pt>
                <c:pt idx="265">
                  <c:v>596.71400000000006</c:v>
                </c:pt>
                <c:pt idx="266">
                  <c:v>605.48900000000003</c:v>
                </c:pt>
                <c:pt idx="267">
                  <c:v>614.26400000000001</c:v>
                </c:pt>
                <c:pt idx="268">
                  <c:v>623.04</c:v>
                </c:pt>
                <c:pt idx="269">
                  <c:v>631.81500000000005</c:v>
                </c:pt>
                <c:pt idx="270">
                  <c:v>640.59</c:v>
                </c:pt>
                <c:pt idx="271">
                  <c:v>649.36500000000001</c:v>
                </c:pt>
                <c:pt idx="272">
                  <c:v>658.14</c:v>
                </c:pt>
                <c:pt idx="273">
                  <c:v>666.91600000000005</c:v>
                </c:pt>
                <c:pt idx="274">
                  <c:v>667.06200000000001</c:v>
                </c:pt>
                <c:pt idx="275">
                  <c:v>675.69100000000003</c:v>
                </c:pt>
                <c:pt idx="276">
                  <c:v>684.46600000000001</c:v>
                </c:pt>
                <c:pt idx="277">
                  <c:v>693.24099999999999</c:v>
                </c:pt>
                <c:pt idx="278">
                  <c:v>702.01700000000005</c:v>
                </c:pt>
                <c:pt idx="279">
                  <c:v>710.79200000000003</c:v>
                </c:pt>
                <c:pt idx="280">
                  <c:v>719.56700000000001</c:v>
                </c:pt>
                <c:pt idx="281">
                  <c:v>728.34199999999998</c:v>
                </c:pt>
                <c:pt idx="282">
                  <c:v>737.11699999999996</c:v>
                </c:pt>
                <c:pt idx="283">
                  <c:v>745.89300000000003</c:v>
                </c:pt>
                <c:pt idx="284">
                  <c:v>754.66800000000001</c:v>
                </c:pt>
                <c:pt idx="285">
                  <c:v>763.44299999999998</c:v>
                </c:pt>
                <c:pt idx="286">
                  <c:v>772.21799999999996</c:v>
                </c:pt>
                <c:pt idx="287">
                  <c:v>780.99300000000005</c:v>
                </c:pt>
                <c:pt idx="288">
                  <c:v>789.76900000000001</c:v>
                </c:pt>
                <c:pt idx="289">
                  <c:v>798.54399999999998</c:v>
                </c:pt>
                <c:pt idx="290">
                  <c:v>807.31899999999996</c:v>
                </c:pt>
                <c:pt idx="291">
                  <c:v>816.09400000000005</c:v>
                </c:pt>
                <c:pt idx="292">
                  <c:v>824.86900000000003</c:v>
                </c:pt>
                <c:pt idx="293">
                  <c:v>833.64499999999998</c:v>
                </c:pt>
                <c:pt idx="294">
                  <c:v>842.42</c:v>
                </c:pt>
                <c:pt idx="295">
                  <c:v>851.19500000000005</c:v>
                </c:pt>
                <c:pt idx="296">
                  <c:v>859.97</c:v>
                </c:pt>
                <c:pt idx="297">
                  <c:v>868.36699999999996</c:v>
                </c:pt>
                <c:pt idx="298">
                  <c:v>868.745</c:v>
                </c:pt>
                <c:pt idx="299">
                  <c:v>877.52099999999996</c:v>
                </c:pt>
                <c:pt idx="300">
                  <c:v>886.29600000000005</c:v>
                </c:pt>
                <c:pt idx="301">
                  <c:v>895.07100000000003</c:v>
                </c:pt>
                <c:pt idx="302">
                  <c:v>903.846</c:v>
                </c:pt>
                <c:pt idx="303">
                  <c:v>912.62099999999998</c:v>
                </c:pt>
                <c:pt idx="304">
                  <c:v>921.39700000000005</c:v>
                </c:pt>
                <c:pt idx="305">
                  <c:v>930.17200000000003</c:v>
                </c:pt>
                <c:pt idx="306">
                  <c:v>938.947</c:v>
                </c:pt>
                <c:pt idx="307">
                  <c:v>947.72199999999998</c:v>
                </c:pt>
                <c:pt idx="308">
                  <c:v>956.49699999999996</c:v>
                </c:pt>
                <c:pt idx="309">
                  <c:v>965.27300000000002</c:v>
                </c:pt>
                <c:pt idx="310">
                  <c:v>974.048</c:v>
                </c:pt>
                <c:pt idx="311">
                  <c:v>982.82299999999998</c:v>
                </c:pt>
                <c:pt idx="312">
                  <c:v>991.59799999999996</c:v>
                </c:pt>
                <c:pt idx="313">
                  <c:v>1000.374</c:v>
                </c:pt>
                <c:pt idx="314">
                  <c:v>1009.149</c:v>
                </c:pt>
                <c:pt idx="315">
                  <c:v>1017.924</c:v>
                </c:pt>
                <c:pt idx="316">
                  <c:v>1026.6990000000001</c:v>
                </c:pt>
                <c:pt idx="317">
                  <c:v>1035.4739999999999</c:v>
                </c:pt>
                <c:pt idx="318">
                  <c:v>1044.25</c:v>
                </c:pt>
                <c:pt idx="319">
                  <c:v>1053.0250000000001</c:v>
                </c:pt>
                <c:pt idx="320">
                  <c:v>1061.8</c:v>
                </c:pt>
                <c:pt idx="321">
                  <c:v>1070.575</c:v>
                </c:pt>
                <c:pt idx="322">
                  <c:v>1079.3499999999999</c:v>
                </c:pt>
                <c:pt idx="323">
                  <c:v>1088.126</c:v>
                </c:pt>
                <c:pt idx="324">
                  <c:v>1096.9010000000001</c:v>
                </c:pt>
                <c:pt idx="325">
                  <c:v>1105.6759999999999</c:v>
                </c:pt>
                <c:pt idx="326">
                  <c:v>1114.451</c:v>
                </c:pt>
                <c:pt idx="327">
                  <c:v>1123.2260000000001</c:v>
                </c:pt>
                <c:pt idx="328">
                  <c:v>1132.002</c:v>
                </c:pt>
                <c:pt idx="329">
                  <c:v>1140.777</c:v>
                </c:pt>
                <c:pt idx="330">
                  <c:v>1149.5519999999999</c:v>
                </c:pt>
                <c:pt idx="331">
                  <c:v>1154.45</c:v>
                </c:pt>
                <c:pt idx="332">
                  <c:v>1158.327</c:v>
                </c:pt>
                <c:pt idx="333">
                  <c:v>1167.1020000000001</c:v>
                </c:pt>
                <c:pt idx="334">
                  <c:v>1175.8779999999999</c:v>
                </c:pt>
                <c:pt idx="335">
                  <c:v>1184.653</c:v>
                </c:pt>
                <c:pt idx="336">
                  <c:v>1193.4280000000001</c:v>
                </c:pt>
                <c:pt idx="337">
                  <c:v>1202.203</c:v>
                </c:pt>
                <c:pt idx="338">
                  <c:v>1210.9780000000001</c:v>
                </c:pt>
                <c:pt idx="339">
                  <c:v>1219.7539999999999</c:v>
                </c:pt>
                <c:pt idx="340">
                  <c:v>1228.529</c:v>
                </c:pt>
                <c:pt idx="341">
                  <c:v>1237.3040000000001</c:v>
                </c:pt>
                <c:pt idx="342">
                  <c:v>1246.079</c:v>
                </c:pt>
                <c:pt idx="343">
                  <c:v>1254.855</c:v>
                </c:pt>
                <c:pt idx="344">
                  <c:v>1263.6300000000001</c:v>
                </c:pt>
                <c:pt idx="345">
                  <c:v>1272.405</c:v>
                </c:pt>
                <c:pt idx="346">
                  <c:v>1281.18</c:v>
                </c:pt>
                <c:pt idx="347">
                  <c:v>1289.9549999999999</c:v>
                </c:pt>
                <c:pt idx="348">
                  <c:v>1298.731</c:v>
                </c:pt>
                <c:pt idx="349">
                  <c:v>1307.5060000000001</c:v>
                </c:pt>
                <c:pt idx="350">
                  <c:v>1316.2809999999999</c:v>
                </c:pt>
                <c:pt idx="351">
                  <c:v>1325.056</c:v>
                </c:pt>
                <c:pt idx="352">
                  <c:v>1333.8309999999999</c:v>
                </c:pt>
                <c:pt idx="353">
                  <c:v>1342.607</c:v>
                </c:pt>
                <c:pt idx="354">
                  <c:v>1351.3820000000001</c:v>
                </c:pt>
                <c:pt idx="355">
                  <c:v>1360.1569999999999</c:v>
                </c:pt>
                <c:pt idx="356">
                  <c:v>1368.932</c:v>
                </c:pt>
                <c:pt idx="357">
                  <c:v>1377.7070000000001</c:v>
                </c:pt>
                <c:pt idx="358">
                  <c:v>1386.4829999999999</c:v>
                </c:pt>
                <c:pt idx="359">
                  <c:v>1395.258</c:v>
                </c:pt>
                <c:pt idx="360">
                  <c:v>1404.0329999999999</c:v>
                </c:pt>
                <c:pt idx="361">
                  <c:v>1412.808</c:v>
                </c:pt>
                <c:pt idx="362">
                  <c:v>1421.5830000000001</c:v>
                </c:pt>
                <c:pt idx="363">
                  <c:v>1430.3589999999999</c:v>
                </c:pt>
                <c:pt idx="364">
                  <c:v>1439.134</c:v>
                </c:pt>
                <c:pt idx="365">
                  <c:v>1447.9090000000001</c:v>
                </c:pt>
                <c:pt idx="366">
                  <c:v>1456.684</c:v>
                </c:pt>
                <c:pt idx="367">
                  <c:v>1465.4590000000001</c:v>
                </c:pt>
                <c:pt idx="368">
                  <c:v>1474.2349999999999</c:v>
                </c:pt>
                <c:pt idx="369">
                  <c:v>1483.01</c:v>
                </c:pt>
                <c:pt idx="370">
                  <c:v>1491.7850000000001</c:v>
                </c:pt>
                <c:pt idx="371">
                  <c:v>1500.56</c:v>
                </c:pt>
                <c:pt idx="372">
                  <c:v>1509.335</c:v>
                </c:pt>
                <c:pt idx="373">
                  <c:v>1518.1110000000001</c:v>
                </c:pt>
                <c:pt idx="374">
                  <c:v>1526.886</c:v>
                </c:pt>
                <c:pt idx="375">
                  <c:v>1535.6610000000001</c:v>
                </c:pt>
                <c:pt idx="376">
                  <c:v>1544.4359999999999</c:v>
                </c:pt>
                <c:pt idx="377">
                  <c:v>1553.212</c:v>
                </c:pt>
                <c:pt idx="378">
                  <c:v>1561.9870000000001</c:v>
                </c:pt>
                <c:pt idx="379">
                  <c:v>1570.7619999999999</c:v>
                </c:pt>
                <c:pt idx="380">
                  <c:v>1579.537</c:v>
                </c:pt>
                <c:pt idx="381">
                  <c:v>1588.3119999999999</c:v>
                </c:pt>
                <c:pt idx="382">
                  <c:v>1597.088</c:v>
                </c:pt>
                <c:pt idx="383">
                  <c:v>1605.8630000000001</c:v>
                </c:pt>
                <c:pt idx="384">
                  <c:v>1614.6379999999999</c:v>
                </c:pt>
                <c:pt idx="385">
                  <c:v>1623.413</c:v>
                </c:pt>
                <c:pt idx="386">
                  <c:v>1632.1880000000001</c:v>
                </c:pt>
                <c:pt idx="387">
                  <c:v>1640.9639999999999</c:v>
                </c:pt>
                <c:pt idx="388">
                  <c:v>1649.739</c:v>
                </c:pt>
                <c:pt idx="389">
                  <c:v>1658.5139999999999</c:v>
                </c:pt>
                <c:pt idx="390">
                  <c:v>1667.289</c:v>
                </c:pt>
                <c:pt idx="391">
                  <c:v>1676.0640000000001</c:v>
                </c:pt>
                <c:pt idx="392">
                  <c:v>1684.84</c:v>
                </c:pt>
                <c:pt idx="393">
                  <c:v>1693.615</c:v>
                </c:pt>
                <c:pt idx="394">
                  <c:v>1702.39</c:v>
                </c:pt>
                <c:pt idx="395">
                  <c:v>1711.165</c:v>
                </c:pt>
                <c:pt idx="396">
                  <c:v>1719.94</c:v>
                </c:pt>
                <c:pt idx="397">
                  <c:v>1728.7159999999999</c:v>
                </c:pt>
                <c:pt idx="398">
                  <c:v>1737.491</c:v>
                </c:pt>
                <c:pt idx="399">
                  <c:v>1746.2660000000001</c:v>
                </c:pt>
                <c:pt idx="400">
                  <c:v>1755.0409999999999</c:v>
                </c:pt>
                <c:pt idx="401">
                  <c:v>1755.0409999999999</c:v>
                </c:pt>
              </c:numCache>
            </c:numRef>
          </c:xVal>
          <c:yVal>
            <c:numRef>
              <c:f>Foglio6!$H$424:$H$82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</c:v>
                </c:pt>
                <c:pt idx="166">
                  <c:v>17.5</c:v>
                </c:pt>
                <c:pt idx="167">
                  <c:v>17</c:v>
                </c:pt>
                <c:pt idx="168">
                  <c:v>16.5</c:v>
                </c:pt>
                <c:pt idx="169">
                  <c:v>16</c:v>
                </c:pt>
                <c:pt idx="170">
                  <c:v>15.5</c:v>
                </c:pt>
                <c:pt idx="171">
                  <c:v>15</c:v>
                </c:pt>
                <c:pt idx="172">
                  <c:v>14.654999999999999</c:v>
                </c:pt>
                <c:pt idx="173">
                  <c:v>14.5</c:v>
                </c:pt>
                <c:pt idx="174">
                  <c:v>14</c:v>
                </c:pt>
                <c:pt idx="175">
                  <c:v>13.5</c:v>
                </c:pt>
                <c:pt idx="176">
                  <c:v>13</c:v>
                </c:pt>
                <c:pt idx="177">
                  <c:v>12.5</c:v>
                </c:pt>
                <c:pt idx="178">
                  <c:v>12</c:v>
                </c:pt>
                <c:pt idx="179">
                  <c:v>11.734</c:v>
                </c:pt>
                <c:pt idx="180">
                  <c:v>11.5</c:v>
                </c:pt>
                <c:pt idx="181">
                  <c:v>11</c:v>
                </c:pt>
                <c:pt idx="182">
                  <c:v>10.5</c:v>
                </c:pt>
                <c:pt idx="183">
                  <c:v>10.223000000000001</c:v>
                </c:pt>
                <c:pt idx="184">
                  <c:v>10</c:v>
                </c:pt>
                <c:pt idx="185">
                  <c:v>9.5</c:v>
                </c:pt>
                <c:pt idx="186">
                  <c:v>9.2210000000000001</c:v>
                </c:pt>
                <c:pt idx="187">
                  <c:v>9</c:v>
                </c:pt>
                <c:pt idx="188">
                  <c:v>8.5050000000000008</c:v>
                </c:pt>
                <c:pt idx="189">
                  <c:v>8.5</c:v>
                </c:pt>
                <c:pt idx="190">
                  <c:v>8</c:v>
                </c:pt>
                <c:pt idx="191">
                  <c:v>7.9279999999999999</c:v>
                </c:pt>
                <c:pt idx="192">
                  <c:v>7.5</c:v>
                </c:pt>
                <c:pt idx="193">
                  <c:v>7.4710000000000001</c:v>
                </c:pt>
                <c:pt idx="194">
                  <c:v>7.08</c:v>
                </c:pt>
                <c:pt idx="195">
                  <c:v>7</c:v>
                </c:pt>
                <c:pt idx="196">
                  <c:v>6.7119999999999997</c:v>
                </c:pt>
                <c:pt idx="197">
                  <c:v>6.5</c:v>
                </c:pt>
                <c:pt idx="198">
                  <c:v>6.423</c:v>
                </c:pt>
                <c:pt idx="199">
                  <c:v>6.1740000000000004</c:v>
                </c:pt>
                <c:pt idx="200">
                  <c:v>6</c:v>
                </c:pt>
                <c:pt idx="201">
                  <c:v>5.9249999999999998</c:v>
                </c:pt>
                <c:pt idx="202">
                  <c:v>5.7160000000000002</c:v>
                </c:pt>
                <c:pt idx="203">
                  <c:v>5.5090000000000003</c:v>
                </c:pt>
                <c:pt idx="204">
                  <c:v>5.5</c:v>
                </c:pt>
                <c:pt idx="205">
                  <c:v>5.3239999999999998</c:v>
                </c:pt>
                <c:pt idx="206">
                  <c:v>5.1539999999999999</c:v>
                </c:pt>
                <c:pt idx="207">
                  <c:v>5</c:v>
                </c:pt>
                <c:pt idx="208">
                  <c:v>4.9930000000000003</c:v>
                </c:pt>
                <c:pt idx="209">
                  <c:v>4.8339999999999996</c:v>
                </c:pt>
                <c:pt idx="210">
                  <c:v>4.7069999999999999</c:v>
                </c:pt>
                <c:pt idx="211">
                  <c:v>4.5789999999999997</c:v>
                </c:pt>
                <c:pt idx="212">
                  <c:v>4.5</c:v>
                </c:pt>
                <c:pt idx="213">
                  <c:v>4.4409999999999998</c:v>
                </c:pt>
                <c:pt idx="214">
                  <c:v>4.3209999999999997</c:v>
                </c:pt>
                <c:pt idx="215">
                  <c:v>4.2130000000000001</c:v>
                </c:pt>
                <c:pt idx="216">
                  <c:v>4.1079999999999997</c:v>
                </c:pt>
                <c:pt idx="217">
                  <c:v>4.0129999999999999</c:v>
                </c:pt>
                <c:pt idx="218">
                  <c:v>4</c:v>
                </c:pt>
                <c:pt idx="219">
                  <c:v>3.915</c:v>
                </c:pt>
                <c:pt idx="220">
                  <c:v>3.823</c:v>
                </c:pt>
                <c:pt idx="221">
                  <c:v>3.7290000000000001</c:v>
                </c:pt>
                <c:pt idx="222">
                  <c:v>3.6379999999999999</c:v>
                </c:pt>
                <c:pt idx="223">
                  <c:v>3.5529999999999999</c:v>
                </c:pt>
                <c:pt idx="224">
                  <c:v>3.5</c:v>
                </c:pt>
                <c:pt idx="225">
                  <c:v>3.4849999999999999</c:v>
                </c:pt>
                <c:pt idx="226">
                  <c:v>3.4089999999999998</c:v>
                </c:pt>
                <c:pt idx="227">
                  <c:v>3.3460000000000001</c:v>
                </c:pt>
                <c:pt idx="228">
                  <c:v>3.2759999999999998</c:v>
                </c:pt>
                <c:pt idx="229">
                  <c:v>3.1970000000000001</c:v>
                </c:pt>
                <c:pt idx="230">
                  <c:v>3.1320000000000001</c:v>
                </c:pt>
                <c:pt idx="231">
                  <c:v>3.0739999999999998</c:v>
                </c:pt>
                <c:pt idx="232">
                  <c:v>3.0110000000000001</c:v>
                </c:pt>
                <c:pt idx="233">
                  <c:v>3</c:v>
                </c:pt>
                <c:pt idx="234">
                  <c:v>2.95</c:v>
                </c:pt>
                <c:pt idx="235">
                  <c:v>2.8849999999999998</c:v>
                </c:pt>
                <c:pt idx="236">
                  <c:v>2.83</c:v>
                </c:pt>
                <c:pt idx="237">
                  <c:v>2.7759999999999998</c:v>
                </c:pt>
                <c:pt idx="238">
                  <c:v>2.7229999999999999</c:v>
                </c:pt>
                <c:pt idx="239">
                  <c:v>2.6720000000000002</c:v>
                </c:pt>
                <c:pt idx="240">
                  <c:v>2.6150000000000002</c:v>
                </c:pt>
                <c:pt idx="241">
                  <c:v>2.5680000000000001</c:v>
                </c:pt>
                <c:pt idx="242">
                  <c:v>2.5270000000000001</c:v>
                </c:pt>
                <c:pt idx="243">
                  <c:v>2.5</c:v>
                </c:pt>
                <c:pt idx="244">
                  <c:v>2.4790000000000001</c:v>
                </c:pt>
                <c:pt idx="245">
                  <c:v>2.4329999999999998</c:v>
                </c:pt>
                <c:pt idx="246">
                  <c:v>2.387</c:v>
                </c:pt>
                <c:pt idx="247">
                  <c:v>2.3460000000000001</c:v>
                </c:pt>
                <c:pt idx="248">
                  <c:v>2.3029999999999999</c:v>
                </c:pt>
                <c:pt idx="249">
                  <c:v>2.2589999999999999</c:v>
                </c:pt>
                <c:pt idx="250">
                  <c:v>2.2189999999999999</c:v>
                </c:pt>
                <c:pt idx="251">
                  <c:v>2.177</c:v>
                </c:pt>
                <c:pt idx="252">
                  <c:v>2.13</c:v>
                </c:pt>
                <c:pt idx="253">
                  <c:v>2.0910000000000002</c:v>
                </c:pt>
                <c:pt idx="254">
                  <c:v>2.0590000000000002</c:v>
                </c:pt>
                <c:pt idx="255">
                  <c:v>2.0209999999999999</c:v>
                </c:pt>
                <c:pt idx="256">
                  <c:v>2</c:v>
                </c:pt>
                <c:pt idx="257">
                  <c:v>1.9910000000000001</c:v>
                </c:pt>
                <c:pt idx="258">
                  <c:v>1.954</c:v>
                </c:pt>
                <c:pt idx="259">
                  <c:v>1.92</c:v>
                </c:pt>
                <c:pt idx="260">
                  <c:v>1.8879999999999999</c:v>
                </c:pt>
                <c:pt idx="261">
                  <c:v>1.859</c:v>
                </c:pt>
                <c:pt idx="262">
                  <c:v>1.827</c:v>
                </c:pt>
                <c:pt idx="263">
                  <c:v>1.7929999999999999</c:v>
                </c:pt>
                <c:pt idx="264">
                  <c:v>1.7589999999999999</c:v>
                </c:pt>
                <c:pt idx="265">
                  <c:v>1.7270000000000001</c:v>
                </c:pt>
                <c:pt idx="266">
                  <c:v>1.69</c:v>
                </c:pt>
                <c:pt idx="267">
                  <c:v>1.6619999999999999</c:v>
                </c:pt>
                <c:pt idx="268">
                  <c:v>1.637</c:v>
                </c:pt>
                <c:pt idx="269">
                  <c:v>1.61</c:v>
                </c:pt>
                <c:pt idx="270">
                  <c:v>1.58</c:v>
                </c:pt>
                <c:pt idx="271">
                  <c:v>1.5509999999999999</c:v>
                </c:pt>
                <c:pt idx="272">
                  <c:v>1.524</c:v>
                </c:pt>
                <c:pt idx="273">
                  <c:v>1.5</c:v>
                </c:pt>
                <c:pt idx="274">
                  <c:v>1.5</c:v>
                </c:pt>
                <c:pt idx="275">
                  <c:v>1.476</c:v>
                </c:pt>
                <c:pt idx="276">
                  <c:v>1.454</c:v>
                </c:pt>
                <c:pt idx="277">
                  <c:v>1.431</c:v>
                </c:pt>
                <c:pt idx="278">
                  <c:v>1.4079999999999999</c:v>
                </c:pt>
                <c:pt idx="279">
                  <c:v>1.381</c:v>
                </c:pt>
                <c:pt idx="280">
                  <c:v>1.353</c:v>
                </c:pt>
                <c:pt idx="281">
                  <c:v>1.33</c:v>
                </c:pt>
                <c:pt idx="282">
                  <c:v>1.302</c:v>
                </c:pt>
                <c:pt idx="283">
                  <c:v>1.2749999999999999</c:v>
                </c:pt>
                <c:pt idx="284">
                  <c:v>1.25</c:v>
                </c:pt>
                <c:pt idx="285">
                  <c:v>1.228</c:v>
                </c:pt>
                <c:pt idx="286">
                  <c:v>1.208</c:v>
                </c:pt>
                <c:pt idx="287">
                  <c:v>1.1890000000000001</c:v>
                </c:pt>
                <c:pt idx="288">
                  <c:v>1.1619999999999999</c:v>
                </c:pt>
                <c:pt idx="289">
                  <c:v>1.141</c:v>
                </c:pt>
                <c:pt idx="290">
                  <c:v>1.127</c:v>
                </c:pt>
                <c:pt idx="291">
                  <c:v>1.1020000000000001</c:v>
                </c:pt>
                <c:pt idx="292">
                  <c:v>1.089</c:v>
                </c:pt>
                <c:pt idx="293">
                  <c:v>1.0740000000000001</c:v>
                </c:pt>
                <c:pt idx="294">
                  <c:v>1.0580000000000001</c:v>
                </c:pt>
                <c:pt idx="295">
                  <c:v>1.0389999999999999</c:v>
                </c:pt>
                <c:pt idx="296">
                  <c:v>1.024</c:v>
                </c:pt>
                <c:pt idx="297">
                  <c:v>1</c:v>
                </c:pt>
                <c:pt idx="298">
                  <c:v>0.999</c:v>
                </c:pt>
                <c:pt idx="299">
                  <c:v>0.98</c:v>
                </c:pt>
                <c:pt idx="300">
                  <c:v>0.95599999999999996</c:v>
                </c:pt>
                <c:pt idx="301">
                  <c:v>0.94199999999999995</c:v>
                </c:pt>
                <c:pt idx="302">
                  <c:v>0.91900000000000004</c:v>
                </c:pt>
                <c:pt idx="303">
                  <c:v>0.90100000000000002</c:v>
                </c:pt>
                <c:pt idx="304">
                  <c:v>0.88600000000000001</c:v>
                </c:pt>
                <c:pt idx="305">
                  <c:v>0.86799999999999999</c:v>
                </c:pt>
                <c:pt idx="306">
                  <c:v>0.85199999999999998</c:v>
                </c:pt>
                <c:pt idx="307">
                  <c:v>0.83</c:v>
                </c:pt>
                <c:pt idx="308">
                  <c:v>0.81399999999999995</c:v>
                </c:pt>
                <c:pt idx="309">
                  <c:v>0.79900000000000004</c:v>
                </c:pt>
                <c:pt idx="310">
                  <c:v>0.78600000000000003</c:v>
                </c:pt>
                <c:pt idx="311">
                  <c:v>0.77200000000000002</c:v>
                </c:pt>
                <c:pt idx="312">
                  <c:v>0.75700000000000001</c:v>
                </c:pt>
                <c:pt idx="313">
                  <c:v>0.74299999999999999</c:v>
                </c:pt>
                <c:pt idx="314">
                  <c:v>0.72899999999999998</c:v>
                </c:pt>
                <c:pt idx="315">
                  <c:v>0.71299999999999997</c:v>
                </c:pt>
                <c:pt idx="316">
                  <c:v>0.69499999999999995</c:v>
                </c:pt>
                <c:pt idx="317">
                  <c:v>0.68400000000000005</c:v>
                </c:pt>
                <c:pt idx="318">
                  <c:v>0.66800000000000004</c:v>
                </c:pt>
                <c:pt idx="319">
                  <c:v>0.65500000000000003</c:v>
                </c:pt>
                <c:pt idx="320">
                  <c:v>0.64300000000000002</c:v>
                </c:pt>
                <c:pt idx="321">
                  <c:v>0.627</c:v>
                </c:pt>
                <c:pt idx="322">
                  <c:v>0.60899999999999999</c:v>
                </c:pt>
                <c:pt idx="323">
                  <c:v>0.6</c:v>
                </c:pt>
                <c:pt idx="324">
                  <c:v>0.58599999999999997</c:v>
                </c:pt>
                <c:pt idx="325">
                  <c:v>0.56899999999999995</c:v>
                </c:pt>
                <c:pt idx="326">
                  <c:v>0.55400000000000005</c:v>
                </c:pt>
                <c:pt idx="327">
                  <c:v>0.53800000000000003</c:v>
                </c:pt>
                <c:pt idx="328">
                  <c:v>0.52800000000000002</c:v>
                </c:pt>
                <c:pt idx="329">
                  <c:v>0.52100000000000002</c:v>
                </c:pt>
                <c:pt idx="330">
                  <c:v>0.51</c:v>
                </c:pt>
                <c:pt idx="331">
                  <c:v>0.5</c:v>
                </c:pt>
                <c:pt idx="332">
                  <c:v>0.49299999999999999</c:v>
                </c:pt>
                <c:pt idx="333">
                  <c:v>0.48399999999999999</c:v>
                </c:pt>
                <c:pt idx="334">
                  <c:v>0.47</c:v>
                </c:pt>
                <c:pt idx="335">
                  <c:v>0.45700000000000002</c:v>
                </c:pt>
                <c:pt idx="336">
                  <c:v>0.44500000000000001</c:v>
                </c:pt>
                <c:pt idx="337">
                  <c:v>0.432</c:v>
                </c:pt>
                <c:pt idx="338">
                  <c:v>0.42299999999999999</c:v>
                </c:pt>
                <c:pt idx="339">
                  <c:v>0.41299999999999998</c:v>
                </c:pt>
                <c:pt idx="340">
                  <c:v>0.40699999999999997</c:v>
                </c:pt>
                <c:pt idx="341">
                  <c:v>0.39500000000000002</c:v>
                </c:pt>
                <c:pt idx="342">
                  <c:v>0.38300000000000001</c:v>
                </c:pt>
                <c:pt idx="343">
                  <c:v>0.36599999999999999</c:v>
                </c:pt>
                <c:pt idx="344">
                  <c:v>0.35499999999999998</c:v>
                </c:pt>
                <c:pt idx="345">
                  <c:v>0.34399999999999997</c:v>
                </c:pt>
                <c:pt idx="346">
                  <c:v>0.33100000000000002</c:v>
                </c:pt>
                <c:pt idx="347">
                  <c:v>0.32</c:v>
                </c:pt>
                <c:pt idx="348">
                  <c:v>0.31</c:v>
                </c:pt>
                <c:pt idx="349">
                  <c:v>0.30399999999999999</c:v>
                </c:pt>
                <c:pt idx="350">
                  <c:v>0.29299999999999998</c:v>
                </c:pt>
                <c:pt idx="351">
                  <c:v>0.28000000000000003</c:v>
                </c:pt>
                <c:pt idx="352">
                  <c:v>0.26600000000000001</c:v>
                </c:pt>
                <c:pt idx="353">
                  <c:v>0.25900000000000001</c:v>
                </c:pt>
                <c:pt idx="354">
                  <c:v>0.25</c:v>
                </c:pt>
                <c:pt idx="355">
                  <c:v>0.23899999999999999</c:v>
                </c:pt>
                <c:pt idx="356">
                  <c:v>0.23100000000000001</c:v>
                </c:pt>
                <c:pt idx="357">
                  <c:v>0.224</c:v>
                </c:pt>
                <c:pt idx="358">
                  <c:v>0.21299999999999999</c:v>
                </c:pt>
                <c:pt idx="359">
                  <c:v>0.20899999999999999</c:v>
                </c:pt>
                <c:pt idx="360">
                  <c:v>0.19900000000000001</c:v>
                </c:pt>
                <c:pt idx="361">
                  <c:v>0.191</c:v>
                </c:pt>
                <c:pt idx="362">
                  <c:v>0.17699999999999999</c:v>
                </c:pt>
                <c:pt idx="363">
                  <c:v>0.16700000000000001</c:v>
                </c:pt>
                <c:pt idx="364">
                  <c:v>0.158</c:v>
                </c:pt>
                <c:pt idx="365">
                  <c:v>0.14799999999999999</c:v>
                </c:pt>
                <c:pt idx="366">
                  <c:v>0.13800000000000001</c:v>
                </c:pt>
                <c:pt idx="367">
                  <c:v>0.13200000000000001</c:v>
                </c:pt>
                <c:pt idx="368">
                  <c:v>0.127</c:v>
                </c:pt>
                <c:pt idx="369">
                  <c:v>0.11899999999999999</c:v>
                </c:pt>
                <c:pt idx="370">
                  <c:v>0.111</c:v>
                </c:pt>
                <c:pt idx="371">
                  <c:v>0.104</c:v>
                </c:pt>
                <c:pt idx="372">
                  <c:v>9.7000000000000003E-2</c:v>
                </c:pt>
                <c:pt idx="373">
                  <c:v>8.7999999999999995E-2</c:v>
                </c:pt>
                <c:pt idx="374">
                  <c:v>8.1000000000000003E-2</c:v>
                </c:pt>
                <c:pt idx="375">
                  <c:v>7.4999999999999997E-2</c:v>
                </c:pt>
                <c:pt idx="376">
                  <c:v>6.4000000000000001E-2</c:v>
                </c:pt>
                <c:pt idx="377">
                  <c:v>5.7000000000000002E-2</c:v>
                </c:pt>
                <c:pt idx="378">
                  <c:v>5.2999999999999999E-2</c:v>
                </c:pt>
                <c:pt idx="379">
                  <c:v>4.8000000000000001E-2</c:v>
                </c:pt>
                <c:pt idx="380">
                  <c:v>4.2999999999999997E-2</c:v>
                </c:pt>
                <c:pt idx="381">
                  <c:v>3.6999999999999998E-2</c:v>
                </c:pt>
                <c:pt idx="382">
                  <c:v>3.3000000000000002E-2</c:v>
                </c:pt>
                <c:pt idx="383">
                  <c:v>2.8000000000000001E-2</c:v>
                </c:pt>
                <c:pt idx="384">
                  <c:v>2.4E-2</c:v>
                </c:pt>
                <c:pt idx="385">
                  <c:v>1.9E-2</c:v>
                </c:pt>
                <c:pt idx="386">
                  <c:v>1.4999999999999999E-2</c:v>
                </c:pt>
                <c:pt idx="387">
                  <c:v>0.01</c:v>
                </c:pt>
                <c:pt idx="388">
                  <c:v>7.0000000000000001E-3</c:v>
                </c:pt>
                <c:pt idx="389">
                  <c:v>5.0000000000000001E-3</c:v>
                </c:pt>
                <c:pt idx="390">
                  <c:v>3.0000000000000001E-3</c:v>
                </c:pt>
                <c:pt idx="391">
                  <c:v>2E-3</c:v>
                </c:pt>
                <c:pt idx="392">
                  <c:v>1E-3</c:v>
                </c:pt>
                <c:pt idx="393">
                  <c:v>1E-3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C237-45B1-A7AA-312291C87353}"/>
            </c:ext>
          </c:extLst>
        </c:ser>
        <c:ser>
          <c:idx val="2"/>
          <c:order val="4"/>
          <c:tx>
            <c:strRef>
              <c:f>Foglio6!$I$1</c:f>
              <c:strCache>
                <c:ptCount val="1"/>
                <c:pt idx="0">
                  <c:v>S0,5M8</c:v>
                </c:pt>
              </c:strCache>
            </c:strRef>
          </c:tx>
          <c:spPr>
            <a:ln w="19050" cap="rnd">
              <a:solidFill>
                <a:schemeClr val="accent6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401"/>
              <c:dLblPos val="r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C237-45B1-A7AA-312291C8735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Foglio6!$I$424:$I$82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1.9E-2</c:v>
                </c:pt>
                <c:pt idx="73">
                  <c:v>0.04</c:v>
                </c:pt>
                <c:pt idx="74">
                  <c:v>6.0999999999999999E-2</c:v>
                </c:pt>
                <c:pt idx="75">
                  <c:v>8.2000000000000003E-2</c:v>
                </c:pt>
                <c:pt idx="76">
                  <c:v>0.10299999999999999</c:v>
                </c:pt>
                <c:pt idx="77">
                  <c:v>0.124</c:v>
                </c:pt>
                <c:pt idx="78">
                  <c:v>0.14499999999999999</c:v>
                </c:pt>
                <c:pt idx="79">
                  <c:v>0.16600000000000001</c:v>
                </c:pt>
                <c:pt idx="80">
                  <c:v>0.187</c:v>
                </c:pt>
                <c:pt idx="81">
                  <c:v>0.20799999999999999</c:v>
                </c:pt>
                <c:pt idx="82">
                  <c:v>0.22900000000000001</c:v>
                </c:pt>
                <c:pt idx="83">
                  <c:v>0.25</c:v>
                </c:pt>
                <c:pt idx="84">
                  <c:v>0.27100000000000002</c:v>
                </c:pt>
                <c:pt idx="85">
                  <c:v>0.29199999999999998</c:v>
                </c:pt>
                <c:pt idx="86">
                  <c:v>0.313</c:v>
                </c:pt>
                <c:pt idx="87">
                  <c:v>0.33400000000000002</c:v>
                </c:pt>
                <c:pt idx="88">
                  <c:v>0.35499999999999998</c:v>
                </c:pt>
                <c:pt idx="89">
                  <c:v>0.376</c:v>
                </c:pt>
                <c:pt idx="90">
                  <c:v>0.39700000000000002</c:v>
                </c:pt>
                <c:pt idx="91">
                  <c:v>0.41799999999999998</c:v>
                </c:pt>
                <c:pt idx="92">
                  <c:v>0.439</c:v>
                </c:pt>
                <c:pt idx="93">
                  <c:v>0.46</c:v>
                </c:pt>
                <c:pt idx="94">
                  <c:v>0.48099999999999998</c:v>
                </c:pt>
                <c:pt idx="95">
                  <c:v>0.502</c:v>
                </c:pt>
                <c:pt idx="96">
                  <c:v>0.52300000000000002</c:v>
                </c:pt>
                <c:pt idx="97">
                  <c:v>0.54400000000000004</c:v>
                </c:pt>
                <c:pt idx="98">
                  <c:v>0.56499999999999995</c:v>
                </c:pt>
                <c:pt idx="99">
                  <c:v>0.58599999999999997</c:v>
                </c:pt>
                <c:pt idx="100">
                  <c:v>0.60699999999999998</c:v>
                </c:pt>
                <c:pt idx="101">
                  <c:v>0.628</c:v>
                </c:pt>
                <c:pt idx="102">
                  <c:v>0.64900000000000002</c:v>
                </c:pt>
                <c:pt idx="103">
                  <c:v>0.67</c:v>
                </c:pt>
                <c:pt idx="104">
                  <c:v>0.69099999999999995</c:v>
                </c:pt>
                <c:pt idx="105">
                  <c:v>0.71199999999999997</c:v>
                </c:pt>
                <c:pt idx="106">
                  <c:v>0.73299999999999998</c:v>
                </c:pt>
                <c:pt idx="107">
                  <c:v>0.754</c:v>
                </c:pt>
                <c:pt idx="108">
                  <c:v>0.77500000000000002</c:v>
                </c:pt>
                <c:pt idx="109">
                  <c:v>0.79600000000000004</c:v>
                </c:pt>
                <c:pt idx="110">
                  <c:v>0.81699999999999995</c:v>
                </c:pt>
                <c:pt idx="111">
                  <c:v>0.83799999999999997</c:v>
                </c:pt>
                <c:pt idx="112">
                  <c:v>0.85899999999999999</c:v>
                </c:pt>
                <c:pt idx="113">
                  <c:v>0.88</c:v>
                </c:pt>
                <c:pt idx="114">
                  <c:v>0.90100000000000002</c:v>
                </c:pt>
                <c:pt idx="115">
                  <c:v>0.92200000000000004</c:v>
                </c:pt>
                <c:pt idx="116">
                  <c:v>0.94299999999999995</c:v>
                </c:pt>
                <c:pt idx="117">
                  <c:v>0.96399999999999997</c:v>
                </c:pt>
                <c:pt idx="118">
                  <c:v>0.98499999999999999</c:v>
                </c:pt>
                <c:pt idx="119">
                  <c:v>1.006</c:v>
                </c:pt>
                <c:pt idx="120">
                  <c:v>1.0269999999999999</c:v>
                </c:pt>
                <c:pt idx="121">
                  <c:v>1.048</c:v>
                </c:pt>
                <c:pt idx="122">
                  <c:v>1.069</c:v>
                </c:pt>
                <c:pt idx="123">
                  <c:v>1.0900000000000001</c:v>
                </c:pt>
                <c:pt idx="124">
                  <c:v>1.111</c:v>
                </c:pt>
                <c:pt idx="125">
                  <c:v>1.1319999999999999</c:v>
                </c:pt>
                <c:pt idx="126">
                  <c:v>1.153</c:v>
                </c:pt>
                <c:pt idx="127">
                  <c:v>1.1739999999999999</c:v>
                </c:pt>
                <c:pt idx="128">
                  <c:v>1.1950000000000001</c:v>
                </c:pt>
                <c:pt idx="129">
                  <c:v>1.216</c:v>
                </c:pt>
                <c:pt idx="130">
                  <c:v>1.2370000000000001</c:v>
                </c:pt>
                <c:pt idx="131">
                  <c:v>1.258</c:v>
                </c:pt>
                <c:pt idx="132">
                  <c:v>1.2789999999999999</c:v>
                </c:pt>
                <c:pt idx="133">
                  <c:v>1.3</c:v>
                </c:pt>
                <c:pt idx="134">
                  <c:v>1.321</c:v>
                </c:pt>
                <c:pt idx="135">
                  <c:v>1.3420000000000001</c:v>
                </c:pt>
                <c:pt idx="136">
                  <c:v>1.363</c:v>
                </c:pt>
                <c:pt idx="137">
                  <c:v>1.3839999999999999</c:v>
                </c:pt>
                <c:pt idx="138">
                  <c:v>1.405</c:v>
                </c:pt>
                <c:pt idx="139">
                  <c:v>1.4259999999999999</c:v>
                </c:pt>
                <c:pt idx="140">
                  <c:v>1.4470000000000001</c:v>
                </c:pt>
                <c:pt idx="141">
                  <c:v>1.468</c:v>
                </c:pt>
                <c:pt idx="142">
                  <c:v>1.488</c:v>
                </c:pt>
                <c:pt idx="143">
                  <c:v>1.5089999999999999</c:v>
                </c:pt>
                <c:pt idx="144">
                  <c:v>1.53</c:v>
                </c:pt>
                <c:pt idx="145">
                  <c:v>1.5509999999999999</c:v>
                </c:pt>
                <c:pt idx="146">
                  <c:v>1.5720000000000001</c:v>
                </c:pt>
                <c:pt idx="147">
                  <c:v>1.593</c:v>
                </c:pt>
                <c:pt idx="148">
                  <c:v>1.7190000000000001</c:v>
                </c:pt>
                <c:pt idx="149">
                  <c:v>1.89</c:v>
                </c:pt>
                <c:pt idx="150">
                  <c:v>2.0619999999999998</c:v>
                </c:pt>
                <c:pt idx="151">
                  <c:v>2.234</c:v>
                </c:pt>
                <c:pt idx="152">
                  <c:v>2.4060000000000001</c:v>
                </c:pt>
                <c:pt idx="153">
                  <c:v>2.577</c:v>
                </c:pt>
                <c:pt idx="154">
                  <c:v>2.7490000000000001</c:v>
                </c:pt>
                <c:pt idx="155">
                  <c:v>2.9209999999999998</c:v>
                </c:pt>
                <c:pt idx="156">
                  <c:v>3.0920000000000001</c:v>
                </c:pt>
                <c:pt idx="157">
                  <c:v>3.3210000000000002</c:v>
                </c:pt>
                <c:pt idx="158">
                  <c:v>3.645</c:v>
                </c:pt>
                <c:pt idx="159">
                  <c:v>3.97</c:v>
                </c:pt>
                <c:pt idx="160">
                  <c:v>4.2939999999999996</c:v>
                </c:pt>
                <c:pt idx="161">
                  <c:v>4.6189999999999998</c:v>
                </c:pt>
                <c:pt idx="162">
                  <c:v>5.0359999999999996</c:v>
                </c:pt>
                <c:pt idx="163">
                  <c:v>5.5709999999999997</c:v>
                </c:pt>
                <c:pt idx="164">
                  <c:v>6.1059999999999999</c:v>
                </c:pt>
                <c:pt idx="165">
                  <c:v>6.74</c:v>
                </c:pt>
                <c:pt idx="166">
                  <c:v>7.4950000000000001</c:v>
                </c:pt>
                <c:pt idx="167">
                  <c:v>8</c:v>
                </c:pt>
                <c:pt idx="168">
                  <c:v>8.3290000000000006</c:v>
                </c:pt>
                <c:pt idx="169">
                  <c:v>9.3179999999999996</c:v>
                </c:pt>
                <c:pt idx="170">
                  <c:v>10.471</c:v>
                </c:pt>
                <c:pt idx="171">
                  <c:v>11.789</c:v>
                </c:pt>
                <c:pt idx="172">
                  <c:v>13.31</c:v>
                </c:pt>
                <c:pt idx="173">
                  <c:v>15.010999999999999</c:v>
                </c:pt>
                <c:pt idx="174">
                  <c:v>15.999000000000001</c:v>
                </c:pt>
                <c:pt idx="175">
                  <c:v>16.908000000000001</c:v>
                </c:pt>
                <c:pt idx="176">
                  <c:v>19.039000000000001</c:v>
                </c:pt>
                <c:pt idx="177">
                  <c:v>21.484999999999999</c:v>
                </c:pt>
                <c:pt idx="178">
                  <c:v>23.998999999999999</c:v>
                </c:pt>
                <c:pt idx="179">
                  <c:v>24.167999999999999</c:v>
                </c:pt>
                <c:pt idx="180">
                  <c:v>27.428000000000001</c:v>
                </c:pt>
                <c:pt idx="181">
                  <c:v>31.228000000000002</c:v>
                </c:pt>
                <c:pt idx="182">
                  <c:v>31.998000000000001</c:v>
                </c:pt>
                <c:pt idx="183">
                  <c:v>35.808999999999997</c:v>
                </c:pt>
                <c:pt idx="184">
                  <c:v>39.997999999999998</c:v>
                </c:pt>
                <c:pt idx="185">
                  <c:v>40.942999999999998</c:v>
                </c:pt>
                <c:pt idx="186">
                  <c:v>46.945</c:v>
                </c:pt>
                <c:pt idx="187">
                  <c:v>47.997</c:v>
                </c:pt>
                <c:pt idx="188">
                  <c:v>54.271999999999998</c:v>
                </c:pt>
                <c:pt idx="189">
                  <c:v>55.997</c:v>
                </c:pt>
                <c:pt idx="190">
                  <c:v>62.692999999999998</c:v>
                </c:pt>
                <c:pt idx="191">
                  <c:v>63.996000000000002</c:v>
                </c:pt>
                <c:pt idx="192">
                  <c:v>71.995999999999995</c:v>
                </c:pt>
                <c:pt idx="193">
                  <c:v>72.938000000000002</c:v>
                </c:pt>
                <c:pt idx="194">
                  <c:v>79.995000000000005</c:v>
                </c:pt>
                <c:pt idx="195">
                  <c:v>84.84</c:v>
                </c:pt>
                <c:pt idx="196">
                  <c:v>87.995000000000005</c:v>
                </c:pt>
                <c:pt idx="197">
                  <c:v>95.994</c:v>
                </c:pt>
                <c:pt idx="198">
                  <c:v>99.585999999999999</c:v>
                </c:pt>
                <c:pt idx="199">
                  <c:v>103.994</c:v>
                </c:pt>
                <c:pt idx="200">
                  <c:v>111.99299999999999</c:v>
                </c:pt>
                <c:pt idx="201">
                  <c:v>116.94</c:v>
                </c:pt>
                <c:pt idx="202">
                  <c:v>119.99299999999999</c:v>
                </c:pt>
                <c:pt idx="203">
                  <c:v>127.992</c:v>
                </c:pt>
                <c:pt idx="204">
                  <c:v>135.99199999999999</c:v>
                </c:pt>
                <c:pt idx="205">
                  <c:v>137.34399999999999</c:v>
                </c:pt>
                <c:pt idx="206">
                  <c:v>143.99100000000001</c:v>
                </c:pt>
                <c:pt idx="207">
                  <c:v>151.99100000000001</c:v>
                </c:pt>
                <c:pt idx="208">
                  <c:v>159.99</c:v>
                </c:pt>
                <c:pt idx="209">
                  <c:v>162.22399999999999</c:v>
                </c:pt>
                <c:pt idx="210">
                  <c:v>167.99</c:v>
                </c:pt>
                <c:pt idx="211">
                  <c:v>175.989</c:v>
                </c:pt>
                <c:pt idx="212">
                  <c:v>183.989</c:v>
                </c:pt>
                <c:pt idx="213">
                  <c:v>191.988</c:v>
                </c:pt>
                <c:pt idx="214">
                  <c:v>192.941</c:v>
                </c:pt>
                <c:pt idx="215">
                  <c:v>199.988</c:v>
                </c:pt>
                <c:pt idx="216">
                  <c:v>207.98699999999999</c:v>
                </c:pt>
                <c:pt idx="217">
                  <c:v>215.98699999999999</c:v>
                </c:pt>
                <c:pt idx="218">
                  <c:v>223.98599999999999</c:v>
                </c:pt>
                <c:pt idx="219">
                  <c:v>230.78</c:v>
                </c:pt>
                <c:pt idx="220">
                  <c:v>231.98599999999999</c:v>
                </c:pt>
                <c:pt idx="221">
                  <c:v>239.98500000000001</c:v>
                </c:pt>
                <c:pt idx="222">
                  <c:v>247.98500000000001</c:v>
                </c:pt>
                <c:pt idx="223">
                  <c:v>255.98400000000001</c:v>
                </c:pt>
                <c:pt idx="224">
                  <c:v>263.98399999999998</c:v>
                </c:pt>
                <c:pt idx="225">
                  <c:v>271.983</c:v>
                </c:pt>
                <c:pt idx="226">
                  <c:v>276.48599999999999</c:v>
                </c:pt>
                <c:pt idx="227">
                  <c:v>279.983</c:v>
                </c:pt>
                <c:pt idx="228">
                  <c:v>287.983</c:v>
                </c:pt>
                <c:pt idx="229">
                  <c:v>295.98200000000003</c:v>
                </c:pt>
                <c:pt idx="230">
                  <c:v>303.98200000000003</c:v>
                </c:pt>
                <c:pt idx="231">
                  <c:v>311.98099999999999</c:v>
                </c:pt>
                <c:pt idx="232">
                  <c:v>319.98099999999999</c:v>
                </c:pt>
                <c:pt idx="233">
                  <c:v>327.98</c:v>
                </c:pt>
                <c:pt idx="234">
                  <c:v>334.226</c:v>
                </c:pt>
                <c:pt idx="235">
                  <c:v>335.98</c:v>
                </c:pt>
                <c:pt idx="236">
                  <c:v>343.97899999999998</c:v>
                </c:pt>
                <c:pt idx="237">
                  <c:v>351.97899999999998</c:v>
                </c:pt>
                <c:pt idx="238">
                  <c:v>359.97800000000001</c:v>
                </c:pt>
                <c:pt idx="239">
                  <c:v>367.97800000000001</c:v>
                </c:pt>
                <c:pt idx="240">
                  <c:v>375.97699999999998</c:v>
                </c:pt>
                <c:pt idx="241">
                  <c:v>383.97699999999998</c:v>
                </c:pt>
                <c:pt idx="242">
                  <c:v>391.976</c:v>
                </c:pt>
                <c:pt idx="243">
                  <c:v>399.976</c:v>
                </c:pt>
                <c:pt idx="244">
                  <c:v>404.87099999999998</c:v>
                </c:pt>
                <c:pt idx="245">
                  <c:v>407.97500000000002</c:v>
                </c:pt>
                <c:pt idx="246">
                  <c:v>415.97500000000002</c:v>
                </c:pt>
                <c:pt idx="247">
                  <c:v>423.97399999999999</c:v>
                </c:pt>
                <c:pt idx="248">
                  <c:v>431.97399999999999</c:v>
                </c:pt>
                <c:pt idx="249">
                  <c:v>439.97300000000001</c:v>
                </c:pt>
                <c:pt idx="250">
                  <c:v>447.97300000000001</c:v>
                </c:pt>
                <c:pt idx="251">
                  <c:v>455.97199999999998</c:v>
                </c:pt>
                <c:pt idx="252">
                  <c:v>463.97199999999998</c:v>
                </c:pt>
                <c:pt idx="253">
                  <c:v>471.971</c:v>
                </c:pt>
                <c:pt idx="254">
                  <c:v>479.971</c:v>
                </c:pt>
                <c:pt idx="255">
                  <c:v>487.97</c:v>
                </c:pt>
                <c:pt idx="256">
                  <c:v>492.20299999999997</c:v>
                </c:pt>
                <c:pt idx="257">
                  <c:v>495.97</c:v>
                </c:pt>
                <c:pt idx="258">
                  <c:v>503.96899999999999</c:v>
                </c:pt>
                <c:pt idx="259">
                  <c:v>511.96899999999999</c:v>
                </c:pt>
                <c:pt idx="260">
                  <c:v>519.96799999999996</c:v>
                </c:pt>
                <c:pt idx="261">
                  <c:v>527.96799999999996</c:v>
                </c:pt>
                <c:pt idx="262">
                  <c:v>535.96699999999998</c:v>
                </c:pt>
                <c:pt idx="263">
                  <c:v>543.96699999999998</c:v>
                </c:pt>
                <c:pt idx="264">
                  <c:v>551.96600000000001</c:v>
                </c:pt>
                <c:pt idx="265">
                  <c:v>559.96600000000001</c:v>
                </c:pt>
                <c:pt idx="266">
                  <c:v>567.96600000000001</c:v>
                </c:pt>
                <c:pt idx="267">
                  <c:v>575.96500000000003</c:v>
                </c:pt>
                <c:pt idx="268">
                  <c:v>583.96500000000003</c:v>
                </c:pt>
                <c:pt idx="269">
                  <c:v>591.96400000000006</c:v>
                </c:pt>
                <c:pt idx="270">
                  <c:v>598.24599999999998</c:v>
                </c:pt>
                <c:pt idx="271">
                  <c:v>599.96400000000006</c:v>
                </c:pt>
                <c:pt idx="272">
                  <c:v>607.96299999999997</c:v>
                </c:pt>
                <c:pt idx="273">
                  <c:v>615.96299999999997</c:v>
                </c:pt>
                <c:pt idx="274">
                  <c:v>623.96199999999999</c:v>
                </c:pt>
                <c:pt idx="275">
                  <c:v>631.96199999999999</c:v>
                </c:pt>
                <c:pt idx="276">
                  <c:v>639.96100000000001</c:v>
                </c:pt>
                <c:pt idx="277">
                  <c:v>647.96100000000001</c:v>
                </c:pt>
                <c:pt idx="278">
                  <c:v>655.96</c:v>
                </c:pt>
                <c:pt idx="279">
                  <c:v>663.96</c:v>
                </c:pt>
                <c:pt idx="280">
                  <c:v>671.95899999999995</c:v>
                </c:pt>
                <c:pt idx="281">
                  <c:v>679.95899999999995</c:v>
                </c:pt>
                <c:pt idx="282">
                  <c:v>687.95799999999997</c:v>
                </c:pt>
                <c:pt idx="283">
                  <c:v>695.95799999999997</c:v>
                </c:pt>
                <c:pt idx="284">
                  <c:v>703.95699999999999</c:v>
                </c:pt>
                <c:pt idx="285">
                  <c:v>711.95699999999999</c:v>
                </c:pt>
                <c:pt idx="286">
                  <c:v>719.95600000000002</c:v>
                </c:pt>
                <c:pt idx="287">
                  <c:v>727.95600000000002</c:v>
                </c:pt>
                <c:pt idx="288">
                  <c:v>730.774</c:v>
                </c:pt>
                <c:pt idx="289">
                  <c:v>735.95500000000004</c:v>
                </c:pt>
                <c:pt idx="290">
                  <c:v>743.95500000000004</c:v>
                </c:pt>
                <c:pt idx="291">
                  <c:v>751.95399999999995</c:v>
                </c:pt>
                <c:pt idx="292">
                  <c:v>759.95399999999995</c:v>
                </c:pt>
                <c:pt idx="293">
                  <c:v>767.95299999999997</c:v>
                </c:pt>
                <c:pt idx="294">
                  <c:v>775.95299999999997</c:v>
                </c:pt>
                <c:pt idx="295">
                  <c:v>783.952</c:v>
                </c:pt>
                <c:pt idx="296">
                  <c:v>791.952</c:v>
                </c:pt>
                <c:pt idx="297">
                  <c:v>799.95100000000002</c:v>
                </c:pt>
                <c:pt idx="298">
                  <c:v>807.95100000000002</c:v>
                </c:pt>
                <c:pt idx="299">
                  <c:v>815.95</c:v>
                </c:pt>
                <c:pt idx="300">
                  <c:v>823.95</c:v>
                </c:pt>
                <c:pt idx="301">
                  <c:v>831.94899999999996</c:v>
                </c:pt>
                <c:pt idx="302">
                  <c:v>839.94899999999996</c:v>
                </c:pt>
                <c:pt idx="303">
                  <c:v>847.94899999999996</c:v>
                </c:pt>
                <c:pt idx="304">
                  <c:v>855.94799999999998</c:v>
                </c:pt>
                <c:pt idx="305">
                  <c:v>863.94799999999998</c:v>
                </c:pt>
                <c:pt idx="306">
                  <c:v>871.947</c:v>
                </c:pt>
                <c:pt idx="307">
                  <c:v>879.947</c:v>
                </c:pt>
                <c:pt idx="308">
                  <c:v>887.94600000000003</c:v>
                </c:pt>
                <c:pt idx="309">
                  <c:v>889.19899999999996</c:v>
                </c:pt>
                <c:pt idx="310">
                  <c:v>895.94600000000003</c:v>
                </c:pt>
                <c:pt idx="311">
                  <c:v>903.94500000000005</c:v>
                </c:pt>
                <c:pt idx="312">
                  <c:v>911.94500000000005</c:v>
                </c:pt>
                <c:pt idx="313">
                  <c:v>919.94399999999996</c:v>
                </c:pt>
                <c:pt idx="314">
                  <c:v>927.94399999999996</c:v>
                </c:pt>
                <c:pt idx="315">
                  <c:v>935.94299999999998</c:v>
                </c:pt>
                <c:pt idx="316">
                  <c:v>943.94299999999998</c:v>
                </c:pt>
                <c:pt idx="317">
                  <c:v>951.94200000000001</c:v>
                </c:pt>
                <c:pt idx="318">
                  <c:v>959.94200000000001</c:v>
                </c:pt>
                <c:pt idx="319">
                  <c:v>967.94100000000003</c:v>
                </c:pt>
                <c:pt idx="320">
                  <c:v>975.94100000000003</c:v>
                </c:pt>
                <c:pt idx="321">
                  <c:v>983.94</c:v>
                </c:pt>
                <c:pt idx="322">
                  <c:v>991.94</c:v>
                </c:pt>
                <c:pt idx="323">
                  <c:v>999.93899999999996</c:v>
                </c:pt>
                <c:pt idx="324">
                  <c:v>1007.939</c:v>
                </c:pt>
                <c:pt idx="325">
                  <c:v>1015.938</c:v>
                </c:pt>
                <c:pt idx="326">
                  <c:v>1023.938</c:v>
                </c:pt>
                <c:pt idx="327">
                  <c:v>1031.9369999999999</c:v>
                </c:pt>
                <c:pt idx="328">
                  <c:v>1039.9369999999999</c:v>
                </c:pt>
                <c:pt idx="329">
                  <c:v>1047.9359999999999</c:v>
                </c:pt>
                <c:pt idx="330">
                  <c:v>1055.9359999999999</c:v>
                </c:pt>
                <c:pt idx="331">
                  <c:v>1063.9349999999999</c:v>
                </c:pt>
                <c:pt idx="332">
                  <c:v>1071.9349999999999</c:v>
                </c:pt>
                <c:pt idx="333">
                  <c:v>1079.3779999999999</c:v>
                </c:pt>
                <c:pt idx="334">
                  <c:v>1079.934</c:v>
                </c:pt>
                <c:pt idx="335">
                  <c:v>1087.934</c:v>
                </c:pt>
                <c:pt idx="336">
                  <c:v>1095.933</c:v>
                </c:pt>
                <c:pt idx="337">
                  <c:v>1103.933</c:v>
                </c:pt>
                <c:pt idx="338">
                  <c:v>1111.932</c:v>
                </c:pt>
                <c:pt idx="339">
                  <c:v>1119.932</c:v>
                </c:pt>
                <c:pt idx="340">
                  <c:v>1127.931</c:v>
                </c:pt>
                <c:pt idx="341">
                  <c:v>1135.931</c:v>
                </c:pt>
                <c:pt idx="342">
                  <c:v>1143.931</c:v>
                </c:pt>
                <c:pt idx="343">
                  <c:v>1151.93</c:v>
                </c:pt>
                <c:pt idx="344">
                  <c:v>1159.93</c:v>
                </c:pt>
                <c:pt idx="345">
                  <c:v>1167.9290000000001</c:v>
                </c:pt>
                <c:pt idx="346">
                  <c:v>1175.9290000000001</c:v>
                </c:pt>
                <c:pt idx="347">
                  <c:v>1183.9280000000001</c:v>
                </c:pt>
                <c:pt idx="348">
                  <c:v>1191.9280000000001</c:v>
                </c:pt>
                <c:pt idx="349">
                  <c:v>1199.9269999999999</c:v>
                </c:pt>
                <c:pt idx="350">
                  <c:v>1207.9269999999999</c:v>
                </c:pt>
                <c:pt idx="351">
                  <c:v>1215.9259999999999</c:v>
                </c:pt>
                <c:pt idx="352">
                  <c:v>1223.9259999999999</c:v>
                </c:pt>
                <c:pt idx="353">
                  <c:v>1231.925</c:v>
                </c:pt>
                <c:pt idx="354">
                  <c:v>1239.925</c:v>
                </c:pt>
                <c:pt idx="355">
                  <c:v>1247.924</c:v>
                </c:pt>
                <c:pt idx="356">
                  <c:v>1255.924</c:v>
                </c:pt>
                <c:pt idx="357">
                  <c:v>1263.923</c:v>
                </c:pt>
                <c:pt idx="358">
                  <c:v>1271.923</c:v>
                </c:pt>
                <c:pt idx="359">
                  <c:v>1279.922</c:v>
                </c:pt>
                <c:pt idx="360">
                  <c:v>1287.922</c:v>
                </c:pt>
                <c:pt idx="361">
                  <c:v>1295.921</c:v>
                </c:pt>
                <c:pt idx="362">
                  <c:v>1300.8150000000001</c:v>
                </c:pt>
                <c:pt idx="363">
                  <c:v>1303.921</c:v>
                </c:pt>
                <c:pt idx="364">
                  <c:v>1311.92</c:v>
                </c:pt>
                <c:pt idx="365">
                  <c:v>1319.92</c:v>
                </c:pt>
                <c:pt idx="366">
                  <c:v>1327.9190000000001</c:v>
                </c:pt>
                <c:pt idx="367">
                  <c:v>1335.9190000000001</c:v>
                </c:pt>
                <c:pt idx="368">
                  <c:v>1343.9179999999999</c:v>
                </c:pt>
                <c:pt idx="369">
                  <c:v>1351.9179999999999</c:v>
                </c:pt>
                <c:pt idx="370">
                  <c:v>1359.9169999999999</c:v>
                </c:pt>
                <c:pt idx="371">
                  <c:v>1367.9169999999999</c:v>
                </c:pt>
                <c:pt idx="372">
                  <c:v>1375.9159999999999</c:v>
                </c:pt>
                <c:pt idx="373">
                  <c:v>1383.9159999999999</c:v>
                </c:pt>
                <c:pt idx="374">
                  <c:v>1391.915</c:v>
                </c:pt>
                <c:pt idx="375">
                  <c:v>1399.915</c:v>
                </c:pt>
                <c:pt idx="376">
                  <c:v>1407.914</c:v>
                </c:pt>
                <c:pt idx="377">
                  <c:v>1415.914</c:v>
                </c:pt>
                <c:pt idx="378">
                  <c:v>1423.914</c:v>
                </c:pt>
                <c:pt idx="379">
                  <c:v>1431.913</c:v>
                </c:pt>
                <c:pt idx="380">
                  <c:v>1439.913</c:v>
                </c:pt>
                <c:pt idx="381">
                  <c:v>1447.912</c:v>
                </c:pt>
                <c:pt idx="382">
                  <c:v>1455.912</c:v>
                </c:pt>
                <c:pt idx="383">
                  <c:v>1463.9110000000001</c:v>
                </c:pt>
                <c:pt idx="384">
                  <c:v>1471.9110000000001</c:v>
                </c:pt>
                <c:pt idx="385">
                  <c:v>1479.91</c:v>
                </c:pt>
                <c:pt idx="386">
                  <c:v>1487.91</c:v>
                </c:pt>
                <c:pt idx="387">
                  <c:v>1495.9090000000001</c:v>
                </c:pt>
                <c:pt idx="388">
                  <c:v>1503.9090000000001</c:v>
                </c:pt>
                <c:pt idx="389">
                  <c:v>1511.9079999999999</c:v>
                </c:pt>
                <c:pt idx="390">
                  <c:v>1519.9079999999999</c:v>
                </c:pt>
                <c:pt idx="391">
                  <c:v>1527.9069999999999</c:v>
                </c:pt>
                <c:pt idx="392">
                  <c:v>1535.9069999999999</c:v>
                </c:pt>
                <c:pt idx="393">
                  <c:v>1543.9059999999999</c:v>
                </c:pt>
                <c:pt idx="394">
                  <c:v>1551.9059999999999</c:v>
                </c:pt>
                <c:pt idx="395">
                  <c:v>1559.905</c:v>
                </c:pt>
                <c:pt idx="396">
                  <c:v>1567.905</c:v>
                </c:pt>
                <c:pt idx="397">
                  <c:v>1575.904</c:v>
                </c:pt>
                <c:pt idx="398">
                  <c:v>1583.904</c:v>
                </c:pt>
                <c:pt idx="399">
                  <c:v>1591.903</c:v>
                </c:pt>
                <c:pt idx="400">
                  <c:v>1599.903</c:v>
                </c:pt>
                <c:pt idx="401">
                  <c:v>1599.903</c:v>
                </c:pt>
              </c:numCache>
            </c:numRef>
          </c:xVal>
          <c:yVal>
            <c:numRef>
              <c:f>Foglio6!$J$424:$J$82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</c:v>
                </c:pt>
                <c:pt idx="166">
                  <c:v>17.5</c:v>
                </c:pt>
                <c:pt idx="167">
                  <c:v>17.166</c:v>
                </c:pt>
                <c:pt idx="168">
                  <c:v>17</c:v>
                </c:pt>
                <c:pt idx="169">
                  <c:v>16.5</c:v>
                </c:pt>
                <c:pt idx="170">
                  <c:v>16</c:v>
                </c:pt>
                <c:pt idx="171">
                  <c:v>15.5</c:v>
                </c:pt>
                <c:pt idx="172">
                  <c:v>15</c:v>
                </c:pt>
                <c:pt idx="173">
                  <c:v>14.5</c:v>
                </c:pt>
                <c:pt idx="174">
                  <c:v>14.228</c:v>
                </c:pt>
                <c:pt idx="175">
                  <c:v>14</c:v>
                </c:pt>
                <c:pt idx="176">
                  <c:v>13.5</c:v>
                </c:pt>
                <c:pt idx="177">
                  <c:v>13</c:v>
                </c:pt>
                <c:pt idx="178">
                  <c:v>12.528</c:v>
                </c:pt>
                <c:pt idx="179">
                  <c:v>12.5</c:v>
                </c:pt>
                <c:pt idx="180">
                  <c:v>12</c:v>
                </c:pt>
                <c:pt idx="181">
                  <c:v>11.5</c:v>
                </c:pt>
                <c:pt idx="182">
                  <c:v>11.406000000000001</c:v>
                </c:pt>
                <c:pt idx="183">
                  <c:v>11</c:v>
                </c:pt>
                <c:pt idx="184">
                  <c:v>10.587999999999999</c:v>
                </c:pt>
                <c:pt idx="185">
                  <c:v>10.5</c:v>
                </c:pt>
                <c:pt idx="186">
                  <c:v>10</c:v>
                </c:pt>
                <c:pt idx="187">
                  <c:v>9.9169999999999998</c:v>
                </c:pt>
                <c:pt idx="188">
                  <c:v>9.5</c:v>
                </c:pt>
                <c:pt idx="189">
                  <c:v>9.3870000000000005</c:v>
                </c:pt>
                <c:pt idx="190">
                  <c:v>9</c:v>
                </c:pt>
                <c:pt idx="191">
                  <c:v>8.9290000000000003</c:v>
                </c:pt>
                <c:pt idx="192">
                  <c:v>8.5459999999999994</c:v>
                </c:pt>
                <c:pt idx="193">
                  <c:v>8.5</c:v>
                </c:pt>
                <c:pt idx="194">
                  <c:v>8.1929999999999996</c:v>
                </c:pt>
                <c:pt idx="195">
                  <c:v>8</c:v>
                </c:pt>
                <c:pt idx="196">
                  <c:v>7.883</c:v>
                </c:pt>
                <c:pt idx="197">
                  <c:v>7.6219999999999999</c:v>
                </c:pt>
                <c:pt idx="198">
                  <c:v>7.5</c:v>
                </c:pt>
                <c:pt idx="199">
                  <c:v>7.36</c:v>
                </c:pt>
                <c:pt idx="200">
                  <c:v>7.125</c:v>
                </c:pt>
                <c:pt idx="201">
                  <c:v>7</c:v>
                </c:pt>
                <c:pt idx="202">
                  <c:v>6.9269999999999996</c:v>
                </c:pt>
                <c:pt idx="203">
                  <c:v>6.718</c:v>
                </c:pt>
                <c:pt idx="204">
                  <c:v>6.5279999999999996</c:v>
                </c:pt>
                <c:pt idx="205">
                  <c:v>6.5</c:v>
                </c:pt>
                <c:pt idx="206">
                  <c:v>6.3460000000000001</c:v>
                </c:pt>
                <c:pt idx="207">
                  <c:v>6.1950000000000003</c:v>
                </c:pt>
                <c:pt idx="208">
                  <c:v>6.0439999999999996</c:v>
                </c:pt>
                <c:pt idx="209">
                  <c:v>6</c:v>
                </c:pt>
                <c:pt idx="210">
                  <c:v>5.907</c:v>
                </c:pt>
                <c:pt idx="211">
                  <c:v>5.7869999999999999</c:v>
                </c:pt>
                <c:pt idx="212">
                  <c:v>5.6420000000000003</c:v>
                </c:pt>
                <c:pt idx="213">
                  <c:v>5.516</c:v>
                </c:pt>
                <c:pt idx="214">
                  <c:v>5.5</c:v>
                </c:pt>
                <c:pt idx="215">
                  <c:v>5.4020000000000001</c:v>
                </c:pt>
                <c:pt idx="216">
                  <c:v>5.3029999999999999</c:v>
                </c:pt>
                <c:pt idx="217">
                  <c:v>5.1890000000000001</c:v>
                </c:pt>
                <c:pt idx="218">
                  <c:v>5.0819999999999999</c:v>
                </c:pt>
                <c:pt idx="219">
                  <c:v>5</c:v>
                </c:pt>
                <c:pt idx="220">
                  <c:v>4.9859999999999998</c:v>
                </c:pt>
                <c:pt idx="221">
                  <c:v>4.899</c:v>
                </c:pt>
                <c:pt idx="222">
                  <c:v>4.806</c:v>
                </c:pt>
                <c:pt idx="223">
                  <c:v>4.7110000000000003</c:v>
                </c:pt>
                <c:pt idx="224">
                  <c:v>4.625</c:v>
                </c:pt>
                <c:pt idx="225">
                  <c:v>4.5510000000000002</c:v>
                </c:pt>
                <c:pt idx="226">
                  <c:v>4.5</c:v>
                </c:pt>
                <c:pt idx="227">
                  <c:v>4.4669999999999996</c:v>
                </c:pt>
                <c:pt idx="228">
                  <c:v>4.3940000000000001</c:v>
                </c:pt>
                <c:pt idx="229">
                  <c:v>4.3159999999999998</c:v>
                </c:pt>
                <c:pt idx="230">
                  <c:v>4.2489999999999997</c:v>
                </c:pt>
                <c:pt idx="231">
                  <c:v>4.1769999999999996</c:v>
                </c:pt>
                <c:pt idx="232">
                  <c:v>4.1180000000000003</c:v>
                </c:pt>
                <c:pt idx="233">
                  <c:v>4.0529999999999999</c:v>
                </c:pt>
                <c:pt idx="234">
                  <c:v>4</c:v>
                </c:pt>
                <c:pt idx="235">
                  <c:v>3.984</c:v>
                </c:pt>
                <c:pt idx="236">
                  <c:v>3.9140000000000001</c:v>
                </c:pt>
                <c:pt idx="237">
                  <c:v>3.855</c:v>
                </c:pt>
                <c:pt idx="238">
                  <c:v>3.7919999999999998</c:v>
                </c:pt>
                <c:pt idx="239">
                  <c:v>3.7330000000000001</c:v>
                </c:pt>
                <c:pt idx="240">
                  <c:v>3.6720000000000002</c:v>
                </c:pt>
                <c:pt idx="241">
                  <c:v>3.6259999999999999</c:v>
                </c:pt>
                <c:pt idx="242">
                  <c:v>3.577</c:v>
                </c:pt>
                <c:pt idx="243">
                  <c:v>3.5329999999999999</c:v>
                </c:pt>
                <c:pt idx="244">
                  <c:v>3.5</c:v>
                </c:pt>
                <c:pt idx="245">
                  <c:v>3.4769999999999999</c:v>
                </c:pt>
                <c:pt idx="246">
                  <c:v>3.4249999999999998</c:v>
                </c:pt>
                <c:pt idx="247">
                  <c:v>3.3809999999999998</c:v>
                </c:pt>
                <c:pt idx="248">
                  <c:v>3.3330000000000002</c:v>
                </c:pt>
                <c:pt idx="249">
                  <c:v>3.2869999999999999</c:v>
                </c:pt>
                <c:pt idx="250">
                  <c:v>3.238</c:v>
                </c:pt>
                <c:pt idx="251">
                  <c:v>3.1949999999999998</c:v>
                </c:pt>
                <c:pt idx="252">
                  <c:v>3.1459999999999999</c:v>
                </c:pt>
                <c:pt idx="253">
                  <c:v>3.1070000000000002</c:v>
                </c:pt>
                <c:pt idx="254">
                  <c:v>3.069</c:v>
                </c:pt>
                <c:pt idx="255">
                  <c:v>3.02</c:v>
                </c:pt>
                <c:pt idx="256">
                  <c:v>3</c:v>
                </c:pt>
                <c:pt idx="257">
                  <c:v>2.984</c:v>
                </c:pt>
                <c:pt idx="258">
                  <c:v>2.9409999999999998</c:v>
                </c:pt>
                <c:pt idx="259">
                  <c:v>2.9020000000000001</c:v>
                </c:pt>
                <c:pt idx="260">
                  <c:v>2.8559999999999999</c:v>
                </c:pt>
                <c:pt idx="261">
                  <c:v>2.8130000000000002</c:v>
                </c:pt>
                <c:pt idx="262">
                  <c:v>2.7749999999999999</c:v>
                </c:pt>
                <c:pt idx="263">
                  <c:v>2.74</c:v>
                </c:pt>
                <c:pt idx="264">
                  <c:v>2.6989999999999998</c:v>
                </c:pt>
                <c:pt idx="265">
                  <c:v>2.6619999999999999</c:v>
                </c:pt>
                <c:pt idx="266">
                  <c:v>2.629</c:v>
                </c:pt>
                <c:pt idx="267">
                  <c:v>2.597</c:v>
                </c:pt>
                <c:pt idx="268">
                  <c:v>2.5659999999999998</c:v>
                </c:pt>
                <c:pt idx="269">
                  <c:v>2.5310000000000001</c:v>
                </c:pt>
                <c:pt idx="270">
                  <c:v>2.5</c:v>
                </c:pt>
                <c:pt idx="271">
                  <c:v>2.4940000000000002</c:v>
                </c:pt>
                <c:pt idx="272">
                  <c:v>2.4620000000000002</c:v>
                </c:pt>
                <c:pt idx="273">
                  <c:v>2.431</c:v>
                </c:pt>
                <c:pt idx="274">
                  <c:v>2.3969999999999998</c:v>
                </c:pt>
                <c:pt idx="275">
                  <c:v>2.359</c:v>
                </c:pt>
                <c:pt idx="276">
                  <c:v>2.323</c:v>
                </c:pt>
                <c:pt idx="277">
                  <c:v>2.2909999999999999</c:v>
                </c:pt>
                <c:pt idx="278">
                  <c:v>2.2589999999999999</c:v>
                </c:pt>
                <c:pt idx="279">
                  <c:v>2.2269999999999999</c:v>
                </c:pt>
                <c:pt idx="280">
                  <c:v>2.2000000000000002</c:v>
                </c:pt>
                <c:pt idx="281">
                  <c:v>2.17</c:v>
                </c:pt>
                <c:pt idx="282">
                  <c:v>2.1429999999999998</c:v>
                </c:pt>
                <c:pt idx="283">
                  <c:v>2.1179999999999999</c:v>
                </c:pt>
                <c:pt idx="284">
                  <c:v>2.0950000000000002</c:v>
                </c:pt>
                <c:pt idx="285">
                  <c:v>2.0680000000000001</c:v>
                </c:pt>
                <c:pt idx="286">
                  <c:v>2.0390000000000001</c:v>
                </c:pt>
                <c:pt idx="287">
                  <c:v>2.0099999999999998</c:v>
                </c:pt>
                <c:pt idx="288">
                  <c:v>2</c:v>
                </c:pt>
                <c:pt idx="289">
                  <c:v>1.9810000000000001</c:v>
                </c:pt>
                <c:pt idx="290">
                  <c:v>1.948</c:v>
                </c:pt>
                <c:pt idx="291">
                  <c:v>1.919</c:v>
                </c:pt>
                <c:pt idx="292">
                  <c:v>1.8879999999999999</c:v>
                </c:pt>
                <c:pt idx="293">
                  <c:v>1.86</c:v>
                </c:pt>
                <c:pt idx="294">
                  <c:v>1.835</c:v>
                </c:pt>
                <c:pt idx="295">
                  <c:v>1.8149999999999999</c:v>
                </c:pt>
                <c:pt idx="296">
                  <c:v>1.796</c:v>
                </c:pt>
                <c:pt idx="297">
                  <c:v>1.7689999999999999</c:v>
                </c:pt>
                <c:pt idx="298">
                  <c:v>1.74</c:v>
                </c:pt>
                <c:pt idx="299">
                  <c:v>1.7130000000000001</c:v>
                </c:pt>
                <c:pt idx="300">
                  <c:v>1.696</c:v>
                </c:pt>
                <c:pt idx="301">
                  <c:v>1.67</c:v>
                </c:pt>
                <c:pt idx="302">
                  <c:v>1.6459999999999999</c:v>
                </c:pt>
                <c:pt idx="303">
                  <c:v>1.621</c:v>
                </c:pt>
                <c:pt idx="304">
                  <c:v>1.5920000000000001</c:v>
                </c:pt>
                <c:pt idx="305">
                  <c:v>1.571</c:v>
                </c:pt>
                <c:pt idx="306">
                  <c:v>1.5489999999999999</c:v>
                </c:pt>
                <c:pt idx="307">
                  <c:v>1.5229999999999999</c:v>
                </c:pt>
                <c:pt idx="308">
                  <c:v>1.5049999999999999</c:v>
                </c:pt>
                <c:pt idx="309">
                  <c:v>1.5</c:v>
                </c:pt>
                <c:pt idx="310">
                  <c:v>1.4750000000000001</c:v>
                </c:pt>
                <c:pt idx="311">
                  <c:v>1.4510000000000001</c:v>
                </c:pt>
                <c:pt idx="312">
                  <c:v>1.43</c:v>
                </c:pt>
                <c:pt idx="313">
                  <c:v>1.4119999999999999</c:v>
                </c:pt>
                <c:pt idx="314">
                  <c:v>1.39</c:v>
                </c:pt>
                <c:pt idx="315">
                  <c:v>1.365</c:v>
                </c:pt>
                <c:pt idx="316">
                  <c:v>1.343</c:v>
                </c:pt>
                <c:pt idx="317">
                  <c:v>1.3240000000000001</c:v>
                </c:pt>
                <c:pt idx="318">
                  <c:v>1.3080000000000001</c:v>
                </c:pt>
                <c:pt idx="319">
                  <c:v>1.2869999999999999</c:v>
                </c:pt>
                <c:pt idx="320">
                  <c:v>1.262</c:v>
                </c:pt>
                <c:pt idx="321">
                  <c:v>1.242</c:v>
                </c:pt>
                <c:pt idx="322">
                  <c:v>1.224</c:v>
                </c:pt>
                <c:pt idx="323">
                  <c:v>1.2010000000000001</c:v>
                </c:pt>
                <c:pt idx="324">
                  <c:v>1.1779999999999999</c:v>
                </c:pt>
                <c:pt idx="325">
                  <c:v>1.1559999999999999</c:v>
                </c:pt>
                <c:pt idx="326">
                  <c:v>1.1339999999999999</c:v>
                </c:pt>
                <c:pt idx="327">
                  <c:v>1.115</c:v>
                </c:pt>
                <c:pt idx="328">
                  <c:v>1.093</c:v>
                </c:pt>
                <c:pt idx="329">
                  <c:v>1.0720000000000001</c:v>
                </c:pt>
                <c:pt idx="330">
                  <c:v>1.0569999999999999</c:v>
                </c:pt>
                <c:pt idx="331">
                  <c:v>1.038</c:v>
                </c:pt>
                <c:pt idx="332">
                  <c:v>1.0149999999999999</c:v>
                </c:pt>
                <c:pt idx="333">
                  <c:v>1</c:v>
                </c:pt>
                <c:pt idx="334">
                  <c:v>0.999</c:v>
                </c:pt>
                <c:pt idx="335">
                  <c:v>0.97899999999999998</c:v>
                </c:pt>
                <c:pt idx="336">
                  <c:v>0.95799999999999996</c:v>
                </c:pt>
                <c:pt idx="337">
                  <c:v>0.94099999999999995</c:v>
                </c:pt>
                <c:pt idx="338">
                  <c:v>0.92200000000000004</c:v>
                </c:pt>
                <c:pt idx="339">
                  <c:v>0.90600000000000003</c:v>
                </c:pt>
                <c:pt idx="340">
                  <c:v>0.88200000000000001</c:v>
                </c:pt>
                <c:pt idx="341">
                  <c:v>0.86199999999999999</c:v>
                </c:pt>
                <c:pt idx="342">
                  <c:v>0.84499999999999997</c:v>
                </c:pt>
                <c:pt idx="343">
                  <c:v>0.82199999999999995</c:v>
                </c:pt>
                <c:pt idx="344">
                  <c:v>0.80700000000000005</c:v>
                </c:pt>
                <c:pt idx="345">
                  <c:v>0.79200000000000004</c:v>
                </c:pt>
                <c:pt idx="346">
                  <c:v>0.77300000000000002</c:v>
                </c:pt>
                <c:pt idx="347">
                  <c:v>0.76</c:v>
                </c:pt>
                <c:pt idx="348">
                  <c:v>0.745</c:v>
                </c:pt>
                <c:pt idx="349">
                  <c:v>0.72499999999999998</c:v>
                </c:pt>
                <c:pt idx="350">
                  <c:v>0.71199999999999997</c:v>
                </c:pt>
                <c:pt idx="351">
                  <c:v>0.68700000000000006</c:v>
                </c:pt>
                <c:pt idx="352">
                  <c:v>0.66600000000000004</c:v>
                </c:pt>
                <c:pt idx="353">
                  <c:v>0.64800000000000002</c:v>
                </c:pt>
                <c:pt idx="354">
                  <c:v>0.629</c:v>
                </c:pt>
                <c:pt idx="355">
                  <c:v>0.61199999999999999</c:v>
                </c:pt>
                <c:pt idx="356">
                  <c:v>0.59199999999999997</c:v>
                </c:pt>
                <c:pt idx="357">
                  <c:v>0.57599999999999996</c:v>
                </c:pt>
                <c:pt idx="358">
                  <c:v>0.56100000000000005</c:v>
                </c:pt>
                <c:pt idx="359">
                  <c:v>0.54500000000000004</c:v>
                </c:pt>
                <c:pt idx="360">
                  <c:v>0.52900000000000003</c:v>
                </c:pt>
                <c:pt idx="361">
                  <c:v>0.51</c:v>
                </c:pt>
                <c:pt idx="362">
                  <c:v>0.5</c:v>
                </c:pt>
                <c:pt idx="363">
                  <c:v>0.496</c:v>
                </c:pt>
                <c:pt idx="364">
                  <c:v>0.48299999999999998</c:v>
                </c:pt>
                <c:pt idx="365">
                  <c:v>0.46100000000000002</c:v>
                </c:pt>
                <c:pt idx="366">
                  <c:v>0.44</c:v>
                </c:pt>
                <c:pt idx="367">
                  <c:v>0.42399999999999999</c:v>
                </c:pt>
                <c:pt idx="368">
                  <c:v>0.40899999999999997</c:v>
                </c:pt>
                <c:pt idx="369">
                  <c:v>0.39300000000000002</c:v>
                </c:pt>
                <c:pt idx="370">
                  <c:v>0.375</c:v>
                </c:pt>
                <c:pt idx="371">
                  <c:v>0.36</c:v>
                </c:pt>
                <c:pt idx="372">
                  <c:v>0.34699999999999998</c:v>
                </c:pt>
                <c:pt idx="373">
                  <c:v>0.33100000000000002</c:v>
                </c:pt>
                <c:pt idx="374">
                  <c:v>0.314</c:v>
                </c:pt>
                <c:pt idx="375">
                  <c:v>0.29099999999999998</c:v>
                </c:pt>
                <c:pt idx="376">
                  <c:v>0.26900000000000002</c:v>
                </c:pt>
                <c:pt idx="377">
                  <c:v>0.254</c:v>
                </c:pt>
                <c:pt idx="378">
                  <c:v>0.24</c:v>
                </c:pt>
                <c:pt idx="379">
                  <c:v>0.22900000000000001</c:v>
                </c:pt>
                <c:pt idx="380">
                  <c:v>0.214</c:v>
                </c:pt>
                <c:pt idx="381">
                  <c:v>0.19800000000000001</c:v>
                </c:pt>
                <c:pt idx="382">
                  <c:v>0.17799999999999999</c:v>
                </c:pt>
                <c:pt idx="383">
                  <c:v>0.16</c:v>
                </c:pt>
                <c:pt idx="384">
                  <c:v>0.14499999999999999</c:v>
                </c:pt>
                <c:pt idx="385">
                  <c:v>0.13100000000000001</c:v>
                </c:pt>
                <c:pt idx="386">
                  <c:v>0.114</c:v>
                </c:pt>
                <c:pt idx="387">
                  <c:v>9.6000000000000002E-2</c:v>
                </c:pt>
                <c:pt idx="388">
                  <c:v>7.5999999999999998E-2</c:v>
                </c:pt>
                <c:pt idx="389">
                  <c:v>6.6000000000000003E-2</c:v>
                </c:pt>
                <c:pt idx="390">
                  <c:v>5.3999999999999999E-2</c:v>
                </c:pt>
                <c:pt idx="391">
                  <c:v>4.2999999999999997E-2</c:v>
                </c:pt>
                <c:pt idx="392">
                  <c:v>3.5000000000000003E-2</c:v>
                </c:pt>
                <c:pt idx="393">
                  <c:v>2.5999999999999999E-2</c:v>
                </c:pt>
                <c:pt idx="394">
                  <c:v>1.6E-2</c:v>
                </c:pt>
                <c:pt idx="395">
                  <c:v>0.01</c:v>
                </c:pt>
                <c:pt idx="396">
                  <c:v>5.0000000000000001E-3</c:v>
                </c:pt>
                <c:pt idx="397">
                  <c:v>2E-3</c:v>
                </c:pt>
                <c:pt idx="398">
                  <c:v>1E-3</c:v>
                </c:pt>
                <c:pt idx="399">
                  <c:v>1E-3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C237-45B1-A7AA-312291C87353}"/>
            </c:ext>
          </c:extLst>
        </c:ser>
        <c:ser>
          <c:idx val="5"/>
          <c:order val="5"/>
          <c:tx>
            <c:strRef>
              <c:f>Foglio6!$K$1</c:f>
              <c:strCache>
                <c:ptCount val="1"/>
                <c:pt idx="0">
                  <c:v>S1,0M8</c:v>
                </c:pt>
              </c:strCache>
            </c:strRef>
          </c:tx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401"/>
              <c:dLblPos val="r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C237-45B1-A7AA-312291C8735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Foglio6!$K$424:$K$82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8.9999999999999993E-3</c:v>
                </c:pt>
                <c:pt idx="73">
                  <c:v>0.03</c:v>
                </c:pt>
                <c:pt idx="74">
                  <c:v>5.0999999999999997E-2</c:v>
                </c:pt>
                <c:pt idx="75">
                  <c:v>7.2999999999999995E-2</c:v>
                </c:pt>
                <c:pt idx="76">
                  <c:v>9.4E-2</c:v>
                </c:pt>
                <c:pt idx="77">
                  <c:v>0.115</c:v>
                </c:pt>
                <c:pt idx="78">
                  <c:v>0.13700000000000001</c:v>
                </c:pt>
                <c:pt idx="79">
                  <c:v>0.158</c:v>
                </c:pt>
                <c:pt idx="80">
                  <c:v>0.17899999999999999</c:v>
                </c:pt>
                <c:pt idx="81">
                  <c:v>0.20100000000000001</c:v>
                </c:pt>
                <c:pt idx="82">
                  <c:v>0.222</c:v>
                </c:pt>
                <c:pt idx="83">
                  <c:v>0.24299999999999999</c:v>
                </c:pt>
                <c:pt idx="84">
                  <c:v>0.26500000000000001</c:v>
                </c:pt>
                <c:pt idx="85">
                  <c:v>0.28599999999999998</c:v>
                </c:pt>
                <c:pt idx="86">
                  <c:v>0.308</c:v>
                </c:pt>
                <c:pt idx="87">
                  <c:v>0.32900000000000001</c:v>
                </c:pt>
                <c:pt idx="88">
                  <c:v>0.35</c:v>
                </c:pt>
                <c:pt idx="89">
                  <c:v>0.372</c:v>
                </c:pt>
                <c:pt idx="90">
                  <c:v>0.39300000000000002</c:v>
                </c:pt>
                <c:pt idx="91">
                  <c:v>0.41399999999999998</c:v>
                </c:pt>
                <c:pt idx="92">
                  <c:v>0.436</c:v>
                </c:pt>
                <c:pt idx="93">
                  <c:v>0.45700000000000002</c:v>
                </c:pt>
                <c:pt idx="94">
                  <c:v>0.47799999999999998</c:v>
                </c:pt>
                <c:pt idx="95">
                  <c:v>0.5</c:v>
                </c:pt>
                <c:pt idx="96">
                  <c:v>0.52100000000000002</c:v>
                </c:pt>
                <c:pt idx="97">
                  <c:v>0.54200000000000004</c:v>
                </c:pt>
                <c:pt idx="98">
                  <c:v>0.56399999999999995</c:v>
                </c:pt>
                <c:pt idx="99">
                  <c:v>0.58499999999999996</c:v>
                </c:pt>
                <c:pt idx="100">
                  <c:v>0.60599999999999998</c:v>
                </c:pt>
                <c:pt idx="101">
                  <c:v>0.628</c:v>
                </c:pt>
                <c:pt idx="102">
                  <c:v>0.64900000000000002</c:v>
                </c:pt>
                <c:pt idx="103">
                  <c:v>0.67100000000000004</c:v>
                </c:pt>
                <c:pt idx="104">
                  <c:v>0.69199999999999995</c:v>
                </c:pt>
                <c:pt idx="105">
                  <c:v>0.71299999999999997</c:v>
                </c:pt>
                <c:pt idx="106">
                  <c:v>0.73499999999999999</c:v>
                </c:pt>
                <c:pt idx="107">
                  <c:v>0.75600000000000001</c:v>
                </c:pt>
                <c:pt idx="108">
                  <c:v>0.77700000000000002</c:v>
                </c:pt>
                <c:pt idx="109">
                  <c:v>0.79900000000000004</c:v>
                </c:pt>
                <c:pt idx="110">
                  <c:v>0.82</c:v>
                </c:pt>
                <c:pt idx="111">
                  <c:v>0.84099999999999997</c:v>
                </c:pt>
                <c:pt idx="112">
                  <c:v>0.86299999999999999</c:v>
                </c:pt>
                <c:pt idx="113">
                  <c:v>0.88400000000000001</c:v>
                </c:pt>
                <c:pt idx="114">
                  <c:v>0.90500000000000003</c:v>
                </c:pt>
                <c:pt idx="115">
                  <c:v>0.92700000000000005</c:v>
                </c:pt>
                <c:pt idx="116">
                  <c:v>0.94799999999999995</c:v>
                </c:pt>
                <c:pt idx="117">
                  <c:v>0.96899999999999997</c:v>
                </c:pt>
                <c:pt idx="118">
                  <c:v>0.99099999999999999</c:v>
                </c:pt>
                <c:pt idx="119">
                  <c:v>1.012</c:v>
                </c:pt>
                <c:pt idx="120">
                  <c:v>1.0329999999999999</c:v>
                </c:pt>
                <c:pt idx="121">
                  <c:v>1.0549999999999999</c:v>
                </c:pt>
                <c:pt idx="122">
                  <c:v>1.0760000000000001</c:v>
                </c:pt>
                <c:pt idx="123">
                  <c:v>1.0980000000000001</c:v>
                </c:pt>
                <c:pt idx="124">
                  <c:v>1.119</c:v>
                </c:pt>
                <c:pt idx="125">
                  <c:v>1.1399999999999999</c:v>
                </c:pt>
                <c:pt idx="126">
                  <c:v>1.1619999999999999</c:v>
                </c:pt>
                <c:pt idx="127">
                  <c:v>1.1830000000000001</c:v>
                </c:pt>
                <c:pt idx="128">
                  <c:v>1.204</c:v>
                </c:pt>
                <c:pt idx="129">
                  <c:v>1.226</c:v>
                </c:pt>
                <c:pt idx="130">
                  <c:v>1.2470000000000001</c:v>
                </c:pt>
                <c:pt idx="131">
                  <c:v>1.268</c:v>
                </c:pt>
                <c:pt idx="132">
                  <c:v>1.29</c:v>
                </c:pt>
                <c:pt idx="133">
                  <c:v>1.3109999999999999</c:v>
                </c:pt>
                <c:pt idx="134">
                  <c:v>1.3320000000000001</c:v>
                </c:pt>
                <c:pt idx="135">
                  <c:v>1.3540000000000001</c:v>
                </c:pt>
                <c:pt idx="136">
                  <c:v>1.375</c:v>
                </c:pt>
                <c:pt idx="137">
                  <c:v>1.3959999999999999</c:v>
                </c:pt>
                <c:pt idx="138">
                  <c:v>1.4179999999999999</c:v>
                </c:pt>
                <c:pt idx="139">
                  <c:v>1.4390000000000001</c:v>
                </c:pt>
                <c:pt idx="140">
                  <c:v>1.4610000000000001</c:v>
                </c:pt>
                <c:pt idx="141">
                  <c:v>1.482</c:v>
                </c:pt>
                <c:pt idx="142">
                  <c:v>1.5029999999999999</c:v>
                </c:pt>
                <c:pt idx="143">
                  <c:v>1.5249999999999999</c:v>
                </c:pt>
                <c:pt idx="144">
                  <c:v>1.546</c:v>
                </c:pt>
                <c:pt idx="145">
                  <c:v>1.5669999999999999</c:v>
                </c:pt>
                <c:pt idx="146">
                  <c:v>1.589</c:v>
                </c:pt>
                <c:pt idx="147">
                  <c:v>1.61</c:v>
                </c:pt>
                <c:pt idx="148">
                  <c:v>1.631</c:v>
                </c:pt>
                <c:pt idx="149">
                  <c:v>1.7050000000000001</c:v>
                </c:pt>
                <c:pt idx="150">
                  <c:v>1.8779999999999999</c:v>
                </c:pt>
                <c:pt idx="151">
                  <c:v>2.0510000000000002</c:v>
                </c:pt>
                <c:pt idx="152">
                  <c:v>2.2240000000000002</c:v>
                </c:pt>
                <c:pt idx="153">
                  <c:v>2.3969999999999998</c:v>
                </c:pt>
                <c:pt idx="154">
                  <c:v>2.57</c:v>
                </c:pt>
                <c:pt idx="155">
                  <c:v>2.7429999999999999</c:v>
                </c:pt>
                <c:pt idx="156">
                  <c:v>2.9159999999999999</c:v>
                </c:pt>
                <c:pt idx="157">
                  <c:v>3.089</c:v>
                </c:pt>
                <c:pt idx="158">
                  <c:v>3.262</c:v>
                </c:pt>
                <c:pt idx="159">
                  <c:v>3.5739999999999998</c:v>
                </c:pt>
                <c:pt idx="160">
                  <c:v>3.915</c:v>
                </c:pt>
                <c:pt idx="161">
                  <c:v>4.2560000000000002</c:v>
                </c:pt>
                <c:pt idx="162">
                  <c:v>4.5970000000000004</c:v>
                </c:pt>
                <c:pt idx="163">
                  <c:v>4.9400000000000004</c:v>
                </c:pt>
                <c:pt idx="164">
                  <c:v>5.4980000000000002</c:v>
                </c:pt>
                <c:pt idx="165">
                  <c:v>6.0549999999999997</c:v>
                </c:pt>
                <c:pt idx="166">
                  <c:v>6.6269999999999998</c:v>
                </c:pt>
                <c:pt idx="167">
                  <c:v>7.423</c:v>
                </c:pt>
                <c:pt idx="168">
                  <c:v>8.218</c:v>
                </c:pt>
                <c:pt idx="169">
                  <c:v>8.2260000000000009</c:v>
                </c:pt>
                <c:pt idx="170">
                  <c:v>9.2100000000000009</c:v>
                </c:pt>
                <c:pt idx="171">
                  <c:v>10.266999999999999</c:v>
                </c:pt>
                <c:pt idx="172">
                  <c:v>11.448</c:v>
                </c:pt>
                <c:pt idx="173">
                  <c:v>12.827999999999999</c:v>
                </c:pt>
                <c:pt idx="174">
                  <c:v>14.37</c:v>
                </c:pt>
                <c:pt idx="175">
                  <c:v>16.102</c:v>
                </c:pt>
                <c:pt idx="176">
                  <c:v>16.452999999999999</c:v>
                </c:pt>
                <c:pt idx="177">
                  <c:v>18.042000000000002</c:v>
                </c:pt>
                <c:pt idx="178">
                  <c:v>20.338000000000001</c:v>
                </c:pt>
                <c:pt idx="179">
                  <c:v>23.074999999999999</c:v>
                </c:pt>
                <c:pt idx="180">
                  <c:v>24.678999999999998</c:v>
                </c:pt>
                <c:pt idx="181">
                  <c:v>26.302</c:v>
                </c:pt>
                <c:pt idx="182">
                  <c:v>30.05</c:v>
                </c:pt>
                <c:pt idx="183">
                  <c:v>32.905000000000001</c:v>
                </c:pt>
                <c:pt idx="184">
                  <c:v>34.357999999999997</c:v>
                </c:pt>
                <c:pt idx="185">
                  <c:v>39.353999999999999</c:v>
                </c:pt>
                <c:pt idx="186">
                  <c:v>41.131</c:v>
                </c:pt>
                <c:pt idx="187">
                  <c:v>45.244999999999997</c:v>
                </c:pt>
                <c:pt idx="188">
                  <c:v>49.357999999999997</c:v>
                </c:pt>
                <c:pt idx="189">
                  <c:v>52.264000000000003</c:v>
                </c:pt>
                <c:pt idx="190">
                  <c:v>57.584000000000003</c:v>
                </c:pt>
                <c:pt idx="191">
                  <c:v>60.764000000000003</c:v>
                </c:pt>
                <c:pt idx="192">
                  <c:v>65.81</c:v>
                </c:pt>
                <c:pt idx="193">
                  <c:v>71.025000000000006</c:v>
                </c:pt>
                <c:pt idx="194">
                  <c:v>74.036000000000001</c:v>
                </c:pt>
                <c:pt idx="195">
                  <c:v>82.263000000000005</c:v>
                </c:pt>
                <c:pt idx="196">
                  <c:v>82.840999999999994</c:v>
                </c:pt>
                <c:pt idx="197">
                  <c:v>90.489000000000004</c:v>
                </c:pt>
                <c:pt idx="198">
                  <c:v>98.058999999999997</c:v>
                </c:pt>
                <c:pt idx="199">
                  <c:v>98.715000000000003</c:v>
                </c:pt>
                <c:pt idx="200">
                  <c:v>106.941</c:v>
                </c:pt>
                <c:pt idx="201">
                  <c:v>115.16800000000001</c:v>
                </c:pt>
                <c:pt idx="202">
                  <c:v>115.304</c:v>
                </c:pt>
                <c:pt idx="203">
                  <c:v>123.39400000000001</c:v>
                </c:pt>
                <c:pt idx="204">
                  <c:v>131.62</c:v>
                </c:pt>
                <c:pt idx="205">
                  <c:v>137.19900000000001</c:v>
                </c:pt>
                <c:pt idx="206">
                  <c:v>139.846</c:v>
                </c:pt>
                <c:pt idx="207">
                  <c:v>148.07300000000001</c:v>
                </c:pt>
                <c:pt idx="208">
                  <c:v>156.29900000000001</c:v>
                </c:pt>
                <c:pt idx="209">
                  <c:v>163.74199999999999</c:v>
                </c:pt>
                <c:pt idx="210">
                  <c:v>164.52500000000001</c:v>
                </c:pt>
                <c:pt idx="211">
                  <c:v>172.75200000000001</c:v>
                </c:pt>
                <c:pt idx="212">
                  <c:v>180.97800000000001</c:v>
                </c:pt>
                <c:pt idx="213">
                  <c:v>189.20400000000001</c:v>
                </c:pt>
                <c:pt idx="214">
                  <c:v>194.845</c:v>
                </c:pt>
                <c:pt idx="215">
                  <c:v>197.43</c:v>
                </c:pt>
                <c:pt idx="216">
                  <c:v>205.65700000000001</c:v>
                </c:pt>
                <c:pt idx="217">
                  <c:v>213.88300000000001</c:v>
                </c:pt>
                <c:pt idx="218">
                  <c:v>222.10900000000001</c:v>
                </c:pt>
                <c:pt idx="219">
                  <c:v>230.33500000000001</c:v>
                </c:pt>
                <c:pt idx="220">
                  <c:v>236.20500000000001</c:v>
                </c:pt>
                <c:pt idx="221">
                  <c:v>238.56200000000001</c:v>
                </c:pt>
                <c:pt idx="222">
                  <c:v>246.78800000000001</c:v>
                </c:pt>
                <c:pt idx="223">
                  <c:v>255.01400000000001</c:v>
                </c:pt>
                <c:pt idx="224">
                  <c:v>263.24</c:v>
                </c:pt>
                <c:pt idx="225">
                  <c:v>271.46699999999998</c:v>
                </c:pt>
                <c:pt idx="226">
                  <c:v>279.69299999999998</c:v>
                </c:pt>
                <c:pt idx="227">
                  <c:v>285.02499999999998</c:v>
                </c:pt>
                <c:pt idx="228">
                  <c:v>287.91899999999998</c:v>
                </c:pt>
                <c:pt idx="229">
                  <c:v>296.14600000000002</c:v>
                </c:pt>
                <c:pt idx="230">
                  <c:v>304.37200000000001</c:v>
                </c:pt>
                <c:pt idx="231">
                  <c:v>312.59800000000001</c:v>
                </c:pt>
                <c:pt idx="232">
                  <c:v>320.82400000000001</c:v>
                </c:pt>
                <c:pt idx="233">
                  <c:v>329.05099999999999</c:v>
                </c:pt>
                <c:pt idx="234">
                  <c:v>337.27699999999999</c:v>
                </c:pt>
                <c:pt idx="235">
                  <c:v>345.50299999999999</c:v>
                </c:pt>
                <c:pt idx="236">
                  <c:v>347.71499999999997</c:v>
                </c:pt>
                <c:pt idx="237">
                  <c:v>353.72899999999998</c:v>
                </c:pt>
                <c:pt idx="238">
                  <c:v>361.95600000000002</c:v>
                </c:pt>
                <c:pt idx="239">
                  <c:v>370.18200000000002</c:v>
                </c:pt>
                <c:pt idx="240">
                  <c:v>378.40800000000002</c:v>
                </c:pt>
                <c:pt idx="241">
                  <c:v>386.63400000000001</c:v>
                </c:pt>
                <c:pt idx="242">
                  <c:v>394.86099999999999</c:v>
                </c:pt>
                <c:pt idx="243">
                  <c:v>403.08699999999999</c:v>
                </c:pt>
                <c:pt idx="244">
                  <c:v>411.31299999999999</c:v>
                </c:pt>
                <c:pt idx="245">
                  <c:v>419.53899999999999</c:v>
                </c:pt>
                <c:pt idx="246">
                  <c:v>426.01799999999997</c:v>
                </c:pt>
                <c:pt idx="247">
                  <c:v>427.76600000000002</c:v>
                </c:pt>
                <c:pt idx="248">
                  <c:v>435.99200000000002</c:v>
                </c:pt>
                <c:pt idx="249">
                  <c:v>444.21800000000002</c:v>
                </c:pt>
                <c:pt idx="250">
                  <c:v>452.44499999999999</c:v>
                </c:pt>
                <c:pt idx="251">
                  <c:v>460.67099999999999</c:v>
                </c:pt>
                <c:pt idx="252">
                  <c:v>468.89699999999999</c:v>
                </c:pt>
                <c:pt idx="253">
                  <c:v>477.12299999999999</c:v>
                </c:pt>
                <c:pt idx="254">
                  <c:v>485.35</c:v>
                </c:pt>
                <c:pt idx="255">
                  <c:v>493.57600000000002</c:v>
                </c:pt>
                <c:pt idx="256">
                  <c:v>501.80200000000002</c:v>
                </c:pt>
                <c:pt idx="257">
                  <c:v>510.02800000000002</c:v>
                </c:pt>
                <c:pt idx="258">
                  <c:v>518.255</c:v>
                </c:pt>
                <c:pt idx="259">
                  <c:v>521.41999999999996</c:v>
                </c:pt>
                <c:pt idx="260">
                  <c:v>526.48099999999999</c:v>
                </c:pt>
                <c:pt idx="261">
                  <c:v>534.70699999999999</c:v>
                </c:pt>
                <c:pt idx="262">
                  <c:v>542.93299999999999</c:v>
                </c:pt>
                <c:pt idx="263">
                  <c:v>551.16</c:v>
                </c:pt>
                <c:pt idx="264">
                  <c:v>559.38599999999997</c:v>
                </c:pt>
                <c:pt idx="265">
                  <c:v>567.61199999999997</c:v>
                </c:pt>
                <c:pt idx="266">
                  <c:v>575.83900000000006</c:v>
                </c:pt>
                <c:pt idx="267">
                  <c:v>584.06500000000005</c:v>
                </c:pt>
                <c:pt idx="268">
                  <c:v>592.29100000000005</c:v>
                </c:pt>
                <c:pt idx="269">
                  <c:v>600.51700000000005</c:v>
                </c:pt>
                <c:pt idx="270">
                  <c:v>608.74400000000003</c:v>
                </c:pt>
                <c:pt idx="271">
                  <c:v>616.97</c:v>
                </c:pt>
                <c:pt idx="272">
                  <c:v>625.19600000000003</c:v>
                </c:pt>
                <c:pt idx="273">
                  <c:v>633.42200000000003</c:v>
                </c:pt>
                <c:pt idx="274">
                  <c:v>641.649</c:v>
                </c:pt>
                <c:pt idx="275">
                  <c:v>643.34199999999998</c:v>
                </c:pt>
                <c:pt idx="276">
                  <c:v>649.875</c:v>
                </c:pt>
                <c:pt idx="277">
                  <c:v>658.101</c:v>
                </c:pt>
                <c:pt idx="278">
                  <c:v>666.327</c:v>
                </c:pt>
                <c:pt idx="279">
                  <c:v>674.55399999999997</c:v>
                </c:pt>
                <c:pt idx="280">
                  <c:v>682.78</c:v>
                </c:pt>
                <c:pt idx="281">
                  <c:v>691.00599999999997</c:v>
                </c:pt>
                <c:pt idx="282">
                  <c:v>699.23199999999997</c:v>
                </c:pt>
                <c:pt idx="283">
                  <c:v>707.45899999999995</c:v>
                </c:pt>
                <c:pt idx="284">
                  <c:v>715.68499999999995</c:v>
                </c:pt>
                <c:pt idx="285">
                  <c:v>723.91099999999994</c:v>
                </c:pt>
                <c:pt idx="286">
                  <c:v>732.13800000000003</c:v>
                </c:pt>
                <c:pt idx="287">
                  <c:v>740.36400000000003</c:v>
                </c:pt>
                <c:pt idx="288">
                  <c:v>748.59</c:v>
                </c:pt>
                <c:pt idx="289">
                  <c:v>756.81600000000003</c:v>
                </c:pt>
                <c:pt idx="290">
                  <c:v>765.04300000000001</c:v>
                </c:pt>
                <c:pt idx="291">
                  <c:v>773.26900000000001</c:v>
                </c:pt>
                <c:pt idx="292">
                  <c:v>781.495</c:v>
                </c:pt>
                <c:pt idx="293">
                  <c:v>789.721</c:v>
                </c:pt>
                <c:pt idx="294">
                  <c:v>793.68700000000001</c:v>
                </c:pt>
                <c:pt idx="295">
                  <c:v>797.94799999999998</c:v>
                </c:pt>
                <c:pt idx="296">
                  <c:v>806.17399999999998</c:v>
                </c:pt>
                <c:pt idx="297">
                  <c:v>814.4</c:v>
                </c:pt>
                <c:pt idx="298">
                  <c:v>822.62599999999998</c:v>
                </c:pt>
                <c:pt idx="299">
                  <c:v>830.85299999999995</c:v>
                </c:pt>
                <c:pt idx="300">
                  <c:v>839.07899999999995</c:v>
                </c:pt>
                <c:pt idx="301">
                  <c:v>847.30499999999995</c:v>
                </c:pt>
                <c:pt idx="302">
                  <c:v>855.53200000000004</c:v>
                </c:pt>
                <c:pt idx="303">
                  <c:v>863.75800000000004</c:v>
                </c:pt>
                <c:pt idx="304">
                  <c:v>871.98400000000004</c:v>
                </c:pt>
                <c:pt idx="305">
                  <c:v>880.21</c:v>
                </c:pt>
                <c:pt idx="306">
                  <c:v>888.43700000000001</c:v>
                </c:pt>
                <c:pt idx="307">
                  <c:v>896.66300000000001</c:v>
                </c:pt>
                <c:pt idx="308">
                  <c:v>904.88900000000001</c:v>
                </c:pt>
                <c:pt idx="309">
                  <c:v>913.11500000000001</c:v>
                </c:pt>
                <c:pt idx="310">
                  <c:v>921.34199999999998</c:v>
                </c:pt>
                <c:pt idx="311">
                  <c:v>929.56799999999998</c:v>
                </c:pt>
                <c:pt idx="312">
                  <c:v>937.79399999999998</c:v>
                </c:pt>
                <c:pt idx="313">
                  <c:v>946.02</c:v>
                </c:pt>
                <c:pt idx="314">
                  <c:v>954.24699999999996</c:v>
                </c:pt>
                <c:pt idx="315">
                  <c:v>962.47299999999996</c:v>
                </c:pt>
                <c:pt idx="316">
                  <c:v>970.69899999999996</c:v>
                </c:pt>
                <c:pt idx="317">
                  <c:v>978.92499999999995</c:v>
                </c:pt>
                <c:pt idx="318">
                  <c:v>981.51499999999999</c:v>
                </c:pt>
                <c:pt idx="319">
                  <c:v>987.15200000000004</c:v>
                </c:pt>
                <c:pt idx="320">
                  <c:v>995.37800000000004</c:v>
                </c:pt>
                <c:pt idx="321">
                  <c:v>1003.604</c:v>
                </c:pt>
                <c:pt idx="322">
                  <c:v>1011.831</c:v>
                </c:pt>
                <c:pt idx="323">
                  <c:v>1020.057</c:v>
                </c:pt>
                <c:pt idx="324">
                  <c:v>1028.2829999999999</c:v>
                </c:pt>
                <c:pt idx="325">
                  <c:v>1036.509</c:v>
                </c:pt>
                <c:pt idx="326">
                  <c:v>1044.7360000000001</c:v>
                </c:pt>
                <c:pt idx="327">
                  <c:v>1052.962</c:v>
                </c:pt>
                <c:pt idx="328">
                  <c:v>1061.1880000000001</c:v>
                </c:pt>
                <c:pt idx="329">
                  <c:v>1069.414</c:v>
                </c:pt>
                <c:pt idx="330">
                  <c:v>1077.6410000000001</c:v>
                </c:pt>
                <c:pt idx="331">
                  <c:v>1085.867</c:v>
                </c:pt>
                <c:pt idx="332">
                  <c:v>1094.0930000000001</c:v>
                </c:pt>
                <c:pt idx="333">
                  <c:v>1102.319</c:v>
                </c:pt>
                <c:pt idx="334">
                  <c:v>1110.546</c:v>
                </c:pt>
                <c:pt idx="335">
                  <c:v>1118.7719999999999</c:v>
                </c:pt>
                <c:pt idx="336">
                  <c:v>1126.998</c:v>
                </c:pt>
                <c:pt idx="337">
                  <c:v>1135.2249999999999</c:v>
                </c:pt>
                <c:pt idx="338">
                  <c:v>1143.451</c:v>
                </c:pt>
                <c:pt idx="339">
                  <c:v>1151.6769999999999</c:v>
                </c:pt>
                <c:pt idx="340">
                  <c:v>1159.903</c:v>
                </c:pt>
                <c:pt idx="341">
                  <c:v>1168.1300000000001</c:v>
                </c:pt>
                <c:pt idx="342">
                  <c:v>1176.356</c:v>
                </c:pt>
                <c:pt idx="343">
                  <c:v>1184.5820000000001</c:v>
                </c:pt>
                <c:pt idx="344">
                  <c:v>1192.808</c:v>
                </c:pt>
                <c:pt idx="345">
                  <c:v>1201.0350000000001</c:v>
                </c:pt>
                <c:pt idx="346">
                  <c:v>1209.261</c:v>
                </c:pt>
                <c:pt idx="347">
                  <c:v>1217.4870000000001</c:v>
                </c:pt>
                <c:pt idx="348">
                  <c:v>1223.2929999999999</c:v>
                </c:pt>
                <c:pt idx="349">
                  <c:v>1225.713</c:v>
                </c:pt>
                <c:pt idx="350">
                  <c:v>1233.94</c:v>
                </c:pt>
                <c:pt idx="351">
                  <c:v>1242.1659999999999</c:v>
                </c:pt>
                <c:pt idx="352">
                  <c:v>1250.3920000000001</c:v>
                </c:pt>
                <c:pt idx="353">
                  <c:v>1258.6179999999999</c:v>
                </c:pt>
                <c:pt idx="354">
                  <c:v>1266.845</c:v>
                </c:pt>
                <c:pt idx="355">
                  <c:v>1275.0709999999999</c:v>
                </c:pt>
                <c:pt idx="356">
                  <c:v>1283.297</c:v>
                </c:pt>
                <c:pt idx="357">
                  <c:v>1291.5239999999999</c:v>
                </c:pt>
                <c:pt idx="358">
                  <c:v>1299.75</c:v>
                </c:pt>
                <c:pt idx="359">
                  <c:v>1307.9760000000001</c:v>
                </c:pt>
                <c:pt idx="360">
                  <c:v>1316.202</c:v>
                </c:pt>
                <c:pt idx="361">
                  <c:v>1324.4290000000001</c:v>
                </c:pt>
                <c:pt idx="362">
                  <c:v>1332.655</c:v>
                </c:pt>
                <c:pt idx="363">
                  <c:v>1340.8810000000001</c:v>
                </c:pt>
                <c:pt idx="364">
                  <c:v>1349.107</c:v>
                </c:pt>
                <c:pt idx="365">
                  <c:v>1357.3340000000001</c:v>
                </c:pt>
                <c:pt idx="366">
                  <c:v>1365.56</c:v>
                </c:pt>
                <c:pt idx="367">
                  <c:v>1373.7860000000001</c:v>
                </c:pt>
                <c:pt idx="368">
                  <c:v>1382.0119999999999</c:v>
                </c:pt>
                <c:pt idx="369">
                  <c:v>1390.239</c:v>
                </c:pt>
                <c:pt idx="370">
                  <c:v>1398.4649999999999</c:v>
                </c:pt>
                <c:pt idx="371">
                  <c:v>1406.691</c:v>
                </c:pt>
                <c:pt idx="372">
                  <c:v>1414.9179999999999</c:v>
                </c:pt>
                <c:pt idx="373">
                  <c:v>1423.144</c:v>
                </c:pt>
                <c:pt idx="374">
                  <c:v>1431.37</c:v>
                </c:pt>
                <c:pt idx="375">
                  <c:v>1439.596</c:v>
                </c:pt>
                <c:pt idx="376">
                  <c:v>1447.8230000000001</c:v>
                </c:pt>
                <c:pt idx="377">
                  <c:v>1456.049</c:v>
                </c:pt>
                <c:pt idx="378">
                  <c:v>1464.2750000000001</c:v>
                </c:pt>
                <c:pt idx="379">
                  <c:v>1472.501</c:v>
                </c:pt>
                <c:pt idx="380">
                  <c:v>1480.7280000000001</c:v>
                </c:pt>
                <c:pt idx="381">
                  <c:v>1488.954</c:v>
                </c:pt>
                <c:pt idx="382">
                  <c:v>1497.18</c:v>
                </c:pt>
                <c:pt idx="383">
                  <c:v>1505.4059999999999</c:v>
                </c:pt>
                <c:pt idx="384">
                  <c:v>1513.633</c:v>
                </c:pt>
                <c:pt idx="385">
                  <c:v>1521.8589999999999</c:v>
                </c:pt>
                <c:pt idx="386">
                  <c:v>1530.085</c:v>
                </c:pt>
                <c:pt idx="387">
                  <c:v>1538.3109999999999</c:v>
                </c:pt>
                <c:pt idx="388">
                  <c:v>1546.538</c:v>
                </c:pt>
                <c:pt idx="389">
                  <c:v>1554.7639999999999</c:v>
                </c:pt>
                <c:pt idx="390">
                  <c:v>1562.99</c:v>
                </c:pt>
                <c:pt idx="391">
                  <c:v>1571.2170000000001</c:v>
                </c:pt>
                <c:pt idx="392">
                  <c:v>1579.443</c:v>
                </c:pt>
                <c:pt idx="393">
                  <c:v>1587.6690000000001</c:v>
                </c:pt>
                <c:pt idx="394">
                  <c:v>1595.895</c:v>
                </c:pt>
                <c:pt idx="395">
                  <c:v>1604.1220000000001</c:v>
                </c:pt>
                <c:pt idx="396">
                  <c:v>1612.348</c:v>
                </c:pt>
                <c:pt idx="397">
                  <c:v>1620.5740000000001</c:v>
                </c:pt>
                <c:pt idx="398">
                  <c:v>1628.8</c:v>
                </c:pt>
                <c:pt idx="399">
                  <c:v>1637.027</c:v>
                </c:pt>
                <c:pt idx="400">
                  <c:v>1645.2529999999999</c:v>
                </c:pt>
                <c:pt idx="401">
                  <c:v>1645.2529999999999</c:v>
                </c:pt>
              </c:numCache>
            </c:numRef>
          </c:xVal>
          <c:yVal>
            <c:numRef>
              <c:f>Foglio6!$L$424:$L$82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</c:v>
                </c:pt>
                <c:pt idx="166">
                  <c:v>17.5</c:v>
                </c:pt>
                <c:pt idx="167">
                  <c:v>17</c:v>
                </c:pt>
                <c:pt idx="168">
                  <c:v>16.5</c:v>
                </c:pt>
                <c:pt idx="169">
                  <c:v>16.495000000000001</c:v>
                </c:pt>
                <c:pt idx="170">
                  <c:v>16</c:v>
                </c:pt>
                <c:pt idx="171">
                  <c:v>15.5</c:v>
                </c:pt>
                <c:pt idx="172">
                  <c:v>15</c:v>
                </c:pt>
                <c:pt idx="173">
                  <c:v>14.5</c:v>
                </c:pt>
                <c:pt idx="174">
                  <c:v>14</c:v>
                </c:pt>
                <c:pt idx="175">
                  <c:v>13.5</c:v>
                </c:pt>
                <c:pt idx="176">
                  <c:v>13.401999999999999</c:v>
                </c:pt>
                <c:pt idx="177">
                  <c:v>13</c:v>
                </c:pt>
                <c:pt idx="178">
                  <c:v>12.5</c:v>
                </c:pt>
                <c:pt idx="179">
                  <c:v>12</c:v>
                </c:pt>
                <c:pt idx="180">
                  <c:v>11.739000000000001</c:v>
                </c:pt>
                <c:pt idx="181">
                  <c:v>11.5</c:v>
                </c:pt>
                <c:pt idx="182">
                  <c:v>11</c:v>
                </c:pt>
                <c:pt idx="183">
                  <c:v>10.667999999999999</c:v>
                </c:pt>
                <c:pt idx="184">
                  <c:v>10.5</c:v>
                </c:pt>
                <c:pt idx="185">
                  <c:v>10</c:v>
                </c:pt>
                <c:pt idx="186">
                  <c:v>9.8379999999999992</c:v>
                </c:pt>
                <c:pt idx="187">
                  <c:v>9.5</c:v>
                </c:pt>
                <c:pt idx="188">
                  <c:v>9.1850000000000005</c:v>
                </c:pt>
                <c:pt idx="189">
                  <c:v>9</c:v>
                </c:pt>
                <c:pt idx="190">
                  <c:v>8.6760000000000002</c:v>
                </c:pt>
                <c:pt idx="191">
                  <c:v>8.5</c:v>
                </c:pt>
                <c:pt idx="192">
                  <c:v>8.2430000000000003</c:v>
                </c:pt>
                <c:pt idx="193">
                  <c:v>8</c:v>
                </c:pt>
                <c:pt idx="194">
                  <c:v>7.8689999999999998</c:v>
                </c:pt>
                <c:pt idx="195">
                  <c:v>7.5190000000000001</c:v>
                </c:pt>
                <c:pt idx="196">
                  <c:v>7.5</c:v>
                </c:pt>
                <c:pt idx="197">
                  <c:v>7.2290000000000001</c:v>
                </c:pt>
                <c:pt idx="198">
                  <c:v>7</c:v>
                </c:pt>
                <c:pt idx="199">
                  <c:v>6.98</c:v>
                </c:pt>
                <c:pt idx="200">
                  <c:v>6.7249999999999996</c:v>
                </c:pt>
                <c:pt idx="201">
                  <c:v>6.5030000000000001</c:v>
                </c:pt>
                <c:pt idx="202">
                  <c:v>6.5</c:v>
                </c:pt>
                <c:pt idx="203">
                  <c:v>6.3070000000000004</c:v>
                </c:pt>
                <c:pt idx="204">
                  <c:v>6.1210000000000004</c:v>
                </c:pt>
                <c:pt idx="205">
                  <c:v>6</c:v>
                </c:pt>
                <c:pt idx="206">
                  <c:v>5.9450000000000003</c:v>
                </c:pt>
                <c:pt idx="207">
                  <c:v>5.7729999999999997</c:v>
                </c:pt>
                <c:pt idx="208">
                  <c:v>5.6289999999999996</c:v>
                </c:pt>
                <c:pt idx="209">
                  <c:v>5.5</c:v>
                </c:pt>
                <c:pt idx="210">
                  <c:v>5.4870000000000001</c:v>
                </c:pt>
                <c:pt idx="211">
                  <c:v>5.3419999999999996</c:v>
                </c:pt>
                <c:pt idx="212">
                  <c:v>5.2080000000000002</c:v>
                </c:pt>
                <c:pt idx="213">
                  <c:v>5.0830000000000002</c:v>
                </c:pt>
                <c:pt idx="214">
                  <c:v>5</c:v>
                </c:pt>
                <c:pt idx="215">
                  <c:v>4.968</c:v>
                </c:pt>
                <c:pt idx="216">
                  <c:v>4.8559999999999999</c:v>
                </c:pt>
                <c:pt idx="217">
                  <c:v>4.7590000000000003</c:v>
                </c:pt>
                <c:pt idx="218">
                  <c:v>4.67</c:v>
                </c:pt>
                <c:pt idx="219">
                  <c:v>4.5650000000000004</c:v>
                </c:pt>
                <c:pt idx="220">
                  <c:v>4.5</c:v>
                </c:pt>
                <c:pt idx="221">
                  <c:v>4.4729999999999999</c:v>
                </c:pt>
                <c:pt idx="222">
                  <c:v>4.3689999999999998</c:v>
                </c:pt>
                <c:pt idx="223">
                  <c:v>4.2880000000000003</c:v>
                </c:pt>
                <c:pt idx="224">
                  <c:v>4.202</c:v>
                </c:pt>
                <c:pt idx="225">
                  <c:v>4.1260000000000003</c:v>
                </c:pt>
                <c:pt idx="226">
                  <c:v>4.0529999999999999</c:v>
                </c:pt>
                <c:pt idx="227">
                  <c:v>4</c:v>
                </c:pt>
                <c:pt idx="228">
                  <c:v>3.9729999999999999</c:v>
                </c:pt>
                <c:pt idx="229">
                  <c:v>3.911</c:v>
                </c:pt>
                <c:pt idx="230">
                  <c:v>3.8420000000000001</c:v>
                </c:pt>
                <c:pt idx="231">
                  <c:v>3.77</c:v>
                </c:pt>
                <c:pt idx="232">
                  <c:v>3.7090000000000001</c:v>
                </c:pt>
                <c:pt idx="233">
                  <c:v>3.645</c:v>
                </c:pt>
                <c:pt idx="234">
                  <c:v>3.5750000000000002</c:v>
                </c:pt>
                <c:pt idx="235">
                  <c:v>3.5179999999999998</c:v>
                </c:pt>
                <c:pt idx="236">
                  <c:v>3.5</c:v>
                </c:pt>
                <c:pt idx="237">
                  <c:v>3.4550000000000001</c:v>
                </c:pt>
                <c:pt idx="238">
                  <c:v>3.403</c:v>
                </c:pt>
                <c:pt idx="239">
                  <c:v>3.3490000000000002</c:v>
                </c:pt>
                <c:pt idx="240">
                  <c:v>3.2959999999999998</c:v>
                </c:pt>
                <c:pt idx="241">
                  <c:v>3.24</c:v>
                </c:pt>
                <c:pt idx="242">
                  <c:v>3.194</c:v>
                </c:pt>
                <c:pt idx="243">
                  <c:v>3.14</c:v>
                </c:pt>
                <c:pt idx="244">
                  <c:v>3.089</c:v>
                </c:pt>
                <c:pt idx="245">
                  <c:v>3.0390000000000001</c:v>
                </c:pt>
                <c:pt idx="246">
                  <c:v>3</c:v>
                </c:pt>
                <c:pt idx="247">
                  <c:v>2.9910000000000001</c:v>
                </c:pt>
                <c:pt idx="248">
                  <c:v>2.9409999999999998</c:v>
                </c:pt>
                <c:pt idx="249">
                  <c:v>2.895</c:v>
                </c:pt>
                <c:pt idx="250">
                  <c:v>2.8519999999999999</c:v>
                </c:pt>
                <c:pt idx="251">
                  <c:v>2.8170000000000002</c:v>
                </c:pt>
                <c:pt idx="252">
                  <c:v>2.7709999999999999</c:v>
                </c:pt>
                <c:pt idx="253">
                  <c:v>2.7269999999999999</c:v>
                </c:pt>
                <c:pt idx="254">
                  <c:v>2.6890000000000001</c:v>
                </c:pt>
                <c:pt idx="255">
                  <c:v>2.6429999999999998</c:v>
                </c:pt>
                <c:pt idx="256">
                  <c:v>2.6019999999999999</c:v>
                </c:pt>
                <c:pt idx="257">
                  <c:v>2.556</c:v>
                </c:pt>
                <c:pt idx="258">
                  <c:v>2.5150000000000001</c:v>
                </c:pt>
                <c:pt idx="259">
                  <c:v>2.5</c:v>
                </c:pt>
                <c:pt idx="260">
                  <c:v>2.4780000000000002</c:v>
                </c:pt>
                <c:pt idx="261">
                  <c:v>2.44</c:v>
                </c:pt>
                <c:pt idx="262">
                  <c:v>2.41</c:v>
                </c:pt>
                <c:pt idx="263">
                  <c:v>2.375</c:v>
                </c:pt>
                <c:pt idx="264">
                  <c:v>2.3380000000000001</c:v>
                </c:pt>
                <c:pt idx="265">
                  <c:v>2.3029999999999999</c:v>
                </c:pt>
                <c:pt idx="266">
                  <c:v>2.258</c:v>
                </c:pt>
                <c:pt idx="267">
                  <c:v>2.2170000000000001</c:v>
                </c:pt>
                <c:pt idx="268">
                  <c:v>2.1890000000000001</c:v>
                </c:pt>
                <c:pt idx="269">
                  <c:v>2.1549999999999998</c:v>
                </c:pt>
                <c:pt idx="270">
                  <c:v>2.121</c:v>
                </c:pt>
                <c:pt idx="271">
                  <c:v>2.0910000000000002</c:v>
                </c:pt>
                <c:pt idx="272">
                  <c:v>2.06</c:v>
                </c:pt>
                <c:pt idx="273">
                  <c:v>2.0270000000000001</c:v>
                </c:pt>
                <c:pt idx="274">
                  <c:v>2.0059999999999998</c:v>
                </c:pt>
                <c:pt idx="275">
                  <c:v>2</c:v>
                </c:pt>
                <c:pt idx="276">
                  <c:v>1.9750000000000001</c:v>
                </c:pt>
                <c:pt idx="277">
                  <c:v>1.9490000000000001</c:v>
                </c:pt>
                <c:pt idx="278">
                  <c:v>1.921</c:v>
                </c:pt>
                <c:pt idx="279">
                  <c:v>1.8919999999999999</c:v>
                </c:pt>
                <c:pt idx="280">
                  <c:v>1.855</c:v>
                </c:pt>
                <c:pt idx="281">
                  <c:v>1.825</c:v>
                </c:pt>
                <c:pt idx="282">
                  <c:v>1.792</c:v>
                </c:pt>
                <c:pt idx="283">
                  <c:v>1.766</c:v>
                </c:pt>
                <c:pt idx="284">
                  <c:v>1.7370000000000001</c:v>
                </c:pt>
                <c:pt idx="285">
                  <c:v>1.7050000000000001</c:v>
                </c:pt>
                <c:pt idx="286">
                  <c:v>1.68</c:v>
                </c:pt>
                <c:pt idx="287">
                  <c:v>1.655</c:v>
                </c:pt>
                <c:pt idx="288">
                  <c:v>1.631</c:v>
                </c:pt>
                <c:pt idx="289">
                  <c:v>1.6060000000000001</c:v>
                </c:pt>
                <c:pt idx="290">
                  <c:v>1.581</c:v>
                </c:pt>
                <c:pt idx="291">
                  <c:v>1.5529999999999999</c:v>
                </c:pt>
                <c:pt idx="292">
                  <c:v>1.532</c:v>
                </c:pt>
                <c:pt idx="293">
                  <c:v>1.51</c:v>
                </c:pt>
                <c:pt idx="294">
                  <c:v>1.5</c:v>
                </c:pt>
                <c:pt idx="295">
                  <c:v>1.484</c:v>
                </c:pt>
                <c:pt idx="296">
                  <c:v>1.4630000000000001</c:v>
                </c:pt>
                <c:pt idx="297">
                  <c:v>1.444</c:v>
                </c:pt>
                <c:pt idx="298">
                  <c:v>1.419</c:v>
                </c:pt>
                <c:pt idx="299">
                  <c:v>1.3939999999999999</c:v>
                </c:pt>
                <c:pt idx="300">
                  <c:v>1.373</c:v>
                </c:pt>
                <c:pt idx="301">
                  <c:v>1.3480000000000001</c:v>
                </c:pt>
                <c:pt idx="302">
                  <c:v>1.32</c:v>
                </c:pt>
                <c:pt idx="303">
                  <c:v>1.296</c:v>
                </c:pt>
                <c:pt idx="304">
                  <c:v>1.2669999999999999</c:v>
                </c:pt>
                <c:pt idx="305">
                  <c:v>1.248</c:v>
                </c:pt>
                <c:pt idx="306">
                  <c:v>1.2270000000000001</c:v>
                </c:pt>
                <c:pt idx="307">
                  <c:v>1.208</c:v>
                </c:pt>
                <c:pt idx="308">
                  <c:v>1.1890000000000001</c:v>
                </c:pt>
                <c:pt idx="309">
                  <c:v>1.1679999999999999</c:v>
                </c:pt>
                <c:pt idx="310">
                  <c:v>1.1479999999999999</c:v>
                </c:pt>
                <c:pt idx="311">
                  <c:v>1.1299999999999999</c:v>
                </c:pt>
                <c:pt idx="312">
                  <c:v>1.1080000000000001</c:v>
                </c:pt>
                <c:pt idx="313">
                  <c:v>1.0880000000000001</c:v>
                </c:pt>
                <c:pt idx="314">
                  <c:v>1.0660000000000001</c:v>
                </c:pt>
                <c:pt idx="315">
                  <c:v>1.0449999999999999</c:v>
                </c:pt>
                <c:pt idx="316">
                  <c:v>1.026</c:v>
                </c:pt>
                <c:pt idx="317">
                  <c:v>1.0069999999999999</c:v>
                </c:pt>
                <c:pt idx="318">
                  <c:v>1</c:v>
                </c:pt>
                <c:pt idx="319">
                  <c:v>0.98599999999999999</c:v>
                </c:pt>
                <c:pt idx="320">
                  <c:v>0.96699999999999997</c:v>
                </c:pt>
                <c:pt idx="321">
                  <c:v>0.95</c:v>
                </c:pt>
                <c:pt idx="322">
                  <c:v>0.93200000000000005</c:v>
                </c:pt>
                <c:pt idx="323">
                  <c:v>0.91400000000000003</c:v>
                </c:pt>
                <c:pt idx="324">
                  <c:v>0.89500000000000002</c:v>
                </c:pt>
                <c:pt idx="325">
                  <c:v>0.878</c:v>
                </c:pt>
                <c:pt idx="326">
                  <c:v>0.86099999999999999</c:v>
                </c:pt>
                <c:pt idx="327">
                  <c:v>0.84099999999999997</c:v>
                </c:pt>
                <c:pt idx="328">
                  <c:v>0.81899999999999995</c:v>
                </c:pt>
                <c:pt idx="329">
                  <c:v>0.80200000000000005</c:v>
                </c:pt>
                <c:pt idx="330">
                  <c:v>0.78800000000000003</c:v>
                </c:pt>
                <c:pt idx="331">
                  <c:v>0.77100000000000002</c:v>
                </c:pt>
                <c:pt idx="332">
                  <c:v>0.754</c:v>
                </c:pt>
                <c:pt idx="333">
                  <c:v>0.73499999999999999</c:v>
                </c:pt>
                <c:pt idx="334">
                  <c:v>0.72</c:v>
                </c:pt>
                <c:pt idx="335">
                  <c:v>0.70299999999999996</c:v>
                </c:pt>
                <c:pt idx="336">
                  <c:v>0.68899999999999995</c:v>
                </c:pt>
                <c:pt idx="337">
                  <c:v>0.67500000000000004</c:v>
                </c:pt>
                <c:pt idx="338">
                  <c:v>0.65500000000000003</c:v>
                </c:pt>
                <c:pt idx="339">
                  <c:v>0.63700000000000001</c:v>
                </c:pt>
                <c:pt idx="340">
                  <c:v>0.623</c:v>
                </c:pt>
                <c:pt idx="341">
                  <c:v>0.60199999999999998</c:v>
                </c:pt>
                <c:pt idx="342">
                  <c:v>0.58899999999999997</c:v>
                </c:pt>
                <c:pt idx="343">
                  <c:v>0.57499999999999996</c:v>
                </c:pt>
                <c:pt idx="344">
                  <c:v>0.55800000000000005</c:v>
                </c:pt>
                <c:pt idx="345">
                  <c:v>0.54100000000000004</c:v>
                </c:pt>
                <c:pt idx="346">
                  <c:v>0.52500000000000002</c:v>
                </c:pt>
                <c:pt idx="347">
                  <c:v>0.51100000000000001</c:v>
                </c:pt>
                <c:pt idx="348">
                  <c:v>0.5</c:v>
                </c:pt>
                <c:pt idx="349">
                  <c:v>0.497</c:v>
                </c:pt>
                <c:pt idx="350">
                  <c:v>0.48</c:v>
                </c:pt>
                <c:pt idx="351">
                  <c:v>0.46500000000000002</c:v>
                </c:pt>
                <c:pt idx="352">
                  <c:v>0.45300000000000001</c:v>
                </c:pt>
                <c:pt idx="353">
                  <c:v>0.44</c:v>
                </c:pt>
                <c:pt idx="354">
                  <c:v>0.42299999999999999</c:v>
                </c:pt>
                <c:pt idx="355">
                  <c:v>0.40799999999999997</c:v>
                </c:pt>
                <c:pt idx="356">
                  <c:v>0.39700000000000002</c:v>
                </c:pt>
                <c:pt idx="357">
                  <c:v>0.38500000000000001</c:v>
                </c:pt>
                <c:pt idx="358">
                  <c:v>0.372</c:v>
                </c:pt>
                <c:pt idx="359">
                  <c:v>0.35499999999999998</c:v>
                </c:pt>
                <c:pt idx="360">
                  <c:v>0.34200000000000003</c:v>
                </c:pt>
                <c:pt idx="361">
                  <c:v>0.33</c:v>
                </c:pt>
                <c:pt idx="362">
                  <c:v>0.316</c:v>
                </c:pt>
                <c:pt idx="363">
                  <c:v>0.30099999999999999</c:v>
                </c:pt>
                <c:pt idx="364">
                  <c:v>0.28599999999999998</c:v>
                </c:pt>
                <c:pt idx="365">
                  <c:v>0.27100000000000002</c:v>
                </c:pt>
                <c:pt idx="366">
                  <c:v>0.25800000000000001</c:v>
                </c:pt>
                <c:pt idx="367">
                  <c:v>0.247</c:v>
                </c:pt>
                <c:pt idx="368">
                  <c:v>0.23300000000000001</c:v>
                </c:pt>
                <c:pt idx="369">
                  <c:v>0.222</c:v>
                </c:pt>
                <c:pt idx="370">
                  <c:v>0.20799999999999999</c:v>
                </c:pt>
                <c:pt idx="371">
                  <c:v>0.192</c:v>
                </c:pt>
                <c:pt idx="372">
                  <c:v>0.184</c:v>
                </c:pt>
                <c:pt idx="373">
                  <c:v>0.17100000000000001</c:v>
                </c:pt>
                <c:pt idx="374">
                  <c:v>0.16</c:v>
                </c:pt>
                <c:pt idx="375">
                  <c:v>0.14699999999999999</c:v>
                </c:pt>
                <c:pt idx="376">
                  <c:v>0.14000000000000001</c:v>
                </c:pt>
                <c:pt idx="377">
                  <c:v>0.126</c:v>
                </c:pt>
                <c:pt idx="378">
                  <c:v>0.113</c:v>
                </c:pt>
                <c:pt idx="379">
                  <c:v>0.1</c:v>
                </c:pt>
                <c:pt idx="380">
                  <c:v>8.8999999999999996E-2</c:v>
                </c:pt>
                <c:pt idx="381">
                  <c:v>0.08</c:v>
                </c:pt>
                <c:pt idx="382">
                  <c:v>7.0999999999999994E-2</c:v>
                </c:pt>
                <c:pt idx="383">
                  <c:v>6.0999999999999999E-2</c:v>
                </c:pt>
                <c:pt idx="384">
                  <c:v>5.5E-2</c:v>
                </c:pt>
                <c:pt idx="385">
                  <c:v>4.4999999999999998E-2</c:v>
                </c:pt>
                <c:pt idx="386">
                  <c:v>3.4000000000000002E-2</c:v>
                </c:pt>
                <c:pt idx="387">
                  <c:v>2.5999999999999999E-2</c:v>
                </c:pt>
                <c:pt idx="388">
                  <c:v>2.1000000000000001E-2</c:v>
                </c:pt>
                <c:pt idx="389">
                  <c:v>1.4999999999999999E-2</c:v>
                </c:pt>
                <c:pt idx="390">
                  <c:v>1.0999999999999999E-2</c:v>
                </c:pt>
                <c:pt idx="391">
                  <c:v>8.0000000000000002E-3</c:v>
                </c:pt>
                <c:pt idx="392">
                  <c:v>5.0000000000000001E-3</c:v>
                </c:pt>
                <c:pt idx="393">
                  <c:v>4.0000000000000001E-3</c:v>
                </c:pt>
                <c:pt idx="394">
                  <c:v>3.0000000000000001E-3</c:v>
                </c:pt>
                <c:pt idx="395">
                  <c:v>2E-3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C237-45B1-A7AA-312291C873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3823016"/>
        <c:axId val="513821376"/>
      </c:scatterChart>
      <c:valAx>
        <c:axId val="513823016"/>
        <c:scaling>
          <c:orientation val="minMax"/>
          <c:max val="15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/>
                  <a:t>Dose [cGy(RBE)]</a:t>
                </a:r>
              </a:p>
            </c:rich>
          </c:tx>
          <c:layout>
            <c:manualLayout>
              <c:xMode val="edge"/>
              <c:yMode val="edge"/>
              <c:x val="0.40460912698412699"/>
              <c:y val="0.867602222222222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1376"/>
        <c:crosses val="autoZero"/>
        <c:crossBetween val="midCat"/>
      </c:valAx>
      <c:valAx>
        <c:axId val="513821376"/>
        <c:scaling>
          <c:orientation val="minMax"/>
          <c:max val="2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/>
                  <a:t>Volume</a:t>
                </a:r>
                <a:r>
                  <a:rPr lang="it-IT" sz="800" baseline="0"/>
                  <a:t> [%]</a:t>
                </a:r>
                <a:endParaRPr lang="it-IT" sz="800"/>
              </a:p>
            </c:rich>
          </c:tx>
          <c:layout>
            <c:manualLayout>
              <c:xMode val="edge"/>
              <c:yMode val="edge"/>
              <c:x val="2.5198412698412699E-2"/>
              <c:y val="0.236921666666666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3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2831746031746"/>
          <c:y val="7.7611111111111117E-2"/>
          <c:w val="0.75096825396825395"/>
          <c:h val="0.66864777777777773"/>
        </c:manualLayout>
      </c:layout>
      <c:scatterChart>
        <c:scatterStyle val="lineMarker"/>
        <c:varyColors val="0"/>
        <c:ser>
          <c:idx val="0"/>
          <c:order val="0"/>
          <c:tx>
            <c:strRef>
              <c:f>Foglio6!$A$1</c:f>
              <c:strCache>
                <c:ptCount val="1"/>
                <c:pt idx="0">
                  <c:v>S0,5NA</c:v>
                </c:pt>
              </c:strCache>
            </c:strRef>
          </c:tx>
          <c:spPr>
            <a:ln w="19050" cap="rnd">
              <a:solidFill>
                <a:srgbClr val="9DC3E6"/>
              </a:solidFill>
              <a:round/>
            </a:ln>
            <a:effectLst/>
          </c:spPr>
          <c:marker>
            <c:symbol val="none"/>
          </c:marker>
          <c:xVal>
            <c:numRef>
              <c:f>Foglio6!$A$5:$A$406</c:f>
              <c:numCache>
                <c:formatCode>General</c:formatCode>
                <c:ptCount val="402"/>
                <c:pt idx="0">
                  <c:v>0</c:v>
                </c:pt>
                <c:pt idx="1">
                  <c:v>8.0640000000000001</c:v>
                </c:pt>
                <c:pt idx="2">
                  <c:v>16.126999999999999</c:v>
                </c:pt>
                <c:pt idx="3">
                  <c:v>24.190999999999999</c:v>
                </c:pt>
                <c:pt idx="4">
                  <c:v>32.253999999999998</c:v>
                </c:pt>
                <c:pt idx="5">
                  <c:v>40.317999999999998</c:v>
                </c:pt>
                <c:pt idx="6">
                  <c:v>48.381999999999998</c:v>
                </c:pt>
                <c:pt idx="7">
                  <c:v>56.445</c:v>
                </c:pt>
                <c:pt idx="8">
                  <c:v>64.509</c:v>
                </c:pt>
                <c:pt idx="9">
                  <c:v>72.572999999999993</c:v>
                </c:pt>
                <c:pt idx="10">
                  <c:v>80.635999999999996</c:v>
                </c:pt>
                <c:pt idx="11">
                  <c:v>88.7</c:v>
                </c:pt>
                <c:pt idx="12">
                  <c:v>96.763000000000005</c:v>
                </c:pt>
                <c:pt idx="13">
                  <c:v>104.827</c:v>
                </c:pt>
                <c:pt idx="14">
                  <c:v>112.89100000000001</c:v>
                </c:pt>
                <c:pt idx="15">
                  <c:v>120.95399999999999</c:v>
                </c:pt>
                <c:pt idx="16">
                  <c:v>129.018</c:v>
                </c:pt>
                <c:pt idx="17">
                  <c:v>137.08099999999999</c:v>
                </c:pt>
                <c:pt idx="18">
                  <c:v>145.14500000000001</c:v>
                </c:pt>
                <c:pt idx="19">
                  <c:v>153.209</c:v>
                </c:pt>
                <c:pt idx="20">
                  <c:v>161.27199999999999</c:v>
                </c:pt>
                <c:pt idx="21">
                  <c:v>169.33600000000001</c:v>
                </c:pt>
                <c:pt idx="22">
                  <c:v>177.4</c:v>
                </c:pt>
                <c:pt idx="23">
                  <c:v>185.46299999999999</c:v>
                </c:pt>
                <c:pt idx="24">
                  <c:v>193.52699999999999</c:v>
                </c:pt>
                <c:pt idx="25">
                  <c:v>201.59</c:v>
                </c:pt>
                <c:pt idx="26">
                  <c:v>209.654</c:v>
                </c:pt>
                <c:pt idx="27">
                  <c:v>217.71799999999999</c:v>
                </c:pt>
                <c:pt idx="28">
                  <c:v>225.78100000000001</c:v>
                </c:pt>
                <c:pt idx="29">
                  <c:v>233.845</c:v>
                </c:pt>
                <c:pt idx="30">
                  <c:v>241.90899999999999</c:v>
                </c:pt>
                <c:pt idx="31">
                  <c:v>249.97200000000001</c:v>
                </c:pt>
                <c:pt idx="32">
                  <c:v>258.036</c:v>
                </c:pt>
                <c:pt idx="33">
                  <c:v>266.09899999999999</c:v>
                </c:pt>
                <c:pt idx="34">
                  <c:v>274.16300000000001</c:v>
                </c:pt>
                <c:pt idx="35">
                  <c:v>282.22699999999998</c:v>
                </c:pt>
                <c:pt idx="36">
                  <c:v>290.29000000000002</c:v>
                </c:pt>
                <c:pt idx="37">
                  <c:v>298.35399999999998</c:v>
                </c:pt>
                <c:pt idx="38">
                  <c:v>306.41699999999997</c:v>
                </c:pt>
                <c:pt idx="39">
                  <c:v>314.48099999999999</c:v>
                </c:pt>
                <c:pt idx="40">
                  <c:v>322.54500000000002</c:v>
                </c:pt>
                <c:pt idx="41">
                  <c:v>330.608</c:v>
                </c:pt>
                <c:pt idx="42">
                  <c:v>338.67200000000003</c:v>
                </c:pt>
                <c:pt idx="43">
                  <c:v>346.73599999999999</c:v>
                </c:pt>
                <c:pt idx="44">
                  <c:v>354.79899999999998</c:v>
                </c:pt>
                <c:pt idx="45">
                  <c:v>362.863</c:v>
                </c:pt>
                <c:pt idx="46">
                  <c:v>370.92599999999999</c:v>
                </c:pt>
                <c:pt idx="47">
                  <c:v>378.99</c:v>
                </c:pt>
                <c:pt idx="48">
                  <c:v>387.05399999999997</c:v>
                </c:pt>
                <c:pt idx="49">
                  <c:v>395.11700000000002</c:v>
                </c:pt>
                <c:pt idx="50">
                  <c:v>403.18099999999998</c:v>
                </c:pt>
                <c:pt idx="51">
                  <c:v>411.24400000000003</c:v>
                </c:pt>
                <c:pt idx="52">
                  <c:v>419.30799999999999</c:v>
                </c:pt>
                <c:pt idx="53">
                  <c:v>427.37200000000001</c:v>
                </c:pt>
                <c:pt idx="54">
                  <c:v>435.435</c:v>
                </c:pt>
                <c:pt idx="55">
                  <c:v>443.49900000000002</c:v>
                </c:pt>
                <c:pt idx="56">
                  <c:v>451.56299999999999</c:v>
                </c:pt>
                <c:pt idx="57">
                  <c:v>459.62599999999998</c:v>
                </c:pt>
                <c:pt idx="58">
                  <c:v>467.69</c:v>
                </c:pt>
                <c:pt idx="59">
                  <c:v>475.75299999999999</c:v>
                </c:pt>
                <c:pt idx="60">
                  <c:v>483.81700000000001</c:v>
                </c:pt>
                <c:pt idx="61">
                  <c:v>491.88099999999997</c:v>
                </c:pt>
                <c:pt idx="62">
                  <c:v>499.94400000000002</c:v>
                </c:pt>
                <c:pt idx="63">
                  <c:v>508.00799999999998</c:v>
                </c:pt>
                <c:pt idx="64">
                  <c:v>516.072</c:v>
                </c:pt>
                <c:pt idx="65">
                  <c:v>524.13499999999999</c:v>
                </c:pt>
                <c:pt idx="66">
                  <c:v>532.19899999999996</c:v>
                </c:pt>
                <c:pt idx="67">
                  <c:v>540.26199999999994</c:v>
                </c:pt>
                <c:pt idx="68">
                  <c:v>548.32600000000002</c:v>
                </c:pt>
                <c:pt idx="69">
                  <c:v>556.39</c:v>
                </c:pt>
                <c:pt idx="70">
                  <c:v>564.45299999999997</c:v>
                </c:pt>
                <c:pt idx="71">
                  <c:v>572.51700000000005</c:v>
                </c:pt>
                <c:pt idx="72">
                  <c:v>580.58000000000004</c:v>
                </c:pt>
                <c:pt idx="73">
                  <c:v>588.64400000000001</c:v>
                </c:pt>
                <c:pt idx="74">
                  <c:v>596.70799999999997</c:v>
                </c:pt>
                <c:pt idx="75">
                  <c:v>604.77099999999996</c:v>
                </c:pt>
                <c:pt idx="76">
                  <c:v>612.83500000000004</c:v>
                </c:pt>
                <c:pt idx="77">
                  <c:v>620.899</c:v>
                </c:pt>
                <c:pt idx="78">
                  <c:v>628.96199999999999</c:v>
                </c:pt>
                <c:pt idx="79">
                  <c:v>637.02599999999995</c:v>
                </c:pt>
                <c:pt idx="80">
                  <c:v>645.08900000000006</c:v>
                </c:pt>
                <c:pt idx="81">
                  <c:v>653.15300000000002</c:v>
                </c:pt>
                <c:pt idx="82">
                  <c:v>661.21699999999998</c:v>
                </c:pt>
                <c:pt idx="83">
                  <c:v>669.28</c:v>
                </c:pt>
                <c:pt idx="84">
                  <c:v>677.34400000000005</c:v>
                </c:pt>
                <c:pt idx="85">
                  <c:v>685.40700000000004</c:v>
                </c:pt>
                <c:pt idx="86">
                  <c:v>693.471</c:v>
                </c:pt>
                <c:pt idx="87">
                  <c:v>701.53499999999997</c:v>
                </c:pt>
                <c:pt idx="88">
                  <c:v>709.59799999999996</c:v>
                </c:pt>
                <c:pt idx="89">
                  <c:v>717.66200000000003</c:v>
                </c:pt>
                <c:pt idx="90">
                  <c:v>725.726</c:v>
                </c:pt>
                <c:pt idx="91">
                  <c:v>733.78899999999999</c:v>
                </c:pt>
                <c:pt idx="92">
                  <c:v>741.85299999999995</c:v>
                </c:pt>
                <c:pt idx="93">
                  <c:v>749.91600000000005</c:v>
                </c:pt>
                <c:pt idx="94">
                  <c:v>757.98</c:v>
                </c:pt>
                <c:pt idx="95">
                  <c:v>766.04399999999998</c:v>
                </c:pt>
                <c:pt idx="96">
                  <c:v>774.10699999999997</c:v>
                </c:pt>
                <c:pt idx="97">
                  <c:v>782.17100000000005</c:v>
                </c:pt>
                <c:pt idx="98">
                  <c:v>790.23500000000001</c:v>
                </c:pt>
                <c:pt idx="99">
                  <c:v>798.298</c:v>
                </c:pt>
                <c:pt idx="100">
                  <c:v>806.36199999999997</c:v>
                </c:pt>
                <c:pt idx="101">
                  <c:v>814.42499999999995</c:v>
                </c:pt>
                <c:pt idx="102">
                  <c:v>822.48900000000003</c:v>
                </c:pt>
                <c:pt idx="103">
                  <c:v>830.553</c:v>
                </c:pt>
                <c:pt idx="104">
                  <c:v>838.61599999999999</c:v>
                </c:pt>
                <c:pt idx="105">
                  <c:v>846.68</c:v>
                </c:pt>
                <c:pt idx="106">
                  <c:v>854.74300000000005</c:v>
                </c:pt>
                <c:pt idx="107">
                  <c:v>862.80700000000002</c:v>
                </c:pt>
                <c:pt idx="108">
                  <c:v>870.87099999999998</c:v>
                </c:pt>
                <c:pt idx="109">
                  <c:v>878.93399999999997</c:v>
                </c:pt>
                <c:pt idx="110">
                  <c:v>886.99800000000005</c:v>
                </c:pt>
                <c:pt idx="111">
                  <c:v>895.06200000000001</c:v>
                </c:pt>
                <c:pt idx="112">
                  <c:v>903.125</c:v>
                </c:pt>
                <c:pt idx="113">
                  <c:v>911.18899999999996</c:v>
                </c:pt>
                <c:pt idx="114">
                  <c:v>919.25199999999995</c:v>
                </c:pt>
                <c:pt idx="115">
                  <c:v>927.31600000000003</c:v>
                </c:pt>
                <c:pt idx="116">
                  <c:v>935.38</c:v>
                </c:pt>
                <c:pt idx="117">
                  <c:v>943.44299999999998</c:v>
                </c:pt>
                <c:pt idx="118">
                  <c:v>951.50699999999995</c:v>
                </c:pt>
                <c:pt idx="119">
                  <c:v>959.57</c:v>
                </c:pt>
                <c:pt idx="120">
                  <c:v>967.63400000000001</c:v>
                </c:pt>
                <c:pt idx="121">
                  <c:v>975.69799999999998</c:v>
                </c:pt>
                <c:pt idx="122">
                  <c:v>983.76099999999997</c:v>
                </c:pt>
                <c:pt idx="123">
                  <c:v>991.82500000000005</c:v>
                </c:pt>
                <c:pt idx="124">
                  <c:v>999.88900000000001</c:v>
                </c:pt>
                <c:pt idx="125">
                  <c:v>1007.952</c:v>
                </c:pt>
                <c:pt idx="126">
                  <c:v>1016.016</c:v>
                </c:pt>
                <c:pt idx="127">
                  <c:v>1024.079</c:v>
                </c:pt>
                <c:pt idx="128">
                  <c:v>1032.143</c:v>
                </c:pt>
                <c:pt idx="129">
                  <c:v>1040.2070000000001</c:v>
                </c:pt>
                <c:pt idx="130">
                  <c:v>1048.27</c:v>
                </c:pt>
                <c:pt idx="131">
                  <c:v>1056.3340000000001</c:v>
                </c:pt>
                <c:pt idx="132">
                  <c:v>1064.3979999999999</c:v>
                </c:pt>
                <c:pt idx="133">
                  <c:v>1072.461</c:v>
                </c:pt>
                <c:pt idx="134">
                  <c:v>1080.5250000000001</c:v>
                </c:pt>
                <c:pt idx="135">
                  <c:v>1088.588</c:v>
                </c:pt>
                <c:pt idx="136">
                  <c:v>1096.652</c:v>
                </c:pt>
                <c:pt idx="137">
                  <c:v>1104.7159999999999</c:v>
                </c:pt>
                <c:pt idx="138">
                  <c:v>1112.779</c:v>
                </c:pt>
                <c:pt idx="139">
                  <c:v>1120.8430000000001</c:v>
                </c:pt>
                <c:pt idx="140">
                  <c:v>1128.9059999999999</c:v>
                </c:pt>
                <c:pt idx="141">
                  <c:v>1136.97</c:v>
                </c:pt>
                <c:pt idx="142">
                  <c:v>1145.0340000000001</c:v>
                </c:pt>
                <c:pt idx="143">
                  <c:v>1153.097</c:v>
                </c:pt>
                <c:pt idx="144">
                  <c:v>1161.1610000000001</c:v>
                </c:pt>
                <c:pt idx="145">
                  <c:v>1169.2249999999999</c:v>
                </c:pt>
                <c:pt idx="146">
                  <c:v>1177.288</c:v>
                </c:pt>
                <c:pt idx="147">
                  <c:v>1185.3520000000001</c:v>
                </c:pt>
                <c:pt idx="148">
                  <c:v>1193.415</c:v>
                </c:pt>
                <c:pt idx="149">
                  <c:v>1201.479</c:v>
                </c:pt>
                <c:pt idx="150">
                  <c:v>1209.5429999999999</c:v>
                </c:pt>
                <c:pt idx="151">
                  <c:v>1217.606</c:v>
                </c:pt>
                <c:pt idx="152">
                  <c:v>1225.67</c:v>
                </c:pt>
                <c:pt idx="153">
                  <c:v>1233.7329999999999</c:v>
                </c:pt>
                <c:pt idx="154">
                  <c:v>1241.797</c:v>
                </c:pt>
                <c:pt idx="155">
                  <c:v>1249.8610000000001</c:v>
                </c:pt>
                <c:pt idx="156">
                  <c:v>1257.924</c:v>
                </c:pt>
                <c:pt idx="157">
                  <c:v>1265.9880000000001</c:v>
                </c:pt>
                <c:pt idx="158">
                  <c:v>1274.0519999999999</c:v>
                </c:pt>
                <c:pt idx="159">
                  <c:v>1282.115</c:v>
                </c:pt>
                <c:pt idx="160">
                  <c:v>1290.1790000000001</c:v>
                </c:pt>
                <c:pt idx="161">
                  <c:v>1298.242</c:v>
                </c:pt>
                <c:pt idx="162">
                  <c:v>1306.306</c:v>
                </c:pt>
                <c:pt idx="163">
                  <c:v>1314.37</c:v>
                </c:pt>
                <c:pt idx="164">
                  <c:v>1322.433</c:v>
                </c:pt>
                <c:pt idx="165">
                  <c:v>1330.4970000000001</c:v>
                </c:pt>
                <c:pt idx="166">
                  <c:v>1338.5609999999999</c:v>
                </c:pt>
                <c:pt idx="167">
                  <c:v>1346.624</c:v>
                </c:pt>
                <c:pt idx="168">
                  <c:v>1354.6880000000001</c:v>
                </c:pt>
                <c:pt idx="169">
                  <c:v>1362.751</c:v>
                </c:pt>
                <c:pt idx="170">
                  <c:v>1370.8150000000001</c:v>
                </c:pt>
                <c:pt idx="171">
                  <c:v>1378.8789999999999</c:v>
                </c:pt>
                <c:pt idx="172">
                  <c:v>1386.942</c:v>
                </c:pt>
                <c:pt idx="173">
                  <c:v>1395.0060000000001</c:v>
                </c:pt>
                <c:pt idx="174">
                  <c:v>1403.069</c:v>
                </c:pt>
                <c:pt idx="175">
                  <c:v>1411.133</c:v>
                </c:pt>
                <c:pt idx="176">
                  <c:v>1419.1969999999999</c:v>
                </c:pt>
                <c:pt idx="177">
                  <c:v>1427.26</c:v>
                </c:pt>
                <c:pt idx="178">
                  <c:v>1435.3240000000001</c:v>
                </c:pt>
                <c:pt idx="179">
                  <c:v>1443.3879999999999</c:v>
                </c:pt>
                <c:pt idx="180">
                  <c:v>1451.451</c:v>
                </c:pt>
                <c:pt idx="181">
                  <c:v>1459.5150000000001</c:v>
                </c:pt>
                <c:pt idx="182">
                  <c:v>1461.4639999999999</c:v>
                </c:pt>
                <c:pt idx="183">
                  <c:v>1467.578</c:v>
                </c:pt>
                <c:pt idx="184">
                  <c:v>1475.6420000000001</c:v>
                </c:pt>
                <c:pt idx="185">
                  <c:v>1483.7059999999999</c:v>
                </c:pt>
                <c:pt idx="186">
                  <c:v>1491.769</c:v>
                </c:pt>
                <c:pt idx="187">
                  <c:v>1494.886</c:v>
                </c:pt>
                <c:pt idx="188">
                  <c:v>1499.8330000000001</c:v>
                </c:pt>
                <c:pt idx="189">
                  <c:v>1500</c:v>
                </c:pt>
                <c:pt idx="190">
                  <c:v>1505.905</c:v>
                </c:pt>
                <c:pt idx="191">
                  <c:v>1507.896</c:v>
                </c:pt>
                <c:pt idx="192">
                  <c:v>1509.3440000000001</c:v>
                </c:pt>
                <c:pt idx="193">
                  <c:v>1511.0450000000001</c:v>
                </c:pt>
                <c:pt idx="194">
                  <c:v>1515.5650000000001</c:v>
                </c:pt>
                <c:pt idx="195">
                  <c:v>1515.96</c:v>
                </c:pt>
                <c:pt idx="196">
                  <c:v>1516.2809999999999</c:v>
                </c:pt>
                <c:pt idx="197">
                  <c:v>1517.4649999999999</c:v>
                </c:pt>
                <c:pt idx="198">
                  <c:v>1520.345</c:v>
                </c:pt>
                <c:pt idx="199">
                  <c:v>1521.6079999999999</c:v>
                </c:pt>
                <c:pt idx="200">
                  <c:v>1522.0450000000001</c:v>
                </c:pt>
                <c:pt idx="201">
                  <c:v>1522.587</c:v>
                </c:pt>
                <c:pt idx="202">
                  <c:v>1523.0050000000001</c:v>
                </c:pt>
                <c:pt idx="203">
                  <c:v>1524.0239999999999</c:v>
                </c:pt>
                <c:pt idx="204">
                  <c:v>1525.174</c:v>
                </c:pt>
                <c:pt idx="205">
                  <c:v>1526.921</c:v>
                </c:pt>
                <c:pt idx="206">
                  <c:v>1527.6990000000001</c:v>
                </c:pt>
                <c:pt idx="207">
                  <c:v>1529.231</c:v>
                </c:pt>
                <c:pt idx="208">
                  <c:v>1530.5409999999999</c:v>
                </c:pt>
                <c:pt idx="209">
                  <c:v>1530.79</c:v>
                </c:pt>
                <c:pt idx="210">
                  <c:v>1530.9690000000001</c:v>
                </c:pt>
                <c:pt idx="211">
                  <c:v>1532.087</c:v>
                </c:pt>
                <c:pt idx="212">
                  <c:v>1532.105</c:v>
                </c:pt>
                <c:pt idx="213">
                  <c:v>1532.856</c:v>
                </c:pt>
                <c:pt idx="214">
                  <c:v>1533.58</c:v>
                </c:pt>
                <c:pt idx="215">
                  <c:v>1533.808</c:v>
                </c:pt>
                <c:pt idx="216">
                  <c:v>1534.001</c:v>
                </c:pt>
                <c:pt idx="217">
                  <c:v>1534.1559999999999</c:v>
                </c:pt>
                <c:pt idx="218">
                  <c:v>1534.5820000000001</c:v>
                </c:pt>
                <c:pt idx="219">
                  <c:v>1535.2619999999999</c:v>
                </c:pt>
                <c:pt idx="220">
                  <c:v>1536.182</c:v>
                </c:pt>
                <c:pt idx="221">
                  <c:v>1536.7180000000001</c:v>
                </c:pt>
                <c:pt idx="222">
                  <c:v>1537.5</c:v>
                </c:pt>
                <c:pt idx="223">
                  <c:v>1537.972</c:v>
                </c:pt>
                <c:pt idx="224">
                  <c:v>1538.425</c:v>
                </c:pt>
                <c:pt idx="225">
                  <c:v>1538.636</c:v>
                </c:pt>
                <c:pt idx="226">
                  <c:v>1538.972</c:v>
                </c:pt>
                <c:pt idx="227">
                  <c:v>1539.518</c:v>
                </c:pt>
                <c:pt idx="228">
                  <c:v>1540.059</c:v>
                </c:pt>
                <c:pt idx="229">
                  <c:v>1540.1510000000001</c:v>
                </c:pt>
                <c:pt idx="230">
                  <c:v>1540.9090000000001</c:v>
                </c:pt>
                <c:pt idx="231">
                  <c:v>1541.325</c:v>
                </c:pt>
                <c:pt idx="232">
                  <c:v>1541.4580000000001</c:v>
                </c:pt>
                <c:pt idx="233">
                  <c:v>1541.771</c:v>
                </c:pt>
                <c:pt idx="234">
                  <c:v>1541.963</c:v>
                </c:pt>
                <c:pt idx="235">
                  <c:v>1542.3209999999999</c:v>
                </c:pt>
                <c:pt idx="236">
                  <c:v>1542.77</c:v>
                </c:pt>
                <c:pt idx="237">
                  <c:v>1543.2570000000001</c:v>
                </c:pt>
                <c:pt idx="238">
                  <c:v>1543.569</c:v>
                </c:pt>
                <c:pt idx="239">
                  <c:v>1544.2729999999999</c:v>
                </c:pt>
                <c:pt idx="240">
                  <c:v>1544.518</c:v>
                </c:pt>
                <c:pt idx="241">
                  <c:v>1544.808</c:v>
                </c:pt>
                <c:pt idx="242">
                  <c:v>1545.326</c:v>
                </c:pt>
                <c:pt idx="243">
                  <c:v>1545.6510000000001</c:v>
                </c:pt>
                <c:pt idx="244">
                  <c:v>1545.8430000000001</c:v>
                </c:pt>
                <c:pt idx="245">
                  <c:v>1545.9459999999999</c:v>
                </c:pt>
                <c:pt idx="246">
                  <c:v>1546.883</c:v>
                </c:pt>
                <c:pt idx="247">
                  <c:v>1548.0309999999999</c:v>
                </c:pt>
                <c:pt idx="248">
                  <c:v>1548.2149999999999</c:v>
                </c:pt>
                <c:pt idx="249">
                  <c:v>1548.306</c:v>
                </c:pt>
                <c:pt idx="250">
                  <c:v>1548.5039999999999</c:v>
                </c:pt>
                <c:pt idx="251">
                  <c:v>1548.596</c:v>
                </c:pt>
                <c:pt idx="252">
                  <c:v>1548.991</c:v>
                </c:pt>
                <c:pt idx="253">
                  <c:v>1549.5029999999999</c:v>
                </c:pt>
                <c:pt idx="254">
                  <c:v>1549.568</c:v>
                </c:pt>
                <c:pt idx="255">
                  <c:v>1549.836</c:v>
                </c:pt>
                <c:pt idx="256">
                  <c:v>1550.0989999999999</c:v>
                </c:pt>
                <c:pt idx="257">
                  <c:v>1551.155</c:v>
                </c:pt>
                <c:pt idx="258">
                  <c:v>1551.2929999999999</c:v>
                </c:pt>
                <c:pt idx="259">
                  <c:v>1551.4659999999999</c:v>
                </c:pt>
                <c:pt idx="260">
                  <c:v>1551.623</c:v>
                </c:pt>
                <c:pt idx="261">
                  <c:v>1551.665</c:v>
                </c:pt>
                <c:pt idx="262">
                  <c:v>1551.7570000000001</c:v>
                </c:pt>
                <c:pt idx="263">
                  <c:v>1551.961</c:v>
                </c:pt>
                <c:pt idx="264">
                  <c:v>1552.2159999999999</c:v>
                </c:pt>
                <c:pt idx="265">
                  <c:v>1552.568</c:v>
                </c:pt>
                <c:pt idx="266">
                  <c:v>1552.836</c:v>
                </c:pt>
                <c:pt idx="267">
                  <c:v>1553.2260000000001</c:v>
                </c:pt>
                <c:pt idx="268">
                  <c:v>1553.614</c:v>
                </c:pt>
                <c:pt idx="269">
                  <c:v>1553.8810000000001</c:v>
                </c:pt>
                <c:pt idx="270">
                  <c:v>1554.8130000000001</c:v>
                </c:pt>
                <c:pt idx="271">
                  <c:v>1555.154</c:v>
                </c:pt>
                <c:pt idx="272">
                  <c:v>1555.3689999999999</c:v>
                </c:pt>
                <c:pt idx="273">
                  <c:v>1555.7729999999999</c:v>
                </c:pt>
                <c:pt idx="274">
                  <c:v>1555.817</c:v>
                </c:pt>
                <c:pt idx="275">
                  <c:v>1556.0409999999999</c:v>
                </c:pt>
                <c:pt idx="276">
                  <c:v>1556.278</c:v>
                </c:pt>
                <c:pt idx="277">
                  <c:v>1556.296</c:v>
                </c:pt>
                <c:pt idx="278">
                  <c:v>1556.373</c:v>
                </c:pt>
                <c:pt idx="279">
                  <c:v>1556.538</c:v>
                </c:pt>
                <c:pt idx="280">
                  <c:v>1556.82</c:v>
                </c:pt>
                <c:pt idx="281">
                  <c:v>1557.11</c:v>
                </c:pt>
                <c:pt idx="282">
                  <c:v>1557.29</c:v>
                </c:pt>
                <c:pt idx="283">
                  <c:v>1557.7539999999999</c:v>
                </c:pt>
                <c:pt idx="284">
                  <c:v>1558.059</c:v>
                </c:pt>
                <c:pt idx="285">
                  <c:v>1558.307</c:v>
                </c:pt>
                <c:pt idx="286">
                  <c:v>1558.462</c:v>
                </c:pt>
                <c:pt idx="287">
                  <c:v>1558.6020000000001</c:v>
                </c:pt>
                <c:pt idx="288">
                  <c:v>1559.0440000000001</c:v>
                </c:pt>
                <c:pt idx="289">
                  <c:v>1559.646</c:v>
                </c:pt>
                <c:pt idx="290">
                  <c:v>1559.886</c:v>
                </c:pt>
                <c:pt idx="291">
                  <c:v>1560.03</c:v>
                </c:pt>
                <c:pt idx="292">
                  <c:v>1560.0709999999999</c:v>
                </c:pt>
                <c:pt idx="293">
                  <c:v>1560.2760000000001</c:v>
                </c:pt>
                <c:pt idx="294">
                  <c:v>1560.586</c:v>
                </c:pt>
                <c:pt idx="295">
                  <c:v>1560.625</c:v>
                </c:pt>
                <c:pt idx="296">
                  <c:v>1560.7660000000001</c:v>
                </c:pt>
                <c:pt idx="297">
                  <c:v>1561.067</c:v>
                </c:pt>
                <c:pt idx="298">
                  <c:v>1561.164</c:v>
                </c:pt>
                <c:pt idx="299">
                  <c:v>1561.5429999999999</c:v>
                </c:pt>
                <c:pt idx="300">
                  <c:v>1561.693</c:v>
                </c:pt>
                <c:pt idx="301">
                  <c:v>1562.0250000000001</c:v>
                </c:pt>
                <c:pt idx="302">
                  <c:v>1562.171</c:v>
                </c:pt>
                <c:pt idx="303">
                  <c:v>1562.2560000000001</c:v>
                </c:pt>
                <c:pt idx="304">
                  <c:v>1562.3009999999999</c:v>
                </c:pt>
                <c:pt idx="305">
                  <c:v>1562.645</c:v>
                </c:pt>
                <c:pt idx="306">
                  <c:v>1562.924</c:v>
                </c:pt>
                <c:pt idx="307">
                  <c:v>1563.316</c:v>
                </c:pt>
                <c:pt idx="308">
                  <c:v>1563.4490000000001</c:v>
                </c:pt>
                <c:pt idx="309">
                  <c:v>1563.6320000000001</c:v>
                </c:pt>
                <c:pt idx="310">
                  <c:v>1563.9659999999999</c:v>
                </c:pt>
                <c:pt idx="311">
                  <c:v>1564.3420000000001</c:v>
                </c:pt>
                <c:pt idx="312">
                  <c:v>1564.471</c:v>
                </c:pt>
                <c:pt idx="313">
                  <c:v>1564.83</c:v>
                </c:pt>
                <c:pt idx="314">
                  <c:v>1565.066</c:v>
                </c:pt>
                <c:pt idx="315">
                  <c:v>1565.1210000000001</c:v>
                </c:pt>
                <c:pt idx="316">
                  <c:v>1565.4069999999999</c:v>
                </c:pt>
                <c:pt idx="317">
                  <c:v>1565.8869999999999</c:v>
                </c:pt>
                <c:pt idx="318">
                  <c:v>1566.88</c:v>
                </c:pt>
                <c:pt idx="319">
                  <c:v>1567.136</c:v>
                </c:pt>
                <c:pt idx="320">
                  <c:v>1567.4970000000001</c:v>
                </c:pt>
                <c:pt idx="321">
                  <c:v>1567.7260000000001</c:v>
                </c:pt>
                <c:pt idx="322">
                  <c:v>1568.08</c:v>
                </c:pt>
                <c:pt idx="323">
                  <c:v>1568.328</c:v>
                </c:pt>
                <c:pt idx="324">
                  <c:v>1568.633</c:v>
                </c:pt>
                <c:pt idx="325">
                  <c:v>1569.059</c:v>
                </c:pt>
                <c:pt idx="326">
                  <c:v>1569.3320000000001</c:v>
                </c:pt>
                <c:pt idx="327">
                  <c:v>1569.5930000000001</c:v>
                </c:pt>
                <c:pt idx="328">
                  <c:v>1569.89</c:v>
                </c:pt>
                <c:pt idx="329">
                  <c:v>1570.117</c:v>
                </c:pt>
                <c:pt idx="330">
                  <c:v>1570.2550000000001</c:v>
                </c:pt>
                <c:pt idx="331">
                  <c:v>1570.627</c:v>
                </c:pt>
                <c:pt idx="332">
                  <c:v>1570.9960000000001</c:v>
                </c:pt>
                <c:pt idx="333">
                  <c:v>1571.4110000000001</c:v>
                </c:pt>
                <c:pt idx="334">
                  <c:v>1571.6959999999999</c:v>
                </c:pt>
                <c:pt idx="335">
                  <c:v>1572.046</c:v>
                </c:pt>
                <c:pt idx="336">
                  <c:v>1572.328</c:v>
                </c:pt>
                <c:pt idx="337">
                  <c:v>1572.405</c:v>
                </c:pt>
                <c:pt idx="338">
                  <c:v>1572.64</c:v>
                </c:pt>
                <c:pt idx="339">
                  <c:v>1572.979</c:v>
                </c:pt>
                <c:pt idx="340">
                  <c:v>1573.192</c:v>
                </c:pt>
                <c:pt idx="341">
                  <c:v>1573.33</c:v>
                </c:pt>
                <c:pt idx="342">
                  <c:v>1573.5509999999999</c:v>
                </c:pt>
                <c:pt idx="343">
                  <c:v>1573.7570000000001</c:v>
                </c:pt>
                <c:pt idx="344">
                  <c:v>1573.903</c:v>
                </c:pt>
                <c:pt idx="345">
                  <c:v>1574.229</c:v>
                </c:pt>
                <c:pt idx="346">
                  <c:v>1575.8340000000001</c:v>
                </c:pt>
                <c:pt idx="347">
                  <c:v>1576.251</c:v>
                </c:pt>
                <c:pt idx="348">
                  <c:v>1576.441</c:v>
                </c:pt>
                <c:pt idx="349">
                  <c:v>1576.6030000000001</c:v>
                </c:pt>
                <c:pt idx="350">
                  <c:v>1576.8810000000001</c:v>
                </c:pt>
                <c:pt idx="351">
                  <c:v>1577.2159999999999</c:v>
                </c:pt>
                <c:pt idx="352">
                  <c:v>1577.529</c:v>
                </c:pt>
                <c:pt idx="353">
                  <c:v>1577.856</c:v>
                </c:pt>
                <c:pt idx="354">
                  <c:v>1578.058</c:v>
                </c:pt>
                <c:pt idx="355">
                  <c:v>1578.4760000000001</c:v>
                </c:pt>
                <c:pt idx="356">
                  <c:v>1578.683</c:v>
                </c:pt>
                <c:pt idx="357">
                  <c:v>1578.7909999999999</c:v>
                </c:pt>
                <c:pt idx="358">
                  <c:v>1579.367</c:v>
                </c:pt>
                <c:pt idx="359">
                  <c:v>1579.652</c:v>
                </c:pt>
                <c:pt idx="360">
                  <c:v>1579.874</c:v>
                </c:pt>
                <c:pt idx="361">
                  <c:v>1580.3040000000001</c:v>
                </c:pt>
                <c:pt idx="362">
                  <c:v>1580.4690000000001</c:v>
                </c:pt>
                <c:pt idx="363">
                  <c:v>1580.9659999999999</c:v>
                </c:pt>
                <c:pt idx="364">
                  <c:v>1581.144</c:v>
                </c:pt>
                <c:pt idx="365">
                  <c:v>1581.3340000000001</c:v>
                </c:pt>
                <c:pt idx="366">
                  <c:v>1582.0820000000001</c:v>
                </c:pt>
                <c:pt idx="367">
                  <c:v>1582.1759999999999</c:v>
                </c:pt>
                <c:pt idx="368">
                  <c:v>1582.383</c:v>
                </c:pt>
                <c:pt idx="369">
                  <c:v>1582.6569999999999</c:v>
                </c:pt>
                <c:pt idx="370">
                  <c:v>1582.8050000000001</c:v>
                </c:pt>
                <c:pt idx="371">
                  <c:v>1582.925</c:v>
                </c:pt>
                <c:pt idx="372">
                  <c:v>1583.242</c:v>
                </c:pt>
                <c:pt idx="373">
                  <c:v>1583.9390000000001</c:v>
                </c:pt>
                <c:pt idx="374">
                  <c:v>1584.1669999999999</c:v>
                </c:pt>
                <c:pt idx="375">
                  <c:v>1584.377</c:v>
                </c:pt>
                <c:pt idx="376">
                  <c:v>1584.7049999999999</c:v>
                </c:pt>
                <c:pt idx="377">
                  <c:v>1585.588</c:v>
                </c:pt>
                <c:pt idx="378">
                  <c:v>1586.6220000000001</c:v>
                </c:pt>
                <c:pt idx="379">
                  <c:v>1586.752</c:v>
                </c:pt>
                <c:pt idx="380">
                  <c:v>1588.5329999999999</c:v>
                </c:pt>
                <c:pt idx="381">
                  <c:v>1589.1130000000001</c:v>
                </c:pt>
                <c:pt idx="382">
                  <c:v>1589.6969999999999</c:v>
                </c:pt>
                <c:pt idx="383">
                  <c:v>1590.172</c:v>
                </c:pt>
                <c:pt idx="384">
                  <c:v>1591.0619999999999</c:v>
                </c:pt>
                <c:pt idx="385">
                  <c:v>1591.7260000000001</c:v>
                </c:pt>
                <c:pt idx="386">
                  <c:v>1592.5050000000001</c:v>
                </c:pt>
                <c:pt idx="387">
                  <c:v>1592.569</c:v>
                </c:pt>
                <c:pt idx="388">
                  <c:v>1592.98</c:v>
                </c:pt>
                <c:pt idx="389">
                  <c:v>1593.3510000000001</c:v>
                </c:pt>
                <c:pt idx="390">
                  <c:v>1594.289</c:v>
                </c:pt>
                <c:pt idx="391">
                  <c:v>1596.1949999999999</c:v>
                </c:pt>
                <c:pt idx="392">
                  <c:v>1596.596</c:v>
                </c:pt>
                <c:pt idx="393">
                  <c:v>1597.105</c:v>
                </c:pt>
                <c:pt idx="394">
                  <c:v>1597.4169999999999</c:v>
                </c:pt>
                <c:pt idx="395">
                  <c:v>1600.8979999999999</c:v>
                </c:pt>
                <c:pt idx="396">
                  <c:v>1604.66</c:v>
                </c:pt>
                <c:pt idx="397">
                  <c:v>1605.4490000000001</c:v>
                </c:pt>
                <c:pt idx="398">
                  <c:v>1608.625</c:v>
                </c:pt>
                <c:pt idx="399">
                  <c:v>1611.1120000000001</c:v>
                </c:pt>
                <c:pt idx="400">
                  <c:v>1612.7239999999999</c:v>
                </c:pt>
                <c:pt idx="401">
                  <c:v>1612.7239999999999</c:v>
                </c:pt>
              </c:numCache>
            </c:numRef>
          </c:xVal>
          <c:yVal>
            <c:numRef>
              <c:f>Foglio6!$B$5:$B$406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100</c:v>
                </c:pt>
                <c:pt idx="162">
                  <c:v>100</c:v>
                </c:pt>
                <c:pt idx="163">
                  <c:v>100</c:v>
                </c:pt>
                <c:pt idx="164">
                  <c:v>100</c:v>
                </c:pt>
                <c:pt idx="165">
                  <c:v>100</c:v>
                </c:pt>
                <c:pt idx="166">
                  <c:v>100</c:v>
                </c:pt>
                <c:pt idx="167">
                  <c:v>100</c:v>
                </c:pt>
                <c:pt idx="168">
                  <c:v>100</c:v>
                </c:pt>
                <c:pt idx="169">
                  <c:v>100</c:v>
                </c:pt>
                <c:pt idx="170">
                  <c:v>100</c:v>
                </c:pt>
                <c:pt idx="171">
                  <c:v>100</c:v>
                </c:pt>
                <c:pt idx="172">
                  <c:v>100</c:v>
                </c:pt>
                <c:pt idx="173">
                  <c:v>100</c:v>
                </c:pt>
                <c:pt idx="174">
                  <c:v>100</c:v>
                </c:pt>
                <c:pt idx="175">
                  <c:v>100</c:v>
                </c:pt>
                <c:pt idx="176">
                  <c:v>100</c:v>
                </c:pt>
                <c:pt idx="177">
                  <c:v>100</c:v>
                </c:pt>
                <c:pt idx="178">
                  <c:v>100</c:v>
                </c:pt>
                <c:pt idx="179">
                  <c:v>100</c:v>
                </c:pt>
                <c:pt idx="180">
                  <c:v>100</c:v>
                </c:pt>
                <c:pt idx="181">
                  <c:v>100</c:v>
                </c:pt>
                <c:pt idx="182">
                  <c:v>100</c:v>
                </c:pt>
                <c:pt idx="183">
                  <c:v>99.983999999999995</c:v>
                </c:pt>
                <c:pt idx="184">
                  <c:v>99.975999999999999</c:v>
                </c:pt>
                <c:pt idx="185">
                  <c:v>99.921000000000006</c:v>
                </c:pt>
                <c:pt idx="186">
                  <c:v>99.667000000000002</c:v>
                </c:pt>
                <c:pt idx="187">
                  <c:v>99.5</c:v>
                </c:pt>
                <c:pt idx="188">
                  <c:v>99.052999999999997</c:v>
                </c:pt>
                <c:pt idx="189">
                  <c:v>99</c:v>
                </c:pt>
                <c:pt idx="190">
                  <c:v>98.5</c:v>
                </c:pt>
                <c:pt idx="191">
                  <c:v>98.353999999999999</c:v>
                </c:pt>
                <c:pt idx="192">
                  <c:v>98</c:v>
                </c:pt>
                <c:pt idx="193">
                  <c:v>97.5</c:v>
                </c:pt>
                <c:pt idx="194">
                  <c:v>97</c:v>
                </c:pt>
                <c:pt idx="195">
                  <c:v>96.673000000000002</c:v>
                </c:pt>
                <c:pt idx="196">
                  <c:v>96.5</c:v>
                </c:pt>
                <c:pt idx="197">
                  <c:v>96</c:v>
                </c:pt>
                <c:pt idx="198">
                  <c:v>95.5</c:v>
                </c:pt>
                <c:pt idx="199">
                  <c:v>95</c:v>
                </c:pt>
                <c:pt idx="200">
                  <c:v>94.5</c:v>
                </c:pt>
                <c:pt idx="201">
                  <c:v>94</c:v>
                </c:pt>
                <c:pt idx="202">
                  <c:v>93.5</c:v>
                </c:pt>
                <c:pt idx="203">
                  <c:v>93.305000000000007</c:v>
                </c:pt>
                <c:pt idx="204">
                  <c:v>93</c:v>
                </c:pt>
                <c:pt idx="205">
                  <c:v>92.5</c:v>
                </c:pt>
                <c:pt idx="206">
                  <c:v>92</c:v>
                </c:pt>
                <c:pt idx="207">
                  <c:v>91.5</c:v>
                </c:pt>
                <c:pt idx="208">
                  <c:v>91</c:v>
                </c:pt>
                <c:pt idx="209">
                  <c:v>90.5</c:v>
                </c:pt>
                <c:pt idx="210">
                  <c:v>90</c:v>
                </c:pt>
                <c:pt idx="211">
                  <c:v>89.501999999999995</c:v>
                </c:pt>
                <c:pt idx="212">
                  <c:v>89.5</c:v>
                </c:pt>
                <c:pt idx="213">
                  <c:v>89</c:v>
                </c:pt>
                <c:pt idx="214">
                  <c:v>88.5</c:v>
                </c:pt>
                <c:pt idx="215">
                  <c:v>88</c:v>
                </c:pt>
                <c:pt idx="216">
                  <c:v>87.5</c:v>
                </c:pt>
                <c:pt idx="217">
                  <c:v>87</c:v>
                </c:pt>
                <c:pt idx="218">
                  <c:v>86.5</c:v>
                </c:pt>
                <c:pt idx="219">
                  <c:v>86</c:v>
                </c:pt>
                <c:pt idx="220">
                  <c:v>85.5</c:v>
                </c:pt>
                <c:pt idx="221">
                  <c:v>85</c:v>
                </c:pt>
                <c:pt idx="222">
                  <c:v>84.5</c:v>
                </c:pt>
                <c:pt idx="223">
                  <c:v>84</c:v>
                </c:pt>
                <c:pt idx="224">
                  <c:v>83.5</c:v>
                </c:pt>
                <c:pt idx="225">
                  <c:v>83</c:v>
                </c:pt>
                <c:pt idx="226">
                  <c:v>82.5</c:v>
                </c:pt>
                <c:pt idx="227">
                  <c:v>82</c:v>
                </c:pt>
                <c:pt idx="228">
                  <c:v>81.5</c:v>
                </c:pt>
                <c:pt idx="229">
                  <c:v>81.421000000000006</c:v>
                </c:pt>
                <c:pt idx="230">
                  <c:v>81</c:v>
                </c:pt>
                <c:pt idx="231">
                  <c:v>80.5</c:v>
                </c:pt>
                <c:pt idx="232">
                  <c:v>80</c:v>
                </c:pt>
                <c:pt idx="233">
                  <c:v>79.5</c:v>
                </c:pt>
                <c:pt idx="234">
                  <c:v>79</c:v>
                </c:pt>
                <c:pt idx="235">
                  <c:v>78.5</c:v>
                </c:pt>
                <c:pt idx="236">
                  <c:v>78</c:v>
                </c:pt>
                <c:pt idx="237">
                  <c:v>77.5</c:v>
                </c:pt>
                <c:pt idx="238">
                  <c:v>77</c:v>
                </c:pt>
                <c:pt idx="239">
                  <c:v>76.5</c:v>
                </c:pt>
                <c:pt idx="240">
                  <c:v>76</c:v>
                </c:pt>
                <c:pt idx="241">
                  <c:v>75.5</c:v>
                </c:pt>
                <c:pt idx="242">
                  <c:v>75</c:v>
                </c:pt>
                <c:pt idx="243">
                  <c:v>74.5</c:v>
                </c:pt>
                <c:pt idx="244">
                  <c:v>74</c:v>
                </c:pt>
                <c:pt idx="245">
                  <c:v>73.5</c:v>
                </c:pt>
                <c:pt idx="246">
                  <c:v>73</c:v>
                </c:pt>
                <c:pt idx="247">
                  <c:v>72.5</c:v>
                </c:pt>
                <c:pt idx="248">
                  <c:v>72.106999999999999</c:v>
                </c:pt>
                <c:pt idx="249">
                  <c:v>72</c:v>
                </c:pt>
                <c:pt idx="250">
                  <c:v>71.5</c:v>
                </c:pt>
                <c:pt idx="251">
                  <c:v>71</c:v>
                </c:pt>
                <c:pt idx="252">
                  <c:v>70.5</c:v>
                </c:pt>
                <c:pt idx="253">
                  <c:v>70</c:v>
                </c:pt>
                <c:pt idx="254">
                  <c:v>69.5</c:v>
                </c:pt>
                <c:pt idx="255">
                  <c:v>69</c:v>
                </c:pt>
                <c:pt idx="256">
                  <c:v>68.5</c:v>
                </c:pt>
                <c:pt idx="257">
                  <c:v>68</c:v>
                </c:pt>
                <c:pt idx="258">
                  <c:v>67.5</c:v>
                </c:pt>
                <c:pt idx="259">
                  <c:v>67</c:v>
                </c:pt>
                <c:pt idx="260">
                  <c:v>66.5</c:v>
                </c:pt>
                <c:pt idx="261">
                  <c:v>66</c:v>
                </c:pt>
                <c:pt idx="262">
                  <c:v>65.5</c:v>
                </c:pt>
                <c:pt idx="263">
                  <c:v>65</c:v>
                </c:pt>
                <c:pt idx="264">
                  <c:v>64.5</c:v>
                </c:pt>
                <c:pt idx="265">
                  <c:v>64</c:v>
                </c:pt>
                <c:pt idx="266">
                  <c:v>63.5</c:v>
                </c:pt>
                <c:pt idx="267">
                  <c:v>63</c:v>
                </c:pt>
                <c:pt idx="268">
                  <c:v>62.5</c:v>
                </c:pt>
                <c:pt idx="269">
                  <c:v>62</c:v>
                </c:pt>
                <c:pt idx="270">
                  <c:v>61.5</c:v>
                </c:pt>
                <c:pt idx="271">
                  <c:v>61</c:v>
                </c:pt>
                <c:pt idx="272">
                  <c:v>60.5</c:v>
                </c:pt>
                <c:pt idx="273">
                  <c:v>60</c:v>
                </c:pt>
                <c:pt idx="274">
                  <c:v>59.5</c:v>
                </c:pt>
                <c:pt idx="275">
                  <c:v>59</c:v>
                </c:pt>
                <c:pt idx="276">
                  <c:v>58.53</c:v>
                </c:pt>
                <c:pt idx="277">
                  <c:v>58.5</c:v>
                </c:pt>
                <c:pt idx="278">
                  <c:v>58</c:v>
                </c:pt>
                <c:pt idx="279">
                  <c:v>57.5</c:v>
                </c:pt>
                <c:pt idx="280">
                  <c:v>57</c:v>
                </c:pt>
                <c:pt idx="281">
                  <c:v>56.5</c:v>
                </c:pt>
                <c:pt idx="282">
                  <c:v>56</c:v>
                </c:pt>
                <c:pt idx="283">
                  <c:v>55.5</c:v>
                </c:pt>
                <c:pt idx="284">
                  <c:v>55</c:v>
                </c:pt>
                <c:pt idx="285">
                  <c:v>54.5</c:v>
                </c:pt>
                <c:pt idx="286">
                  <c:v>54</c:v>
                </c:pt>
                <c:pt idx="287">
                  <c:v>53.5</c:v>
                </c:pt>
                <c:pt idx="288">
                  <c:v>53</c:v>
                </c:pt>
                <c:pt idx="289">
                  <c:v>52.5</c:v>
                </c:pt>
                <c:pt idx="290">
                  <c:v>52</c:v>
                </c:pt>
                <c:pt idx="291">
                  <c:v>51.5</c:v>
                </c:pt>
                <c:pt idx="292">
                  <c:v>51</c:v>
                </c:pt>
                <c:pt idx="293">
                  <c:v>50.5</c:v>
                </c:pt>
                <c:pt idx="294">
                  <c:v>50</c:v>
                </c:pt>
                <c:pt idx="295">
                  <c:v>49.5</c:v>
                </c:pt>
                <c:pt idx="296">
                  <c:v>49</c:v>
                </c:pt>
                <c:pt idx="297">
                  <c:v>48.5</c:v>
                </c:pt>
                <c:pt idx="298">
                  <c:v>48</c:v>
                </c:pt>
                <c:pt idx="299">
                  <c:v>47.5</c:v>
                </c:pt>
                <c:pt idx="300">
                  <c:v>47</c:v>
                </c:pt>
                <c:pt idx="301">
                  <c:v>46.5</c:v>
                </c:pt>
                <c:pt idx="302">
                  <c:v>46</c:v>
                </c:pt>
                <c:pt idx="303">
                  <c:v>45.5</c:v>
                </c:pt>
                <c:pt idx="304">
                  <c:v>45</c:v>
                </c:pt>
                <c:pt idx="305">
                  <c:v>44.5</c:v>
                </c:pt>
                <c:pt idx="306">
                  <c:v>44</c:v>
                </c:pt>
                <c:pt idx="307">
                  <c:v>43.5</c:v>
                </c:pt>
                <c:pt idx="308">
                  <c:v>43</c:v>
                </c:pt>
                <c:pt idx="309">
                  <c:v>42.5</c:v>
                </c:pt>
                <c:pt idx="310">
                  <c:v>42</c:v>
                </c:pt>
                <c:pt idx="311">
                  <c:v>41.811999999999998</c:v>
                </c:pt>
                <c:pt idx="312">
                  <c:v>41.5</c:v>
                </c:pt>
                <c:pt idx="313">
                  <c:v>41</c:v>
                </c:pt>
                <c:pt idx="314">
                  <c:v>40.5</c:v>
                </c:pt>
                <c:pt idx="315">
                  <c:v>40</c:v>
                </c:pt>
                <c:pt idx="316">
                  <c:v>39.5</c:v>
                </c:pt>
                <c:pt idx="317">
                  <c:v>39</c:v>
                </c:pt>
                <c:pt idx="318">
                  <c:v>38.5</c:v>
                </c:pt>
                <c:pt idx="319">
                  <c:v>38</c:v>
                </c:pt>
                <c:pt idx="320">
                  <c:v>37.5</c:v>
                </c:pt>
                <c:pt idx="321">
                  <c:v>37</c:v>
                </c:pt>
                <c:pt idx="322">
                  <c:v>36.5</c:v>
                </c:pt>
                <c:pt idx="323">
                  <c:v>36</c:v>
                </c:pt>
                <c:pt idx="324">
                  <c:v>35.5</c:v>
                </c:pt>
                <c:pt idx="325">
                  <c:v>35</c:v>
                </c:pt>
                <c:pt idx="326">
                  <c:v>34.5</c:v>
                </c:pt>
                <c:pt idx="327">
                  <c:v>34</c:v>
                </c:pt>
                <c:pt idx="328">
                  <c:v>33.5</c:v>
                </c:pt>
                <c:pt idx="329">
                  <c:v>33</c:v>
                </c:pt>
                <c:pt idx="330">
                  <c:v>32.5</c:v>
                </c:pt>
                <c:pt idx="331">
                  <c:v>32</c:v>
                </c:pt>
                <c:pt idx="332">
                  <c:v>31.5</c:v>
                </c:pt>
                <c:pt idx="333">
                  <c:v>31</c:v>
                </c:pt>
                <c:pt idx="334">
                  <c:v>30.5</c:v>
                </c:pt>
                <c:pt idx="335">
                  <c:v>30</c:v>
                </c:pt>
                <c:pt idx="336">
                  <c:v>29.5</c:v>
                </c:pt>
                <c:pt idx="337">
                  <c:v>29.425000000000001</c:v>
                </c:pt>
                <c:pt idx="338">
                  <c:v>29</c:v>
                </c:pt>
                <c:pt idx="339">
                  <c:v>28.5</c:v>
                </c:pt>
                <c:pt idx="340">
                  <c:v>28</c:v>
                </c:pt>
                <c:pt idx="341">
                  <c:v>27.5</c:v>
                </c:pt>
                <c:pt idx="342">
                  <c:v>27</c:v>
                </c:pt>
                <c:pt idx="343">
                  <c:v>26.5</c:v>
                </c:pt>
                <c:pt idx="344">
                  <c:v>26</c:v>
                </c:pt>
                <c:pt idx="345">
                  <c:v>25.5</c:v>
                </c:pt>
                <c:pt idx="346">
                  <c:v>25</c:v>
                </c:pt>
                <c:pt idx="347">
                  <c:v>24.5</c:v>
                </c:pt>
                <c:pt idx="348">
                  <c:v>24</c:v>
                </c:pt>
                <c:pt idx="349">
                  <c:v>23.5</c:v>
                </c:pt>
                <c:pt idx="350">
                  <c:v>23</c:v>
                </c:pt>
                <c:pt idx="351">
                  <c:v>22.5</c:v>
                </c:pt>
                <c:pt idx="352">
                  <c:v>22</c:v>
                </c:pt>
                <c:pt idx="353">
                  <c:v>21.5</c:v>
                </c:pt>
                <c:pt idx="354">
                  <c:v>21</c:v>
                </c:pt>
                <c:pt idx="355">
                  <c:v>20.5</c:v>
                </c:pt>
                <c:pt idx="356">
                  <c:v>20</c:v>
                </c:pt>
                <c:pt idx="357">
                  <c:v>19.5</c:v>
                </c:pt>
                <c:pt idx="358">
                  <c:v>19</c:v>
                </c:pt>
                <c:pt idx="359">
                  <c:v>18.5</c:v>
                </c:pt>
                <c:pt idx="360">
                  <c:v>18</c:v>
                </c:pt>
                <c:pt idx="361">
                  <c:v>17.5</c:v>
                </c:pt>
                <c:pt idx="362">
                  <c:v>17.363</c:v>
                </c:pt>
                <c:pt idx="363">
                  <c:v>17</c:v>
                </c:pt>
                <c:pt idx="364">
                  <c:v>16.5</c:v>
                </c:pt>
                <c:pt idx="365">
                  <c:v>16</c:v>
                </c:pt>
                <c:pt idx="366">
                  <c:v>15.5</c:v>
                </c:pt>
                <c:pt idx="367">
                  <c:v>15</c:v>
                </c:pt>
                <c:pt idx="368">
                  <c:v>14.5</c:v>
                </c:pt>
                <c:pt idx="369">
                  <c:v>14</c:v>
                </c:pt>
                <c:pt idx="370">
                  <c:v>13.5</c:v>
                </c:pt>
                <c:pt idx="371">
                  <c:v>13</c:v>
                </c:pt>
                <c:pt idx="372">
                  <c:v>12.5</c:v>
                </c:pt>
                <c:pt idx="373">
                  <c:v>12</c:v>
                </c:pt>
                <c:pt idx="374">
                  <c:v>11.5</c:v>
                </c:pt>
                <c:pt idx="375">
                  <c:v>11</c:v>
                </c:pt>
                <c:pt idx="376">
                  <c:v>10.5</c:v>
                </c:pt>
                <c:pt idx="377">
                  <c:v>10</c:v>
                </c:pt>
                <c:pt idx="378">
                  <c:v>9.5</c:v>
                </c:pt>
                <c:pt idx="379">
                  <c:v>9</c:v>
                </c:pt>
                <c:pt idx="380">
                  <c:v>8.6969999999999992</c:v>
                </c:pt>
                <c:pt idx="381">
                  <c:v>8.5</c:v>
                </c:pt>
                <c:pt idx="382">
                  <c:v>8</c:v>
                </c:pt>
                <c:pt idx="383">
                  <c:v>7.5</c:v>
                </c:pt>
                <c:pt idx="384">
                  <c:v>7</c:v>
                </c:pt>
                <c:pt idx="385">
                  <c:v>6.5</c:v>
                </c:pt>
                <c:pt idx="386">
                  <c:v>6</c:v>
                </c:pt>
                <c:pt idx="387">
                  <c:v>5.5</c:v>
                </c:pt>
                <c:pt idx="388">
                  <c:v>5</c:v>
                </c:pt>
                <c:pt idx="389">
                  <c:v>4.5</c:v>
                </c:pt>
                <c:pt idx="390">
                  <c:v>4</c:v>
                </c:pt>
                <c:pt idx="391">
                  <c:v>3.5</c:v>
                </c:pt>
                <c:pt idx="392">
                  <c:v>3.4180000000000001</c:v>
                </c:pt>
                <c:pt idx="393">
                  <c:v>3</c:v>
                </c:pt>
                <c:pt idx="394">
                  <c:v>2.5</c:v>
                </c:pt>
                <c:pt idx="395">
                  <c:v>2</c:v>
                </c:pt>
                <c:pt idx="396">
                  <c:v>1.631</c:v>
                </c:pt>
                <c:pt idx="397">
                  <c:v>1.5</c:v>
                </c:pt>
                <c:pt idx="398">
                  <c:v>1</c:v>
                </c:pt>
                <c:pt idx="399">
                  <c:v>0.5</c:v>
                </c:pt>
                <c:pt idx="400">
                  <c:v>0.14399999999999999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331-46BE-B50F-9AAB614B149E}"/>
            </c:ext>
          </c:extLst>
        </c:ser>
        <c:ser>
          <c:idx val="3"/>
          <c:order val="1"/>
          <c:tx>
            <c:strRef>
              <c:f>Foglio6!$C$1</c:f>
              <c:strCache>
                <c:ptCount val="1"/>
                <c:pt idx="0">
                  <c:v>S1,0NA</c:v>
                </c:pt>
              </c:strCache>
            </c:strRef>
          </c:tx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none"/>
          </c:marker>
          <c:xVal>
            <c:numRef>
              <c:f>Foglio6!$C$5:$C$418</c:f>
              <c:numCache>
                <c:formatCode>General</c:formatCode>
                <c:ptCount val="414"/>
                <c:pt idx="0">
                  <c:v>0</c:v>
                </c:pt>
                <c:pt idx="1">
                  <c:v>8.4689999999999994</c:v>
                </c:pt>
                <c:pt idx="2">
                  <c:v>16.939</c:v>
                </c:pt>
                <c:pt idx="3">
                  <c:v>25.408000000000001</c:v>
                </c:pt>
                <c:pt idx="4">
                  <c:v>33.878</c:v>
                </c:pt>
                <c:pt idx="5">
                  <c:v>42.347000000000001</c:v>
                </c:pt>
                <c:pt idx="6">
                  <c:v>50.817</c:v>
                </c:pt>
                <c:pt idx="7">
                  <c:v>59.286000000000001</c:v>
                </c:pt>
                <c:pt idx="8">
                  <c:v>67.756</c:v>
                </c:pt>
                <c:pt idx="9">
                  <c:v>76.224999999999994</c:v>
                </c:pt>
                <c:pt idx="10">
                  <c:v>84.694999999999993</c:v>
                </c:pt>
                <c:pt idx="11">
                  <c:v>93.164000000000001</c:v>
                </c:pt>
                <c:pt idx="12">
                  <c:v>101.633</c:v>
                </c:pt>
                <c:pt idx="13">
                  <c:v>110.10299999999999</c:v>
                </c:pt>
                <c:pt idx="14">
                  <c:v>118.572</c:v>
                </c:pt>
                <c:pt idx="15">
                  <c:v>127.042</c:v>
                </c:pt>
                <c:pt idx="16">
                  <c:v>135.511</c:v>
                </c:pt>
                <c:pt idx="17">
                  <c:v>143.98099999999999</c:v>
                </c:pt>
                <c:pt idx="18">
                  <c:v>152.44999999999999</c:v>
                </c:pt>
                <c:pt idx="19">
                  <c:v>160.91999999999999</c:v>
                </c:pt>
                <c:pt idx="20">
                  <c:v>169.38900000000001</c:v>
                </c:pt>
                <c:pt idx="21">
                  <c:v>177.858</c:v>
                </c:pt>
                <c:pt idx="22">
                  <c:v>186.328</c:v>
                </c:pt>
                <c:pt idx="23">
                  <c:v>194.797</c:v>
                </c:pt>
                <c:pt idx="24">
                  <c:v>203.267</c:v>
                </c:pt>
                <c:pt idx="25">
                  <c:v>211.73599999999999</c:v>
                </c:pt>
                <c:pt idx="26">
                  <c:v>220.20599999999999</c:v>
                </c:pt>
                <c:pt idx="27">
                  <c:v>228.67500000000001</c:v>
                </c:pt>
                <c:pt idx="28">
                  <c:v>237.14500000000001</c:v>
                </c:pt>
                <c:pt idx="29">
                  <c:v>245.614</c:v>
                </c:pt>
                <c:pt idx="30">
                  <c:v>254.084</c:v>
                </c:pt>
                <c:pt idx="31">
                  <c:v>262.553</c:v>
                </c:pt>
                <c:pt idx="32">
                  <c:v>271.02199999999999</c:v>
                </c:pt>
                <c:pt idx="33">
                  <c:v>279.49200000000002</c:v>
                </c:pt>
                <c:pt idx="34">
                  <c:v>287.96100000000001</c:v>
                </c:pt>
                <c:pt idx="35">
                  <c:v>296.43099999999998</c:v>
                </c:pt>
                <c:pt idx="36">
                  <c:v>304.89999999999998</c:v>
                </c:pt>
                <c:pt idx="37">
                  <c:v>313.37</c:v>
                </c:pt>
                <c:pt idx="38">
                  <c:v>321.839</c:v>
                </c:pt>
                <c:pt idx="39">
                  <c:v>330.30900000000003</c:v>
                </c:pt>
                <c:pt idx="40">
                  <c:v>338.77800000000002</c:v>
                </c:pt>
                <c:pt idx="41">
                  <c:v>347.24799999999999</c:v>
                </c:pt>
                <c:pt idx="42">
                  <c:v>355.71699999999998</c:v>
                </c:pt>
                <c:pt idx="43">
                  <c:v>364.18599999999998</c:v>
                </c:pt>
                <c:pt idx="44">
                  <c:v>372.65600000000001</c:v>
                </c:pt>
                <c:pt idx="45">
                  <c:v>381.125</c:v>
                </c:pt>
                <c:pt idx="46">
                  <c:v>389.59500000000003</c:v>
                </c:pt>
                <c:pt idx="47">
                  <c:v>398.06400000000002</c:v>
                </c:pt>
                <c:pt idx="48">
                  <c:v>406.53399999999999</c:v>
                </c:pt>
                <c:pt idx="49">
                  <c:v>415.00299999999999</c:v>
                </c:pt>
                <c:pt idx="50">
                  <c:v>423.47300000000001</c:v>
                </c:pt>
                <c:pt idx="51">
                  <c:v>431.94200000000001</c:v>
                </c:pt>
                <c:pt idx="52">
                  <c:v>440.411</c:v>
                </c:pt>
                <c:pt idx="53">
                  <c:v>448.88099999999997</c:v>
                </c:pt>
                <c:pt idx="54">
                  <c:v>457.35</c:v>
                </c:pt>
                <c:pt idx="55">
                  <c:v>465.82</c:v>
                </c:pt>
                <c:pt idx="56">
                  <c:v>474.28899999999999</c:v>
                </c:pt>
                <c:pt idx="57">
                  <c:v>482.75900000000001</c:v>
                </c:pt>
                <c:pt idx="58">
                  <c:v>491.22800000000001</c:v>
                </c:pt>
                <c:pt idx="59">
                  <c:v>499.69799999999998</c:v>
                </c:pt>
                <c:pt idx="60">
                  <c:v>508.16699999999997</c:v>
                </c:pt>
                <c:pt idx="61">
                  <c:v>516.63699999999994</c:v>
                </c:pt>
                <c:pt idx="62">
                  <c:v>525.10599999999999</c:v>
                </c:pt>
                <c:pt idx="63">
                  <c:v>533.57500000000005</c:v>
                </c:pt>
                <c:pt idx="64">
                  <c:v>542.04499999999996</c:v>
                </c:pt>
                <c:pt idx="65">
                  <c:v>550.51400000000001</c:v>
                </c:pt>
                <c:pt idx="66">
                  <c:v>558.98400000000004</c:v>
                </c:pt>
                <c:pt idx="67">
                  <c:v>567.45299999999997</c:v>
                </c:pt>
                <c:pt idx="68">
                  <c:v>575.923</c:v>
                </c:pt>
                <c:pt idx="69">
                  <c:v>584.39200000000005</c:v>
                </c:pt>
                <c:pt idx="70">
                  <c:v>592.86199999999997</c:v>
                </c:pt>
                <c:pt idx="71">
                  <c:v>601.33100000000002</c:v>
                </c:pt>
                <c:pt idx="72">
                  <c:v>609.79999999999995</c:v>
                </c:pt>
                <c:pt idx="73">
                  <c:v>618.27</c:v>
                </c:pt>
                <c:pt idx="74">
                  <c:v>626.73900000000003</c:v>
                </c:pt>
                <c:pt idx="75">
                  <c:v>635.20899999999995</c:v>
                </c:pt>
                <c:pt idx="76">
                  <c:v>643.678</c:v>
                </c:pt>
                <c:pt idx="77">
                  <c:v>652.14800000000002</c:v>
                </c:pt>
                <c:pt idx="78">
                  <c:v>660.61699999999996</c:v>
                </c:pt>
                <c:pt idx="79">
                  <c:v>669.08699999999999</c:v>
                </c:pt>
                <c:pt idx="80">
                  <c:v>677.55600000000004</c:v>
                </c:pt>
                <c:pt idx="81">
                  <c:v>686.02599999999995</c:v>
                </c:pt>
                <c:pt idx="82">
                  <c:v>694.495</c:v>
                </c:pt>
                <c:pt idx="83">
                  <c:v>702.96400000000006</c:v>
                </c:pt>
                <c:pt idx="84">
                  <c:v>711.43399999999997</c:v>
                </c:pt>
                <c:pt idx="85">
                  <c:v>719.90300000000002</c:v>
                </c:pt>
                <c:pt idx="86">
                  <c:v>728.37300000000005</c:v>
                </c:pt>
                <c:pt idx="87">
                  <c:v>736.84199999999998</c:v>
                </c:pt>
                <c:pt idx="88">
                  <c:v>745.31200000000001</c:v>
                </c:pt>
                <c:pt idx="89">
                  <c:v>753.78099999999995</c:v>
                </c:pt>
                <c:pt idx="90">
                  <c:v>762.25099999999998</c:v>
                </c:pt>
                <c:pt idx="91">
                  <c:v>770.72</c:v>
                </c:pt>
                <c:pt idx="92">
                  <c:v>779.19</c:v>
                </c:pt>
                <c:pt idx="93">
                  <c:v>787.65899999999999</c:v>
                </c:pt>
                <c:pt idx="94">
                  <c:v>796.12800000000004</c:v>
                </c:pt>
                <c:pt idx="95">
                  <c:v>804.59799999999996</c:v>
                </c:pt>
                <c:pt idx="96">
                  <c:v>813.06700000000001</c:v>
                </c:pt>
                <c:pt idx="97">
                  <c:v>821.53700000000003</c:v>
                </c:pt>
                <c:pt idx="98">
                  <c:v>830.00599999999997</c:v>
                </c:pt>
                <c:pt idx="99">
                  <c:v>838.476</c:v>
                </c:pt>
                <c:pt idx="100">
                  <c:v>846.94500000000005</c:v>
                </c:pt>
                <c:pt idx="101">
                  <c:v>855.41499999999996</c:v>
                </c:pt>
                <c:pt idx="102">
                  <c:v>863.88400000000001</c:v>
                </c:pt>
                <c:pt idx="103">
                  <c:v>872.35299999999995</c:v>
                </c:pt>
                <c:pt idx="104">
                  <c:v>880.82299999999998</c:v>
                </c:pt>
                <c:pt idx="105">
                  <c:v>889.29200000000003</c:v>
                </c:pt>
                <c:pt idx="106">
                  <c:v>897.76199999999994</c:v>
                </c:pt>
                <c:pt idx="107">
                  <c:v>906.23099999999999</c:v>
                </c:pt>
                <c:pt idx="108">
                  <c:v>914.70100000000002</c:v>
                </c:pt>
                <c:pt idx="109">
                  <c:v>923.17</c:v>
                </c:pt>
                <c:pt idx="110">
                  <c:v>931.64</c:v>
                </c:pt>
                <c:pt idx="111">
                  <c:v>940.10900000000004</c:v>
                </c:pt>
                <c:pt idx="112">
                  <c:v>948.57899999999995</c:v>
                </c:pt>
                <c:pt idx="113">
                  <c:v>957.048</c:v>
                </c:pt>
                <c:pt idx="114">
                  <c:v>965.51700000000005</c:v>
                </c:pt>
                <c:pt idx="115">
                  <c:v>973.98699999999997</c:v>
                </c:pt>
                <c:pt idx="116">
                  <c:v>982.45600000000002</c:v>
                </c:pt>
                <c:pt idx="117">
                  <c:v>990.92600000000004</c:v>
                </c:pt>
                <c:pt idx="118">
                  <c:v>999.39499999999998</c:v>
                </c:pt>
                <c:pt idx="119">
                  <c:v>1007.865</c:v>
                </c:pt>
                <c:pt idx="120">
                  <c:v>1016.3339999999999</c:v>
                </c:pt>
                <c:pt idx="121">
                  <c:v>1024.8040000000001</c:v>
                </c:pt>
                <c:pt idx="122">
                  <c:v>1033.2729999999999</c:v>
                </c:pt>
                <c:pt idx="123">
                  <c:v>1041.7429999999999</c:v>
                </c:pt>
                <c:pt idx="124">
                  <c:v>1050.212</c:v>
                </c:pt>
                <c:pt idx="125">
                  <c:v>1058.681</c:v>
                </c:pt>
                <c:pt idx="126">
                  <c:v>1067.1510000000001</c:v>
                </c:pt>
                <c:pt idx="127">
                  <c:v>1075.6199999999999</c:v>
                </c:pt>
                <c:pt idx="128">
                  <c:v>1084.0899999999999</c:v>
                </c:pt>
                <c:pt idx="129">
                  <c:v>1092.559</c:v>
                </c:pt>
                <c:pt idx="130">
                  <c:v>1101.029</c:v>
                </c:pt>
                <c:pt idx="131">
                  <c:v>1109.498</c:v>
                </c:pt>
                <c:pt idx="132">
                  <c:v>1117.9680000000001</c:v>
                </c:pt>
                <c:pt idx="133">
                  <c:v>1126.4369999999999</c:v>
                </c:pt>
                <c:pt idx="134">
                  <c:v>1134.9059999999999</c:v>
                </c:pt>
                <c:pt idx="135">
                  <c:v>1143.376</c:v>
                </c:pt>
                <c:pt idx="136">
                  <c:v>1151.845</c:v>
                </c:pt>
                <c:pt idx="137">
                  <c:v>1160.3150000000001</c:v>
                </c:pt>
                <c:pt idx="138">
                  <c:v>1168.7840000000001</c:v>
                </c:pt>
                <c:pt idx="139">
                  <c:v>1177.2539999999999</c:v>
                </c:pt>
                <c:pt idx="140">
                  <c:v>1185.723</c:v>
                </c:pt>
                <c:pt idx="141">
                  <c:v>1194.193</c:v>
                </c:pt>
                <c:pt idx="142">
                  <c:v>1202.662</c:v>
                </c:pt>
                <c:pt idx="143">
                  <c:v>1211.1320000000001</c:v>
                </c:pt>
                <c:pt idx="144">
                  <c:v>1219.6010000000001</c:v>
                </c:pt>
                <c:pt idx="145">
                  <c:v>1228.07</c:v>
                </c:pt>
                <c:pt idx="146">
                  <c:v>1236.54</c:v>
                </c:pt>
                <c:pt idx="147">
                  <c:v>1245.009</c:v>
                </c:pt>
                <c:pt idx="148">
                  <c:v>1253.479</c:v>
                </c:pt>
                <c:pt idx="149">
                  <c:v>1261.9480000000001</c:v>
                </c:pt>
                <c:pt idx="150">
                  <c:v>1270.4179999999999</c:v>
                </c:pt>
                <c:pt idx="151">
                  <c:v>1278.8869999999999</c:v>
                </c:pt>
                <c:pt idx="152">
                  <c:v>1287.357</c:v>
                </c:pt>
                <c:pt idx="153">
                  <c:v>1295.826</c:v>
                </c:pt>
                <c:pt idx="154">
                  <c:v>1304.2950000000001</c:v>
                </c:pt>
                <c:pt idx="155">
                  <c:v>1312.7650000000001</c:v>
                </c:pt>
                <c:pt idx="156">
                  <c:v>1321.2339999999999</c:v>
                </c:pt>
                <c:pt idx="157">
                  <c:v>1329.704</c:v>
                </c:pt>
                <c:pt idx="158">
                  <c:v>1338.173</c:v>
                </c:pt>
                <c:pt idx="159">
                  <c:v>1346.643</c:v>
                </c:pt>
                <c:pt idx="160">
                  <c:v>1355.1120000000001</c:v>
                </c:pt>
                <c:pt idx="161">
                  <c:v>1363.5820000000001</c:v>
                </c:pt>
                <c:pt idx="162">
                  <c:v>1372.0509999999999</c:v>
                </c:pt>
                <c:pt idx="163">
                  <c:v>1380.521</c:v>
                </c:pt>
                <c:pt idx="164">
                  <c:v>1388.99</c:v>
                </c:pt>
                <c:pt idx="165">
                  <c:v>1397.4590000000001</c:v>
                </c:pt>
                <c:pt idx="166">
                  <c:v>1405.9290000000001</c:v>
                </c:pt>
                <c:pt idx="167">
                  <c:v>1414.3979999999999</c:v>
                </c:pt>
                <c:pt idx="168">
                  <c:v>1422.8679999999999</c:v>
                </c:pt>
                <c:pt idx="169">
                  <c:v>1431.337</c:v>
                </c:pt>
                <c:pt idx="170">
                  <c:v>1436.809</c:v>
                </c:pt>
                <c:pt idx="171">
                  <c:v>1439.807</c:v>
                </c:pt>
                <c:pt idx="172">
                  <c:v>1448.2760000000001</c:v>
                </c:pt>
                <c:pt idx="173">
                  <c:v>1456.7460000000001</c:v>
                </c:pt>
                <c:pt idx="174">
                  <c:v>1465.2149999999999</c:v>
                </c:pt>
                <c:pt idx="175">
                  <c:v>1473.6849999999999</c:v>
                </c:pt>
                <c:pt idx="176">
                  <c:v>1482.154</c:v>
                </c:pt>
                <c:pt idx="177">
                  <c:v>1490.623</c:v>
                </c:pt>
                <c:pt idx="178">
                  <c:v>1493.09</c:v>
                </c:pt>
                <c:pt idx="179">
                  <c:v>1499.0930000000001</c:v>
                </c:pt>
                <c:pt idx="180">
                  <c:v>1500</c:v>
                </c:pt>
                <c:pt idx="181">
                  <c:v>1501.684</c:v>
                </c:pt>
                <c:pt idx="182">
                  <c:v>1504.3620000000001</c:v>
                </c:pt>
                <c:pt idx="183">
                  <c:v>1507.5619999999999</c:v>
                </c:pt>
                <c:pt idx="184">
                  <c:v>1509.23</c:v>
                </c:pt>
                <c:pt idx="185">
                  <c:v>1509.867</c:v>
                </c:pt>
                <c:pt idx="186">
                  <c:v>1516.0219999999999</c:v>
                </c:pt>
                <c:pt idx="187">
                  <c:v>1516.0319999999999</c:v>
                </c:pt>
                <c:pt idx="188">
                  <c:v>1519.2719999999999</c:v>
                </c:pt>
                <c:pt idx="189">
                  <c:v>1522.569</c:v>
                </c:pt>
                <c:pt idx="190">
                  <c:v>1524.12</c:v>
                </c:pt>
                <c:pt idx="191">
                  <c:v>1524.501</c:v>
                </c:pt>
                <c:pt idx="192">
                  <c:v>1526.1469999999999</c:v>
                </c:pt>
                <c:pt idx="193">
                  <c:v>1527.653</c:v>
                </c:pt>
                <c:pt idx="194">
                  <c:v>1530.675</c:v>
                </c:pt>
                <c:pt idx="195">
                  <c:v>1532.9280000000001</c:v>
                </c:pt>
                <c:pt idx="196">
                  <c:v>1532.971</c:v>
                </c:pt>
                <c:pt idx="197">
                  <c:v>1533.662</c:v>
                </c:pt>
                <c:pt idx="198">
                  <c:v>1535.0650000000001</c:v>
                </c:pt>
                <c:pt idx="199">
                  <c:v>1535.865</c:v>
                </c:pt>
                <c:pt idx="200">
                  <c:v>1536.133</c:v>
                </c:pt>
                <c:pt idx="201">
                  <c:v>1539.384</c:v>
                </c:pt>
                <c:pt idx="202">
                  <c:v>1541.2529999999999</c:v>
                </c:pt>
                <c:pt idx="203">
                  <c:v>1541.44</c:v>
                </c:pt>
                <c:pt idx="204">
                  <c:v>1542.3430000000001</c:v>
                </c:pt>
                <c:pt idx="205">
                  <c:v>1543.1369999999999</c:v>
                </c:pt>
                <c:pt idx="206">
                  <c:v>1546.3109999999999</c:v>
                </c:pt>
                <c:pt idx="207">
                  <c:v>1547.2760000000001</c:v>
                </c:pt>
                <c:pt idx="208">
                  <c:v>1548.5889999999999</c:v>
                </c:pt>
                <c:pt idx="209">
                  <c:v>1549.2670000000001</c:v>
                </c:pt>
                <c:pt idx="210">
                  <c:v>1549.91</c:v>
                </c:pt>
                <c:pt idx="211">
                  <c:v>1551.19</c:v>
                </c:pt>
                <c:pt idx="212">
                  <c:v>1551.502</c:v>
                </c:pt>
                <c:pt idx="213">
                  <c:v>1553.117</c:v>
                </c:pt>
                <c:pt idx="214">
                  <c:v>1553.384</c:v>
                </c:pt>
                <c:pt idx="215">
                  <c:v>1554.2550000000001</c:v>
                </c:pt>
                <c:pt idx="216">
                  <c:v>1554.5129999999999</c:v>
                </c:pt>
                <c:pt idx="217">
                  <c:v>1555.441</c:v>
                </c:pt>
                <c:pt idx="218">
                  <c:v>1555.607</c:v>
                </c:pt>
                <c:pt idx="219">
                  <c:v>1555.895</c:v>
                </c:pt>
                <c:pt idx="220">
                  <c:v>1557.1110000000001</c:v>
                </c:pt>
                <c:pt idx="221">
                  <c:v>1557.3</c:v>
                </c:pt>
                <c:pt idx="222">
                  <c:v>1558.069</c:v>
                </c:pt>
                <c:pt idx="223">
                  <c:v>1558.3789999999999</c:v>
                </c:pt>
                <c:pt idx="224">
                  <c:v>1559.665</c:v>
                </c:pt>
                <c:pt idx="225">
                  <c:v>1560.3019999999999</c:v>
                </c:pt>
                <c:pt idx="226">
                  <c:v>1560.963</c:v>
                </c:pt>
                <c:pt idx="227">
                  <c:v>1561.268</c:v>
                </c:pt>
                <c:pt idx="228">
                  <c:v>1561.932</c:v>
                </c:pt>
                <c:pt idx="229">
                  <c:v>1562.424</c:v>
                </c:pt>
                <c:pt idx="230">
                  <c:v>1562.999</c:v>
                </c:pt>
                <c:pt idx="231">
                  <c:v>1563.4839999999999</c:v>
                </c:pt>
                <c:pt idx="232">
                  <c:v>1564.5219999999999</c:v>
                </c:pt>
                <c:pt idx="233">
                  <c:v>1565.556</c:v>
                </c:pt>
                <c:pt idx="234">
                  <c:v>1566.153</c:v>
                </c:pt>
                <c:pt idx="235">
                  <c:v>1566.848</c:v>
                </c:pt>
                <c:pt idx="236">
                  <c:v>1568.0070000000001</c:v>
                </c:pt>
                <c:pt idx="237">
                  <c:v>1569.4280000000001</c:v>
                </c:pt>
                <c:pt idx="238">
                  <c:v>1570.528</c:v>
                </c:pt>
                <c:pt idx="239">
                  <c:v>1571.1880000000001</c:v>
                </c:pt>
                <c:pt idx="240">
                  <c:v>1571.28</c:v>
                </c:pt>
                <c:pt idx="241">
                  <c:v>1571.3440000000001</c:v>
                </c:pt>
                <c:pt idx="242">
                  <c:v>1571.5360000000001</c:v>
                </c:pt>
                <c:pt idx="243">
                  <c:v>1571.701</c:v>
                </c:pt>
                <c:pt idx="244">
                  <c:v>1571.826</c:v>
                </c:pt>
                <c:pt idx="245">
                  <c:v>1572.3050000000001</c:v>
                </c:pt>
                <c:pt idx="246">
                  <c:v>1572.8679999999999</c:v>
                </c:pt>
                <c:pt idx="247">
                  <c:v>1573.4069999999999</c:v>
                </c:pt>
                <c:pt idx="248">
                  <c:v>1573.973</c:v>
                </c:pt>
                <c:pt idx="249">
                  <c:v>1574.6489999999999</c:v>
                </c:pt>
                <c:pt idx="250">
                  <c:v>1575.0239999999999</c:v>
                </c:pt>
                <c:pt idx="251">
                  <c:v>1575.318</c:v>
                </c:pt>
                <c:pt idx="252">
                  <c:v>1575.7850000000001</c:v>
                </c:pt>
                <c:pt idx="253">
                  <c:v>1577.1420000000001</c:v>
                </c:pt>
                <c:pt idx="254">
                  <c:v>1577.347</c:v>
                </c:pt>
                <c:pt idx="255">
                  <c:v>1577.7840000000001</c:v>
                </c:pt>
                <c:pt idx="256">
                  <c:v>1577.9490000000001</c:v>
                </c:pt>
                <c:pt idx="257">
                  <c:v>1578.3520000000001</c:v>
                </c:pt>
                <c:pt idx="258">
                  <c:v>1578.9939999999999</c:v>
                </c:pt>
                <c:pt idx="259">
                  <c:v>1579.184</c:v>
                </c:pt>
                <c:pt idx="260">
                  <c:v>1579.461</c:v>
                </c:pt>
                <c:pt idx="261">
                  <c:v>1580.05</c:v>
                </c:pt>
                <c:pt idx="262">
                  <c:v>1580.6990000000001</c:v>
                </c:pt>
                <c:pt idx="263">
                  <c:v>1581.4839999999999</c:v>
                </c:pt>
                <c:pt idx="264">
                  <c:v>1582.087</c:v>
                </c:pt>
                <c:pt idx="265">
                  <c:v>1583.058</c:v>
                </c:pt>
                <c:pt idx="266">
                  <c:v>1583.787</c:v>
                </c:pt>
                <c:pt idx="267">
                  <c:v>1584.0250000000001</c:v>
                </c:pt>
                <c:pt idx="268">
                  <c:v>1584.1769999999999</c:v>
                </c:pt>
                <c:pt idx="269">
                  <c:v>1585.124</c:v>
                </c:pt>
                <c:pt idx="270">
                  <c:v>1585.3689999999999</c:v>
                </c:pt>
                <c:pt idx="271">
                  <c:v>1585.654</c:v>
                </c:pt>
                <c:pt idx="272">
                  <c:v>1585.9469999999999</c:v>
                </c:pt>
                <c:pt idx="273">
                  <c:v>1586.326</c:v>
                </c:pt>
                <c:pt idx="274">
                  <c:v>1586.693</c:v>
                </c:pt>
                <c:pt idx="275">
                  <c:v>1587.068</c:v>
                </c:pt>
                <c:pt idx="276">
                  <c:v>1587.5809999999999</c:v>
                </c:pt>
                <c:pt idx="277">
                  <c:v>1589.5909999999999</c:v>
                </c:pt>
                <c:pt idx="278">
                  <c:v>1590.328</c:v>
                </c:pt>
                <c:pt idx="279">
                  <c:v>1591.848</c:v>
                </c:pt>
                <c:pt idx="280">
                  <c:v>1592.021</c:v>
                </c:pt>
                <c:pt idx="281">
                  <c:v>1592.2570000000001</c:v>
                </c:pt>
                <c:pt idx="282">
                  <c:v>1592.316</c:v>
                </c:pt>
                <c:pt idx="283">
                  <c:v>1593.3440000000001</c:v>
                </c:pt>
                <c:pt idx="284">
                  <c:v>1593.7239999999999</c:v>
                </c:pt>
                <c:pt idx="285">
                  <c:v>1594.0540000000001</c:v>
                </c:pt>
                <c:pt idx="286">
                  <c:v>1594.307</c:v>
                </c:pt>
                <c:pt idx="287">
                  <c:v>1594.7170000000001</c:v>
                </c:pt>
                <c:pt idx="288">
                  <c:v>1595.2650000000001</c:v>
                </c:pt>
                <c:pt idx="289">
                  <c:v>1595.933</c:v>
                </c:pt>
                <c:pt idx="290">
                  <c:v>1596.9929999999999</c:v>
                </c:pt>
                <c:pt idx="291">
                  <c:v>1597.1869999999999</c:v>
                </c:pt>
                <c:pt idx="292">
                  <c:v>1598.133</c:v>
                </c:pt>
                <c:pt idx="293">
                  <c:v>1598.73</c:v>
                </c:pt>
                <c:pt idx="294">
                  <c:v>1599.4010000000001</c:v>
                </c:pt>
                <c:pt idx="295">
                  <c:v>1599.8209999999999</c:v>
                </c:pt>
                <c:pt idx="296">
                  <c:v>1600.1990000000001</c:v>
                </c:pt>
                <c:pt idx="297">
                  <c:v>1600.2650000000001</c:v>
                </c:pt>
                <c:pt idx="298">
                  <c:v>1600.396</c:v>
                </c:pt>
                <c:pt idx="299">
                  <c:v>1600.7260000000001</c:v>
                </c:pt>
                <c:pt idx="300">
                  <c:v>1600.7539999999999</c:v>
                </c:pt>
                <c:pt idx="301">
                  <c:v>1602.297</c:v>
                </c:pt>
                <c:pt idx="302">
                  <c:v>1602.78</c:v>
                </c:pt>
                <c:pt idx="303">
                  <c:v>1603.683</c:v>
                </c:pt>
                <c:pt idx="304">
                  <c:v>1605.43</c:v>
                </c:pt>
                <c:pt idx="305">
                  <c:v>1606.3979999999999</c:v>
                </c:pt>
                <c:pt idx="306">
                  <c:v>1607.5509999999999</c:v>
                </c:pt>
                <c:pt idx="307">
                  <c:v>1607.9929999999999</c:v>
                </c:pt>
                <c:pt idx="308">
                  <c:v>1608.204</c:v>
                </c:pt>
                <c:pt idx="309">
                  <c:v>1609.1959999999999</c:v>
                </c:pt>
                <c:pt idx="310">
                  <c:v>1609.3309999999999</c:v>
                </c:pt>
                <c:pt idx="311">
                  <c:v>1610.1279999999999</c:v>
                </c:pt>
                <c:pt idx="312">
                  <c:v>1610.325</c:v>
                </c:pt>
                <c:pt idx="313">
                  <c:v>1611.0060000000001</c:v>
                </c:pt>
                <c:pt idx="314">
                  <c:v>1611.413</c:v>
                </c:pt>
                <c:pt idx="315">
                  <c:v>1611.8979999999999</c:v>
                </c:pt>
                <c:pt idx="316">
                  <c:v>1612.2860000000001</c:v>
                </c:pt>
                <c:pt idx="317">
                  <c:v>1613.711</c:v>
                </c:pt>
                <c:pt idx="318">
                  <c:v>1613.883</c:v>
                </c:pt>
                <c:pt idx="319">
                  <c:v>1614.5309999999999</c:v>
                </c:pt>
                <c:pt idx="320">
                  <c:v>1614.933</c:v>
                </c:pt>
                <c:pt idx="321">
                  <c:v>1615.2550000000001</c:v>
                </c:pt>
                <c:pt idx="322">
                  <c:v>1615.482</c:v>
                </c:pt>
                <c:pt idx="323">
                  <c:v>1616.309</c:v>
                </c:pt>
                <c:pt idx="324">
                  <c:v>1617.3810000000001</c:v>
                </c:pt>
                <c:pt idx="325">
                  <c:v>1617.665</c:v>
                </c:pt>
                <c:pt idx="326">
                  <c:v>1617.6890000000001</c:v>
                </c:pt>
                <c:pt idx="327">
                  <c:v>1618.4079999999999</c:v>
                </c:pt>
                <c:pt idx="328">
                  <c:v>1618.701</c:v>
                </c:pt>
                <c:pt idx="329">
                  <c:v>1619.0809999999999</c:v>
                </c:pt>
                <c:pt idx="330">
                  <c:v>1619.3150000000001</c:v>
                </c:pt>
                <c:pt idx="331">
                  <c:v>1621.0309999999999</c:v>
                </c:pt>
                <c:pt idx="332">
                  <c:v>1621.268</c:v>
                </c:pt>
                <c:pt idx="333">
                  <c:v>1622.002</c:v>
                </c:pt>
                <c:pt idx="334">
                  <c:v>1622.2339999999999</c:v>
                </c:pt>
                <c:pt idx="335">
                  <c:v>1622.9169999999999</c:v>
                </c:pt>
                <c:pt idx="336">
                  <c:v>1624.335</c:v>
                </c:pt>
                <c:pt idx="337">
                  <c:v>1624.93</c:v>
                </c:pt>
                <c:pt idx="338">
                  <c:v>1625.56</c:v>
                </c:pt>
                <c:pt idx="339">
                  <c:v>1626.135</c:v>
                </c:pt>
                <c:pt idx="340">
                  <c:v>1626.5170000000001</c:v>
                </c:pt>
                <c:pt idx="341">
                  <c:v>1627.1679999999999</c:v>
                </c:pt>
                <c:pt idx="342">
                  <c:v>1627.682</c:v>
                </c:pt>
                <c:pt idx="343">
                  <c:v>1628.835</c:v>
                </c:pt>
                <c:pt idx="344">
                  <c:v>1629.9459999999999</c:v>
                </c:pt>
                <c:pt idx="345">
                  <c:v>1631.0830000000001</c:v>
                </c:pt>
                <c:pt idx="346">
                  <c:v>1633.104</c:v>
                </c:pt>
                <c:pt idx="347">
                  <c:v>1633.4169999999999</c:v>
                </c:pt>
                <c:pt idx="348">
                  <c:v>1633.8810000000001</c:v>
                </c:pt>
                <c:pt idx="349">
                  <c:v>1634.604</c:v>
                </c:pt>
                <c:pt idx="350">
                  <c:v>1634.6189999999999</c:v>
                </c:pt>
                <c:pt idx="351">
                  <c:v>1635.2349999999999</c:v>
                </c:pt>
                <c:pt idx="352">
                  <c:v>1636.6990000000001</c:v>
                </c:pt>
                <c:pt idx="353">
                  <c:v>1637.598</c:v>
                </c:pt>
                <c:pt idx="354">
                  <c:v>1637.8689999999999</c:v>
                </c:pt>
                <c:pt idx="355">
                  <c:v>1638.1010000000001</c:v>
                </c:pt>
                <c:pt idx="356">
                  <c:v>1638.6320000000001</c:v>
                </c:pt>
                <c:pt idx="357">
                  <c:v>1639.6849999999999</c:v>
                </c:pt>
                <c:pt idx="358">
                  <c:v>1640.644</c:v>
                </c:pt>
                <c:pt idx="359">
                  <c:v>1640.9870000000001</c:v>
                </c:pt>
                <c:pt idx="360">
                  <c:v>1641.5070000000001</c:v>
                </c:pt>
                <c:pt idx="361">
                  <c:v>1641.799</c:v>
                </c:pt>
                <c:pt idx="362">
                  <c:v>1642.058</c:v>
                </c:pt>
                <c:pt idx="363">
                  <c:v>1642.192</c:v>
                </c:pt>
                <c:pt idx="364">
                  <c:v>1642.9280000000001</c:v>
                </c:pt>
                <c:pt idx="365">
                  <c:v>1643.0740000000001</c:v>
                </c:pt>
                <c:pt idx="366">
                  <c:v>1644.5909999999999</c:v>
                </c:pt>
                <c:pt idx="367">
                  <c:v>1645.796</c:v>
                </c:pt>
                <c:pt idx="368">
                  <c:v>1646.711</c:v>
                </c:pt>
                <c:pt idx="369">
                  <c:v>1647.2190000000001</c:v>
                </c:pt>
                <c:pt idx="370">
                  <c:v>1648.7950000000001</c:v>
                </c:pt>
                <c:pt idx="371">
                  <c:v>1649.711</c:v>
                </c:pt>
                <c:pt idx="372">
                  <c:v>1650.296</c:v>
                </c:pt>
                <c:pt idx="373">
                  <c:v>1650.5360000000001</c:v>
                </c:pt>
                <c:pt idx="374">
                  <c:v>1651.5429999999999</c:v>
                </c:pt>
                <c:pt idx="375">
                  <c:v>1652.548</c:v>
                </c:pt>
                <c:pt idx="376">
                  <c:v>1653.412</c:v>
                </c:pt>
                <c:pt idx="377">
                  <c:v>1654.8689999999999</c:v>
                </c:pt>
                <c:pt idx="378">
                  <c:v>1657.4169999999999</c:v>
                </c:pt>
                <c:pt idx="379">
                  <c:v>1657.8679999999999</c:v>
                </c:pt>
                <c:pt idx="380">
                  <c:v>1658.6310000000001</c:v>
                </c:pt>
                <c:pt idx="381">
                  <c:v>1658.819</c:v>
                </c:pt>
                <c:pt idx="382">
                  <c:v>1659.0550000000001</c:v>
                </c:pt>
                <c:pt idx="383">
                  <c:v>1660.0119999999999</c:v>
                </c:pt>
                <c:pt idx="384">
                  <c:v>1661.38</c:v>
                </c:pt>
                <c:pt idx="385">
                  <c:v>1662.961</c:v>
                </c:pt>
                <c:pt idx="386">
                  <c:v>1667.029</c:v>
                </c:pt>
                <c:pt idx="387">
                  <c:v>1667.2529999999999</c:v>
                </c:pt>
                <c:pt idx="388">
                  <c:v>1667.7249999999999</c:v>
                </c:pt>
                <c:pt idx="389">
                  <c:v>1668.4179999999999</c:v>
                </c:pt>
                <c:pt idx="390">
                  <c:v>1668.482</c:v>
                </c:pt>
                <c:pt idx="391">
                  <c:v>1669.98</c:v>
                </c:pt>
                <c:pt idx="392">
                  <c:v>1672.1569999999999</c:v>
                </c:pt>
                <c:pt idx="393">
                  <c:v>1672.856</c:v>
                </c:pt>
                <c:pt idx="394">
                  <c:v>1675.1179999999999</c:v>
                </c:pt>
                <c:pt idx="395">
                  <c:v>1676.0840000000001</c:v>
                </c:pt>
                <c:pt idx="396">
                  <c:v>1676.951</c:v>
                </c:pt>
                <c:pt idx="397">
                  <c:v>1677.442</c:v>
                </c:pt>
                <c:pt idx="398">
                  <c:v>1685.421</c:v>
                </c:pt>
                <c:pt idx="399">
                  <c:v>1686.0940000000001</c:v>
                </c:pt>
                <c:pt idx="400">
                  <c:v>1693.89</c:v>
                </c:pt>
                <c:pt idx="401">
                  <c:v>1693.89</c:v>
                </c:pt>
              </c:numCache>
            </c:numRef>
          </c:xVal>
          <c:yVal>
            <c:numRef>
              <c:f>Foglio6!$D$5:$D$418</c:f>
              <c:numCache>
                <c:formatCode>General</c:formatCode>
                <c:ptCount val="414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100</c:v>
                </c:pt>
                <c:pt idx="162">
                  <c:v>100</c:v>
                </c:pt>
                <c:pt idx="163">
                  <c:v>100</c:v>
                </c:pt>
                <c:pt idx="164">
                  <c:v>100</c:v>
                </c:pt>
                <c:pt idx="165">
                  <c:v>100</c:v>
                </c:pt>
                <c:pt idx="166">
                  <c:v>100</c:v>
                </c:pt>
                <c:pt idx="167">
                  <c:v>100</c:v>
                </c:pt>
                <c:pt idx="168">
                  <c:v>100</c:v>
                </c:pt>
                <c:pt idx="169">
                  <c:v>100</c:v>
                </c:pt>
                <c:pt idx="170">
                  <c:v>100</c:v>
                </c:pt>
                <c:pt idx="171">
                  <c:v>99.989000000000004</c:v>
                </c:pt>
                <c:pt idx="172">
                  <c:v>99.983000000000004</c:v>
                </c:pt>
                <c:pt idx="173">
                  <c:v>99.977999999999994</c:v>
                </c:pt>
                <c:pt idx="174">
                  <c:v>99.972999999999999</c:v>
                </c:pt>
                <c:pt idx="175">
                  <c:v>99.927999999999997</c:v>
                </c:pt>
                <c:pt idx="176">
                  <c:v>99.652000000000001</c:v>
                </c:pt>
                <c:pt idx="177">
                  <c:v>99.56</c:v>
                </c:pt>
                <c:pt idx="178">
                  <c:v>99.5</c:v>
                </c:pt>
                <c:pt idx="179">
                  <c:v>99.07</c:v>
                </c:pt>
                <c:pt idx="180">
                  <c:v>99</c:v>
                </c:pt>
                <c:pt idx="181">
                  <c:v>98.5</c:v>
                </c:pt>
                <c:pt idx="182">
                  <c:v>98</c:v>
                </c:pt>
                <c:pt idx="183">
                  <c:v>97.551000000000002</c:v>
                </c:pt>
                <c:pt idx="184">
                  <c:v>97.5</c:v>
                </c:pt>
                <c:pt idx="185">
                  <c:v>97</c:v>
                </c:pt>
                <c:pt idx="186">
                  <c:v>96.5</c:v>
                </c:pt>
                <c:pt idx="187">
                  <c:v>96.492000000000004</c:v>
                </c:pt>
                <c:pt idx="188">
                  <c:v>96</c:v>
                </c:pt>
                <c:pt idx="189">
                  <c:v>95.5</c:v>
                </c:pt>
                <c:pt idx="190">
                  <c:v>95</c:v>
                </c:pt>
                <c:pt idx="191">
                  <c:v>94.977999999999994</c:v>
                </c:pt>
                <c:pt idx="192">
                  <c:v>94.5</c:v>
                </c:pt>
                <c:pt idx="193">
                  <c:v>94</c:v>
                </c:pt>
                <c:pt idx="194">
                  <c:v>93.5</c:v>
                </c:pt>
                <c:pt idx="195">
                  <c:v>93</c:v>
                </c:pt>
                <c:pt idx="196">
                  <c:v>92.977999999999994</c:v>
                </c:pt>
                <c:pt idx="197">
                  <c:v>92.5</c:v>
                </c:pt>
                <c:pt idx="198">
                  <c:v>92</c:v>
                </c:pt>
                <c:pt idx="199">
                  <c:v>91.5</c:v>
                </c:pt>
                <c:pt idx="200">
                  <c:v>91</c:v>
                </c:pt>
                <c:pt idx="201">
                  <c:v>90.5</c:v>
                </c:pt>
                <c:pt idx="202">
                  <c:v>90</c:v>
                </c:pt>
                <c:pt idx="203">
                  <c:v>89.965000000000003</c:v>
                </c:pt>
                <c:pt idx="204">
                  <c:v>89.5</c:v>
                </c:pt>
                <c:pt idx="205">
                  <c:v>89</c:v>
                </c:pt>
                <c:pt idx="206">
                  <c:v>88.5</c:v>
                </c:pt>
                <c:pt idx="207">
                  <c:v>88</c:v>
                </c:pt>
                <c:pt idx="208">
                  <c:v>87.5</c:v>
                </c:pt>
                <c:pt idx="209">
                  <c:v>87</c:v>
                </c:pt>
                <c:pt idx="210">
                  <c:v>86.760999999999996</c:v>
                </c:pt>
                <c:pt idx="211">
                  <c:v>86.5</c:v>
                </c:pt>
                <c:pt idx="212">
                  <c:v>86</c:v>
                </c:pt>
                <c:pt idx="213">
                  <c:v>85.5</c:v>
                </c:pt>
                <c:pt idx="214">
                  <c:v>85</c:v>
                </c:pt>
                <c:pt idx="215">
                  <c:v>84.5</c:v>
                </c:pt>
                <c:pt idx="216">
                  <c:v>84</c:v>
                </c:pt>
                <c:pt idx="217">
                  <c:v>83.5</c:v>
                </c:pt>
                <c:pt idx="218">
                  <c:v>83</c:v>
                </c:pt>
                <c:pt idx="219">
                  <c:v>82.5</c:v>
                </c:pt>
                <c:pt idx="220">
                  <c:v>82</c:v>
                </c:pt>
                <c:pt idx="221">
                  <c:v>81.5</c:v>
                </c:pt>
                <c:pt idx="222">
                  <c:v>81</c:v>
                </c:pt>
                <c:pt idx="223">
                  <c:v>80.844999999999999</c:v>
                </c:pt>
                <c:pt idx="224">
                  <c:v>80.5</c:v>
                </c:pt>
                <c:pt idx="225">
                  <c:v>80</c:v>
                </c:pt>
                <c:pt idx="226">
                  <c:v>79.5</c:v>
                </c:pt>
                <c:pt idx="227">
                  <c:v>79</c:v>
                </c:pt>
                <c:pt idx="228">
                  <c:v>78.5</c:v>
                </c:pt>
                <c:pt idx="229">
                  <c:v>78</c:v>
                </c:pt>
                <c:pt idx="230">
                  <c:v>77.5</c:v>
                </c:pt>
                <c:pt idx="231">
                  <c:v>77</c:v>
                </c:pt>
                <c:pt idx="232">
                  <c:v>76.5</c:v>
                </c:pt>
                <c:pt idx="233">
                  <c:v>76</c:v>
                </c:pt>
                <c:pt idx="234">
                  <c:v>75.5</c:v>
                </c:pt>
                <c:pt idx="235">
                  <c:v>75.42</c:v>
                </c:pt>
                <c:pt idx="236">
                  <c:v>75</c:v>
                </c:pt>
                <c:pt idx="237">
                  <c:v>74.5</c:v>
                </c:pt>
                <c:pt idx="238">
                  <c:v>74</c:v>
                </c:pt>
                <c:pt idx="239">
                  <c:v>73.5</c:v>
                </c:pt>
                <c:pt idx="240">
                  <c:v>73</c:v>
                </c:pt>
                <c:pt idx="241">
                  <c:v>72.5</c:v>
                </c:pt>
                <c:pt idx="242">
                  <c:v>72</c:v>
                </c:pt>
                <c:pt idx="243">
                  <c:v>71.5</c:v>
                </c:pt>
                <c:pt idx="244">
                  <c:v>71</c:v>
                </c:pt>
                <c:pt idx="245">
                  <c:v>70.5</c:v>
                </c:pt>
                <c:pt idx="246">
                  <c:v>70</c:v>
                </c:pt>
                <c:pt idx="247">
                  <c:v>69.5</c:v>
                </c:pt>
                <c:pt idx="248">
                  <c:v>69</c:v>
                </c:pt>
                <c:pt idx="249">
                  <c:v>68.5</c:v>
                </c:pt>
                <c:pt idx="250">
                  <c:v>68</c:v>
                </c:pt>
                <c:pt idx="251">
                  <c:v>67.712999999999994</c:v>
                </c:pt>
                <c:pt idx="252">
                  <c:v>67.5</c:v>
                </c:pt>
                <c:pt idx="253">
                  <c:v>67</c:v>
                </c:pt>
                <c:pt idx="254">
                  <c:v>66.5</c:v>
                </c:pt>
                <c:pt idx="255">
                  <c:v>66</c:v>
                </c:pt>
                <c:pt idx="256">
                  <c:v>65.5</c:v>
                </c:pt>
                <c:pt idx="257">
                  <c:v>65</c:v>
                </c:pt>
                <c:pt idx="258">
                  <c:v>64.5</c:v>
                </c:pt>
                <c:pt idx="259">
                  <c:v>64</c:v>
                </c:pt>
                <c:pt idx="260">
                  <c:v>63.5</c:v>
                </c:pt>
                <c:pt idx="261">
                  <c:v>63</c:v>
                </c:pt>
                <c:pt idx="262">
                  <c:v>62.5</c:v>
                </c:pt>
                <c:pt idx="263">
                  <c:v>62</c:v>
                </c:pt>
                <c:pt idx="264">
                  <c:v>61.5</c:v>
                </c:pt>
                <c:pt idx="265">
                  <c:v>61</c:v>
                </c:pt>
                <c:pt idx="266">
                  <c:v>60.619</c:v>
                </c:pt>
                <c:pt idx="267">
                  <c:v>60.5</c:v>
                </c:pt>
                <c:pt idx="268">
                  <c:v>60</c:v>
                </c:pt>
                <c:pt idx="269">
                  <c:v>59.5</c:v>
                </c:pt>
                <c:pt idx="270">
                  <c:v>59</c:v>
                </c:pt>
                <c:pt idx="271">
                  <c:v>58.5</c:v>
                </c:pt>
                <c:pt idx="272">
                  <c:v>58</c:v>
                </c:pt>
                <c:pt idx="273">
                  <c:v>57.5</c:v>
                </c:pt>
                <c:pt idx="274">
                  <c:v>57</c:v>
                </c:pt>
                <c:pt idx="275">
                  <c:v>56.5</c:v>
                </c:pt>
                <c:pt idx="276">
                  <c:v>56</c:v>
                </c:pt>
                <c:pt idx="277">
                  <c:v>55.5</c:v>
                </c:pt>
                <c:pt idx="278">
                  <c:v>55</c:v>
                </c:pt>
                <c:pt idx="279">
                  <c:v>54.5</c:v>
                </c:pt>
                <c:pt idx="280">
                  <c:v>54</c:v>
                </c:pt>
                <c:pt idx="281">
                  <c:v>53.536999999999999</c:v>
                </c:pt>
                <c:pt idx="282">
                  <c:v>53.5</c:v>
                </c:pt>
                <c:pt idx="283">
                  <c:v>53</c:v>
                </c:pt>
                <c:pt idx="284">
                  <c:v>52.5</c:v>
                </c:pt>
                <c:pt idx="285">
                  <c:v>52</c:v>
                </c:pt>
                <c:pt idx="286">
                  <c:v>51.5</c:v>
                </c:pt>
                <c:pt idx="287">
                  <c:v>51</c:v>
                </c:pt>
                <c:pt idx="288">
                  <c:v>50.5</c:v>
                </c:pt>
                <c:pt idx="289">
                  <c:v>50</c:v>
                </c:pt>
                <c:pt idx="290">
                  <c:v>49.5</c:v>
                </c:pt>
                <c:pt idx="291">
                  <c:v>49</c:v>
                </c:pt>
                <c:pt idx="292">
                  <c:v>48.5</c:v>
                </c:pt>
                <c:pt idx="293">
                  <c:v>48</c:v>
                </c:pt>
                <c:pt idx="294">
                  <c:v>47.5</c:v>
                </c:pt>
                <c:pt idx="295">
                  <c:v>47</c:v>
                </c:pt>
                <c:pt idx="296">
                  <c:v>46.5</c:v>
                </c:pt>
                <c:pt idx="297">
                  <c:v>46</c:v>
                </c:pt>
                <c:pt idx="298">
                  <c:v>45.5</c:v>
                </c:pt>
                <c:pt idx="299">
                  <c:v>45.021999999999998</c:v>
                </c:pt>
                <c:pt idx="300">
                  <c:v>45</c:v>
                </c:pt>
                <c:pt idx="301">
                  <c:v>44.5</c:v>
                </c:pt>
                <c:pt idx="302">
                  <c:v>44</c:v>
                </c:pt>
                <c:pt idx="303">
                  <c:v>43.5</c:v>
                </c:pt>
                <c:pt idx="304">
                  <c:v>43</c:v>
                </c:pt>
                <c:pt idx="305">
                  <c:v>42.5</c:v>
                </c:pt>
                <c:pt idx="306">
                  <c:v>42</c:v>
                </c:pt>
                <c:pt idx="307">
                  <c:v>41.5</c:v>
                </c:pt>
                <c:pt idx="308">
                  <c:v>41</c:v>
                </c:pt>
                <c:pt idx="309">
                  <c:v>40.536999999999999</c:v>
                </c:pt>
                <c:pt idx="310">
                  <c:v>40.5</c:v>
                </c:pt>
                <c:pt idx="311">
                  <c:v>40</c:v>
                </c:pt>
                <c:pt idx="312">
                  <c:v>39.5</c:v>
                </c:pt>
                <c:pt idx="313">
                  <c:v>39</c:v>
                </c:pt>
                <c:pt idx="314">
                  <c:v>38.5</c:v>
                </c:pt>
                <c:pt idx="315">
                  <c:v>38</c:v>
                </c:pt>
                <c:pt idx="316">
                  <c:v>37.5</c:v>
                </c:pt>
                <c:pt idx="317">
                  <c:v>37</c:v>
                </c:pt>
                <c:pt idx="318">
                  <c:v>36.5</c:v>
                </c:pt>
                <c:pt idx="319">
                  <c:v>36</c:v>
                </c:pt>
                <c:pt idx="320">
                  <c:v>35.5</c:v>
                </c:pt>
                <c:pt idx="321">
                  <c:v>35</c:v>
                </c:pt>
                <c:pt idx="322">
                  <c:v>34.5</c:v>
                </c:pt>
                <c:pt idx="323">
                  <c:v>34</c:v>
                </c:pt>
                <c:pt idx="324">
                  <c:v>33.5</c:v>
                </c:pt>
                <c:pt idx="325">
                  <c:v>33.130000000000003</c:v>
                </c:pt>
                <c:pt idx="326">
                  <c:v>33</c:v>
                </c:pt>
                <c:pt idx="327">
                  <c:v>32.5</c:v>
                </c:pt>
                <c:pt idx="328">
                  <c:v>32</c:v>
                </c:pt>
                <c:pt idx="329">
                  <c:v>31.5</c:v>
                </c:pt>
                <c:pt idx="330">
                  <c:v>31</c:v>
                </c:pt>
                <c:pt idx="331">
                  <c:v>30.5</c:v>
                </c:pt>
                <c:pt idx="332">
                  <c:v>30</c:v>
                </c:pt>
                <c:pt idx="333">
                  <c:v>29.5</c:v>
                </c:pt>
                <c:pt idx="334">
                  <c:v>29</c:v>
                </c:pt>
                <c:pt idx="335">
                  <c:v>28.5</c:v>
                </c:pt>
                <c:pt idx="336">
                  <c:v>28</c:v>
                </c:pt>
                <c:pt idx="337">
                  <c:v>27.5</c:v>
                </c:pt>
                <c:pt idx="338">
                  <c:v>27</c:v>
                </c:pt>
                <c:pt idx="339">
                  <c:v>26.779</c:v>
                </c:pt>
                <c:pt idx="340">
                  <c:v>26.5</c:v>
                </c:pt>
                <c:pt idx="341">
                  <c:v>26</c:v>
                </c:pt>
                <c:pt idx="342">
                  <c:v>25.5</c:v>
                </c:pt>
                <c:pt idx="343">
                  <c:v>25</c:v>
                </c:pt>
                <c:pt idx="344">
                  <c:v>24.5</c:v>
                </c:pt>
                <c:pt idx="345">
                  <c:v>24</c:v>
                </c:pt>
                <c:pt idx="346">
                  <c:v>23.5</c:v>
                </c:pt>
                <c:pt idx="347">
                  <c:v>23</c:v>
                </c:pt>
                <c:pt idx="348">
                  <c:v>22.5</c:v>
                </c:pt>
                <c:pt idx="349">
                  <c:v>22.004999999999999</c:v>
                </c:pt>
                <c:pt idx="350">
                  <c:v>22</c:v>
                </c:pt>
                <c:pt idx="351">
                  <c:v>21.5</c:v>
                </c:pt>
                <c:pt idx="352">
                  <c:v>21</c:v>
                </c:pt>
                <c:pt idx="353">
                  <c:v>20.5</c:v>
                </c:pt>
                <c:pt idx="354">
                  <c:v>20</c:v>
                </c:pt>
                <c:pt idx="355">
                  <c:v>19.5</c:v>
                </c:pt>
                <c:pt idx="356">
                  <c:v>19</c:v>
                </c:pt>
                <c:pt idx="357">
                  <c:v>18.5</c:v>
                </c:pt>
                <c:pt idx="358">
                  <c:v>18</c:v>
                </c:pt>
                <c:pt idx="359">
                  <c:v>17.5</c:v>
                </c:pt>
                <c:pt idx="360">
                  <c:v>17</c:v>
                </c:pt>
                <c:pt idx="361">
                  <c:v>16.5</c:v>
                </c:pt>
                <c:pt idx="362">
                  <c:v>16</c:v>
                </c:pt>
                <c:pt idx="363">
                  <c:v>15.5</c:v>
                </c:pt>
                <c:pt idx="364">
                  <c:v>15</c:v>
                </c:pt>
                <c:pt idx="365">
                  <c:v>14.911</c:v>
                </c:pt>
                <c:pt idx="366">
                  <c:v>14.5</c:v>
                </c:pt>
                <c:pt idx="367">
                  <c:v>14</c:v>
                </c:pt>
                <c:pt idx="368">
                  <c:v>13.5</c:v>
                </c:pt>
                <c:pt idx="369">
                  <c:v>13</c:v>
                </c:pt>
                <c:pt idx="370">
                  <c:v>12.5</c:v>
                </c:pt>
                <c:pt idx="371">
                  <c:v>12</c:v>
                </c:pt>
                <c:pt idx="372">
                  <c:v>11.5</c:v>
                </c:pt>
                <c:pt idx="373">
                  <c:v>11</c:v>
                </c:pt>
                <c:pt idx="374">
                  <c:v>10.72</c:v>
                </c:pt>
                <c:pt idx="375">
                  <c:v>10.5</c:v>
                </c:pt>
                <c:pt idx="376">
                  <c:v>10</c:v>
                </c:pt>
                <c:pt idx="377">
                  <c:v>9.5</c:v>
                </c:pt>
                <c:pt idx="378">
                  <c:v>9</c:v>
                </c:pt>
                <c:pt idx="379">
                  <c:v>8.5</c:v>
                </c:pt>
                <c:pt idx="380">
                  <c:v>8</c:v>
                </c:pt>
                <c:pt idx="381">
                  <c:v>7.5</c:v>
                </c:pt>
                <c:pt idx="382">
                  <c:v>7</c:v>
                </c:pt>
                <c:pt idx="383">
                  <c:v>6.8650000000000002</c:v>
                </c:pt>
                <c:pt idx="384">
                  <c:v>6.5</c:v>
                </c:pt>
                <c:pt idx="385">
                  <c:v>6</c:v>
                </c:pt>
                <c:pt idx="386">
                  <c:v>5.5</c:v>
                </c:pt>
                <c:pt idx="387">
                  <c:v>5</c:v>
                </c:pt>
                <c:pt idx="388">
                  <c:v>4.5</c:v>
                </c:pt>
                <c:pt idx="389">
                  <c:v>4</c:v>
                </c:pt>
                <c:pt idx="390">
                  <c:v>3.91</c:v>
                </c:pt>
                <c:pt idx="391">
                  <c:v>3.5</c:v>
                </c:pt>
                <c:pt idx="392">
                  <c:v>3</c:v>
                </c:pt>
                <c:pt idx="393">
                  <c:v>2.5</c:v>
                </c:pt>
                <c:pt idx="394">
                  <c:v>2</c:v>
                </c:pt>
                <c:pt idx="395">
                  <c:v>1.5</c:v>
                </c:pt>
                <c:pt idx="396">
                  <c:v>1.2250000000000001</c:v>
                </c:pt>
                <c:pt idx="397">
                  <c:v>1</c:v>
                </c:pt>
                <c:pt idx="398">
                  <c:v>0.69399999999999995</c:v>
                </c:pt>
                <c:pt idx="399">
                  <c:v>0.5</c:v>
                </c:pt>
                <c:pt idx="400">
                  <c:v>0.14399999999999999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331-46BE-B50F-9AAB614B149E}"/>
            </c:ext>
          </c:extLst>
        </c:ser>
        <c:ser>
          <c:idx val="1"/>
          <c:order val="2"/>
          <c:tx>
            <c:strRef>
              <c:f>Foglio6!$E$1</c:f>
              <c:strCache>
                <c:ptCount val="1"/>
                <c:pt idx="0">
                  <c:v>S0,5M5</c:v>
                </c:pt>
              </c:strCache>
            </c:strRef>
          </c:tx>
          <c:spPr>
            <a:ln w="19050" cap="rnd">
              <a:solidFill>
                <a:srgbClr val="FFCCCC"/>
              </a:solidFill>
              <a:round/>
            </a:ln>
            <a:effectLst/>
          </c:spPr>
          <c:marker>
            <c:symbol val="none"/>
          </c:marker>
          <c:xVal>
            <c:numRef>
              <c:f>Foglio6!$E$5:$E$418</c:f>
              <c:numCache>
                <c:formatCode>General</c:formatCode>
                <c:ptCount val="414"/>
                <c:pt idx="0">
                  <c:v>0</c:v>
                </c:pt>
                <c:pt idx="1">
                  <c:v>8.7059999999999995</c:v>
                </c:pt>
                <c:pt idx="2">
                  <c:v>17.413</c:v>
                </c:pt>
                <c:pt idx="3">
                  <c:v>26.119</c:v>
                </c:pt>
                <c:pt idx="4">
                  <c:v>34.826000000000001</c:v>
                </c:pt>
                <c:pt idx="5">
                  <c:v>43.531999999999996</c:v>
                </c:pt>
                <c:pt idx="6">
                  <c:v>52.238</c:v>
                </c:pt>
                <c:pt idx="7">
                  <c:v>60.945</c:v>
                </c:pt>
                <c:pt idx="8">
                  <c:v>69.650999999999996</c:v>
                </c:pt>
                <c:pt idx="9">
                  <c:v>78.358000000000004</c:v>
                </c:pt>
                <c:pt idx="10">
                  <c:v>87.063999999999993</c:v>
                </c:pt>
                <c:pt idx="11">
                  <c:v>95.77</c:v>
                </c:pt>
                <c:pt idx="12">
                  <c:v>104.477</c:v>
                </c:pt>
                <c:pt idx="13">
                  <c:v>113.18300000000001</c:v>
                </c:pt>
                <c:pt idx="14">
                  <c:v>121.89</c:v>
                </c:pt>
                <c:pt idx="15">
                  <c:v>130.596</c:v>
                </c:pt>
                <c:pt idx="16">
                  <c:v>139.30199999999999</c:v>
                </c:pt>
                <c:pt idx="17">
                  <c:v>148.00899999999999</c:v>
                </c:pt>
                <c:pt idx="18">
                  <c:v>156.715</c:v>
                </c:pt>
                <c:pt idx="19">
                  <c:v>165.422</c:v>
                </c:pt>
                <c:pt idx="20">
                  <c:v>174.12799999999999</c:v>
                </c:pt>
                <c:pt idx="21">
                  <c:v>182.834</c:v>
                </c:pt>
                <c:pt idx="22">
                  <c:v>191.541</c:v>
                </c:pt>
                <c:pt idx="23">
                  <c:v>200.24700000000001</c:v>
                </c:pt>
                <c:pt idx="24">
                  <c:v>208.95400000000001</c:v>
                </c:pt>
                <c:pt idx="25">
                  <c:v>217.66</c:v>
                </c:pt>
                <c:pt idx="26">
                  <c:v>226.36600000000001</c:v>
                </c:pt>
                <c:pt idx="27">
                  <c:v>235.07300000000001</c:v>
                </c:pt>
                <c:pt idx="28">
                  <c:v>243.779</c:v>
                </c:pt>
                <c:pt idx="29">
                  <c:v>252.48599999999999</c:v>
                </c:pt>
                <c:pt idx="30">
                  <c:v>261.19200000000001</c:v>
                </c:pt>
                <c:pt idx="31">
                  <c:v>269.89800000000002</c:v>
                </c:pt>
                <c:pt idx="32">
                  <c:v>278.60500000000002</c:v>
                </c:pt>
                <c:pt idx="33">
                  <c:v>287.31099999999998</c:v>
                </c:pt>
                <c:pt idx="34">
                  <c:v>296.01799999999997</c:v>
                </c:pt>
                <c:pt idx="35">
                  <c:v>304.72399999999999</c:v>
                </c:pt>
                <c:pt idx="36">
                  <c:v>313.43</c:v>
                </c:pt>
                <c:pt idx="37">
                  <c:v>322.137</c:v>
                </c:pt>
                <c:pt idx="38">
                  <c:v>330.84300000000002</c:v>
                </c:pt>
                <c:pt idx="39">
                  <c:v>339.55</c:v>
                </c:pt>
                <c:pt idx="40">
                  <c:v>348.25599999999997</c:v>
                </c:pt>
                <c:pt idx="41">
                  <c:v>356.96199999999999</c:v>
                </c:pt>
                <c:pt idx="42">
                  <c:v>365.66899999999998</c:v>
                </c:pt>
                <c:pt idx="43">
                  <c:v>374.375</c:v>
                </c:pt>
                <c:pt idx="44">
                  <c:v>383.08199999999999</c:v>
                </c:pt>
                <c:pt idx="45">
                  <c:v>391.78800000000001</c:v>
                </c:pt>
                <c:pt idx="46">
                  <c:v>400.49400000000003</c:v>
                </c:pt>
                <c:pt idx="47">
                  <c:v>409.20100000000002</c:v>
                </c:pt>
                <c:pt idx="48">
                  <c:v>417.90699999999998</c:v>
                </c:pt>
                <c:pt idx="49">
                  <c:v>426.61399999999998</c:v>
                </c:pt>
                <c:pt idx="50">
                  <c:v>435.32</c:v>
                </c:pt>
                <c:pt idx="51">
                  <c:v>444.02600000000001</c:v>
                </c:pt>
                <c:pt idx="52">
                  <c:v>452.733</c:v>
                </c:pt>
                <c:pt idx="53">
                  <c:v>461.43900000000002</c:v>
                </c:pt>
                <c:pt idx="54">
                  <c:v>470.14600000000002</c:v>
                </c:pt>
                <c:pt idx="55">
                  <c:v>478.85199999999998</c:v>
                </c:pt>
                <c:pt idx="56">
                  <c:v>487.55799999999999</c:v>
                </c:pt>
                <c:pt idx="57">
                  <c:v>496.26499999999999</c:v>
                </c:pt>
                <c:pt idx="58">
                  <c:v>504.971</c:v>
                </c:pt>
                <c:pt idx="59">
                  <c:v>513.678</c:v>
                </c:pt>
                <c:pt idx="60">
                  <c:v>522.38400000000001</c:v>
                </c:pt>
                <c:pt idx="61">
                  <c:v>531.09</c:v>
                </c:pt>
                <c:pt idx="62">
                  <c:v>539.79700000000003</c:v>
                </c:pt>
                <c:pt idx="63">
                  <c:v>548.50300000000004</c:v>
                </c:pt>
                <c:pt idx="64">
                  <c:v>557.21</c:v>
                </c:pt>
                <c:pt idx="65">
                  <c:v>565.91600000000005</c:v>
                </c:pt>
                <c:pt idx="66">
                  <c:v>574.62199999999996</c:v>
                </c:pt>
                <c:pt idx="67">
                  <c:v>583.32899999999995</c:v>
                </c:pt>
                <c:pt idx="68">
                  <c:v>592.03499999999997</c:v>
                </c:pt>
                <c:pt idx="69">
                  <c:v>600.74199999999996</c:v>
                </c:pt>
                <c:pt idx="70">
                  <c:v>609.44799999999998</c:v>
                </c:pt>
                <c:pt idx="71">
                  <c:v>618.154</c:v>
                </c:pt>
                <c:pt idx="72">
                  <c:v>626.86099999999999</c:v>
                </c:pt>
                <c:pt idx="73">
                  <c:v>635.56700000000001</c:v>
                </c:pt>
                <c:pt idx="74">
                  <c:v>644.274</c:v>
                </c:pt>
                <c:pt idx="75">
                  <c:v>652.98</c:v>
                </c:pt>
                <c:pt idx="76">
                  <c:v>661.68600000000004</c:v>
                </c:pt>
                <c:pt idx="77">
                  <c:v>670.39300000000003</c:v>
                </c:pt>
                <c:pt idx="78">
                  <c:v>679.09900000000005</c:v>
                </c:pt>
                <c:pt idx="79">
                  <c:v>687.80600000000004</c:v>
                </c:pt>
                <c:pt idx="80">
                  <c:v>696.51199999999994</c:v>
                </c:pt>
                <c:pt idx="81">
                  <c:v>705.21799999999996</c:v>
                </c:pt>
                <c:pt idx="82">
                  <c:v>713.92499999999995</c:v>
                </c:pt>
                <c:pt idx="83">
                  <c:v>722.63099999999997</c:v>
                </c:pt>
                <c:pt idx="84">
                  <c:v>731.33799999999997</c:v>
                </c:pt>
                <c:pt idx="85">
                  <c:v>740.04399999999998</c:v>
                </c:pt>
                <c:pt idx="86">
                  <c:v>748.75</c:v>
                </c:pt>
                <c:pt idx="87">
                  <c:v>757.45699999999999</c:v>
                </c:pt>
                <c:pt idx="88">
                  <c:v>766.16300000000001</c:v>
                </c:pt>
                <c:pt idx="89">
                  <c:v>774.87</c:v>
                </c:pt>
                <c:pt idx="90">
                  <c:v>783.57600000000002</c:v>
                </c:pt>
                <c:pt idx="91">
                  <c:v>792.28200000000004</c:v>
                </c:pt>
                <c:pt idx="92">
                  <c:v>800.98900000000003</c:v>
                </c:pt>
                <c:pt idx="93">
                  <c:v>809.69500000000005</c:v>
                </c:pt>
                <c:pt idx="94">
                  <c:v>818.40099999999995</c:v>
                </c:pt>
                <c:pt idx="95">
                  <c:v>827.10799999999995</c:v>
                </c:pt>
                <c:pt idx="96">
                  <c:v>835.81399999999996</c:v>
                </c:pt>
                <c:pt idx="97">
                  <c:v>844.52099999999996</c:v>
                </c:pt>
                <c:pt idx="98">
                  <c:v>853.22699999999998</c:v>
                </c:pt>
                <c:pt idx="99">
                  <c:v>861.93299999999999</c:v>
                </c:pt>
                <c:pt idx="100">
                  <c:v>870.64</c:v>
                </c:pt>
                <c:pt idx="101">
                  <c:v>879.346</c:v>
                </c:pt>
                <c:pt idx="102">
                  <c:v>888.053</c:v>
                </c:pt>
                <c:pt idx="103">
                  <c:v>896.75900000000001</c:v>
                </c:pt>
                <c:pt idx="104">
                  <c:v>905.46500000000003</c:v>
                </c:pt>
                <c:pt idx="105">
                  <c:v>914.17200000000003</c:v>
                </c:pt>
                <c:pt idx="106">
                  <c:v>922.87800000000004</c:v>
                </c:pt>
                <c:pt idx="107">
                  <c:v>931.58500000000004</c:v>
                </c:pt>
                <c:pt idx="108">
                  <c:v>940.29100000000005</c:v>
                </c:pt>
                <c:pt idx="109">
                  <c:v>948.99699999999996</c:v>
                </c:pt>
                <c:pt idx="110">
                  <c:v>957.70399999999995</c:v>
                </c:pt>
                <c:pt idx="111">
                  <c:v>966.41</c:v>
                </c:pt>
                <c:pt idx="112">
                  <c:v>975.11699999999996</c:v>
                </c:pt>
                <c:pt idx="113">
                  <c:v>983.82299999999998</c:v>
                </c:pt>
                <c:pt idx="114">
                  <c:v>992.529</c:v>
                </c:pt>
                <c:pt idx="115">
                  <c:v>1001.236</c:v>
                </c:pt>
                <c:pt idx="116">
                  <c:v>1009.942</c:v>
                </c:pt>
                <c:pt idx="117">
                  <c:v>1018.649</c:v>
                </c:pt>
                <c:pt idx="118">
                  <c:v>1027.355</c:v>
                </c:pt>
                <c:pt idx="119">
                  <c:v>1036.0609999999999</c:v>
                </c:pt>
                <c:pt idx="120">
                  <c:v>1044.768</c:v>
                </c:pt>
                <c:pt idx="121">
                  <c:v>1053.4739999999999</c:v>
                </c:pt>
                <c:pt idx="122">
                  <c:v>1062.181</c:v>
                </c:pt>
                <c:pt idx="123">
                  <c:v>1070.8869999999999</c:v>
                </c:pt>
                <c:pt idx="124">
                  <c:v>1079.5930000000001</c:v>
                </c:pt>
                <c:pt idx="125">
                  <c:v>1088.3</c:v>
                </c:pt>
                <c:pt idx="126">
                  <c:v>1097.0060000000001</c:v>
                </c:pt>
                <c:pt idx="127">
                  <c:v>1105.713</c:v>
                </c:pt>
                <c:pt idx="128">
                  <c:v>1114.4190000000001</c:v>
                </c:pt>
                <c:pt idx="129">
                  <c:v>1123.125</c:v>
                </c:pt>
                <c:pt idx="130">
                  <c:v>1131.8320000000001</c:v>
                </c:pt>
                <c:pt idx="131">
                  <c:v>1140.538</c:v>
                </c:pt>
                <c:pt idx="132">
                  <c:v>1149.2449999999999</c:v>
                </c:pt>
                <c:pt idx="133">
                  <c:v>1157.951</c:v>
                </c:pt>
                <c:pt idx="134">
                  <c:v>1166.6569999999999</c:v>
                </c:pt>
                <c:pt idx="135">
                  <c:v>1175.364</c:v>
                </c:pt>
                <c:pt idx="136">
                  <c:v>1184.07</c:v>
                </c:pt>
                <c:pt idx="137">
                  <c:v>1192.777</c:v>
                </c:pt>
                <c:pt idx="138">
                  <c:v>1201.4829999999999</c:v>
                </c:pt>
                <c:pt idx="139">
                  <c:v>1210.1890000000001</c:v>
                </c:pt>
                <c:pt idx="140">
                  <c:v>1218.896</c:v>
                </c:pt>
                <c:pt idx="141">
                  <c:v>1227.6020000000001</c:v>
                </c:pt>
                <c:pt idx="142">
                  <c:v>1236.309</c:v>
                </c:pt>
                <c:pt idx="143">
                  <c:v>1245.0150000000001</c:v>
                </c:pt>
                <c:pt idx="144">
                  <c:v>1253.721</c:v>
                </c:pt>
                <c:pt idx="145">
                  <c:v>1262.4280000000001</c:v>
                </c:pt>
                <c:pt idx="146">
                  <c:v>1271.134</c:v>
                </c:pt>
                <c:pt idx="147">
                  <c:v>1279.8409999999999</c:v>
                </c:pt>
                <c:pt idx="148">
                  <c:v>1288.547</c:v>
                </c:pt>
                <c:pt idx="149">
                  <c:v>1297.2529999999999</c:v>
                </c:pt>
                <c:pt idx="150">
                  <c:v>1305.96</c:v>
                </c:pt>
                <c:pt idx="151">
                  <c:v>1314.6659999999999</c:v>
                </c:pt>
                <c:pt idx="152">
                  <c:v>1323.373</c:v>
                </c:pt>
                <c:pt idx="153">
                  <c:v>1332.079</c:v>
                </c:pt>
                <c:pt idx="154">
                  <c:v>1340.7850000000001</c:v>
                </c:pt>
                <c:pt idx="155">
                  <c:v>1349.492</c:v>
                </c:pt>
                <c:pt idx="156">
                  <c:v>1358.1980000000001</c:v>
                </c:pt>
                <c:pt idx="157">
                  <c:v>1366.905</c:v>
                </c:pt>
                <c:pt idx="158">
                  <c:v>1375.6110000000001</c:v>
                </c:pt>
                <c:pt idx="159">
                  <c:v>1384.317</c:v>
                </c:pt>
                <c:pt idx="160">
                  <c:v>1391.9849999999999</c:v>
                </c:pt>
                <c:pt idx="161">
                  <c:v>1393.0239999999999</c:v>
                </c:pt>
                <c:pt idx="162">
                  <c:v>1401.73</c:v>
                </c:pt>
                <c:pt idx="163">
                  <c:v>1410.4369999999999</c:v>
                </c:pt>
                <c:pt idx="164">
                  <c:v>1419.143</c:v>
                </c:pt>
                <c:pt idx="165">
                  <c:v>1427.8489999999999</c:v>
                </c:pt>
                <c:pt idx="166">
                  <c:v>1436.556</c:v>
                </c:pt>
                <c:pt idx="167">
                  <c:v>1445.2619999999999</c:v>
                </c:pt>
                <c:pt idx="168">
                  <c:v>1453.9690000000001</c:v>
                </c:pt>
                <c:pt idx="169">
                  <c:v>1462.675</c:v>
                </c:pt>
                <c:pt idx="170">
                  <c:v>1471.3810000000001</c:v>
                </c:pt>
                <c:pt idx="171">
                  <c:v>1480.088</c:v>
                </c:pt>
                <c:pt idx="172">
                  <c:v>1488.7940000000001</c:v>
                </c:pt>
                <c:pt idx="173">
                  <c:v>1493.451</c:v>
                </c:pt>
                <c:pt idx="174">
                  <c:v>1497.501</c:v>
                </c:pt>
                <c:pt idx="175">
                  <c:v>1500</c:v>
                </c:pt>
                <c:pt idx="176">
                  <c:v>1505.9179999999999</c:v>
                </c:pt>
                <c:pt idx="177">
                  <c:v>1506.2070000000001</c:v>
                </c:pt>
                <c:pt idx="178">
                  <c:v>1514.913</c:v>
                </c:pt>
                <c:pt idx="179">
                  <c:v>1517.2819999999999</c:v>
                </c:pt>
                <c:pt idx="180">
                  <c:v>1520.1</c:v>
                </c:pt>
                <c:pt idx="181">
                  <c:v>1523.3910000000001</c:v>
                </c:pt>
                <c:pt idx="182">
                  <c:v>1523.62</c:v>
                </c:pt>
                <c:pt idx="183">
                  <c:v>1525.181</c:v>
                </c:pt>
                <c:pt idx="184">
                  <c:v>1528.1179999999999</c:v>
                </c:pt>
                <c:pt idx="185">
                  <c:v>1531.962</c:v>
                </c:pt>
                <c:pt idx="186">
                  <c:v>1532.326</c:v>
                </c:pt>
                <c:pt idx="187">
                  <c:v>1532.5889999999999</c:v>
                </c:pt>
                <c:pt idx="188">
                  <c:v>1533.3789999999999</c:v>
                </c:pt>
                <c:pt idx="189">
                  <c:v>1535.539</c:v>
                </c:pt>
                <c:pt idx="190">
                  <c:v>1536.9839999999999</c:v>
                </c:pt>
                <c:pt idx="191">
                  <c:v>1537.672</c:v>
                </c:pt>
                <c:pt idx="192">
                  <c:v>1539.6379999999999</c:v>
                </c:pt>
                <c:pt idx="193">
                  <c:v>1541.0329999999999</c:v>
                </c:pt>
                <c:pt idx="194">
                  <c:v>1541.5709999999999</c:v>
                </c:pt>
                <c:pt idx="195">
                  <c:v>1542.5530000000001</c:v>
                </c:pt>
                <c:pt idx="196">
                  <c:v>1544.1110000000001</c:v>
                </c:pt>
                <c:pt idx="197">
                  <c:v>1546.0039999999999</c:v>
                </c:pt>
                <c:pt idx="198">
                  <c:v>1547.9839999999999</c:v>
                </c:pt>
                <c:pt idx="199">
                  <c:v>1549.739</c:v>
                </c:pt>
                <c:pt idx="200">
                  <c:v>1550.759</c:v>
                </c:pt>
                <c:pt idx="201">
                  <c:v>1552.3630000000001</c:v>
                </c:pt>
                <c:pt idx="202">
                  <c:v>1555.049</c:v>
                </c:pt>
                <c:pt idx="203">
                  <c:v>1556.5719999999999</c:v>
                </c:pt>
                <c:pt idx="204">
                  <c:v>1558.4449999999999</c:v>
                </c:pt>
                <c:pt idx="205">
                  <c:v>1561.5160000000001</c:v>
                </c:pt>
                <c:pt idx="206">
                  <c:v>1563.441</c:v>
                </c:pt>
                <c:pt idx="207">
                  <c:v>1564.8889999999999</c:v>
                </c:pt>
                <c:pt idx="208">
                  <c:v>1565.7070000000001</c:v>
                </c:pt>
                <c:pt idx="209">
                  <c:v>1566.229</c:v>
                </c:pt>
                <c:pt idx="210">
                  <c:v>1566.7429999999999</c:v>
                </c:pt>
                <c:pt idx="211">
                  <c:v>1567.152</c:v>
                </c:pt>
                <c:pt idx="212">
                  <c:v>1567.268</c:v>
                </c:pt>
                <c:pt idx="213">
                  <c:v>1567.604</c:v>
                </c:pt>
                <c:pt idx="214">
                  <c:v>1567.9359999999999</c:v>
                </c:pt>
                <c:pt idx="215">
                  <c:v>1568.4349999999999</c:v>
                </c:pt>
                <c:pt idx="216">
                  <c:v>1570.2249999999999</c:v>
                </c:pt>
                <c:pt idx="217">
                  <c:v>1570.65</c:v>
                </c:pt>
                <c:pt idx="218">
                  <c:v>1571.825</c:v>
                </c:pt>
                <c:pt idx="219">
                  <c:v>1572.9059999999999</c:v>
                </c:pt>
                <c:pt idx="220">
                  <c:v>1573.8879999999999</c:v>
                </c:pt>
                <c:pt idx="221">
                  <c:v>1574.904</c:v>
                </c:pt>
                <c:pt idx="222">
                  <c:v>1575.8579999999999</c:v>
                </c:pt>
                <c:pt idx="223">
                  <c:v>1577.0160000000001</c:v>
                </c:pt>
                <c:pt idx="224">
                  <c:v>1578.1210000000001</c:v>
                </c:pt>
                <c:pt idx="225">
                  <c:v>1578.913</c:v>
                </c:pt>
                <c:pt idx="226">
                  <c:v>1581.221</c:v>
                </c:pt>
                <c:pt idx="227">
                  <c:v>1582.771</c:v>
                </c:pt>
                <c:pt idx="228">
                  <c:v>1583.9190000000001</c:v>
                </c:pt>
                <c:pt idx="229">
                  <c:v>1584.5650000000001</c:v>
                </c:pt>
                <c:pt idx="230">
                  <c:v>1584.74</c:v>
                </c:pt>
                <c:pt idx="231">
                  <c:v>1585.5050000000001</c:v>
                </c:pt>
                <c:pt idx="232">
                  <c:v>1586.134</c:v>
                </c:pt>
                <c:pt idx="233">
                  <c:v>1586.5119999999999</c:v>
                </c:pt>
                <c:pt idx="234">
                  <c:v>1587.5540000000001</c:v>
                </c:pt>
                <c:pt idx="235">
                  <c:v>1589.3209999999999</c:v>
                </c:pt>
                <c:pt idx="236">
                  <c:v>1589.5830000000001</c:v>
                </c:pt>
                <c:pt idx="237">
                  <c:v>1590.8620000000001</c:v>
                </c:pt>
                <c:pt idx="238">
                  <c:v>1592.6849999999999</c:v>
                </c:pt>
                <c:pt idx="239">
                  <c:v>1593.271</c:v>
                </c:pt>
                <c:pt idx="240">
                  <c:v>1593.758</c:v>
                </c:pt>
                <c:pt idx="241">
                  <c:v>1594.5029999999999</c:v>
                </c:pt>
                <c:pt idx="242">
                  <c:v>1594.63</c:v>
                </c:pt>
                <c:pt idx="243">
                  <c:v>1595.0050000000001</c:v>
                </c:pt>
                <c:pt idx="244">
                  <c:v>1596.107</c:v>
                </c:pt>
                <c:pt idx="245">
                  <c:v>1596.838</c:v>
                </c:pt>
                <c:pt idx="246">
                  <c:v>1597.2850000000001</c:v>
                </c:pt>
                <c:pt idx="247">
                  <c:v>1597.905</c:v>
                </c:pt>
                <c:pt idx="248">
                  <c:v>1598.867</c:v>
                </c:pt>
                <c:pt idx="249">
                  <c:v>1599.0150000000001</c:v>
                </c:pt>
                <c:pt idx="250">
                  <c:v>1599.5930000000001</c:v>
                </c:pt>
                <c:pt idx="251">
                  <c:v>1600.5060000000001</c:v>
                </c:pt>
                <c:pt idx="252">
                  <c:v>1600.943</c:v>
                </c:pt>
                <c:pt idx="253">
                  <c:v>1601.9770000000001</c:v>
                </c:pt>
                <c:pt idx="254">
                  <c:v>1602.15</c:v>
                </c:pt>
                <c:pt idx="255">
                  <c:v>1603.62</c:v>
                </c:pt>
                <c:pt idx="256">
                  <c:v>1604.2380000000001</c:v>
                </c:pt>
                <c:pt idx="257">
                  <c:v>1604.664</c:v>
                </c:pt>
                <c:pt idx="258">
                  <c:v>1605.788</c:v>
                </c:pt>
                <c:pt idx="259">
                  <c:v>1605.9169999999999</c:v>
                </c:pt>
                <c:pt idx="260">
                  <c:v>1606.106</c:v>
                </c:pt>
                <c:pt idx="261">
                  <c:v>1607.001</c:v>
                </c:pt>
                <c:pt idx="262">
                  <c:v>1607.78</c:v>
                </c:pt>
                <c:pt idx="263">
                  <c:v>1609.942</c:v>
                </c:pt>
                <c:pt idx="264">
                  <c:v>1610.684</c:v>
                </c:pt>
                <c:pt idx="265">
                  <c:v>1611.8869999999999</c:v>
                </c:pt>
                <c:pt idx="266">
                  <c:v>1613.002</c:v>
                </c:pt>
                <c:pt idx="267">
                  <c:v>1613.124</c:v>
                </c:pt>
                <c:pt idx="268">
                  <c:v>1614.296</c:v>
                </c:pt>
                <c:pt idx="269">
                  <c:v>1615.0160000000001</c:v>
                </c:pt>
                <c:pt idx="270">
                  <c:v>1616.021</c:v>
                </c:pt>
                <c:pt idx="271">
                  <c:v>1616.431</c:v>
                </c:pt>
                <c:pt idx="272">
                  <c:v>1617.4659999999999</c:v>
                </c:pt>
                <c:pt idx="273">
                  <c:v>1618.723</c:v>
                </c:pt>
                <c:pt idx="274">
                  <c:v>1619.39</c:v>
                </c:pt>
                <c:pt idx="275">
                  <c:v>1620.6489999999999</c:v>
                </c:pt>
                <c:pt idx="276">
                  <c:v>1621.366</c:v>
                </c:pt>
                <c:pt idx="277">
                  <c:v>1623.346</c:v>
                </c:pt>
                <c:pt idx="278">
                  <c:v>1623.8420000000001</c:v>
                </c:pt>
                <c:pt idx="279">
                  <c:v>1624.731</c:v>
                </c:pt>
                <c:pt idx="280">
                  <c:v>1625.202</c:v>
                </c:pt>
                <c:pt idx="281">
                  <c:v>1625.836</c:v>
                </c:pt>
                <c:pt idx="282">
                  <c:v>1626.578</c:v>
                </c:pt>
                <c:pt idx="283">
                  <c:v>1627.0519999999999</c:v>
                </c:pt>
                <c:pt idx="284">
                  <c:v>1627.9580000000001</c:v>
                </c:pt>
                <c:pt idx="285">
                  <c:v>1628.097</c:v>
                </c:pt>
                <c:pt idx="286">
                  <c:v>1628.9690000000001</c:v>
                </c:pt>
                <c:pt idx="287">
                  <c:v>1630.2650000000001</c:v>
                </c:pt>
                <c:pt idx="288">
                  <c:v>1631.079</c:v>
                </c:pt>
                <c:pt idx="289">
                  <c:v>1632.1790000000001</c:v>
                </c:pt>
                <c:pt idx="290">
                  <c:v>1632.922</c:v>
                </c:pt>
                <c:pt idx="291">
                  <c:v>1632.99</c:v>
                </c:pt>
                <c:pt idx="292">
                  <c:v>1633.452</c:v>
                </c:pt>
                <c:pt idx="293">
                  <c:v>1634.55</c:v>
                </c:pt>
                <c:pt idx="294">
                  <c:v>1635.1220000000001</c:v>
                </c:pt>
                <c:pt idx="295">
                  <c:v>1635.335</c:v>
                </c:pt>
                <c:pt idx="296">
                  <c:v>1635.8309999999999</c:v>
                </c:pt>
                <c:pt idx="297">
                  <c:v>1636.328</c:v>
                </c:pt>
                <c:pt idx="298">
                  <c:v>1636.8030000000001</c:v>
                </c:pt>
                <c:pt idx="299">
                  <c:v>1636.9849999999999</c:v>
                </c:pt>
                <c:pt idx="300">
                  <c:v>1638.299</c:v>
                </c:pt>
                <c:pt idx="301">
                  <c:v>1639.7860000000001</c:v>
                </c:pt>
                <c:pt idx="302">
                  <c:v>1641.1659999999999</c:v>
                </c:pt>
                <c:pt idx="303">
                  <c:v>1642.249</c:v>
                </c:pt>
                <c:pt idx="304">
                  <c:v>1642.761</c:v>
                </c:pt>
                <c:pt idx="305">
                  <c:v>1645.0630000000001</c:v>
                </c:pt>
                <c:pt idx="306">
                  <c:v>1645.509</c:v>
                </c:pt>
                <c:pt idx="307">
                  <c:v>1645.8879999999999</c:v>
                </c:pt>
                <c:pt idx="308">
                  <c:v>1646.212</c:v>
                </c:pt>
                <c:pt idx="309">
                  <c:v>1646.7539999999999</c:v>
                </c:pt>
                <c:pt idx="310">
                  <c:v>1646.808</c:v>
                </c:pt>
                <c:pt idx="311">
                  <c:v>1647.357</c:v>
                </c:pt>
                <c:pt idx="312">
                  <c:v>1648.826</c:v>
                </c:pt>
                <c:pt idx="313">
                  <c:v>1650.0730000000001</c:v>
                </c:pt>
                <c:pt idx="314">
                  <c:v>1650.441</c:v>
                </c:pt>
                <c:pt idx="315">
                  <c:v>1651.106</c:v>
                </c:pt>
                <c:pt idx="316">
                  <c:v>1651.5340000000001</c:v>
                </c:pt>
                <c:pt idx="317">
                  <c:v>1652.5039999999999</c:v>
                </c:pt>
                <c:pt idx="318">
                  <c:v>1652.99</c:v>
                </c:pt>
                <c:pt idx="319">
                  <c:v>1653.6679999999999</c:v>
                </c:pt>
                <c:pt idx="320">
                  <c:v>1654.2159999999999</c:v>
                </c:pt>
                <c:pt idx="321">
                  <c:v>1654.395</c:v>
                </c:pt>
                <c:pt idx="322">
                  <c:v>1655.7339999999999</c:v>
                </c:pt>
                <c:pt idx="323">
                  <c:v>1656.72</c:v>
                </c:pt>
                <c:pt idx="324">
                  <c:v>1656.99</c:v>
                </c:pt>
                <c:pt idx="325">
                  <c:v>1657.635</c:v>
                </c:pt>
                <c:pt idx="326">
                  <c:v>1658.4090000000001</c:v>
                </c:pt>
                <c:pt idx="327">
                  <c:v>1659.3409999999999</c:v>
                </c:pt>
                <c:pt idx="328">
                  <c:v>1659.5730000000001</c:v>
                </c:pt>
                <c:pt idx="329">
                  <c:v>1659.9760000000001</c:v>
                </c:pt>
                <c:pt idx="330">
                  <c:v>1660.498</c:v>
                </c:pt>
                <c:pt idx="331">
                  <c:v>1661.2860000000001</c:v>
                </c:pt>
                <c:pt idx="332">
                  <c:v>1662.922</c:v>
                </c:pt>
                <c:pt idx="333">
                  <c:v>1663.249</c:v>
                </c:pt>
                <c:pt idx="334">
                  <c:v>1664.076</c:v>
                </c:pt>
                <c:pt idx="335">
                  <c:v>1664.7470000000001</c:v>
                </c:pt>
                <c:pt idx="336">
                  <c:v>1665.444</c:v>
                </c:pt>
                <c:pt idx="337">
                  <c:v>1665.854</c:v>
                </c:pt>
                <c:pt idx="338">
                  <c:v>1666.0050000000001</c:v>
                </c:pt>
                <c:pt idx="339">
                  <c:v>1666.424</c:v>
                </c:pt>
                <c:pt idx="340">
                  <c:v>1667.8440000000001</c:v>
                </c:pt>
                <c:pt idx="341">
                  <c:v>1668.08</c:v>
                </c:pt>
                <c:pt idx="342">
                  <c:v>1668.2629999999999</c:v>
                </c:pt>
                <c:pt idx="343">
                  <c:v>1668.4269999999999</c:v>
                </c:pt>
                <c:pt idx="344">
                  <c:v>1668.7840000000001</c:v>
                </c:pt>
                <c:pt idx="345">
                  <c:v>1669.077</c:v>
                </c:pt>
                <c:pt idx="346">
                  <c:v>1669.5250000000001</c:v>
                </c:pt>
                <c:pt idx="347">
                  <c:v>1670.402</c:v>
                </c:pt>
                <c:pt idx="348">
                  <c:v>1670.9269999999999</c:v>
                </c:pt>
                <c:pt idx="349">
                  <c:v>1671.6289999999999</c:v>
                </c:pt>
                <c:pt idx="350">
                  <c:v>1671.6489999999999</c:v>
                </c:pt>
                <c:pt idx="351">
                  <c:v>1672.184</c:v>
                </c:pt>
                <c:pt idx="352">
                  <c:v>1672.827</c:v>
                </c:pt>
                <c:pt idx="353">
                  <c:v>1674.7850000000001</c:v>
                </c:pt>
                <c:pt idx="354">
                  <c:v>1676.473</c:v>
                </c:pt>
                <c:pt idx="355">
                  <c:v>1677.847</c:v>
                </c:pt>
                <c:pt idx="356">
                  <c:v>1677.9169999999999</c:v>
                </c:pt>
                <c:pt idx="357">
                  <c:v>1679.5329999999999</c:v>
                </c:pt>
                <c:pt idx="358">
                  <c:v>1680.335</c:v>
                </c:pt>
                <c:pt idx="359">
                  <c:v>1681.221</c:v>
                </c:pt>
                <c:pt idx="360">
                  <c:v>1682.0730000000001</c:v>
                </c:pt>
                <c:pt idx="361">
                  <c:v>1684.221</c:v>
                </c:pt>
                <c:pt idx="362">
                  <c:v>1685.5630000000001</c:v>
                </c:pt>
                <c:pt idx="363">
                  <c:v>1686.6990000000001</c:v>
                </c:pt>
                <c:pt idx="364">
                  <c:v>1688.9570000000001</c:v>
                </c:pt>
                <c:pt idx="365">
                  <c:v>1689.0409999999999</c:v>
                </c:pt>
                <c:pt idx="366">
                  <c:v>1689.066</c:v>
                </c:pt>
                <c:pt idx="367">
                  <c:v>1689.348</c:v>
                </c:pt>
                <c:pt idx="368">
                  <c:v>1690.6890000000001</c:v>
                </c:pt>
                <c:pt idx="369">
                  <c:v>1690.864</c:v>
                </c:pt>
                <c:pt idx="370">
                  <c:v>1691.4770000000001</c:v>
                </c:pt>
                <c:pt idx="371">
                  <c:v>1693.231</c:v>
                </c:pt>
                <c:pt idx="372">
                  <c:v>1694.3420000000001</c:v>
                </c:pt>
                <c:pt idx="373">
                  <c:v>1695.2280000000001</c:v>
                </c:pt>
                <c:pt idx="374">
                  <c:v>1695.934</c:v>
                </c:pt>
                <c:pt idx="375">
                  <c:v>1697.0219999999999</c:v>
                </c:pt>
                <c:pt idx="376">
                  <c:v>1697.748</c:v>
                </c:pt>
                <c:pt idx="377">
                  <c:v>1699.297</c:v>
                </c:pt>
                <c:pt idx="378">
                  <c:v>1699.6610000000001</c:v>
                </c:pt>
                <c:pt idx="379">
                  <c:v>1700.4960000000001</c:v>
                </c:pt>
                <c:pt idx="380">
                  <c:v>1702.297</c:v>
                </c:pt>
                <c:pt idx="381">
                  <c:v>1703.9860000000001</c:v>
                </c:pt>
                <c:pt idx="382">
                  <c:v>1704.857</c:v>
                </c:pt>
                <c:pt idx="383">
                  <c:v>1705.182</c:v>
                </c:pt>
                <c:pt idx="384">
                  <c:v>1706.454</c:v>
                </c:pt>
                <c:pt idx="385">
                  <c:v>1706.6210000000001</c:v>
                </c:pt>
                <c:pt idx="386">
                  <c:v>1709.105</c:v>
                </c:pt>
                <c:pt idx="387">
                  <c:v>1711.4090000000001</c:v>
                </c:pt>
                <c:pt idx="388">
                  <c:v>1715.1610000000001</c:v>
                </c:pt>
                <c:pt idx="389">
                  <c:v>1715.175</c:v>
                </c:pt>
                <c:pt idx="390">
                  <c:v>1717.114</c:v>
                </c:pt>
                <c:pt idx="391">
                  <c:v>1718.0170000000001</c:v>
                </c:pt>
                <c:pt idx="392">
                  <c:v>1718.596</c:v>
                </c:pt>
                <c:pt idx="393">
                  <c:v>1719.6469999999999</c:v>
                </c:pt>
                <c:pt idx="394">
                  <c:v>1720.4860000000001</c:v>
                </c:pt>
                <c:pt idx="395">
                  <c:v>1723.867</c:v>
                </c:pt>
                <c:pt idx="396">
                  <c:v>1726.752</c:v>
                </c:pt>
                <c:pt idx="397">
                  <c:v>1730.442</c:v>
                </c:pt>
                <c:pt idx="398">
                  <c:v>1732.5730000000001</c:v>
                </c:pt>
                <c:pt idx="399">
                  <c:v>1739.722</c:v>
                </c:pt>
                <c:pt idx="400">
                  <c:v>1741.28</c:v>
                </c:pt>
                <c:pt idx="401">
                  <c:v>1741.28</c:v>
                </c:pt>
              </c:numCache>
            </c:numRef>
          </c:xVal>
          <c:yVal>
            <c:numRef>
              <c:f>Foglio6!$F$5:$F$418</c:f>
              <c:numCache>
                <c:formatCode>General</c:formatCode>
                <c:ptCount val="414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99.994</c:v>
                </c:pt>
                <c:pt idx="162">
                  <c:v>99.989000000000004</c:v>
                </c:pt>
                <c:pt idx="163">
                  <c:v>99.988</c:v>
                </c:pt>
                <c:pt idx="164">
                  <c:v>99.986999999999995</c:v>
                </c:pt>
                <c:pt idx="165">
                  <c:v>99.986000000000004</c:v>
                </c:pt>
                <c:pt idx="166">
                  <c:v>99.983999999999995</c:v>
                </c:pt>
                <c:pt idx="167">
                  <c:v>99.980999999999995</c:v>
                </c:pt>
                <c:pt idx="168">
                  <c:v>99.974999999999994</c:v>
                </c:pt>
                <c:pt idx="169">
                  <c:v>99.906999999999996</c:v>
                </c:pt>
                <c:pt idx="170">
                  <c:v>99.882999999999996</c:v>
                </c:pt>
                <c:pt idx="171">
                  <c:v>99.814999999999998</c:v>
                </c:pt>
                <c:pt idx="172">
                  <c:v>99.646000000000001</c:v>
                </c:pt>
                <c:pt idx="173">
                  <c:v>99.5</c:v>
                </c:pt>
                <c:pt idx="174">
                  <c:v>99.218999999999994</c:v>
                </c:pt>
                <c:pt idx="175">
                  <c:v>99</c:v>
                </c:pt>
                <c:pt idx="176">
                  <c:v>98.5</c:v>
                </c:pt>
                <c:pt idx="177">
                  <c:v>98.498000000000005</c:v>
                </c:pt>
                <c:pt idx="178">
                  <c:v>98.094999999999999</c:v>
                </c:pt>
                <c:pt idx="179">
                  <c:v>98</c:v>
                </c:pt>
                <c:pt idx="180">
                  <c:v>97.5</c:v>
                </c:pt>
                <c:pt idx="181">
                  <c:v>97</c:v>
                </c:pt>
                <c:pt idx="182">
                  <c:v>96.991</c:v>
                </c:pt>
                <c:pt idx="183">
                  <c:v>96.5</c:v>
                </c:pt>
                <c:pt idx="184">
                  <c:v>96</c:v>
                </c:pt>
                <c:pt idx="185">
                  <c:v>95.5</c:v>
                </c:pt>
                <c:pt idx="186">
                  <c:v>95.367999999999995</c:v>
                </c:pt>
                <c:pt idx="187">
                  <c:v>95</c:v>
                </c:pt>
                <c:pt idx="188">
                  <c:v>94.5</c:v>
                </c:pt>
                <c:pt idx="189">
                  <c:v>94</c:v>
                </c:pt>
                <c:pt idx="190">
                  <c:v>93.5</c:v>
                </c:pt>
                <c:pt idx="191">
                  <c:v>93</c:v>
                </c:pt>
                <c:pt idx="192">
                  <c:v>92.5</c:v>
                </c:pt>
                <c:pt idx="193">
                  <c:v>92.135999999999996</c:v>
                </c:pt>
                <c:pt idx="194">
                  <c:v>92</c:v>
                </c:pt>
                <c:pt idx="195">
                  <c:v>91.5</c:v>
                </c:pt>
                <c:pt idx="196">
                  <c:v>91</c:v>
                </c:pt>
                <c:pt idx="197">
                  <c:v>90.5</c:v>
                </c:pt>
                <c:pt idx="198">
                  <c:v>90</c:v>
                </c:pt>
                <c:pt idx="199">
                  <c:v>89.572999999999993</c:v>
                </c:pt>
                <c:pt idx="200">
                  <c:v>89.5</c:v>
                </c:pt>
                <c:pt idx="201">
                  <c:v>89</c:v>
                </c:pt>
                <c:pt idx="202">
                  <c:v>88.5</c:v>
                </c:pt>
                <c:pt idx="203">
                  <c:v>88</c:v>
                </c:pt>
                <c:pt idx="204">
                  <c:v>87.747</c:v>
                </c:pt>
                <c:pt idx="205">
                  <c:v>87.5</c:v>
                </c:pt>
                <c:pt idx="206">
                  <c:v>87</c:v>
                </c:pt>
                <c:pt idx="207">
                  <c:v>86.5</c:v>
                </c:pt>
                <c:pt idx="208">
                  <c:v>86</c:v>
                </c:pt>
                <c:pt idx="209">
                  <c:v>85.5</c:v>
                </c:pt>
                <c:pt idx="210">
                  <c:v>85</c:v>
                </c:pt>
                <c:pt idx="211">
                  <c:v>84.695999999999998</c:v>
                </c:pt>
                <c:pt idx="212">
                  <c:v>84.5</c:v>
                </c:pt>
                <c:pt idx="213">
                  <c:v>84</c:v>
                </c:pt>
                <c:pt idx="214">
                  <c:v>83.5</c:v>
                </c:pt>
                <c:pt idx="215">
                  <c:v>83</c:v>
                </c:pt>
                <c:pt idx="216">
                  <c:v>82.5</c:v>
                </c:pt>
                <c:pt idx="217">
                  <c:v>82</c:v>
                </c:pt>
                <c:pt idx="218">
                  <c:v>81.5</c:v>
                </c:pt>
                <c:pt idx="219">
                  <c:v>81</c:v>
                </c:pt>
                <c:pt idx="220">
                  <c:v>80.5</c:v>
                </c:pt>
                <c:pt idx="221">
                  <c:v>80</c:v>
                </c:pt>
                <c:pt idx="222">
                  <c:v>79.807000000000002</c:v>
                </c:pt>
                <c:pt idx="223">
                  <c:v>79.5</c:v>
                </c:pt>
                <c:pt idx="224">
                  <c:v>79</c:v>
                </c:pt>
                <c:pt idx="225">
                  <c:v>78.5</c:v>
                </c:pt>
                <c:pt idx="226">
                  <c:v>78</c:v>
                </c:pt>
                <c:pt idx="227">
                  <c:v>77.5</c:v>
                </c:pt>
                <c:pt idx="228">
                  <c:v>77</c:v>
                </c:pt>
                <c:pt idx="229">
                  <c:v>76.602999999999994</c:v>
                </c:pt>
                <c:pt idx="230">
                  <c:v>76.5</c:v>
                </c:pt>
                <c:pt idx="231">
                  <c:v>76</c:v>
                </c:pt>
                <c:pt idx="232">
                  <c:v>75.5</c:v>
                </c:pt>
                <c:pt idx="233">
                  <c:v>75</c:v>
                </c:pt>
                <c:pt idx="234">
                  <c:v>74.5</c:v>
                </c:pt>
                <c:pt idx="235">
                  <c:v>74</c:v>
                </c:pt>
                <c:pt idx="236">
                  <c:v>73.5</c:v>
                </c:pt>
                <c:pt idx="237">
                  <c:v>73</c:v>
                </c:pt>
                <c:pt idx="238">
                  <c:v>72.5</c:v>
                </c:pt>
                <c:pt idx="239">
                  <c:v>72.245000000000005</c:v>
                </c:pt>
                <c:pt idx="240">
                  <c:v>72</c:v>
                </c:pt>
                <c:pt idx="241">
                  <c:v>71.5</c:v>
                </c:pt>
                <c:pt idx="242">
                  <c:v>71</c:v>
                </c:pt>
                <c:pt idx="243">
                  <c:v>70.5</c:v>
                </c:pt>
                <c:pt idx="244">
                  <c:v>70</c:v>
                </c:pt>
                <c:pt idx="245">
                  <c:v>69.5</c:v>
                </c:pt>
                <c:pt idx="246">
                  <c:v>69</c:v>
                </c:pt>
                <c:pt idx="247">
                  <c:v>68.5</c:v>
                </c:pt>
                <c:pt idx="248">
                  <c:v>68</c:v>
                </c:pt>
                <c:pt idx="249">
                  <c:v>67.5</c:v>
                </c:pt>
                <c:pt idx="250">
                  <c:v>67</c:v>
                </c:pt>
                <c:pt idx="251">
                  <c:v>66.5</c:v>
                </c:pt>
                <c:pt idx="252">
                  <c:v>66</c:v>
                </c:pt>
                <c:pt idx="253">
                  <c:v>65.623000000000005</c:v>
                </c:pt>
                <c:pt idx="254">
                  <c:v>65.5</c:v>
                </c:pt>
                <c:pt idx="255">
                  <c:v>65</c:v>
                </c:pt>
                <c:pt idx="256">
                  <c:v>64.5</c:v>
                </c:pt>
                <c:pt idx="257">
                  <c:v>64</c:v>
                </c:pt>
                <c:pt idx="258">
                  <c:v>63.5</c:v>
                </c:pt>
                <c:pt idx="259">
                  <c:v>63</c:v>
                </c:pt>
                <c:pt idx="260">
                  <c:v>62.5</c:v>
                </c:pt>
                <c:pt idx="261">
                  <c:v>62</c:v>
                </c:pt>
                <c:pt idx="262">
                  <c:v>61.5</c:v>
                </c:pt>
                <c:pt idx="263">
                  <c:v>61</c:v>
                </c:pt>
                <c:pt idx="264">
                  <c:v>60.973999999999997</c:v>
                </c:pt>
                <c:pt idx="265">
                  <c:v>60.5</c:v>
                </c:pt>
                <c:pt idx="266">
                  <c:v>60</c:v>
                </c:pt>
                <c:pt idx="267">
                  <c:v>59.5</c:v>
                </c:pt>
                <c:pt idx="268">
                  <c:v>59</c:v>
                </c:pt>
                <c:pt idx="269">
                  <c:v>58.5</c:v>
                </c:pt>
                <c:pt idx="270">
                  <c:v>58</c:v>
                </c:pt>
                <c:pt idx="271">
                  <c:v>57.5</c:v>
                </c:pt>
                <c:pt idx="272">
                  <c:v>57</c:v>
                </c:pt>
                <c:pt idx="273">
                  <c:v>56.5</c:v>
                </c:pt>
                <c:pt idx="274">
                  <c:v>56.372</c:v>
                </c:pt>
                <c:pt idx="275">
                  <c:v>56</c:v>
                </c:pt>
                <c:pt idx="276">
                  <c:v>55.5</c:v>
                </c:pt>
                <c:pt idx="277">
                  <c:v>55</c:v>
                </c:pt>
                <c:pt idx="278">
                  <c:v>54.5</c:v>
                </c:pt>
                <c:pt idx="279">
                  <c:v>54</c:v>
                </c:pt>
                <c:pt idx="280">
                  <c:v>53.5</c:v>
                </c:pt>
                <c:pt idx="281">
                  <c:v>53</c:v>
                </c:pt>
                <c:pt idx="282">
                  <c:v>52.5</c:v>
                </c:pt>
                <c:pt idx="283">
                  <c:v>52</c:v>
                </c:pt>
                <c:pt idx="284">
                  <c:v>51.5</c:v>
                </c:pt>
                <c:pt idx="285">
                  <c:v>51.463999999999999</c:v>
                </c:pt>
                <c:pt idx="286">
                  <c:v>51</c:v>
                </c:pt>
                <c:pt idx="287">
                  <c:v>50.5</c:v>
                </c:pt>
                <c:pt idx="288">
                  <c:v>50</c:v>
                </c:pt>
                <c:pt idx="289">
                  <c:v>49.5</c:v>
                </c:pt>
                <c:pt idx="290">
                  <c:v>49</c:v>
                </c:pt>
                <c:pt idx="291">
                  <c:v>48.5</c:v>
                </c:pt>
                <c:pt idx="292">
                  <c:v>48</c:v>
                </c:pt>
                <c:pt idx="293">
                  <c:v>47.5</c:v>
                </c:pt>
                <c:pt idx="294">
                  <c:v>47</c:v>
                </c:pt>
                <c:pt idx="295">
                  <c:v>46.5</c:v>
                </c:pt>
                <c:pt idx="296">
                  <c:v>46</c:v>
                </c:pt>
                <c:pt idx="297">
                  <c:v>45.5</c:v>
                </c:pt>
                <c:pt idx="298">
                  <c:v>45.343000000000004</c:v>
                </c:pt>
                <c:pt idx="299">
                  <c:v>45</c:v>
                </c:pt>
                <c:pt idx="300">
                  <c:v>44.5</c:v>
                </c:pt>
                <c:pt idx="301">
                  <c:v>44</c:v>
                </c:pt>
                <c:pt idx="302">
                  <c:v>43.5</c:v>
                </c:pt>
                <c:pt idx="303">
                  <c:v>43</c:v>
                </c:pt>
                <c:pt idx="304">
                  <c:v>42.5</c:v>
                </c:pt>
                <c:pt idx="305">
                  <c:v>42</c:v>
                </c:pt>
                <c:pt idx="306">
                  <c:v>41.822000000000003</c:v>
                </c:pt>
                <c:pt idx="307">
                  <c:v>41.5</c:v>
                </c:pt>
                <c:pt idx="308">
                  <c:v>41</c:v>
                </c:pt>
                <c:pt idx="309">
                  <c:v>40.5</c:v>
                </c:pt>
                <c:pt idx="310">
                  <c:v>40</c:v>
                </c:pt>
                <c:pt idx="311">
                  <c:v>39.5</c:v>
                </c:pt>
                <c:pt idx="312">
                  <c:v>39</c:v>
                </c:pt>
                <c:pt idx="313">
                  <c:v>38.5</c:v>
                </c:pt>
                <c:pt idx="314">
                  <c:v>38</c:v>
                </c:pt>
                <c:pt idx="315">
                  <c:v>37.5</c:v>
                </c:pt>
                <c:pt idx="316">
                  <c:v>37</c:v>
                </c:pt>
                <c:pt idx="317">
                  <c:v>36.5</c:v>
                </c:pt>
                <c:pt idx="318">
                  <c:v>36</c:v>
                </c:pt>
                <c:pt idx="319">
                  <c:v>35.5</c:v>
                </c:pt>
                <c:pt idx="320">
                  <c:v>35.073999999999998</c:v>
                </c:pt>
                <c:pt idx="321">
                  <c:v>35</c:v>
                </c:pt>
                <c:pt idx="322">
                  <c:v>34.5</c:v>
                </c:pt>
                <c:pt idx="323">
                  <c:v>34</c:v>
                </c:pt>
                <c:pt idx="324">
                  <c:v>33.5</c:v>
                </c:pt>
                <c:pt idx="325">
                  <c:v>33</c:v>
                </c:pt>
                <c:pt idx="326">
                  <c:v>32.5</c:v>
                </c:pt>
                <c:pt idx="327">
                  <c:v>32</c:v>
                </c:pt>
                <c:pt idx="328">
                  <c:v>31.5</c:v>
                </c:pt>
                <c:pt idx="329">
                  <c:v>31</c:v>
                </c:pt>
                <c:pt idx="330">
                  <c:v>30.5</c:v>
                </c:pt>
                <c:pt idx="331">
                  <c:v>30</c:v>
                </c:pt>
                <c:pt idx="332">
                  <c:v>29.675999999999998</c:v>
                </c:pt>
                <c:pt idx="333">
                  <c:v>29.5</c:v>
                </c:pt>
                <c:pt idx="334">
                  <c:v>29</c:v>
                </c:pt>
                <c:pt idx="335">
                  <c:v>28.5</c:v>
                </c:pt>
                <c:pt idx="336">
                  <c:v>28</c:v>
                </c:pt>
                <c:pt idx="337">
                  <c:v>27.5</c:v>
                </c:pt>
                <c:pt idx="338">
                  <c:v>27</c:v>
                </c:pt>
                <c:pt idx="339">
                  <c:v>26.5</c:v>
                </c:pt>
                <c:pt idx="340">
                  <c:v>26</c:v>
                </c:pt>
                <c:pt idx="341">
                  <c:v>25.5</c:v>
                </c:pt>
                <c:pt idx="342">
                  <c:v>25</c:v>
                </c:pt>
                <c:pt idx="343">
                  <c:v>24.5</c:v>
                </c:pt>
                <c:pt idx="344">
                  <c:v>24</c:v>
                </c:pt>
                <c:pt idx="345">
                  <c:v>23.5</c:v>
                </c:pt>
                <c:pt idx="346">
                  <c:v>23</c:v>
                </c:pt>
                <c:pt idx="347">
                  <c:v>22.5</c:v>
                </c:pt>
                <c:pt idx="348">
                  <c:v>22</c:v>
                </c:pt>
                <c:pt idx="349">
                  <c:v>21.507999999999999</c:v>
                </c:pt>
                <c:pt idx="350">
                  <c:v>21.5</c:v>
                </c:pt>
                <c:pt idx="351">
                  <c:v>21</c:v>
                </c:pt>
                <c:pt idx="352">
                  <c:v>20.5</c:v>
                </c:pt>
                <c:pt idx="353">
                  <c:v>20</c:v>
                </c:pt>
                <c:pt idx="354">
                  <c:v>19.5</c:v>
                </c:pt>
                <c:pt idx="355">
                  <c:v>19</c:v>
                </c:pt>
                <c:pt idx="356">
                  <c:v>18.5</c:v>
                </c:pt>
                <c:pt idx="357">
                  <c:v>18</c:v>
                </c:pt>
                <c:pt idx="358">
                  <c:v>17.844999999999999</c:v>
                </c:pt>
                <c:pt idx="359">
                  <c:v>17.5</c:v>
                </c:pt>
                <c:pt idx="360">
                  <c:v>17</c:v>
                </c:pt>
                <c:pt idx="361">
                  <c:v>16.5</c:v>
                </c:pt>
                <c:pt idx="362">
                  <c:v>16</c:v>
                </c:pt>
                <c:pt idx="363">
                  <c:v>15.5</c:v>
                </c:pt>
                <c:pt idx="364">
                  <c:v>15</c:v>
                </c:pt>
                <c:pt idx="365">
                  <c:v>14.635999999999999</c:v>
                </c:pt>
                <c:pt idx="366">
                  <c:v>14.5</c:v>
                </c:pt>
                <c:pt idx="367">
                  <c:v>14</c:v>
                </c:pt>
                <c:pt idx="368">
                  <c:v>13.5</c:v>
                </c:pt>
                <c:pt idx="369">
                  <c:v>13</c:v>
                </c:pt>
                <c:pt idx="370">
                  <c:v>12.5</c:v>
                </c:pt>
                <c:pt idx="371">
                  <c:v>12</c:v>
                </c:pt>
                <c:pt idx="372">
                  <c:v>11.5</c:v>
                </c:pt>
                <c:pt idx="373">
                  <c:v>11</c:v>
                </c:pt>
                <c:pt idx="374">
                  <c:v>10.5</c:v>
                </c:pt>
                <c:pt idx="375">
                  <c:v>10</c:v>
                </c:pt>
                <c:pt idx="376">
                  <c:v>9.8209999999999997</c:v>
                </c:pt>
                <c:pt idx="377">
                  <c:v>9.5</c:v>
                </c:pt>
                <c:pt idx="378">
                  <c:v>9</c:v>
                </c:pt>
                <c:pt idx="379">
                  <c:v>8.5</c:v>
                </c:pt>
                <c:pt idx="380">
                  <c:v>8</c:v>
                </c:pt>
                <c:pt idx="381">
                  <c:v>7.5</c:v>
                </c:pt>
                <c:pt idx="382">
                  <c:v>7</c:v>
                </c:pt>
                <c:pt idx="383">
                  <c:v>6.5</c:v>
                </c:pt>
                <c:pt idx="384">
                  <c:v>6.032</c:v>
                </c:pt>
                <c:pt idx="385">
                  <c:v>6</c:v>
                </c:pt>
                <c:pt idx="386">
                  <c:v>5.5</c:v>
                </c:pt>
                <c:pt idx="387">
                  <c:v>5</c:v>
                </c:pt>
                <c:pt idx="388">
                  <c:v>4.5060000000000002</c:v>
                </c:pt>
                <c:pt idx="389">
                  <c:v>4.5</c:v>
                </c:pt>
                <c:pt idx="390">
                  <c:v>4</c:v>
                </c:pt>
                <c:pt idx="391">
                  <c:v>3.5</c:v>
                </c:pt>
                <c:pt idx="392">
                  <c:v>3</c:v>
                </c:pt>
                <c:pt idx="393">
                  <c:v>2.5</c:v>
                </c:pt>
                <c:pt idx="394">
                  <c:v>2</c:v>
                </c:pt>
                <c:pt idx="395">
                  <c:v>1.62</c:v>
                </c:pt>
                <c:pt idx="396">
                  <c:v>1.5</c:v>
                </c:pt>
                <c:pt idx="397">
                  <c:v>1</c:v>
                </c:pt>
                <c:pt idx="398">
                  <c:v>0.81699999999999995</c:v>
                </c:pt>
                <c:pt idx="399">
                  <c:v>0.5</c:v>
                </c:pt>
                <c:pt idx="400">
                  <c:v>6.5000000000000002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331-46BE-B50F-9AAB614B149E}"/>
            </c:ext>
          </c:extLst>
        </c:ser>
        <c:ser>
          <c:idx val="4"/>
          <c:order val="3"/>
          <c:tx>
            <c:strRef>
              <c:f>Foglio6!$G$1</c:f>
              <c:strCache>
                <c:ptCount val="1"/>
                <c:pt idx="0">
                  <c:v>S1,0M5</c:v>
                </c:pt>
              </c:strCache>
            </c:strRef>
          </c:tx>
          <c:spPr>
            <a:ln w="19050" cap="rnd">
              <a:solidFill>
                <a:srgbClr val="990000"/>
              </a:solidFill>
              <a:round/>
            </a:ln>
            <a:effectLst/>
          </c:spPr>
          <c:marker>
            <c:symbol val="none"/>
          </c:marker>
          <c:xVal>
            <c:numRef>
              <c:f>Foglio6!$G$5:$G$418</c:f>
              <c:numCache>
                <c:formatCode>General</c:formatCode>
                <c:ptCount val="414"/>
                <c:pt idx="0">
                  <c:v>0</c:v>
                </c:pt>
                <c:pt idx="1">
                  <c:v>9.3800000000000008</c:v>
                </c:pt>
                <c:pt idx="2">
                  <c:v>18.760999999999999</c:v>
                </c:pt>
                <c:pt idx="3">
                  <c:v>28.140999999999998</c:v>
                </c:pt>
                <c:pt idx="4">
                  <c:v>37.521000000000001</c:v>
                </c:pt>
                <c:pt idx="5">
                  <c:v>46.902000000000001</c:v>
                </c:pt>
                <c:pt idx="6">
                  <c:v>56.281999999999996</c:v>
                </c:pt>
                <c:pt idx="7">
                  <c:v>65.662000000000006</c:v>
                </c:pt>
                <c:pt idx="8">
                  <c:v>75.043000000000006</c:v>
                </c:pt>
                <c:pt idx="9">
                  <c:v>84.423000000000002</c:v>
                </c:pt>
                <c:pt idx="10">
                  <c:v>93.802999999999997</c:v>
                </c:pt>
                <c:pt idx="11">
                  <c:v>103.184</c:v>
                </c:pt>
                <c:pt idx="12">
                  <c:v>112.56399999999999</c:v>
                </c:pt>
                <c:pt idx="13">
                  <c:v>121.944</c:v>
                </c:pt>
                <c:pt idx="14">
                  <c:v>131.32499999999999</c:v>
                </c:pt>
                <c:pt idx="15">
                  <c:v>140.70500000000001</c:v>
                </c:pt>
                <c:pt idx="16">
                  <c:v>150.08500000000001</c:v>
                </c:pt>
                <c:pt idx="17">
                  <c:v>159.46600000000001</c:v>
                </c:pt>
                <c:pt idx="18">
                  <c:v>168.846</c:v>
                </c:pt>
                <c:pt idx="19">
                  <c:v>178.226</c:v>
                </c:pt>
                <c:pt idx="20">
                  <c:v>187.607</c:v>
                </c:pt>
                <c:pt idx="21">
                  <c:v>196.98699999999999</c:v>
                </c:pt>
                <c:pt idx="22">
                  <c:v>206.36799999999999</c:v>
                </c:pt>
                <c:pt idx="23">
                  <c:v>215.74799999999999</c:v>
                </c:pt>
                <c:pt idx="24">
                  <c:v>225.12799999999999</c:v>
                </c:pt>
                <c:pt idx="25">
                  <c:v>234.50899999999999</c:v>
                </c:pt>
                <c:pt idx="26">
                  <c:v>243.88900000000001</c:v>
                </c:pt>
                <c:pt idx="27">
                  <c:v>253.26900000000001</c:v>
                </c:pt>
                <c:pt idx="28">
                  <c:v>262.64999999999998</c:v>
                </c:pt>
                <c:pt idx="29">
                  <c:v>272.02999999999997</c:v>
                </c:pt>
                <c:pt idx="30">
                  <c:v>281.41000000000003</c:v>
                </c:pt>
                <c:pt idx="31">
                  <c:v>290.791</c:v>
                </c:pt>
                <c:pt idx="32">
                  <c:v>300.17099999999999</c:v>
                </c:pt>
                <c:pt idx="33">
                  <c:v>309.55099999999999</c:v>
                </c:pt>
                <c:pt idx="34">
                  <c:v>318.93200000000002</c:v>
                </c:pt>
                <c:pt idx="35">
                  <c:v>328.31200000000001</c:v>
                </c:pt>
                <c:pt idx="36">
                  <c:v>337.69200000000001</c:v>
                </c:pt>
                <c:pt idx="37">
                  <c:v>347.07299999999998</c:v>
                </c:pt>
                <c:pt idx="38">
                  <c:v>356.45299999999997</c:v>
                </c:pt>
                <c:pt idx="39">
                  <c:v>365.83300000000003</c:v>
                </c:pt>
                <c:pt idx="40">
                  <c:v>375.214</c:v>
                </c:pt>
                <c:pt idx="41">
                  <c:v>384.59399999999999</c:v>
                </c:pt>
                <c:pt idx="42">
                  <c:v>393.97399999999999</c:v>
                </c:pt>
                <c:pt idx="43">
                  <c:v>403.35500000000002</c:v>
                </c:pt>
                <c:pt idx="44">
                  <c:v>412.73500000000001</c:v>
                </c:pt>
                <c:pt idx="45">
                  <c:v>422.11500000000001</c:v>
                </c:pt>
                <c:pt idx="46">
                  <c:v>431.49599999999998</c:v>
                </c:pt>
                <c:pt idx="47">
                  <c:v>440.87599999999998</c:v>
                </c:pt>
                <c:pt idx="48">
                  <c:v>450.25599999999997</c:v>
                </c:pt>
                <c:pt idx="49">
                  <c:v>459.637</c:v>
                </c:pt>
                <c:pt idx="50">
                  <c:v>469.017</c:v>
                </c:pt>
                <c:pt idx="51">
                  <c:v>478.39699999999999</c:v>
                </c:pt>
                <c:pt idx="52">
                  <c:v>487.77800000000002</c:v>
                </c:pt>
                <c:pt idx="53">
                  <c:v>497.15800000000002</c:v>
                </c:pt>
                <c:pt idx="54">
                  <c:v>506.53800000000001</c:v>
                </c:pt>
                <c:pt idx="55">
                  <c:v>515.91899999999998</c:v>
                </c:pt>
                <c:pt idx="56">
                  <c:v>525.29899999999998</c:v>
                </c:pt>
                <c:pt idx="57">
                  <c:v>534.67899999999997</c:v>
                </c:pt>
                <c:pt idx="58">
                  <c:v>544.05999999999995</c:v>
                </c:pt>
                <c:pt idx="59">
                  <c:v>553.44000000000005</c:v>
                </c:pt>
                <c:pt idx="60">
                  <c:v>562.82100000000003</c:v>
                </c:pt>
                <c:pt idx="61">
                  <c:v>572.20100000000002</c:v>
                </c:pt>
                <c:pt idx="62">
                  <c:v>581.58100000000002</c:v>
                </c:pt>
                <c:pt idx="63">
                  <c:v>590.96199999999999</c:v>
                </c:pt>
                <c:pt idx="64">
                  <c:v>600.34199999999998</c:v>
                </c:pt>
                <c:pt idx="65">
                  <c:v>609.72199999999998</c:v>
                </c:pt>
                <c:pt idx="66">
                  <c:v>619.10299999999995</c:v>
                </c:pt>
                <c:pt idx="67">
                  <c:v>628.48299999999995</c:v>
                </c:pt>
                <c:pt idx="68">
                  <c:v>637.86300000000006</c:v>
                </c:pt>
                <c:pt idx="69">
                  <c:v>647.24400000000003</c:v>
                </c:pt>
                <c:pt idx="70">
                  <c:v>656.62400000000002</c:v>
                </c:pt>
                <c:pt idx="71">
                  <c:v>666.00400000000002</c:v>
                </c:pt>
                <c:pt idx="72">
                  <c:v>675.38499999999999</c:v>
                </c:pt>
                <c:pt idx="73">
                  <c:v>684.76499999999999</c:v>
                </c:pt>
                <c:pt idx="74">
                  <c:v>694.14499999999998</c:v>
                </c:pt>
                <c:pt idx="75">
                  <c:v>703.52599999999995</c:v>
                </c:pt>
                <c:pt idx="76">
                  <c:v>712.90599999999995</c:v>
                </c:pt>
                <c:pt idx="77">
                  <c:v>722.28599999999994</c:v>
                </c:pt>
                <c:pt idx="78">
                  <c:v>731.66700000000003</c:v>
                </c:pt>
                <c:pt idx="79">
                  <c:v>741.04700000000003</c:v>
                </c:pt>
                <c:pt idx="80">
                  <c:v>750.42700000000002</c:v>
                </c:pt>
                <c:pt idx="81">
                  <c:v>759.80799999999999</c:v>
                </c:pt>
                <c:pt idx="82">
                  <c:v>769.18799999999999</c:v>
                </c:pt>
                <c:pt idx="83">
                  <c:v>778.56799999999998</c:v>
                </c:pt>
                <c:pt idx="84">
                  <c:v>787.94899999999996</c:v>
                </c:pt>
                <c:pt idx="85">
                  <c:v>797.32899999999995</c:v>
                </c:pt>
                <c:pt idx="86">
                  <c:v>806.70899999999995</c:v>
                </c:pt>
                <c:pt idx="87">
                  <c:v>816.09</c:v>
                </c:pt>
                <c:pt idx="88">
                  <c:v>825.47</c:v>
                </c:pt>
                <c:pt idx="89">
                  <c:v>834.85</c:v>
                </c:pt>
                <c:pt idx="90">
                  <c:v>844.23099999999999</c:v>
                </c:pt>
                <c:pt idx="91">
                  <c:v>853.61099999999999</c:v>
                </c:pt>
                <c:pt idx="92">
                  <c:v>862.99099999999999</c:v>
                </c:pt>
                <c:pt idx="93">
                  <c:v>872.37199999999996</c:v>
                </c:pt>
                <c:pt idx="94">
                  <c:v>881.75199999999995</c:v>
                </c:pt>
                <c:pt idx="95">
                  <c:v>891.13199999999995</c:v>
                </c:pt>
                <c:pt idx="96">
                  <c:v>900.51300000000003</c:v>
                </c:pt>
                <c:pt idx="97">
                  <c:v>909.89300000000003</c:v>
                </c:pt>
                <c:pt idx="98">
                  <c:v>919.27300000000002</c:v>
                </c:pt>
                <c:pt idx="99">
                  <c:v>928.654</c:v>
                </c:pt>
                <c:pt idx="100">
                  <c:v>938.03399999999999</c:v>
                </c:pt>
                <c:pt idx="101">
                  <c:v>947.41499999999996</c:v>
                </c:pt>
                <c:pt idx="102">
                  <c:v>956.79499999999996</c:v>
                </c:pt>
                <c:pt idx="103">
                  <c:v>966.17499999999995</c:v>
                </c:pt>
                <c:pt idx="104">
                  <c:v>975.55600000000004</c:v>
                </c:pt>
                <c:pt idx="105">
                  <c:v>984.93600000000004</c:v>
                </c:pt>
                <c:pt idx="106">
                  <c:v>994.31600000000003</c:v>
                </c:pt>
                <c:pt idx="107">
                  <c:v>1003.697</c:v>
                </c:pt>
                <c:pt idx="108">
                  <c:v>1013.077</c:v>
                </c:pt>
                <c:pt idx="109">
                  <c:v>1022.457</c:v>
                </c:pt>
                <c:pt idx="110">
                  <c:v>1031.838</c:v>
                </c:pt>
                <c:pt idx="111">
                  <c:v>1041.2180000000001</c:v>
                </c:pt>
                <c:pt idx="112">
                  <c:v>1050.598</c:v>
                </c:pt>
                <c:pt idx="113">
                  <c:v>1059.979</c:v>
                </c:pt>
                <c:pt idx="114">
                  <c:v>1069.3589999999999</c:v>
                </c:pt>
                <c:pt idx="115">
                  <c:v>1078.739</c:v>
                </c:pt>
                <c:pt idx="116">
                  <c:v>1088.1199999999999</c:v>
                </c:pt>
                <c:pt idx="117">
                  <c:v>1097.5</c:v>
                </c:pt>
                <c:pt idx="118">
                  <c:v>1106.8800000000001</c:v>
                </c:pt>
                <c:pt idx="119">
                  <c:v>1116.261</c:v>
                </c:pt>
                <c:pt idx="120">
                  <c:v>1125.6410000000001</c:v>
                </c:pt>
                <c:pt idx="121">
                  <c:v>1135.021</c:v>
                </c:pt>
                <c:pt idx="122">
                  <c:v>1144.402</c:v>
                </c:pt>
                <c:pt idx="123">
                  <c:v>1153.7819999999999</c:v>
                </c:pt>
                <c:pt idx="124">
                  <c:v>1163.162</c:v>
                </c:pt>
                <c:pt idx="125">
                  <c:v>1172.5429999999999</c:v>
                </c:pt>
                <c:pt idx="126">
                  <c:v>1181.923</c:v>
                </c:pt>
                <c:pt idx="127">
                  <c:v>1191.3030000000001</c:v>
                </c:pt>
                <c:pt idx="128">
                  <c:v>1200.684</c:v>
                </c:pt>
                <c:pt idx="129">
                  <c:v>1210.0640000000001</c:v>
                </c:pt>
                <c:pt idx="130">
                  <c:v>1219.444</c:v>
                </c:pt>
                <c:pt idx="131">
                  <c:v>1228.825</c:v>
                </c:pt>
                <c:pt idx="132">
                  <c:v>1238.2049999999999</c:v>
                </c:pt>
                <c:pt idx="133">
                  <c:v>1247.585</c:v>
                </c:pt>
                <c:pt idx="134">
                  <c:v>1256.9659999999999</c:v>
                </c:pt>
                <c:pt idx="135">
                  <c:v>1266.346</c:v>
                </c:pt>
                <c:pt idx="136">
                  <c:v>1275.7260000000001</c:v>
                </c:pt>
                <c:pt idx="137">
                  <c:v>1285.107</c:v>
                </c:pt>
                <c:pt idx="138">
                  <c:v>1294.4870000000001</c:v>
                </c:pt>
                <c:pt idx="139">
                  <c:v>1303.8679999999999</c:v>
                </c:pt>
                <c:pt idx="140">
                  <c:v>1313.248</c:v>
                </c:pt>
                <c:pt idx="141">
                  <c:v>1322.6279999999999</c:v>
                </c:pt>
                <c:pt idx="142">
                  <c:v>1332.009</c:v>
                </c:pt>
                <c:pt idx="143">
                  <c:v>1341.3889999999999</c:v>
                </c:pt>
                <c:pt idx="144">
                  <c:v>1350.769</c:v>
                </c:pt>
                <c:pt idx="145">
                  <c:v>1351.788</c:v>
                </c:pt>
                <c:pt idx="146">
                  <c:v>1360.15</c:v>
                </c:pt>
                <c:pt idx="147">
                  <c:v>1369.53</c:v>
                </c:pt>
                <c:pt idx="148">
                  <c:v>1378.91</c:v>
                </c:pt>
                <c:pt idx="149">
                  <c:v>1388.2909999999999</c:v>
                </c:pt>
                <c:pt idx="150">
                  <c:v>1397.671</c:v>
                </c:pt>
                <c:pt idx="151">
                  <c:v>1407.0509999999999</c:v>
                </c:pt>
                <c:pt idx="152">
                  <c:v>1416.432</c:v>
                </c:pt>
                <c:pt idx="153">
                  <c:v>1425.8119999999999</c:v>
                </c:pt>
                <c:pt idx="154">
                  <c:v>1435.192</c:v>
                </c:pt>
                <c:pt idx="155">
                  <c:v>1444.5730000000001</c:v>
                </c:pt>
                <c:pt idx="156">
                  <c:v>1453.953</c:v>
                </c:pt>
                <c:pt idx="157">
                  <c:v>1463.3330000000001</c:v>
                </c:pt>
                <c:pt idx="158">
                  <c:v>1472.7139999999999</c:v>
                </c:pt>
                <c:pt idx="159">
                  <c:v>1477.9179999999999</c:v>
                </c:pt>
                <c:pt idx="160">
                  <c:v>1482.0940000000001</c:v>
                </c:pt>
                <c:pt idx="161">
                  <c:v>1491.4739999999999</c:v>
                </c:pt>
                <c:pt idx="162">
                  <c:v>1500</c:v>
                </c:pt>
                <c:pt idx="163">
                  <c:v>1500.855</c:v>
                </c:pt>
                <c:pt idx="164">
                  <c:v>1510.2349999999999</c:v>
                </c:pt>
                <c:pt idx="165">
                  <c:v>1519.615</c:v>
                </c:pt>
                <c:pt idx="166">
                  <c:v>1520.3040000000001</c:v>
                </c:pt>
                <c:pt idx="167">
                  <c:v>1528.9960000000001</c:v>
                </c:pt>
                <c:pt idx="168">
                  <c:v>1532.9090000000001</c:v>
                </c:pt>
                <c:pt idx="169">
                  <c:v>1535.8219999999999</c:v>
                </c:pt>
                <c:pt idx="170">
                  <c:v>1538.376</c:v>
                </c:pt>
                <c:pt idx="171">
                  <c:v>1538.857</c:v>
                </c:pt>
                <c:pt idx="172">
                  <c:v>1543.011</c:v>
                </c:pt>
                <c:pt idx="173">
                  <c:v>1547.7560000000001</c:v>
                </c:pt>
                <c:pt idx="174">
                  <c:v>1550.4</c:v>
                </c:pt>
                <c:pt idx="175">
                  <c:v>1555.211</c:v>
                </c:pt>
                <c:pt idx="176">
                  <c:v>1557.1369999999999</c:v>
                </c:pt>
                <c:pt idx="177">
                  <c:v>1562.902</c:v>
                </c:pt>
                <c:pt idx="178">
                  <c:v>1566.5170000000001</c:v>
                </c:pt>
                <c:pt idx="179">
                  <c:v>1569.086</c:v>
                </c:pt>
                <c:pt idx="180">
                  <c:v>1574.4960000000001</c:v>
                </c:pt>
                <c:pt idx="181">
                  <c:v>1575.7049999999999</c:v>
                </c:pt>
                <c:pt idx="182">
                  <c:v>1575.8969999999999</c:v>
                </c:pt>
                <c:pt idx="183">
                  <c:v>1577.489</c:v>
                </c:pt>
                <c:pt idx="184">
                  <c:v>1581.18</c:v>
                </c:pt>
                <c:pt idx="185">
                  <c:v>1583.0029999999999</c:v>
                </c:pt>
                <c:pt idx="186">
                  <c:v>1583.787</c:v>
                </c:pt>
                <c:pt idx="187">
                  <c:v>1585.278</c:v>
                </c:pt>
                <c:pt idx="188">
                  <c:v>1586.5820000000001</c:v>
                </c:pt>
                <c:pt idx="189">
                  <c:v>1587.2370000000001</c:v>
                </c:pt>
                <c:pt idx="190">
                  <c:v>1589.0619999999999</c:v>
                </c:pt>
                <c:pt idx="191">
                  <c:v>1592.0139999999999</c:v>
                </c:pt>
                <c:pt idx="192">
                  <c:v>1594.347</c:v>
                </c:pt>
                <c:pt idx="193">
                  <c:v>1594.6579999999999</c:v>
                </c:pt>
                <c:pt idx="194">
                  <c:v>1597.347</c:v>
                </c:pt>
                <c:pt idx="195">
                  <c:v>1598.345</c:v>
                </c:pt>
                <c:pt idx="196">
                  <c:v>1599.8050000000001</c:v>
                </c:pt>
                <c:pt idx="197">
                  <c:v>1601.3679999999999</c:v>
                </c:pt>
                <c:pt idx="198">
                  <c:v>1603.385</c:v>
                </c:pt>
                <c:pt idx="199">
                  <c:v>1603.8009999999999</c:v>
                </c:pt>
                <c:pt idx="200">
                  <c:v>1604.038</c:v>
                </c:pt>
                <c:pt idx="201">
                  <c:v>1606.126</c:v>
                </c:pt>
                <c:pt idx="202">
                  <c:v>1608.4010000000001</c:v>
                </c:pt>
                <c:pt idx="203">
                  <c:v>1609.674</c:v>
                </c:pt>
                <c:pt idx="204">
                  <c:v>1610.77</c:v>
                </c:pt>
                <c:pt idx="205">
                  <c:v>1611.2470000000001</c:v>
                </c:pt>
                <c:pt idx="206">
                  <c:v>1613.0650000000001</c:v>
                </c:pt>
                <c:pt idx="207">
                  <c:v>1613.4190000000001</c:v>
                </c:pt>
                <c:pt idx="208">
                  <c:v>1615.1220000000001</c:v>
                </c:pt>
                <c:pt idx="209">
                  <c:v>1616.682</c:v>
                </c:pt>
                <c:pt idx="210">
                  <c:v>1618.7339999999999</c:v>
                </c:pt>
                <c:pt idx="211">
                  <c:v>1619.866</c:v>
                </c:pt>
                <c:pt idx="212">
                  <c:v>1620.606</c:v>
                </c:pt>
                <c:pt idx="213">
                  <c:v>1621.0640000000001</c:v>
                </c:pt>
                <c:pt idx="214">
                  <c:v>1622.7249999999999</c:v>
                </c:pt>
                <c:pt idx="215">
                  <c:v>1622.799</c:v>
                </c:pt>
                <c:pt idx="216">
                  <c:v>1625.586</c:v>
                </c:pt>
                <c:pt idx="217">
                  <c:v>1627.442</c:v>
                </c:pt>
                <c:pt idx="218">
                  <c:v>1628.9860000000001</c:v>
                </c:pt>
                <c:pt idx="219">
                  <c:v>1629.8389999999999</c:v>
                </c:pt>
                <c:pt idx="220">
                  <c:v>1630.9970000000001</c:v>
                </c:pt>
                <c:pt idx="221">
                  <c:v>1632.1790000000001</c:v>
                </c:pt>
                <c:pt idx="222">
                  <c:v>1632.9010000000001</c:v>
                </c:pt>
                <c:pt idx="223">
                  <c:v>1634.558</c:v>
                </c:pt>
                <c:pt idx="224">
                  <c:v>1635.5930000000001</c:v>
                </c:pt>
                <c:pt idx="225">
                  <c:v>1637.2059999999999</c:v>
                </c:pt>
                <c:pt idx="226">
                  <c:v>1638.8710000000001</c:v>
                </c:pt>
                <c:pt idx="227">
                  <c:v>1639.98</c:v>
                </c:pt>
                <c:pt idx="228">
                  <c:v>1641.279</c:v>
                </c:pt>
                <c:pt idx="229">
                  <c:v>1641.56</c:v>
                </c:pt>
                <c:pt idx="230">
                  <c:v>1642.12</c:v>
                </c:pt>
                <c:pt idx="231">
                  <c:v>1644.2560000000001</c:v>
                </c:pt>
                <c:pt idx="232">
                  <c:v>1645.992</c:v>
                </c:pt>
                <c:pt idx="233">
                  <c:v>1648.3330000000001</c:v>
                </c:pt>
                <c:pt idx="234">
                  <c:v>1649.57</c:v>
                </c:pt>
                <c:pt idx="235">
                  <c:v>1649.931</c:v>
                </c:pt>
                <c:pt idx="236">
                  <c:v>1650.94</c:v>
                </c:pt>
                <c:pt idx="237">
                  <c:v>1651.759</c:v>
                </c:pt>
                <c:pt idx="238">
                  <c:v>1653.5350000000001</c:v>
                </c:pt>
                <c:pt idx="239">
                  <c:v>1654.59</c:v>
                </c:pt>
                <c:pt idx="240">
                  <c:v>1657.9780000000001</c:v>
                </c:pt>
                <c:pt idx="241">
                  <c:v>1659.9290000000001</c:v>
                </c:pt>
                <c:pt idx="242">
                  <c:v>1660.32</c:v>
                </c:pt>
                <c:pt idx="243">
                  <c:v>1660.8489999999999</c:v>
                </c:pt>
                <c:pt idx="244">
                  <c:v>1662.787</c:v>
                </c:pt>
                <c:pt idx="245">
                  <c:v>1663.7750000000001</c:v>
                </c:pt>
                <c:pt idx="246">
                  <c:v>1665.2</c:v>
                </c:pt>
                <c:pt idx="247">
                  <c:v>1666.134</c:v>
                </c:pt>
                <c:pt idx="248">
                  <c:v>1666.6489999999999</c:v>
                </c:pt>
                <c:pt idx="249">
                  <c:v>1667.0129999999999</c:v>
                </c:pt>
                <c:pt idx="250">
                  <c:v>1667.5550000000001</c:v>
                </c:pt>
                <c:pt idx="251">
                  <c:v>1668.2139999999999</c:v>
                </c:pt>
                <c:pt idx="252">
                  <c:v>1668.3610000000001</c:v>
                </c:pt>
                <c:pt idx="253">
                  <c:v>1669.0219999999999</c:v>
                </c:pt>
                <c:pt idx="254">
                  <c:v>1669.701</c:v>
                </c:pt>
                <c:pt idx="255">
                  <c:v>1670.63</c:v>
                </c:pt>
                <c:pt idx="256">
                  <c:v>1673.3140000000001</c:v>
                </c:pt>
                <c:pt idx="257">
                  <c:v>1674.7950000000001</c:v>
                </c:pt>
                <c:pt idx="258">
                  <c:v>1675.71</c:v>
                </c:pt>
                <c:pt idx="259">
                  <c:v>1676.2529999999999</c:v>
                </c:pt>
                <c:pt idx="260">
                  <c:v>1677.175</c:v>
                </c:pt>
                <c:pt idx="261">
                  <c:v>1678.2380000000001</c:v>
                </c:pt>
                <c:pt idx="262">
                  <c:v>1679.0809999999999</c:v>
                </c:pt>
                <c:pt idx="263">
                  <c:v>1681.049</c:v>
                </c:pt>
                <c:pt idx="264">
                  <c:v>1682.442</c:v>
                </c:pt>
                <c:pt idx="265">
                  <c:v>1683.7059999999999</c:v>
                </c:pt>
                <c:pt idx="266">
                  <c:v>1685.3240000000001</c:v>
                </c:pt>
                <c:pt idx="267">
                  <c:v>1688.242</c:v>
                </c:pt>
                <c:pt idx="268">
                  <c:v>1688.462</c:v>
                </c:pt>
                <c:pt idx="269">
                  <c:v>1689.8879999999999</c:v>
                </c:pt>
                <c:pt idx="270">
                  <c:v>1691.268</c:v>
                </c:pt>
                <c:pt idx="271">
                  <c:v>1692.164</c:v>
                </c:pt>
                <c:pt idx="272">
                  <c:v>1693.32</c:v>
                </c:pt>
                <c:pt idx="273">
                  <c:v>1695.25</c:v>
                </c:pt>
                <c:pt idx="274">
                  <c:v>1696.8050000000001</c:v>
                </c:pt>
                <c:pt idx="275">
                  <c:v>1697.6949999999999</c:v>
                </c:pt>
                <c:pt idx="276">
                  <c:v>1697.8420000000001</c:v>
                </c:pt>
                <c:pt idx="277">
                  <c:v>1698.0250000000001</c:v>
                </c:pt>
                <c:pt idx="278">
                  <c:v>1698.335</c:v>
                </c:pt>
                <c:pt idx="279">
                  <c:v>1699.94</c:v>
                </c:pt>
                <c:pt idx="280">
                  <c:v>1700.846</c:v>
                </c:pt>
                <c:pt idx="281">
                  <c:v>1702.2049999999999</c:v>
                </c:pt>
                <c:pt idx="282">
                  <c:v>1702.992</c:v>
                </c:pt>
                <c:pt idx="283">
                  <c:v>1704.6849999999999</c:v>
                </c:pt>
                <c:pt idx="284">
                  <c:v>1704.9179999999999</c:v>
                </c:pt>
                <c:pt idx="285">
                  <c:v>1705.2750000000001</c:v>
                </c:pt>
                <c:pt idx="286">
                  <c:v>1705.9829999999999</c:v>
                </c:pt>
                <c:pt idx="287">
                  <c:v>1707.222</c:v>
                </c:pt>
                <c:pt idx="288">
                  <c:v>1707.3330000000001</c:v>
                </c:pt>
                <c:pt idx="289">
                  <c:v>1711.6690000000001</c:v>
                </c:pt>
                <c:pt idx="290">
                  <c:v>1712.615</c:v>
                </c:pt>
                <c:pt idx="291">
                  <c:v>1712.9059999999999</c:v>
                </c:pt>
                <c:pt idx="292">
                  <c:v>1713.9090000000001</c:v>
                </c:pt>
                <c:pt idx="293">
                  <c:v>1715.2349999999999</c:v>
                </c:pt>
                <c:pt idx="294">
                  <c:v>1715.7470000000001</c:v>
                </c:pt>
                <c:pt idx="295">
                  <c:v>1716.2760000000001</c:v>
                </c:pt>
                <c:pt idx="296">
                  <c:v>1716.6030000000001</c:v>
                </c:pt>
                <c:pt idx="297">
                  <c:v>1717.8</c:v>
                </c:pt>
                <c:pt idx="298">
                  <c:v>1718.655</c:v>
                </c:pt>
                <c:pt idx="299">
                  <c:v>1719.472</c:v>
                </c:pt>
                <c:pt idx="300">
                  <c:v>1720.1980000000001</c:v>
                </c:pt>
                <c:pt idx="301">
                  <c:v>1721.422</c:v>
                </c:pt>
                <c:pt idx="302">
                  <c:v>1721.836</c:v>
                </c:pt>
                <c:pt idx="303">
                  <c:v>1722.893</c:v>
                </c:pt>
                <c:pt idx="304">
                  <c:v>1723.114</c:v>
                </c:pt>
                <c:pt idx="305">
                  <c:v>1724.5160000000001</c:v>
                </c:pt>
                <c:pt idx="306">
                  <c:v>1725.173</c:v>
                </c:pt>
                <c:pt idx="307">
                  <c:v>1725.6869999999999</c:v>
                </c:pt>
                <c:pt idx="308">
                  <c:v>1725.9829999999999</c:v>
                </c:pt>
                <c:pt idx="309">
                  <c:v>1726.5630000000001</c:v>
                </c:pt>
                <c:pt idx="310">
                  <c:v>1727.7560000000001</c:v>
                </c:pt>
                <c:pt idx="311">
                  <c:v>1729.569</c:v>
                </c:pt>
                <c:pt idx="312">
                  <c:v>1730.192</c:v>
                </c:pt>
                <c:pt idx="313">
                  <c:v>1731.461</c:v>
                </c:pt>
                <c:pt idx="314">
                  <c:v>1734.1569999999999</c:v>
                </c:pt>
                <c:pt idx="315">
                  <c:v>1735.3630000000001</c:v>
                </c:pt>
                <c:pt idx="316">
                  <c:v>1736.133</c:v>
                </c:pt>
                <c:pt idx="317">
                  <c:v>1736.875</c:v>
                </c:pt>
                <c:pt idx="318">
                  <c:v>1737.7570000000001</c:v>
                </c:pt>
                <c:pt idx="319">
                  <c:v>1739.2629999999999</c:v>
                </c:pt>
                <c:pt idx="320">
                  <c:v>1740.0519999999999</c:v>
                </c:pt>
                <c:pt idx="321">
                  <c:v>1740.9380000000001</c:v>
                </c:pt>
                <c:pt idx="322">
                  <c:v>1742.559</c:v>
                </c:pt>
                <c:pt idx="323">
                  <c:v>1744.7439999999999</c:v>
                </c:pt>
                <c:pt idx="324">
                  <c:v>1746.2380000000001</c:v>
                </c:pt>
                <c:pt idx="325">
                  <c:v>1748.3679999999999</c:v>
                </c:pt>
                <c:pt idx="326">
                  <c:v>1750.088</c:v>
                </c:pt>
                <c:pt idx="327">
                  <c:v>1750.2570000000001</c:v>
                </c:pt>
                <c:pt idx="328">
                  <c:v>1751.595</c:v>
                </c:pt>
                <c:pt idx="329">
                  <c:v>1752.1210000000001</c:v>
                </c:pt>
                <c:pt idx="330">
                  <c:v>1753.2280000000001</c:v>
                </c:pt>
                <c:pt idx="331">
                  <c:v>1754.124</c:v>
                </c:pt>
                <c:pt idx="332">
                  <c:v>1754.3330000000001</c:v>
                </c:pt>
                <c:pt idx="333">
                  <c:v>1754.854</c:v>
                </c:pt>
                <c:pt idx="334">
                  <c:v>1755.8720000000001</c:v>
                </c:pt>
                <c:pt idx="335">
                  <c:v>1756.296</c:v>
                </c:pt>
                <c:pt idx="336">
                  <c:v>1757.819</c:v>
                </c:pt>
                <c:pt idx="337">
                  <c:v>1758.348</c:v>
                </c:pt>
                <c:pt idx="338">
                  <c:v>1759.47</c:v>
                </c:pt>
                <c:pt idx="339">
                  <c:v>1761.2660000000001</c:v>
                </c:pt>
                <c:pt idx="340">
                  <c:v>1763.377</c:v>
                </c:pt>
                <c:pt idx="341">
                  <c:v>1763.5039999999999</c:v>
                </c:pt>
                <c:pt idx="342">
                  <c:v>1764.4639999999999</c:v>
                </c:pt>
                <c:pt idx="343">
                  <c:v>1765.1089999999999</c:v>
                </c:pt>
                <c:pt idx="344">
                  <c:v>1766.01</c:v>
                </c:pt>
                <c:pt idx="345">
                  <c:v>1767.386</c:v>
                </c:pt>
                <c:pt idx="346">
                  <c:v>1767.9549999999999</c:v>
                </c:pt>
                <c:pt idx="347">
                  <c:v>1768.585</c:v>
                </c:pt>
                <c:pt idx="348">
                  <c:v>1769.191</c:v>
                </c:pt>
                <c:pt idx="349">
                  <c:v>1770.3520000000001</c:v>
                </c:pt>
                <c:pt idx="350">
                  <c:v>1770.961</c:v>
                </c:pt>
                <c:pt idx="351">
                  <c:v>1772.885</c:v>
                </c:pt>
                <c:pt idx="352">
                  <c:v>1773.5360000000001</c:v>
                </c:pt>
                <c:pt idx="353">
                  <c:v>1773.923</c:v>
                </c:pt>
                <c:pt idx="354">
                  <c:v>1775.0229999999999</c:v>
                </c:pt>
                <c:pt idx="355">
                  <c:v>1775.403</c:v>
                </c:pt>
                <c:pt idx="356">
                  <c:v>1778.7850000000001</c:v>
                </c:pt>
                <c:pt idx="357">
                  <c:v>1781.318</c:v>
                </c:pt>
                <c:pt idx="358">
                  <c:v>1782.2650000000001</c:v>
                </c:pt>
                <c:pt idx="359">
                  <c:v>1783.0909999999999</c:v>
                </c:pt>
                <c:pt idx="360">
                  <c:v>1783.97</c:v>
                </c:pt>
                <c:pt idx="361">
                  <c:v>1784.8150000000001</c:v>
                </c:pt>
                <c:pt idx="362">
                  <c:v>1786.827</c:v>
                </c:pt>
                <c:pt idx="363">
                  <c:v>1787.9169999999999</c:v>
                </c:pt>
                <c:pt idx="364">
                  <c:v>1788.154</c:v>
                </c:pt>
                <c:pt idx="365">
                  <c:v>1789.069</c:v>
                </c:pt>
                <c:pt idx="366">
                  <c:v>1791.3330000000001</c:v>
                </c:pt>
                <c:pt idx="367">
                  <c:v>1791.645</c:v>
                </c:pt>
                <c:pt idx="368">
                  <c:v>1791.9059999999999</c:v>
                </c:pt>
                <c:pt idx="369">
                  <c:v>1792.59</c:v>
                </c:pt>
                <c:pt idx="370">
                  <c:v>1795.577</c:v>
                </c:pt>
                <c:pt idx="371">
                  <c:v>1798.538</c:v>
                </c:pt>
                <c:pt idx="372">
                  <c:v>1800.2470000000001</c:v>
                </c:pt>
                <c:pt idx="373">
                  <c:v>1801.0260000000001</c:v>
                </c:pt>
                <c:pt idx="374">
                  <c:v>1801.9570000000001</c:v>
                </c:pt>
                <c:pt idx="375">
                  <c:v>1804.1469999999999</c:v>
                </c:pt>
                <c:pt idx="376">
                  <c:v>1805.38</c:v>
                </c:pt>
                <c:pt idx="377">
                  <c:v>1808.6690000000001</c:v>
                </c:pt>
                <c:pt idx="378">
                  <c:v>1810.4059999999999</c:v>
                </c:pt>
                <c:pt idx="379">
                  <c:v>1810.7270000000001</c:v>
                </c:pt>
                <c:pt idx="380">
                  <c:v>1812.9069999999999</c:v>
                </c:pt>
                <c:pt idx="381">
                  <c:v>1814.67</c:v>
                </c:pt>
                <c:pt idx="382">
                  <c:v>1816.558</c:v>
                </c:pt>
                <c:pt idx="383">
                  <c:v>1818.4069999999999</c:v>
                </c:pt>
                <c:pt idx="384">
                  <c:v>1819.7860000000001</c:v>
                </c:pt>
                <c:pt idx="385">
                  <c:v>1821.4659999999999</c:v>
                </c:pt>
                <c:pt idx="386">
                  <c:v>1823.3579999999999</c:v>
                </c:pt>
                <c:pt idx="387">
                  <c:v>1827.53</c:v>
                </c:pt>
                <c:pt idx="388">
                  <c:v>1829.1669999999999</c:v>
                </c:pt>
                <c:pt idx="389">
                  <c:v>1830.8009999999999</c:v>
                </c:pt>
                <c:pt idx="390">
                  <c:v>1832.6220000000001</c:v>
                </c:pt>
                <c:pt idx="391">
                  <c:v>1835.3230000000001</c:v>
                </c:pt>
                <c:pt idx="392">
                  <c:v>1837.91</c:v>
                </c:pt>
                <c:pt idx="393">
                  <c:v>1838.547</c:v>
                </c:pt>
                <c:pt idx="394">
                  <c:v>1843.846</c:v>
                </c:pt>
                <c:pt idx="395">
                  <c:v>1845.6590000000001</c:v>
                </c:pt>
                <c:pt idx="396">
                  <c:v>1847.9269999999999</c:v>
                </c:pt>
                <c:pt idx="397">
                  <c:v>1849.47</c:v>
                </c:pt>
                <c:pt idx="398">
                  <c:v>1857.308</c:v>
                </c:pt>
                <c:pt idx="399">
                  <c:v>1866.6880000000001</c:v>
                </c:pt>
                <c:pt idx="400">
                  <c:v>1876.068</c:v>
                </c:pt>
                <c:pt idx="401">
                  <c:v>1876.068</c:v>
                </c:pt>
              </c:numCache>
            </c:numRef>
          </c:xVal>
          <c:yVal>
            <c:numRef>
              <c:f>Foglio6!$H$5:$H$418</c:f>
              <c:numCache>
                <c:formatCode>General</c:formatCode>
                <c:ptCount val="414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99.998999999999995</c:v>
                </c:pt>
                <c:pt idx="147">
                  <c:v>99.998000000000005</c:v>
                </c:pt>
                <c:pt idx="148">
                  <c:v>99.998000000000005</c:v>
                </c:pt>
                <c:pt idx="149">
                  <c:v>99.998000000000005</c:v>
                </c:pt>
                <c:pt idx="150">
                  <c:v>99.998000000000005</c:v>
                </c:pt>
                <c:pt idx="151">
                  <c:v>99.997</c:v>
                </c:pt>
                <c:pt idx="152">
                  <c:v>99.984999999999999</c:v>
                </c:pt>
                <c:pt idx="153">
                  <c:v>99.947999999999993</c:v>
                </c:pt>
                <c:pt idx="154">
                  <c:v>99.911000000000001</c:v>
                </c:pt>
                <c:pt idx="155">
                  <c:v>99.897999999999996</c:v>
                </c:pt>
                <c:pt idx="156">
                  <c:v>99.876000000000005</c:v>
                </c:pt>
                <c:pt idx="157">
                  <c:v>99.846999999999994</c:v>
                </c:pt>
                <c:pt idx="158">
                  <c:v>99.757000000000005</c:v>
                </c:pt>
                <c:pt idx="159">
                  <c:v>99.5</c:v>
                </c:pt>
                <c:pt idx="160">
                  <c:v>99.42</c:v>
                </c:pt>
                <c:pt idx="161">
                  <c:v>99.162999999999997</c:v>
                </c:pt>
                <c:pt idx="162">
                  <c:v>99</c:v>
                </c:pt>
                <c:pt idx="163">
                  <c:v>98.96</c:v>
                </c:pt>
                <c:pt idx="164">
                  <c:v>98.605000000000004</c:v>
                </c:pt>
                <c:pt idx="165">
                  <c:v>98.558999999999997</c:v>
                </c:pt>
                <c:pt idx="166">
                  <c:v>98.5</c:v>
                </c:pt>
                <c:pt idx="167">
                  <c:v>98.210999999999999</c:v>
                </c:pt>
                <c:pt idx="168">
                  <c:v>98</c:v>
                </c:pt>
                <c:pt idx="169">
                  <c:v>97.5</c:v>
                </c:pt>
                <c:pt idx="170">
                  <c:v>97.146000000000001</c:v>
                </c:pt>
                <c:pt idx="171">
                  <c:v>97</c:v>
                </c:pt>
                <c:pt idx="172">
                  <c:v>96.5</c:v>
                </c:pt>
                <c:pt idx="173">
                  <c:v>96.100999999999999</c:v>
                </c:pt>
                <c:pt idx="174">
                  <c:v>96</c:v>
                </c:pt>
                <c:pt idx="175">
                  <c:v>95.5</c:v>
                </c:pt>
                <c:pt idx="176">
                  <c:v>95.305000000000007</c:v>
                </c:pt>
                <c:pt idx="177">
                  <c:v>95</c:v>
                </c:pt>
                <c:pt idx="178">
                  <c:v>94.754999999999995</c:v>
                </c:pt>
                <c:pt idx="179">
                  <c:v>94.5</c:v>
                </c:pt>
                <c:pt idx="180">
                  <c:v>94</c:v>
                </c:pt>
                <c:pt idx="181">
                  <c:v>93.5</c:v>
                </c:pt>
                <c:pt idx="182">
                  <c:v>93.462999999999994</c:v>
                </c:pt>
                <c:pt idx="183">
                  <c:v>93</c:v>
                </c:pt>
                <c:pt idx="184">
                  <c:v>92.5</c:v>
                </c:pt>
                <c:pt idx="185">
                  <c:v>92</c:v>
                </c:pt>
                <c:pt idx="186">
                  <c:v>91.5</c:v>
                </c:pt>
                <c:pt idx="187">
                  <c:v>91.191000000000003</c:v>
                </c:pt>
                <c:pt idx="188">
                  <c:v>91</c:v>
                </c:pt>
                <c:pt idx="189">
                  <c:v>90.5</c:v>
                </c:pt>
                <c:pt idx="190">
                  <c:v>90</c:v>
                </c:pt>
                <c:pt idx="191">
                  <c:v>89.5</c:v>
                </c:pt>
                <c:pt idx="192">
                  <c:v>89</c:v>
                </c:pt>
                <c:pt idx="193">
                  <c:v>88.974999999999994</c:v>
                </c:pt>
                <c:pt idx="194">
                  <c:v>88.5</c:v>
                </c:pt>
                <c:pt idx="195">
                  <c:v>88</c:v>
                </c:pt>
                <c:pt idx="196">
                  <c:v>87.5</c:v>
                </c:pt>
                <c:pt idx="197">
                  <c:v>87</c:v>
                </c:pt>
                <c:pt idx="198">
                  <c:v>86.5</c:v>
                </c:pt>
                <c:pt idx="199">
                  <c:v>86</c:v>
                </c:pt>
                <c:pt idx="200">
                  <c:v>85.846000000000004</c:v>
                </c:pt>
                <c:pt idx="201">
                  <c:v>85.5</c:v>
                </c:pt>
                <c:pt idx="202">
                  <c:v>85</c:v>
                </c:pt>
                <c:pt idx="203">
                  <c:v>84.5</c:v>
                </c:pt>
                <c:pt idx="204">
                  <c:v>84</c:v>
                </c:pt>
                <c:pt idx="205">
                  <c:v>83.5</c:v>
                </c:pt>
                <c:pt idx="206">
                  <c:v>83</c:v>
                </c:pt>
                <c:pt idx="207">
                  <c:v>82.978999999999999</c:v>
                </c:pt>
                <c:pt idx="208">
                  <c:v>82.5</c:v>
                </c:pt>
                <c:pt idx="209">
                  <c:v>82</c:v>
                </c:pt>
                <c:pt idx="210">
                  <c:v>81.5</c:v>
                </c:pt>
                <c:pt idx="211">
                  <c:v>81</c:v>
                </c:pt>
                <c:pt idx="212">
                  <c:v>80.5</c:v>
                </c:pt>
                <c:pt idx="213">
                  <c:v>80</c:v>
                </c:pt>
                <c:pt idx="214">
                  <c:v>79.5</c:v>
                </c:pt>
                <c:pt idx="215">
                  <c:v>79.495000000000005</c:v>
                </c:pt>
                <c:pt idx="216">
                  <c:v>79</c:v>
                </c:pt>
                <c:pt idx="217">
                  <c:v>78.5</c:v>
                </c:pt>
                <c:pt idx="218">
                  <c:v>78</c:v>
                </c:pt>
                <c:pt idx="219">
                  <c:v>77.5</c:v>
                </c:pt>
                <c:pt idx="220">
                  <c:v>77</c:v>
                </c:pt>
                <c:pt idx="221">
                  <c:v>76.680000000000007</c:v>
                </c:pt>
                <c:pt idx="222">
                  <c:v>76.5</c:v>
                </c:pt>
                <c:pt idx="223">
                  <c:v>76</c:v>
                </c:pt>
                <c:pt idx="224">
                  <c:v>75.5</c:v>
                </c:pt>
                <c:pt idx="225">
                  <c:v>75</c:v>
                </c:pt>
                <c:pt idx="226">
                  <c:v>74.5</c:v>
                </c:pt>
                <c:pt idx="227">
                  <c:v>74</c:v>
                </c:pt>
                <c:pt idx="228">
                  <c:v>73.5</c:v>
                </c:pt>
                <c:pt idx="229">
                  <c:v>73.417000000000002</c:v>
                </c:pt>
                <c:pt idx="230">
                  <c:v>73</c:v>
                </c:pt>
                <c:pt idx="231">
                  <c:v>72.5</c:v>
                </c:pt>
                <c:pt idx="232">
                  <c:v>72</c:v>
                </c:pt>
                <c:pt idx="233">
                  <c:v>71.5</c:v>
                </c:pt>
                <c:pt idx="234">
                  <c:v>71</c:v>
                </c:pt>
                <c:pt idx="235">
                  <c:v>70.5</c:v>
                </c:pt>
                <c:pt idx="236">
                  <c:v>70.102999999999994</c:v>
                </c:pt>
                <c:pt idx="237">
                  <c:v>70</c:v>
                </c:pt>
                <c:pt idx="238">
                  <c:v>69.5</c:v>
                </c:pt>
                <c:pt idx="239">
                  <c:v>69</c:v>
                </c:pt>
                <c:pt idx="240">
                  <c:v>68.5</c:v>
                </c:pt>
                <c:pt idx="241">
                  <c:v>68</c:v>
                </c:pt>
                <c:pt idx="242">
                  <c:v>67.953999999999994</c:v>
                </c:pt>
                <c:pt idx="243">
                  <c:v>67.5</c:v>
                </c:pt>
                <c:pt idx="244">
                  <c:v>67</c:v>
                </c:pt>
                <c:pt idx="245">
                  <c:v>66.5</c:v>
                </c:pt>
                <c:pt idx="246">
                  <c:v>66</c:v>
                </c:pt>
                <c:pt idx="247">
                  <c:v>65.5</c:v>
                </c:pt>
                <c:pt idx="248">
                  <c:v>65</c:v>
                </c:pt>
                <c:pt idx="249">
                  <c:v>64.5</c:v>
                </c:pt>
                <c:pt idx="250">
                  <c:v>64</c:v>
                </c:pt>
                <c:pt idx="251">
                  <c:v>63.5</c:v>
                </c:pt>
                <c:pt idx="252">
                  <c:v>63</c:v>
                </c:pt>
                <c:pt idx="253">
                  <c:v>62.5</c:v>
                </c:pt>
                <c:pt idx="254">
                  <c:v>62.167000000000002</c:v>
                </c:pt>
                <c:pt idx="255">
                  <c:v>62</c:v>
                </c:pt>
                <c:pt idx="256">
                  <c:v>61.5</c:v>
                </c:pt>
                <c:pt idx="257">
                  <c:v>61</c:v>
                </c:pt>
                <c:pt idx="258">
                  <c:v>60.5</c:v>
                </c:pt>
                <c:pt idx="259">
                  <c:v>60</c:v>
                </c:pt>
                <c:pt idx="260">
                  <c:v>59.5</c:v>
                </c:pt>
                <c:pt idx="261">
                  <c:v>59</c:v>
                </c:pt>
                <c:pt idx="262">
                  <c:v>58.866</c:v>
                </c:pt>
                <c:pt idx="263">
                  <c:v>58.5</c:v>
                </c:pt>
                <c:pt idx="264">
                  <c:v>58</c:v>
                </c:pt>
                <c:pt idx="265">
                  <c:v>57.5</c:v>
                </c:pt>
                <c:pt idx="266">
                  <c:v>57</c:v>
                </c:pt>
                <c:pt idx="267">
                  <c:v>56.5</c:v>
                </c:pt>
                <c:pt idx="268">
                  <c:v>56.476999999999997</c:v>
                </c:pt>
                <c:pt idx="269">
                  <c:v>56</c:v>
                </c:pt>
                <c:pt idx="270">
                  <c:v>55.5</c:v>
                </c:pt>
                <c:pt idx="271">
                  <c:v>55</c:v>
                </c:pt>
                <c:pt idx="272">
                  <c:v>54.5</c:v>
                </c:pt>
                <c:pt idx="273">
                  <c:v>54</c:v>
                </c:pt>
                <c:pt idx="274">
                  <c:v>53.5</c:v>
                </c:pt>
                <c:pt idx="275">
                  <c:v>53</c:v>
                </c:pt>
                <c:pt idx="276">
                  <c:v>52.718000000000004</c:v>
                </c:pt>
                <c:pt idx="277">
                  <c:v>52.5</c:v>
                </c:pt>
                <c:pt idx="278">
                  <c:v>52</c:v>
                </c:pt>
                <c:pt idx="279">
                  <c:v>51.5</c:v>
                </c:pt>
                <c:pt idx="280">
                  <c:v>51</c:v>
                </c:pt>
                <c:pt idx="281">
                  <c:v>50.5</c:v>
                </c:pt>
                <c:pt idx="282">
                  <c:v>50</c:v>
                </c:pt>
                <c:pt idx="283">
                  <c:v>49.5</c:v>
                </c:pt>
                <c:pt idx="284">
                  <c:v>49</c:v>
                </c:pt>
                <c:pt idx="285">
                  <c:v>48.5</c:v>
                </c:pt>
                <c:pt idx="286">
                  <c:v>48</c:v>
                </c:pt>
                <c:pt idx="287">
                  <c:v>47.517000000000003</c:v>
                </c:pt>
                <c:pt idx="288">
                  <c:v>47.5</c:v>
                </c:pt>
                <c:pt idx="289">
                  <c:v>47</c:v>
                </c:pt>
                <c:pt idx="290">
                  <c:v>46.5</c:v>
                </c:pt>
                <c:pt idx="291">
                  <c:v>46</c:v>
                </c:pt>
                <c:pt idx="292">
                  <c:v>45.5</c:v>
                </c:pt>
                <c:pt idx="293">
                  <c:v>45</c:v>
                </c:pt>
                <c:pt idx="294">
                  <c:v>44.5</c:v>
                </c:pt>
                <c:pt idx="295">
                  <c:v>44</c:v>
                </c:pt>
                <c:pt idx="296">
                  <c:v>43.88</c:v>
                </c:pt>
                <c:pt idx="297">
                  <c:v>43.5</c:v>
                </c:pt>
                <c:pt idx="298">
                  <c:v>43</c:v>
                </c:pt>
                <c:pt idx="299">
                  <c:v>42.5</c:v>
                </c:pt>
                <c:pt idx="300">
                  <c:v>42</c:v>
                </c:pt>
                <c:pt idx="301">
                  <c:v>41.5</c:v>
                </c:pt>
                <c:pt idx="302">
                  <c:v>41</c:v>
                </c:pt>
                <c:pt idx="303">
                  <c:v>40.5</c:v>
                </c:pt>
                <c:pt idx="304">
                  <c:v>40</c:v>
                </c:pt>
                <c:pt idx="305">
                  <c:v>39.5</c:v>
                </c:pt>
                <c:pt idx="306">
                  <c:v>39</c:v>
                </c:pt>
                <c:pt idx="307">
                  <c:v>38.5</c:v>
                </c:pt>
                <c:pt idx="308">
                  <c:v>38.200000000000003</c:v>
                </c:pt>
                <c:pt idx="309">
                  <c:v>38</c:v>
                </c:pt>
                <c:pt idx="310">
                  <c:v>37.5</c:v>
                </c:pt>
                <c:pt idx="311">
                  <c:v>37</c:v>
                </c:pt>
                <c:pt idx="312">
                  <c:v>36.5</c:v>
                </c:pt>
                <c:pt idx="313">
                  <c:v>36</c:v>
                </c:pt>
                <c:pt idx="314">
                  <c:v>35.5</c:v>
                </c:pt>
                <c:pt idx="315">
                  <c:v>35.293999999999997</c:v>
                </c:pt>
                <c:pt idx="316">
                  <c:v>35</c:v>
                </c:pt>
                <c:pt idx="317">
                  <c:v>34.5</c:v>
                </c:pt>
                <c:pt idx="318">
                  <c:v>34</c:v>
                </c:pt>
                <c:pt idx="319">
                  <c:v>33.5</c:v>
                </c:pt>
                <c:pt idx="320">
                  <c:v>33</c:v>
                </c:pt>
                <c:pt idx="321">
                  <c:v>32.5</c:v>
                </c:pt>
                <c:pt idx="322">
                  <c:v>32</c:v>
                </c:pt>
                <c:pt idx="323">
                  <c:v>31.602</c:v>
                </c:pt>
                <c:pt idx="324">
                  <c:v>31.5</c:v>
                </c:pt>
                <c:pt idx="325">
                  <c:v>31</c:v>
                </c:pt>
                <c:pt idx="326">
                  <c:v>30.5</c:v>
                </c:pt>
                <c:pt idx="327">
                  <c:v>30</c:v>
                </c:pt>
                <c:pt idx="328">
                  <c:v>29.5</c:v>
                </c:pt>
                <c:pt idx="329">
                  <c:v>29</c:v>
                </c:pt>
                <c:pt idx="330">
                  <c:v>28.5</c:v>
                </c:pt>
                <c:pt idx="331">
                  <c:v>28.317</c:v>
                </c:pt>
                <c:pt idx="332">
                  <c:v>28</c:v>
                </c:pt>
                <c:pt idx="333">
                  <c:v>27.5</c:v>
                </c:pt>
                <c:pt idx="334">
                  <c:v>27</c:v>
                </c:pt>
                <c:pt idx="335">
                  <c:v>26.5</c:v>
                </c:pt>
                <c:pt idx="336">
                  <c:v>26</c:v>
                </c:pt>
                <c:pt idx="337">
                  <c:v>25.5</c:v>
                </c:pt>
                <c:pt idx="338">
                  <c:v>25</c:v>
                </c:pt>
                <c:pt idx="339">
                  <c:v>24.5</c:v>
                </c:pt>
                <c:pt idx="340">
                  <c:v>24</c:v>
                </c:pt>
                <c:pt idx="341">
                  <c:v>23.97</c:v>
                </c:pt>
                <c:pt idx="342">
                  <c:v>23.5</c:v>
                </c:pt>
                <c:pt idx="343">
                  <c:v>23</c:v>
                </c:pt>
                <c:pt idx="344">
                  <c:v>22.5</c:v>
                </c:pt>
                <c:pt idx="345">
                  <c:v>22</c:v>
                </c:pt>
                <c:pt idx="346">
                  <c:v>21.5</c:v>
                </c:pt>
                <c:pt idx="347">
                  <c:v>21</c:v>
                </c:pt>
                <c:pt idx="348">
                  <c:v>20.5</c:v>
                </c:pt>
                <c:pt idx="349">
                  <c:v>20</c:v>
                </c:pt>
                <c:pt idx="350">
                  <c:v>19.5</c:v>
                </c:pt>
                <c:pt idx="351">
                  <c:v>19.228999999999999</c:v>
                </c:pt>
                <c:pt idx="352">
                  <c:v>19</c:v>
                </c:pt>
                <c:pt idx="353">
                  <c:v>18.5</c:v>
                </c:pt>
                <c:pt idx="354">
                  <c:v>18</c:v>
                </c:pt>
                <c:pt idx="355">
                  <c:v>17.5</c:v>
                </c:pt>
                <c:pt idx="356">
                  <c:v>17</c:v>
                </c:pt>
                <c:pt idx="357">
                  <c:v>16.5</c:v>
                </c:pt>
                <c:pt idx="358">
                  <c:v>16.222999999999999</c:v>
                </c:pt>
                <c:pt idx="359">
                  <c:v>16</c:v>
                </c:pt>
                <c:pt idx="360">
                  <c:v>15.5</c:v>
                </c:pt>
                <c:pt idx="361">
                  <c:v>15</c:v>
                </c:pt>
                <c:pt idx="362">
                  <c:v>14.5</c:v>
                </c:pt>
                <c:pt idx="363">
                  <c:v>14</c:v>
                </c:pt>
                <c:pt idx="364">
                  <c:v>13.5</c:v>
                </c:pt>
                <c:pt idx="365">
                  <c:v>13</c:v>
                </c:pt>
                <c:pt idx="366">
                  <c:v>12.5</c:v>
                </c:pt>
                <c:pt idx="367">
                  <c:v>12.364000000000001</c:v>
                </c:pt>
                <c:pt idx="368">
                  <c:v>12</c:v>
                </c:pt>
                <c:pt idx="369">
                  <c:v>11.5</c:v>
                </c:pt>
                <c:pt idx="370">
                  <c:v>11</c:v>
                </c:pt>
                <c:pt idx="371">
                  <c:v>10.5</c:v>
                </c:pt>
                <c:pt idx="372">
                  <c:v>10</c:v>
                </c:pt>
                <c:pt idx="373">
                  <c:v>9.6519999999999992</c:v>
                </c:pt>
                <c:pt idx="374">
                  <c:v>9.5</c:v>
                </c:pt>
                <c:pt idx="375">
                  <c:v>9</c:v>
                </c:pt>
                <c:pt idx="376">
                  <c:v>8.5</c:v>
                </c:pt>
                <c:pt idx="377">
                  <c:v>8</c:v>
                </c:pt>
                <c:pt idx="378">
                  <c:v>7.55</c:v>
                </c:pt>
                <c:pt idx="379">
                  <c:v>7.5</c:v>
                </c:pt>
                <c:pt idx="380">
                  <c:v>7</c:v>
                </c:pt>
                <c:pt idx="381">
                  <c:v>6.5</c:v>
                </c:pt>
                <c:pt idx="382">
                  <c:v>6</c:v>
                </c:pt>
                <c:pt idx="383">
                  <c:v>5.5</c:v>
                </c:pt>
                <c:pt idx="384">
                  <c:v>5.2960000000000003</c:v>
                </c:pt>
                <c:pt idx="385">
                  <c:v>5</c:v>
                </c:pt>
                <c:pt idx="386">
                  <c:v>4.5</c:v>
                </c:pt>
                <c:pt idx="387">
                  <c:v>4</c:v>
                </c:pt>
                <c:pt idx="388">
                  <c:v>3.7639999999999998</c:v>
                </c:pt>
                <c:pt idx="389">
                  <c:v>3.5</c:v>
                </c:pt>
                <c:pt idx="390">
                  <c:v>3</c:v>
                </c:pt>
                <c:pt idx="391">
                  <c:v>2.5</c:v>
                </c:pt>
                <c:pt idx="392">
                  <c:v>2</c:v>
                </c:pt>
                <c:pt idx="393">
                  <c:v>1.8560000000000001</c:v>
                </c:pt>
                <c:pt idx="394">
                  <c:v>1.5</c:v>
                </c:pt>
                <c:pt idx="395">
                  <c:v>1</c:v>
                </c:pt>
                <c:pt idx="396">
                  <c:v>0.78600000000000003</c:v>
                </c:pt>
                <c:pt idx="397">
                  <c:v>0.5</c:v>
                </c:pt>
                <c:pt idx="398">
                  <c:v>0.215</c:v>
                </c:pt>
                <c:pt idx="399">
                  <c:v>0.11</c:v>
                </c:pt>
                <c:pt idx="400">
                  <c:v>4.5999999999999999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331-46BE-B50F-9AAB614B149E}"/>
            </c:ext>
          </c:extLst>
        </c:ser>
        <c:ser>
          <c:idx val="2"/>
          <c:order val="4"/>
          <c:tx>
            <c:strRef>
              <c:f>Foglio6!$I$1</c:f>
              <c:strCache>
                <c:ptCount val="1"/>
                <c:pt idx="0">
                  <c:v>S0,5M8</c:v>
                </c:pt>
              </c:strCache>
            </c:strRef>
          </c:tx>
          <c:spPr>
            <a:ln w="19050" cap="rnd">
              <a:solidFill>
                <a:schemeClr val="accent6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I$5:$I$418</c:f>
              <c:numCache>
                <c:formatCode>General</c:formatCode>
                <c:ptCount val="414"/>
                <c:pt idx="0">
                  <c:v>0</c:v>
                </c:pt>
                <c:pt idx="1">
                  <c:v>8.18</c:v>
                </c:pt>
                <c:pt idx="2">
                  <c:v>16.361000000000001</c:v>
                </c:pt>
                <c:pt idx="3">
                  <c:v>24.541</c:v>
                </c:pt>
                <c:pt idx="4">
                  <c:v>32.720999999999997</c:v>
                </c:pt>
                <c:pt idx="5">
                  <c:v>40.902000000000001</c:v>
                </c:pt>
                <c:pt idx="6">
                  <c:v>49.082000000000001</c:v>
                </c:pt>
                <c:pt idx="7">
                  <c:v>57.262999999999998</c:v>
                </c:pt>
                <c:pt idx="8">
                  <c:v>65.442999999999998</c:v>
                </c:pt>
                <c:pt idx="9">
                  <c:v>73.623000000000005</c:v>
                </c:pt>
                <c:pt idx="10">
                  <c:v>81.804000000000002</c:v>
                </c:pt>
                <c:pt idx="11">
                  <c:v>89.983999999999995</c:v>
                </c:pt>
                <c:pt idx="12">
                  <c:v>98.164000000000001</c:v>
                </c:pt>
                <c:pt idx="13">
                  <c:v>106.345</c:v>
                </c:pt>
                <c:pt idx="14">
                  <c:v>114.52500000000001</c:v>
                </c:pt>
                <c:pt idx="15">
                  <c:v>122.705</c:v>
                </c:pt>
                <c:pt idx="16">
                  <c:v>130.886</c:v>
                </c:pt>
                <c:pt idx="17">
                  <c:v>139.066</c:v>
                </c:pt>
                <c:pt idx="18">
                  <c:v>147.24600000000001</c:v>
                </c:pt>
                <c:pt idx="19">
                  <c:v>155.42699999999999</c:v>
                </c:pt>
                <c:pt idx="20">
                  <c:v>163.607</c:v>
                </c:pt>
                <c:pt idx="21">
                  <c:v>171.78800000000001</c:v>
                </c:pt>
                <c:pt idx="22">
                  <c:v>179.96799999999999</c:v>
                </c:pt>
                <c:pt idx="23">
                  <c:v>188.148</c:v>
                </c:pt>
                <c:pt idx="24">
                  <c:v>196.32900000000001</c:v>
                </c:pt>
                <c:pt idx="25">
                  <c:v>204.50899999999999</c:v>
                </c:pt>
                <c:pt idx="26">
                  <c:v>212.68899999999999</c:v>
                </c:pt>
                <c:pt idx="27">
                  <c:v>220.87</c:v>
                </c:pt>
                <c:pt idx="28">
                  <c:v>229.05</c:v>
                </c:pt>
                <c:pt idx="29">
                  <c:v>237.23</c:v>
                </c:pt>
                <c:pt idx="30">
                  <c:v>245.411</c:v>
                </c:pt>
                <c:pt idx="31">
                  <c:v>253.59100000000001</c:v>
                </c:pt>
                <c:pt idx="32">
                  <c:v>261.77199999999999</c:v>
                </c:pt>
                <c:pt idx="33">
                  <c:v>269.952</c:v>
                </c:pt>
                <c:pt idx="34">
                  <c:v>278.13200000000001</c:v>
                </c:pt>
                <c:pt idx="35">
                  <c:v>286.31299999999999</c:v>
                </c:pt>
                <c:pt idx="36">
                  <c:v>294.49299999999999</c:v>
                </c:pt>
                <c:pt idx="37">
                  <c:v>302.673</c:v>
                </c:pt>
                <c:pt idx="38">
                  <c:v>310.85399999999998</c:v>
                </c:pt>
                <c:pt idx="39">
                  <c:v>319.03399999999999</c:v>
                </c:pt>
                <c:pt idx="40">
                  <c:v>327.214</c:v>
                </c:pt>
                <c:pt idx="41">
                  <c:v>335.39499999999998</c:v>
                </c:pt>
                <c:pt idx="42">
                  <c:v>343.57499999999999</c:v>
                </c:pt>
                <c:pt idx="43">
                  <c:v>351.75599999999997</c:v>
                </c:pt>
                <c:pt idx="44">
                  <c:v>359.93599999999998</c:v>
                </c:pt>
                <c:pt idx="45">
                  <c:v>368.11599999999999</c:v>
                </c:pt>
                <c:pt idx="46">
                  <c:v>376.29700000000003</c:v>
                </c:pt>
                <c:pt idx="47">
                  <c:v>384.47699999999998</c:v>
                </c:pt>
                <c:pt idx="48">
                  <c:v>392.65699999999998</c:v>
                </c:pt>
                <c:pt idx="49">
                  <c:v>400.83800000000002</c:v>
                </c:pt>
                <c:pt idx="50">
                  <c:v>409.01799999999997</c:v>
                </c:pt>
                <c:pt idx="51">
                  <c:v>417.19799999999998</c:v>
                </c:pt>
                <c:pt idx="52">
                  <c:v>425.37900000000002</c:v>
                </c:pt>
                <c:pt idx="53">
                  <c:v>433.55900000000003</c:v>
                </c:pt>
                <c:pt idx="54">
                  <c:v>441.73899999999998</c:v>
                </c:pt>
                <c:pt idx="55">
                  <c:v>449.92</c:v>
                </c:pt>
                <c:pt idx="56">
                  <c:v>458.1</c:v>
                </c:pt>
                <c:pt idx="57">
                  <c:v>466.28100000000001</c:v>
                </c:pt>
                <c:pt idx="58">
                  <c:v>474.46100000000001</c:v>
                </c:pt>
                <c:pt idx="59">
                  <c:v>482.64100000000002</c:v>
                </c:pt>
                <c:pt idx="60">
                  <c:v>490.822</c:v>
                </c:pt>
                <c:pt idx="61">
                  <c:v>499.00200000000001</c:v>
                </c:pt>
                <c:pt idx="62">
                  <c:v>507.18200000000002</c:v>
                </c:pt>
                <c:pt idx="63">
                  <c:v>515.36300000000006</c:v>
                </c:pt>
                <c:pt idx="64">
                  <c:v>523.54300000000001</c:v>
                </c:pt>
                <c:pt idx="65">
                  <c:v>531.72299999999996</c:v>
                </c:pt>
                <c:pt idx="66">
                  <c:v>539.904</c:v>
                </c:pt>
                <c:pt idx="67">
                  <c:v>548.08399999999995</c:v>
                </c:pt>
                <c:pt idx="68">
                  <c:v>556.26499999999999</c:v>
                </c:pt>
                <c:pt idx="69">
                  <c:v>564.44500000000005</c:v>
                </c:pt>
                <c:pt idx="70">
                  <c:v>572.625</c:v>
                </c:pt>
                <c:pt idx="71">
                  <c:v>580.80600000000004</c:v>
                </c:pt>
                <c:pt idx="72">
                  <c:v>588.98599999999999</c:v>
                </c:pt>
                <c:pt idx="73">
                  <c:v>597.16600000000005</c:v>
                </c:pt>
                <c:pt idx="74">
                  <c:v>605.34699999999998</c:v>
                </c:pt>
                <c:pt idx="75">
                  <c:v>613.52700000000004</c:v>
                </c:pt>
                <c:pt idx="76">
                  <c:v>621.70699999999999</c:v>
                </c:pt>
                <c:pt idx="77">
                  <c:v>629.88800000000003</c:v>
                </c:pt>
                <c:pt idx="78">
                  <c:v>638.06799999999998</c:v>
                </c:pt>
                <c:pt idx="79">
                  <c:v>646.24800000000005</c:v>
                </c:pt>
                <c:pt idx="80">
                  <c:v>654.42899999999997</c:v>
                </c:pt>
                <c:pt idx="81">
                  <c:v>662.60900000000004</c:v>
                </c:pt>
                <c:pt idx="82">
                  <c:v>670.79</c:v>
                </c:pt>
                <c:pt idx="83">
                  <c:v>678.97</c:v>
                </c:pt>
                <c:pt idx="84">
                  <c:v>687.15</c:v>
                </c:pt>
                <c:pt idx="85">
                  <c:v>695.33100000000002</c:v>
                </c:pt>
                <c:pt idx="86">
                  <c:v>703.51099999999997</c:v>
                </c:pt>
                <c:pt idx="87">
                  <c:v>711.69100000000003</c:v>
                </c:pt>
                <c:pt idx="88">
                  <c:v>719.87199999999996</c:v>
                </c:pt>
                <c:pt idx="89">
                  <c:v>728.05200000000002</c:v>
                </c:pt>
                <c:pt idx="90">
                  <c:v>736.23199999999997</c:v>
                </c:pt>
                <c:pt idx="91">
                  <c:v>744.41300000000001</c:v>
                </c:pt>
                <c:pt idx="92">
                  <c:v>752.59299999999996</c:v>
                </c:pt>
                <c:pt idx="93">
                  <c:v>760.774</c:v>
                </c:pt>
                <c:pt idx="94">
                  <c:v>768.95399999999995</c:v>
                </c:pt>
                <c:pt idx="95">
                  <c:v>777.13400000000001</c:v>
                </c:pt>
                <c:pt idx="96">
                  <c:v>785.31500000000005</c:v>
                </c:pt>
                <c:pt idx="97">
                  <c:v>793.495</c:v>
                </c:pt>
                <c:pt idx="98">
                  <c:v>801.67499999999995</c:v>
                </c:pt>
                <c:pt idx="99">
                  <c:v>809.85599999999999</c:v>
                </c:pt>
                <c:pt idx="100">
                  <c:v>818.03599999999994</c:v>
                </c:pt>
                <c:pt idx="101">
                  <c:v>826.21600000000001</c:v>
                </c:pt>
                <c:pt idx="102">
                  <c:v>834.39700000000005</c:v>
                </c:pt>
                <c:pt idx="103">
                  <c:v>842.577</c:v>
                </c:pt>
                <c:pt idx="104">
                  <c:v>850.75800000000004</c:v>
                </c:pt>
                <c:pt idx="105">
                  <c:v>858.93799999999999</c:v>
                </c:pt>
                <c:pt idx="106">
                  <c:v>867.11800000000005</c:v>
                </c:pt>
                <c:pt idx="107">
                  <c:v>875.29899999999998</c:v>
                </c:pt>
                <c:pt idx="108">
                  <c:v>883.47900000000004</c:v>
                </c:pt>
                <c:pt idx="109">
                  <c:v>891.65899999999999</c:v>
                </c:pt>
                <c:pt idx="110">
                  <c:v>899.84</c:v>
                </c:pt>
                <c:pt idx="111">
                  <c:v>908.02</c:v>
                </c:pt>
                <c:pt idx="112">
                  <c:v>916.2</c:v>
                </c:pt>
                <c:pt idx="113">
                  <c:v>924.38099999999997</c:v>
                </c:pt>
                <c:pt idx="114">
                  <c:v>932.56100000000004</c:v>
                </c:pt>
                <c:pt idx="115">
                  <c:v>940.74099999999999</c:v>
                </c:pt>
                <c:pt idx="116">
                  <c:v>948.92200000000003</c:v>
                </c:pt>
                <c:pt idx="117">
                  <c:v>957.10199999999998</c:v>
                </c:pt>
                <c:pt idx="118">
                  <c:v>965.28300000000002</c:v>
                </c:pt>
                <c:pt idx="119">
                  <c:v>973.46299999999997</c:v>
                </c:pt>
                <c:pt idx="120">
                  <c:v>981.64300000000003</c:v>
                </c:pt>
                <c:pt idx="121">
                  <c:v>989.82399999999996</c:v>
                </c:pt>
                <c:pt idx="122">
                  <c:v>998.00400000000002</c:v>
                </c:pt>
                <c:pt idx="123">
                  <c:v>1006.184</c:v>
                </c:pt>
                <c:pt idx="124">
                  <c:v>1014.365</c:v>
                </c:pt>
                <c:pt idx="125">
                  <c:v>1022.545</c:v>
                </c:pt>
                <c:pt idx="126">
                  <c:v>1030.7249999999999</c:v>
                </c:pt>
                <c:pt idx="127">
                  <c:v>1038.9059999999999</c:v>
                </c:pt>
                <c:pt idx="128">
                  <c:v>1047.086</c:v>
                </c:pt>
                <c:pt idx="129">
                  <c:v>1055.2670000000001</c:v>
                </c:pt>
                <c:pt idx="130">
                  <c:v>1063.4469999999999</c:v>
                </c:pt>
                <c:pt idx="131">
                  <c:v>1071.627</c:v>
                </c:pt>
                <c:pt idx="132">
                  <c:v>1079.808</c:v>
                </c:pt>
                <c:pt idx="133">
                  <c:v>1087.9880000000001</c:v>
                </c:pt>
                <c:pt idx="134">
                  <c:v>1096.1679999999999</c:v>
                </c:pt>
                <c:pt idx="135">
                  <c:v>1104.3489999999999</c:v>
                </c:pt>
                <c:pt idx="136">
                  <c:v>1112.529</c:v>
                </c:pt>
                <c:pt idx="137">
                  <c:v>1120.7090000000001</c:v>
                </c:pt>
                <c:pt idx="138">
                  <c:v>1128.8900000000001</c:v>
                </c:pt>
                <c:pt idx="139">
                  <c:v>1137.07</c:v>
                </c:pt>
                <c:pt idx="140">
                  <c:v>1145.251</c:v>
                </c:pt>
                <c:pt idx="141">
                  <c:v>1153.431</c:v>
                </c:pt>
                <c:pt idx="142">
                  <c:v>1161.6110000000001</c:v>
                </c:pt>
                <c:pt idx="143">
                  <c:v>1169.7919999999999</c:v>
                </c:pt>
                <c:pt idx="144">
                  <c:v>1177.972</c:v>
                </c:pt>
                <c:pt idx="145">
                  <c:v>1186.152</c:v>
                </c:pt>
                <c:pt idx="146">
                  <c:v>1194.3330000000001</c:v>
                </c:pt>
                <c:pt idx="147">
                  <c:v>1202.5129999999999</c:v>
                </c:pt>
                <c:pt idx="148">
                  <c:v>1210.693</c:v>
                </c:pt>
                <c:pt idx="149">
                  <c:v>1218.874</c:v>
                </c:pt>
                <c:pt idx="150">
                  <c:v>1227.0540000000001</c:v>
                </c:pt>
                <c:pt idx="151">
                  <c:v>1235.2339999999999</c:v>
                </c:pt>
                <c:pt idx="152">
                  <c:v>1243.415</c:v>
                </c:pt>
                <c:pt idx="153">
                  <c:v>1251.595</c:v>
                </c:pt>
                <c:pt idx="154">
                  <c:v>1259.7760000000001</c:v>
                </c:pt>
                <c:pt idx="155">
                  <c:v>1267.9559999999999</c:v>
                </c:pt>
                <c:pt idx="156">
                  <c:v>1276.136</c:v>
                </c:pt>
                <c:pt idx="157">
                  <c:v>1284.317</c:v>
                </c:pt>
                <c:pt idx="158">
                  <c:v>1292.4970000000001</c:v>
                </c:pt>
                <c:pt idx="159">
                  <c:v>1300.6769999999999</c:v>
                </c:pt>
                <c:pt idx="160">
                  <c:v>1308.8579999999999</c:v>
                </c:pt>
                <c:pt idx="161">
                  <c:v>1317.038</c:v>
                </c:pt>
                <c:pt idx="162">
                  <c:v>1325.2180000000001</c:v>
                </c:pt>
                <c:pt idx="163">
                  <c:v>1333.3989999999999</c:v>
                </c:pt>
                <c:pt idx="164">
                  <c:v>1341.579</c:v>
                </c:pt>
                <c:pt idx="165">
                  <c:v>1349.76</c:v>
                </c:pt>
                <c:pt idx="166">
                  <c:v>1357.94</c:v>
                </c:pt>
                <c:pt idx="167">
                  <c:v>1366.12</c:v>
                </c:pt>
                <c:pt idx="168">
                  <c:v>1374.3009999999999</c:v>
                </c:pt>
                <c:pt idx="169">
                  <c:v>1382.481</c:v>
                </c:pt>
                <c:pt idx="170">
                  <c:v>1390.6610000000001</c:v>
                </c:pt>
                <c:pt idx="171">
                  <c:v>1398.8420000000001</c:v>
                </c:pt>
                <c:pt idx="172">
                  <c:v>1407.0219999999999</c:v>
                </c:pt>
                <c:pt idx="173">
                  <c:v>1415.202</c:v>
                </c:pt>
                <c:pt idx="174">
                  <c:v>1423.383</c:v>
                </c:pt>
                <c:pt idx="175">
                  <c:v>1431.5630000000001</c:v>
                </c:pt>
                <c:pt idx="176">
                  <c:v>1439.624</c:v>
                </c:pt>
                <c:pt idx="177">
                  <c:v>1439.7429999999999</c:v>
                </c:pt>
                <c:pt idx="178">
                  <c:v>1447.924</c:v>
                </c:pt>
                <c:pt idx="179">
                  <c:v>1456.104</c:v>
                </c:pt>
                <c:pt idx="180">
                  <c:v>1464.2850000000001</c:v>
                </c:pt>
                <c:pt idx="181">
                  <c:v>1472.4649999999999</c:v>
                </c:pt>
                <c:pt idx="182">
                  <c:v>1480.645</c:v>
                </c:pt>
                <c:pt idx="183">
                  <c:v>1488.826</c:v>
                </c:pt>
                <c:pt idx="184">
                  <c:v>1489.7929999999999</c:v>
                </c:pt>
                <c:pt idx="185">
                  <c:v>1497.0060000000001</c:v>
                </c:pt>
                <c:pt idx="186">
                  <c:v>1500</c:v>
                </c:pt>
                <c:pt idx="187">
                  <c:v>1503.124</c:v>
                </c:pt>
                <c:pt idx="188">
                  <c:v>1505.1859999999999</c:v>
                </c:pt>
                <c:pt idx="189">
                  <c:v>1505.8230000000001</c:v>
                </c:pt>
                <c:pt idx="190">
                  <c:v>1507.539</c:v>
                </c:pt>
                <c:pt idx="191">
                  <c:v>1508.2629999999999</c:v>
                </c:pt>
                <c:pt idx="192">
                  <c:v>1510.29</c:v>
                </c:pt>
                <c:pt idx="193">
                  <c:v>1511.663</c:v>
                </c:pt>
                <c:pt idx="194">
                  <c:v>1513.367</c:v>
                </c:pt>
                <c:pt idx="195">
                  <c:v>1515.634</c:v>
                </c:pt>
                <c:pt idx="196">
                  <c:v>1515.941</c:v>
                </c:pt>
                <c:pt idx="197">
                  <c:v>1517.663</c:v>
                </c:pt>
                <c:pt idx="198">
                  <c:v>1520.877</c:v>
                </c:pt>
                <c:pt idx="199">
                  <c:v>1521.547</c:v>
                </c:pt>
                <c:pt idx="200">
                  <c:v>1521.934</c:v>
                </c:pt>
                <c:pt idx="201">
                  <c:v>1523.3320000000001</c:v>
                </c:pt>
                <c:pt idx="202">
                  <c:v>1525.6510000000001</c:v>
                </c:pt>
                <c:pt idx="203">
                  <c:v>1528</c:v>
                </c:pt>
                <c:pt idx="204">
                  <c:v>1528.9459999999999</c:v>
                </c:pt>
                <c:pt idx="205">
                  <c:v>1529.7270000000001</c:v>
                </c:pt>
                <c:pt idx="206">
                  <c:v>1530.2380000000001</c:v>
                </c:pt>
                <c:pt idx="207">
                  <c:v>1530.5519999999999</c:v>
                </c:pt>
                <c:pt idx="208">
                  <c:v>1531.4659999999999</c:v>
                </c:pt>
                <c:pt idx="209">
                  <c:v>1531.721</c:v>
                </c:pt>
                <c:pt idx="210">
                  <c:v>1532.3610000000001</c:v>
                </c:pt>
                <c:pt idx="211">
                  <c:v>1532.817</c:v>
                </c:pt>
                <c:pt idx="212">
                  <c:v>1532.9939999999999</c:v>
                </c:pt>
                <c:pt idx="213">
                  <c:v>1533.2809999999999</c:v>
                </c:pt>
                <c:pt idx="214">
                  <c:v>1534.4079999999999</c:v>
                </c:pt>
                <c:pt idx="215">
                  <c:v>1535.2380000000001</c:v>
                </c:pt>
                <c:pt idx="216">
                  <c:v>1535.954</c:v>
                </c:pt>
                <c:pt idx="217">
                  <c:v>1536.1990000000001</c:v>
                </c:pt>
                <c:pt idx="218">
                  <c:v>1536.9829999999999</c:v>
                </c:pt>
                <c:pt idx="219">
                  <c:v>1537.2529999999999</c:v>
                </c:pt>
                <c:pt idx="220">
                  <c:v>1537.788</c:v>
                </c:pt>
                <c:pt idx="221">
                  <c:v>1537.9079999999999</c:v>
                </c:pt>
                <c:pt idx="222">
                  <c:v>1538.0239999999999</c:v>
                </c:pt>
                <c:pt idx="223">
                  <c:v>1538.277</c:v>
                </c:pt>
                <c:pt idx="224">
                  <c:v>1538.4870000000001</c:v>
                </c:pt>
                <c:pt idx="225">
                  <c:v>1539.2329999999999</c:v>
                </c:pt>
                <c:pt idx="226">
                  <c:v>1539.5550000000001</c:v>
                </c:pt>
                <c:pt idx="227">
                  <c:v>1539.8440000000001</c:v>
                </c:pt>
                <c:pt idx="228">
                  <c:v>1540.24</c:v>
                </c:pt>
                <c:pt idx="229">
                  <c:v>1540.7739999999999</c:v>
                </c:pt>
                <c:pt idx="230">
                  <c:v>1541.645</c:v>
                </c:pt>
                <c:pt idx="231">
                  <c:v>1542.528</c:v>
                </c:pt>
                <c:pt idx="232">
                  <c:v>1543.67</c:v>
                </c:pt>
                <c:pt idx="233">
                  <c:v>1544.5719999999999</c:v>
                </c:pt>
                <c:pt idx="234">
                  <c:v>1545.9749999999999</c:v>
                </c:pt>
                <c:pt idx="235">
                  <c:v>1546.088</c:v>
                </c:pt>
                <c:pt idx="236">
                  <c:v>1546.471</c:v>
                </c:pt>
                <c:pt idx="237">
                  <c:v>1546.8610000000001</c:v>
                </c:pt>
                <c:pt idx="238">
                  <c:v>1547.403</c:v>
                </c:pt>
                <c:pt idx="239">
                  <c:v>1547.4760000000001</c:v>
                </c:pt>
                <c:pt idx="240">
                  <c:v>1547.76</c:v>
                </c:pt>
                <c:pt idx="241">
                  <c:v>1548.4649999999999</c:v>
                </c:pt>
                <c:pt idx="242">
                  <c:v>1548.5</c:v>
                </c:pt>
                <c:pt idx="243">
                  <c:v>1548.604</c:v>
                </c:pt>
                <c:pt idx="244">
                  <c:v>1549.0619999999999</c:v>
                </c:pt>
                <c:pt idx="245">
                  <c:v>1549.8109999999999</c:v>
                </c:pt>
                <c:pt idx="246">
                  <c:v>1550.2439999999999</c:v>
                </c:pt>
                <c:pt idx="247">
                  <c:v>1550.5840000000001</c:v>
                </c:pt>
                <c:pt idx="248">
                  <c:v>1550.856</c:v>
                </c:pt>
                <c:pt idx="249">
                  <c:v>1551.19</c:v>
                </c:pt>
                <c:pt idx="250">
                  <c:v>1551.4880000000001</c:v>
                </c:pt>
                <c:pt idx="251">
                  <c:v>1551.925</c:v>
                </c:pt>
                <c:pt idx="252">
                  <c:v>1552.8689999999999</c:v>
                </c:pt>
                <c:pt idx="253">
                  <c:v>1553.1469999999999</c:v>
                </c:pt>
                <c:pt idx="254">
                  <c:v>1553.6010000000001</c:v>
                </c:pt>
                <c:pt idx="255">
                  <c:v>1553.9680000000001</c:v>
                </c:pt>
                <c:pt idx="256">
                  <c:v>1554.269</c:v>
                </c:pt>
                <c:pt idx="257">
                  <c:v>1554.6780000000001</c:v>
                </c:pt>
                <c:pt idx="258">
                  <c:v>1554.7739999999999</c:v>
                </c:pt>
                <c:pt idx="259">
                  <c:v>1555.6079999999999</c:v>
                </c:pt>
                <c:pt idx="260">
                  <c:v>1555.9949999999999</c:v>
                </c:pt>
                <c:pt idx="261">
                  <c:v>1556.3040000000001</c:v>
                </c:pt>
                <c:pt idx="262">
                  <c:v>1556.4449999999999</c:v>
                </c:pt>
                <c:pt idx="263">
                  <c:v>1556.53</c:v>
                </c:pt>
                <c:pt idx="264">
                  <c:v>1556.846</c:v>
                </c:pt>
                <c:pt idx="265">
                  <c:v>1557.278</c:v>
                </c:pt>
                <c:pt idx="266">
                  <c:v>1557.827</c:v>
                </c:pt>
                <c:pt idx="267">
                  <c:v>1558.403</c:v>
                </c:pt>
                <c:pt idx="268">
                  <c:v>1558.549</c:v>
                </c:pt>
                <c:pt idx="269">
                  <c:v>1558.806</c:v>
                </c:pt>
                <c:pt idx="270">
                  <c:v>1560.0730000000001</c:v>
                </c:pt>
                <c:pt idx="271">
                  <c:v>1560.6310000000001</c:v>
                </c:pt>
                <c:pt idx="272">
                  <c:v>1560.8430000000001</c:v>
                </c:pt>
                <c:pt idx="273">
                  <c:v>1561.2819999999999</c:v>
                </c:pt>
                <c:pt idx="274">
                  <c:v>1561.56</c:v>
                </c:pt>
                <c:pt idx="275">
                  <c:v>1561.76</c:v>
                </c:pt>
                <c:pt idx="276">
                  <c:v>1562.0170000000001</c:v>
                </c:pt>
                <c:pt idx="277">
                  <c:v>1562.1859999999999</c:v>
                </c:pt>
                <c:pt idx="278">
                  <c:v>1562.4490000000001</c:v>
                </c:pt>
                <c:pt idx="279">
                  <c:v>1562.73</c:v>
                </c:pt>
                <c:pt idx="280">
                  <c:v>1562.9590000000001</c:v>
                </c:pt>
                <c:pt idx="281">
                  <c:v>1563.2760000000001</c:v>
                </c:pt>
                <c:pt idx="282">
                  <c:v>1564.4010000000001</c:v>
                </c:pt>
                <c:pt idx="283">
                  <c:v>1564.8820000000001</c:v>
                </c:pt>
                <c:pt idx="284">
                  <c:v>1565.068</c:v>
                </c:pt>
                <c:pt idx="285">
                  <c:v>1565.2180000000001</c:v>
                </c:pt>
                <c:pt idx="286">
                  <c:v>1565.6780000000001</c:v>
                </c:pt>
                <c:pt idx="287">
                  <c:v>1566.2370000000001</c:v>
                </c:pt>
                <c:pt idx="288">
                  <c:v>1566.403</c:v>
                </c:pt>
                <c:pt idx="289">
                  <c:v>1566.49</c:v>
                </c:pt>
                <c:pt idx="290">
                  <c:v>1566.8</c:v>
                </c:pt>
                <c:pt idx="291">
                  <c:v>1567.0519999999999</c:v>
                </c:pt>
                <c:pt idx="292">
                  <c:v>1567.1659999999999</c:v>
                </c:pt>
                <c:pt idx="293">
                  <c:v>1567.2329999999999</c:v>
                </c:pt>
                <c:pt idx="294">
                  <c:v>1567.5889999999999</c:v>
                </c:pt>
                <c:pt idx="295">
                  <c:v>1568.104</c:v>
                </c:pt>
                <c:pt idx="296">
                  <c:v>1568.3330000000001</c:v>
                </c:pt>
                <c:pt idx="297">
                  <c:v>1568.633</c:v>
                </c:pt>
                <c:pt idx="298">
                  <c:v>1569.105</c:v>
                </c:pt>
                <c:pt idx="299">
                  <c:v>1569.6790000000001</c:v>
                </c:pt>
                <c:pt idx="300">
                  <c:v>1570.104</c:v>
                </c:pt>
                <c:pt idx="301">
                  <c:v>1570.3579999999999</c:v>
                </c:pt>
                <c:pt idx="302">
                  <c:v>1570.6289999999999</c:v>
                </c:pt>
                <c:pt idx="303">
                  <c:v>1571.117</c:v>
                </c:pt>
                <c:pt idx="304">
                  <c:v>1571.6569999999999</c:v>
                </c:pt>
                <c:pt idx="305">
                  <c:v>1572.2670000000001</c:v>
                </c:pt>
                <c:pt idx="306">
                  <c:v>1572.3389999999999</c:v>
                </c:pt>
                <c:pt idx="307">
                  <c:v>1572.422</c:v>
                </c:pt>
                <c:pt idx="308">
                  <c:v>1572.538</c:v>
                </c:pt>
                <c:pt idx="309">
                  <c:v>1572.8330000000001</c:v>
                </c:pt>
                <c:pt idx="310">
                  <c:v>1573.0070000000001</c:v>
                </c:pt>
                <c:pt idx="311">
                  <c:v>1573.3009999999999</c:v>
                </c:pt>
                <c:pt idx="312">
                  <c:v>1573.5429999999999</c:v>
                </c:pt>
                <c:pt idx="313">
                  <c:v>1573.915</c:v>
                </c:pt>
                <c:pt idx="314">
                  <c:v>1574.201</c:v>
                </c:pt>
                <c:pt idx="315">
                  <c:v>1574.463</c:v>
                </c:pt>
                <c:pt idx="316">
                  <c:v>1574.5550000000001</c:v>
                </c:pt>
                <c:pt idx="317">
                  <c:v>1574.877</c:v>
                </c:pt>
                <c:pt idx="318">
                  <c:v>1575.0119999999999</c:v>
                </c:pt>
                <c:pt idx="319">
                  <c:v>1575.2370000000001</c:v>
                </c:pt>
                <c:pt idx="320">
                  <c:v>1575.6079999999999</c:v>
                </c:pt>
                <c:pt idx="321">
                  <c:v>1575.7370000000001</c:v>
                </c:pt>
                <c:pt idx="322">
                  <c:v>1576.114</c:v>
                </c:pt>
                <c:pt idx="323">
                  <c:v>1576.239</c:v>
                </c:pt>
                <c:pt idx="324">
                  <c:v>1576.537</c:v>
                </c:pt>
                <c:pt idx="325">
                  <c:v>1576.962</c:v>
                </c:pt>
                <c:pt idx="326">
                  <c:v>1577.789</c:v>
                </c:pt>
                <c:pt idx="327">
                  <c:v>1578.6469999999999</c:v>
                </c:pt>
                <c:pt idx="328">
                  <c:v>1578.81</c:v>
                </c:pt>
                <c:pt idx="329">
                  <c:v>1579.242</c:v>
                </c:pt>
                <c:pt idx="330">
                  <c:v>1579.5940000000001</c:v>
                </c:pt>
                <c:pt idx="331">
                  <c:v>1579.7660000000001</c:v>
                </c:pt>
                <c:pt idx="332">
                  <c:v>1580.0550000000001</c:v>
                </c:pt>
                <c:pt idx="333">
                  <c:v>1580.6479999999999</c:v>
                </c:pt>
                <c:pt idx="334">
                  <c:v>1580.9169999999999</c:v>
                </c:pt>
                <c:pt idx="335">
                  <c:v>1580.9860000000001</c:v>
                </c:pt>
                <c:pt idx="336">
                  <c:v>1581.704</c:v>
                </c:pt>
                <c:pt idx="337">
                  <c:v>1582.069</c:v>
                </c:pt>
                <c:pt idx="338">
                  <c:v>1582.5709999999999</c:v>
                </c:pt>
                <c:pt idx="339">
                  <c:v>1582.7470000000001</c:v>
                </c:pt>
                <c:pt idx="340">
                  <c:v>1582.9580000000001</c:v>
                </c:pt>
                <c:pt idx="341">
                  <c:v>1583.0150000000001</c:v>
                </c:pt>
                <c:pt idx="342">
                  <c:v>1583.3520000000001</c:v>
                </c:pt>
                <c:pt idx="343">
                  <c:v>1583.6780000000001</c:v>
                </c:pt>
                <c:pt idx="344">
                  <c:v>1584.364</c:v>
                </c:pt>
                <c:pt idx="345">
                  <c:v>1584.7439999999999</c:v>
                </c:pt>
                <c:pt idx="346">
                  <c:v>1585.2159999999999</c:v>
                </c:pt>
                <c:pt idx="347">
                  <c:v>1585.79</c:v>
                </c:pt>
                <c:pt idx="348">
                  <c:v>1586.99</c:v>
                </c:pt>
                <c:pt idx="349">
                  <c:v>1587.1610000000001</c:v>
                </c:pt>
                <c:pt idx="350">
                  <c:v>1587.306</c:v>
                </c:pt>
                <c:pt idx="351">
                  <c:v>1587.895</c:v>
                </c:pt>
                <c:pt idx="352">
                  <c:v>1588.875</c:v>
                </c:pt>
                <c:pt idx="353">
                  <c:v>1589.6130000000001</c:v>
                </c:pt>
                <c:pt idx="354">
                  <c:v>1590.088</c:v>
                </c:pt>
                <c:pt idx="355">
                  <c:v>1590.4459999999999</c:v>
                </c:pt>
                <c:pt idx="356">
                  <c:v>1590.6120000000001</c:v>
                </c:pt>
                <c:pt idx="357">
                  <c:v>1590.87</c:v>
                </c:pt>
                <c:pt idx="358">
                  <c:v>1591.1369999999999</c:v>
                </c:pt>
                <c:pt idx="359">
                  <c:v>1591.2729999999999</c:v>
                </c:pt>
                <c:pt idx="360">
                  <c:v>1591.5609999999999</c:v>
                </c:pt>
                <c:pt idx="361">
                  <c:v>1592.1310000000001</c:v>
                </c:pt>
                <c:pt idx="362">
                  <c:v>1592.5229999999999</c:v>
                </c:pt>
                <c:pt idx="363">
                  <c:v>1592.799</c:v>
                </c:pt>
                <c:pt idx="364">
                  <c:v>1592.979</c:v>
                </c:pt>
                <c:pt idx="365">
                  <c:v>1593.1679999999999</c:v>
                </c:pt>
                <c:pt idx="366">
                  <c:v>1593.4739999999999</c:v>
                </c:pt>
                <c:pt idx="367">
                  <c:v>1594.4960000000001</c:v>
                </c:pt>
                <c:pt idx="368">
                  <c:v>1594.9860000000001</c:v>
                </c:pt>
                <c:pt idx="369">
                  <c:v>1595.17</c:v>
                </c:pt>
                <c:pt idx="370">
                  <c:v>1596.3330000000001</c:v>
                </c:pt>
                <c:pt idx="371">
                  <c:v>1596.59</c:v>
                </c:pt>
                <c:pt idx="372">
                  <c:v>1597.269</c:v>
                </c:pt>
                <c:pt idx="373">
                  <c:v>1597.749</c:v>
                </c:pt>
                <c:pt idx="374">
                  <c:v>1598.4549999999999</c:v>
                </c:pt>
                <c:pt idx="375">
                  <c:v>1599.903</c:v>
                </c:pt>
                <c:pt idx="376">
                  <c:v>1601.1210000000001</c:v>
                </c:pt>
                <c:pt idx="377">
                  <c:v>1602.4459999999999</c:v>
                </c:pt>
                <c:pt idx="378">
                  <c:v>1602.6410000000001</c:v>
                </c:pt>
                <c:pt idx="379">
                  <c:v>1603.0360000000001</c:v>
                </c:pt>
                <c:pt idx="380">
                  <c:v>1603.2270000000001</c:v>
                </c:pt>
                <c:pt idx="381">
                  <c:v>1603.3510000000001</c:v>
                </c:pt>
                <c:pt idx="382">
                  <c:v>1604.671</c:v>
                </c:pt>
                <c:pt idx="383">
                  <c:v>1605.259</c:v>
                </c:pt>
                <c:pt idx="384">
                  <c:v>1605.97</c:v>
                </c:pt>
                <c:pt idx="385">
                  <c:v>1606.441</c:v>
                </c:pt>
                <c:pt idx="386">
                  <c:v>1606.826</c:v>
                </c:pt>
                <c:pt idx="387">
                  <c:v>1607.164</c:v>
                </c:pt>
                <c:pt idx="388">
                  <c:v>1608.5329999999999</c:v>
                </c:pt>
                <c:pt idx="389">
                  <c:v>1608.6849999999999</c:v>
                </c:pt>
                <c:pt idx="390">
                  <c:v>1609.6379999999999</c:v>
                </c:pt>
                <c:pt idx="391">
                  <c:v>1610.49</c:v>
                </c:pt>
                <c:pt idx="392">
                  <c:v>1611.269</c:v>
                </c:pt>
                <c:pt idx="393">
                  <c:v>1611.5309999999999</c:v>
                </c:pt>
                <c:pt idx="394">
                  <c:v>1612.537</c:v>
                </c:pt>
                <c:pt idx="395">
                  <c:v>1616.3610000000001</c:v>
                </c:pt>
                <c:pt idx="396">
                  <c:v>1617.2</c:v>
                </c:pt>
                <c:pt idx="397">
                  <c:v>1619.711</c:v>
                </c:pt>
                <c:pt idx="398">
                  <c:v>1624.732</c:v>
                </c:pt>
                <c:pt idx="399">
                  <c:v>1627.8920000000001</c:v>
                </c:pt>
                <c:pt idx="400">
                  <c:v>1636.0719999999999</c:v>
                </c:pt>
                <c:pt idx="401">
                  <c:v>1636.0719999999999</c:v>
                </c:pt>
              </c:numCache>
            </c:numRef>
          </c:xVal>
          <c:yVal>
            <c:numRef>
              <c:f>Foglio6!$J$5:$J$418</c:f>
              <c:numCache>
                <c:formatCode>General</c:formatCode>
                <c:ptCount val="414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100</c:v>
                </c:pt>
                <c:pt idx="162">
                  <c:v>100</c:v>
                </c:pt>
                <c:pt idx="163">
                  <c:v>100</c:v>
                </c:pt>
                <c:pt idx="164">
                  <c:v>100</c:v>
                </c:pt>
                <c:pt idx="165">
                  <c:v>100</c:v>
                </c:pt>
                <c:pt idx="166">
                  <c:v>100</c:v>
                </c:pt>
                <c:pt idx="167">
                  <c:v>100</c:v>
                </c:pt>
                <c:pt idx="168">
                  <c:v>100</c:v>
                </c:pt>
                <c:pt idx="169">
                  <c:v>100</c:v>
                </c:pt>
                <c:pt idx="170">
                  <c:v>100</c:v>
                </c:pt>
                <c:pt idx="171">
                  <c:v>100</c:v>
                </c:pt>
                <c:pt idx="172">
                  <c:v>100</c:v>
                </c:pt>
                <c:pt idx="173">
                  <c:v>100</c:v>
                </c:pt>
                <c:pt idx="174">
                  <c:v>100</c:v>
                </c:pt>
                <c:pt idx="175">
                  <c:v>100</c:v>
                </c:pt>
                <c:pt idx="176">
                  <c:v>100</c:v>
                </c:pt>
                <c:pt idx="177">
                  <c:v>99.994</c:v>
                </c:pt>
                <c:pt idx="178">
                  <c:v>99.989000000000004</c:v>
                </c:pt>
                <c:pt idx="179">
                  <c:v>99.989000000000004</c:v>
                </c:pt>
                <c:pt idx="180">
                  <c:v>99.989000000000004</c:v>
                </c:pt>
                <c:pt idx="181">
                  <c:v>99.983999999999995</c:v>
                </c:pt>
                <c:pt idx="182">
                  <c:v>99.954999999999998</c:v>
                </c:pt>
                <c:pt idx="183">
                  <c:v>99.522999999999996</c:v>
                </c:pt>
                <c:pt idx="184">
                  <c:v>99.5</c:v>
                </c:pt>
                <c:pt idx="185">
                  <c:v>99.221999999999994</c:v>
                </c:pt>
                <c:pt idx="186">
                  <c:v>99</c:v>
                </c:pt>
                <c:pt idx="187">
                  <c:v>98.5</c:v>
                </c:pt>
                <c:pt idx="188">
                  <c:v>98.173000000000002</c:v>
                </c:pt>
                <c:pt idx="189">
                  <c:v>98</c:v>
                </c:pt>
                <c:pt idx="190">
                  <c:v>97.5</c:v>
                </c:pt>
                <c:pt idx="191">
                  <c:v>97</c:v>
                </c:pt>
                <c:pt idx="192">
                  <c:v>96.5</c:v>
                </c:pt>
                <c:pt idx="193">
                  <c:v>96</c:v>
                </c:pt>
                <c:pt idx="194">
                  <c:v>95.7</c:v>
                </c:pt>
                <c:pt idx="195">
                  <c:v>95.5</c:v>
                </c:pt>
                <c:pt idx="196">
                  <c:v>95</c:v>
                </c:pt>
                <c:pt idx="197">
                  <c:v>94.5</c:v>
                </c:pt>
                <c:pt idx="198">
                  <c:v>94</c:v>
                </c:pt>
                <c:pt idx="199">
                  <c:v>93.593000000000004</c:v>
                </c:pt>
                <c:pt idx="200">
                  <c:v>93.5</c:v>
                </c:pt>
                <c:pt idx="201">
                  <c:v>93</c:v>
                </c:pt>
                <c:pt idx="202">
                  <c:v>92.5</c:v>
                </c:pt>
                <c:pt idx="203">
                  <c:v>92</c:v>
                </c:pt>
                <c:pt idx="204">
                  <c:v>91.5</c:v>
                </c:pt>
                <c:pt idx="205">
                  <c:v>91.18</c:v>
                </c:pt>
                <c:pt idx="206">
                  <c:v>91</c:v>
                </c:pt>
                <c:pt idx="207">
                  <c:v>90.5</c:v>
                </c:pt>
                <c:pt idx="208">
                  <c:v>90</c:v>
                </c:pt>
                <c:pt idx="209">
                  <c:v>89.5</c:v>
                </c:pt>
                <c:pt idx="210">
                  <c:v>89</c:v>
                </c:pt>
                <c:pt idx="211">
                  <c:v>88.5</c:v>
                </c:pt>
                <c:pt idx="212">
                  <c:v>88</c:v>
                </c:pt>
                <c:pt idx="213">
                  <c:v>87.5</c:v>
                </c:pt>
                <c:pt idx="214">
                  <c:v>87</c:v>
                </c:pt>
                <c:pt idx="215">
                  <c:v>86.5</c:v>
                </c:pt>
                <c:pt idx="216">
                  <c:v>86</c:v>
                </c:pt>
                <c:pt idx="217">
                  <c:v>85.5</c:v>
                </c:pt>
                <c:pt idx="218">
                  <c:v>85</c:v>
                </c:pt>
                <c:pt idx="219">
                  <c:v>84.5</c:v>
                </c:pt>
                <c:pt idx="220">
                  <c:v>84</c:v>
                </c:pt>
                <c:pt idx="221">
                  <c:v>83.858000000000004</c:v>
                </c:pt>
                <c:pt idx="222">
                  <c:v>83.5</c:v>
                </c:pt>
                <c:pt idx="223">
                  <c:v>83</c:v>
                </c:pt>
                <c:pt idx="224">
                  <c:v>82.5</c:v>
                </c:pt>
                <c:pt idx="225">
                  <c:v>82</c:v>
                </c:pt>
                <c:pt idx="226">
                  <c:v>81.5</c:v>
                </c:pt>
                <c:pt idx="227">
                  <c:v>81</c:v>
                </c:pt>
                <c:pt idx="228">
                  <c:v>80.5</c:v>
                </c:pt>
                <c:pt idx="229">
                  <c:v>80</c:v>
                </c:pt>
                <c:pt idx="230">
                  <c:v>79.5</c:v>
                </c:pt>
                <c:pt idx="231">
                  <c:v>79</c:v>
                </c:pt>
                <c:pt idx="232">
                  <c:v>78.5</c:v>
                </c:pt>
                <c:pt idx="233">
                  <c:v>78</c:v>
                </c:pt>
                <c:pt idx="234">
                  <c:v>77.5</c:v>
                </c:pt>
                <c:pt idx="235">
                  <c:v>77.41</c:v>
                </c:pt>
                <c:pt idx="236">
                  <c:v>77</c:v>
                </c:pt>
                <c:pt idx="237">
                  <c:v>76.5</c:v>
                </c:pt>
                <c:pt idx="238">
                  <c:v>76</c:v>
                </c:pt>
                <c:pt idx="239">
                  <c:v>75.5</c:v>
                </c:pt>
                <c:pt idx="240">
                  <c:v>75</c:v>
                </c:pt>
                <c:pt idx="241">
                  <c:v>74.5</c:v>
                </c:pt>
                <c:pt idx="242">
                  <c:v>74</c:v>
                </c:pt>
                <c:pt idx="243">
                  <c:v>73.5</c:v>
                </c:pt>
                <c:pt idx="244">
                  <c:v>73</c:v>
                </c:pt>
                <c:pt idx="245">
                  <c:v>72.5</c:v>
                </c:pt>
                <c:pt idx="246">
                  <c:v>72</c:v>
                </c:pt>
                <c:pt idx="247">
                  <c:v>71.5</c:v>
                </c:pt>
                <c:pt idx="248">
                  <c:v>71</c:v>
                </c:pt>
                <c:pt idx="249">
                  <c:v>70.5</c:v>
                </c:pt>
                <c:pt idx="250">
                  <c:v>70</c:v>
                </c:pt>
                <c:pt idx="251">
                  <c:v>69.5</c:v>
                </c:pt>
                <c:pt idx="252">
                  <c:v>69</c:v>
                </c:pt>
                <c:pt idx="253">
                  <c:v>68.5</c:v>
                </c:pt>
                <c:pt idx="254">
                  <c:v>68</c:v>
                </c:pt>
                <c:pt idx="255">
                  <c:v>67.5</c:v>
                </c:pt>
                <c:pt idx="256">
                  <c:v>67.191000000000003</c:v>
                </c:pt>
                <c:pt idx="257">
                  <c:v>67</c:v>
                </c:pt>
                <c:pt idx="258">
                  <c:v>66.5</c:v>
                </c:pt>
                <c:pt idx="259">
                  <c:v>66</c:v>
                </c:pt>
                <c:pt idx="260">
                  <c:v>65.5</c:v>
                </c:pt>
                <c:pt idx="261">
                  <c:v>65</c:v>
                </c:pt>
                <c:pt idx="262">
                  <c:v>64.5</c:v>
                </c:pt>
                <c:pt idx="263">
                  <c:v>64</c:v>
                </c:pt>
                <c:pt idx="264">
                  <c:v>63.5</c:v>
                </c:pt>
                <c:pt idx="265">
                  <c:v>63</c:v>
                </c:pt>
                <c:pt idx="266">
                  <c:v>62.5</c:v>
                </c:pt>
                <c:pt idx="267">
                  <c:v>62</c:v>
                </c:pt>
                <c:pt idx="268">
                  <c:v>61.5</c:v>
                </c:pt>
                <c:pt idx="269">
                  <c:v>61</c:v>
                </c:pt>
                <c:pt idx="270">
                  <c:v>60.5</c:v>
                </c:pt>
                <c:pt idx="271">
                  <c:v>60</c:v>
                </c:pt>
                <c:pt idx="272">
                  <c:v>59.5</c:v>
                </c:pt>
                <c:pt idx="273">
                  <c:v>59</c:v>
                </c:pt>
                <c:pt idx="274">
                  <c:v>58.5</c:v>
                </c:pt>
                <c:pt idx="275">
                  <c:v>58</c:v>
                </c:pt>
                <c:pt idx="276">
                  <c:v>57.5</c:v>
                </c:pt>
                <c:pt idx="277">
                  <c:v>57</c:v>
                </c:pt>
                <c:pt idx="278">
                  <c:v>56.731000000000002</c:v>
                </c:pt>
                <c:pt idx="279">
                  <c:v>56.5</c:v>
                </c:pt>
                <c:pt idx="280">
                  <c:v>56</c:v>
                </c:pt>
                <c:pt idx="281">
                  <c:v>55.5</c:v>
                </c:pt>
                <c:pt idx="282">
                  <c:v>55</c:v>
                </c:pt>
                <c:pt idx="283">
                  <c:v>54.5</c:v>
                </c:pt>
                <c:pt idx="284">
                  <c:v>54</c:v>
                </c:pt>
                <c:pt idx="285">
                  <c:v>53.5</c:v>
                </c:pt>
                <c:pt idx="286">
                  <c:v>53</c:v>
                </c:pt>
                <c:pt idx="287">
                  <c:v>52.5</c:v>
                </c:pt>
                <c:pt idx="288">
                  <c:v>52</c:v>
                </c:pt>
                <c:pt idx="289">
                  <c:v>51.5</c:v>
                </c:pt>
                <c:pt idx="290">
                  <c:v>51</c:v>
                </c:pt>
                <c:pt idx="291">
                  <c:v>50.5</c:v>
                </c:pt>
                <c:pt idx="292">
                  <c:v>50</c:v>
                </c:pt>
                <c:pt idx="293">
                  <c:v>49.5</c:v>
                </c:pt>
                <c:pt idx="294">
                  <c:v>49</c:v>
                </c:pt>
                <c:pt idx="295">
                  <c:v>48.5</c:v>
                </c:pt>
                <c:pt idx="296">
                  <c:v>48</c:v>
                </c:pt>
                <c:pt idx="297">
                  <c:v>47.5</c:v>
                </c:pt>
                <c:pt idx="298">
                  <c:v>47</c:v>
                </c:pt>
                <c:pt idx="299">
                  <c:v>46.5</c:v>
                </c:pt>
                <c:pt idx="300">
                  <c:v>46</c:v>
                </c:pt>
                <c:pt idx="301">
                  <c:v>45.5</c:v>
                </c:pt>
                <c:pt idx="302">
                  <c:v>45.326000000000001</c:v>
                </c:pt>
                <c:pt idx="303">
                  <c:v>45</c:v>
                </c:pt>
                <c:pt idx="304">
                  <c:v>44.5</c:v>
                </c:pt>
                <c:pt idx="305">
                  <c:v>44</c:v>
                </c:pt>
                <c:pt idx="306">
                  <c:v>43.5</c:v>
                </c:pt>
                <c:pt idx="307">
                  <c:v>43</c:v>
                </c:pt>
                <c:pt idx="308">
                  <c:v>42.5</c:v>
                </c:pt>
                <c:pt idx="309">
                  <c:v>42</c:v>
                </c:pt>
                <c:pt idx="310">
                  <c:v>41.5</c:v>
                </c:pt>
                <c:pt idx="311">
                  <c:v>41</c:v>
                </c:pt>
                <c:pt idx="312">
                  <c:v>40.5</c:v>
                </c:pt>
                <c:pt idx="313">
                  <c:v>40</c:v>
                </c:pt>
                <c:pt idx="314">
                  <c:v>39.5</c:v>
                </c:pt>
                <c:pt idx="315">
                  <c:v>39</c:v>
                </c:pt>
                <c:pt idx="316">
                  <c:v>38.5</c:v>
                </c:pt>
                <c:pt idx="317">
                  <c:v>38</c:v>
                </c:pt>
                <c:pt idx="318">
                  <c:v>37.5</c:v>
                </c:pt>
                <c:pt idx="319">
                  <c:v>37</c:v>
                </c:pt>
                <c:pt idx="320">
                  <c:v>36.5</c:v>
                </c:pt>
                <c:pt idx="321">
                  <c:v>36</c:v>
                </c:pt>
                <c:pt idx="322">
                  <c:v>35.5</c:v>
                </c:pt>
                <c:pt idx="323">
                  <c:v>35</c:v>
                </c:pt>
                <c:pt idx="324">
                  <c:v>34.5</c:v>
                </c:pt>
                <c:pt idx="325">
                  <c:v>34</c:v>
                </c:pt>
                <c:pt idx="326">
                  <c:v>33.5</c:v>
                </c:pt>
                <c:pt idx="327">
                  <c:v>33</c:v>
                </c:pt>
                <c:pt idx="328">
                  <c:v>32.939</c:v>
                </c:pt>
                <c:pt idx="329">
                  <c:v>32.5</c:v>
                </c:pt>
                <c:pt idx="330">
                  <c:v>32</c:v>
                </c:pt>
                <c:pt idx="331">
                  <c:v>31.5</c:v>
                </c:pt>
                <c:pt idx="332">
                  <c:v>31</c:v>
                </c:pt>
                <c:pt idx="333">
                  <c:v>30.5</c:v>
                </c:pt>
                <c:pt idx="334">
                  <c:v>30</c:v>
                </c:pt>
                <c:pt idx="335">
                  <c:v>29.5</c:v>
                </c:pt>
                <c:pt idx="336">
                  <c:v>29</c:v>
                </c:pt>
                <c:pt idx="337">
                  <c:v>28.5</c:v>
                </c:pt>
                <c:pt idx="338">
                  <c:v>28</c:v>
                </c:pt>
                <c:pt idx="339">
                  <c:v>27.5</c:v>
                </c:pt>
                <c:pt idx="340">
                  <c:v>27</c:v>
                </c:pt>
                <c:pt idx="341">
                  <c:v>26.5</c:v>
                </c:pt>
                <c:pt idx="342">
                  <c:v>26</c:v>
                </c:pt>
                <c:pt idx="343">
                  <c:v>25.5</c:v>
                </c:pt>
                <c:pt idx="344">
                  <c:v>25</c:v>
                </c:pt>
                <c:pt idx="345">
                  <c:v>24.5</c:v>
                </c:pt>
                <c:pt idx="346">
                  <c:v>24</c:v>
                </c:pt>
                <c:pt idx="347">
                  <c:v>23.5</c:v>
                </c:pt>
                <c:pt idx="348">
                  <c:v>23.206</c:v>
                </c:pt>
                <c:pt idx="349">
                  <c:v>23</c:v>
                </c:pt>
                <c:pt idx="350">
                  <c:v>22.5</c:v>
                </c:pt>
                <c:pt idx="351">
                  <c:v>22</c:v>
                </c:pt>
                <c:pt idx="352">
                  <c:v>21.5</c:v>
                </c:pt>
                <c:pt idx="353">
                  <c:v>21</c:v>
                </c:pt>
                <c:pt idx="354">
                  <c:v>20.5</c:v>
                </c:pt>
                <c:pt idx="355">
                  <c:v>20</c:v>
                </c:pt>
                <c:pt idx="356">
                  <c:v>19.5</c:v>
                </c:pt>
                <c:pt idx="357">
                  <c:v>19</c:v>
                </c:pt>
                <c:pt idx="358">
                  <c:v>18.5</c:v>
                </c:pt>
                <c:pt idx="359">
                  <c:v>18</c:v>
                </c:pt>
                <c:pt idx="360">
                  <c:v>17.5</c:v>
                </c:pt>
                <c:pt idx="361">
                  <c:v>17</c:v>
                </c:pt>
                <c:pt idx="362">
                  <c:v>16.5</c:v>
                </c:pt>
                <c:pt idx="363">
                  <c:v>16</c:v>
                </c:pt>
                <c:pt idx="364">
                  <c:v>15.5</c:v>
                </c:pt>
                <c:pt idx="365">
                  <c:v>15</c:v>
                </c:pt>
                <c:pt idx="366">
                  <c:v>14.5</c:v>
                </c:pt>
                <c:pt idx="367">
                  <c:v>14</c:v>
                </c:pt>
                <c:pt idx="368">
                  <c:v>13.5</c:v>
                </c:pt>
                <c:pt idx="369">
                  <c:v>13.313000000000001</c:v>
                </c:pt>
                <c:pt idx="370">
                  <c:v>13</c:v>
                </c:pt>
                <c:pt idx="371">
                  <c:v>12.5</c:v>
                </c:pt>
                <c:pt idx="372">
                  <c:v>12</c:v>
                </c:pt>
                <c:pt idx="373">
                  <c:v>11.5</c:v>
                </c:pt>
                <c:pt idx="374">
                  <c:v>11</c:v>
                </c:pt>
                <c:pt idx="375">
                  <c:v>10.5</c:v>
                </c:pt>
                <c:pt idx="376">
                  <c:v>10</c:v>
                </c:pt>
                <c:pt idx="377">
                  <c:v>9.5</c:v>
                </c:pt>
                <c:pt idx="378">
                  <c:v>9</c:v>
                </c:pt>
                <c:pt idx="379">
                  <c:v>8.5</c:v>
                </c:pt>
                <c:pt idx="380">
                  <c:v>8</c:v>
                </c:pt>
                <c:pt idx="381">
                  <c:v>7.7320000000000002</c:v>
                </c:pt>
                <c:pt idx="382">
                  <c:v>7.5</c:v>
                </c:pt>
                <c:pt idx="383">
                  <c:v>7</c:v>
                </c:pt>
                <c:pt idx="384">
                  <c:v>6.5</c:v>
                </c:pt>
                <c:pt idx="385">
                  <c:v>6</c:v>
                </c:pt>
                <c:pt idx="386">
                  <c:v>5.5</c:v>
                </c:pt>
                <c:pt idx="387">
                  <c:v>5</c:v>
                </c:pt>
                <c:pt idx="388">
                  <c:v>4.5</c:v>
                </c:pt>
                <c:pt idx="389">
                  <c:v>4</c:v>
                </c:pt>
                <c:pt idx="390">
                  <c:v>3.5</c:v>
                </c:pt>
                <c:pt idx="391">
                  <c:v>3</c:v>
                </c:pt>
                <c:pt idx="392">
                  <c:v>2.5</c:v>
                </c:pt>
                <c:pt idx="393">
                  <c:v>2.2429999999999999</c:v>
                </c:pt>
                <c:pt idx="394">
                  <c:v>2</c:v>
                </c:pt>
                <c:pt idx="395">
                  <c:v>1.5</c:v>
                </c:pt>
                <c:pt idx="396">
                  <c:v>1</c:v>
                </c:pt>
                <c:pt idx="397">
                  <c:v>0.88200000000000001</c:v>
                </c:pt>
                <c:pt idx="398">
                  <c:v>0.5</c:v>
                </c:pt>
                <c:pt idx="399">
                  <c:v>0.36099999999999999</c:v>
                </c:pt>
                <c:pt idx="400">
                  <c:v>0.14399999999999999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331-46BE-B50F-9AAB614B149E}"/>
            </c:ext>
          </c:extLst>
        </c:ser>
        <c:ser>
          <c:idx val="5"/>
          <c:order val="5"/>
          <c:tx>
            <c:strRef>
              <c:f>Foglio6!$K$1</c:f>
              <c:strCache>
                <c:ptCount val="1"/>
                <c:pt idx="0">
                  <c:v>S1,0M8</c:v>
                </c:pt>
              </c:strCache>
            </c:strRef>
          </c:tx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K$5:$K$418</c:f>
              <c:numCache>
                <c:formatCode>General</c:formatCode>
                <c:ptCount val="414"/>
                <c:pt idx="0">
                  <c:v>0</c:v>
                </c:pt>
                <c:pt idx="1">
                  <c:v>8.5220000000000002</c:v>
                </c:pt>
                <c:pt idx="2">
                  <c:v>17.045000000000002</c:v>
                </c:pt>
                <c:pt idx="3">
                  <c:v>25.567</c:v>
                </c:pt>
                <c:pt idx="4">
                  <c:v>34.090000000000003</c:v>
                </c:pt>
                <c:pt idx="5">
                  <c:v>42.612000000000002</c:v>
                </c:pt>
                <c:pt idx="6">
                  <c:v>51.134</c:v>
                </c:pt>
                <c:pt idx="7">
                  <c:v>59.656999999999996</c:v>
                </c:pt>
                <c:pt idx="8">
                  <c:v>68.179000000000002</c:v>
                </c:pt>
                <c:pt idx="9">
                  <c:v>76.700999999999993</c:v>
                </c:pt>
                <c:pt idx="10">
                  <c:v>85.224000000000004</c:v>
                </c:pt>
                <c:pt idx="11">
                  <c:v>93.745999999999995</c:v>
                </c:pt>
                <c:pt idx="12">
                  <c:v>102.26900000000001</c:v>
                </c:pt>
                <c:pt idx="13">
                  <c:v>110.791</c:v>
                </c:pt>
                <c:pt idx="14">
                  <c:v>119.313</c:v>
                </c:pt>
                <c:pt idx="15">
                  <c:v>127.836</c:v>
                </c:pt>
                <c:pt idx="16">
                  <c:v>136.358</c:v>
                </c:pt>
                <c:pt idx="17">
                  <c:v>144.88</c:v>
                </c:pt>
                <c:pt idx="18">
                  <c:v>153.40299999999999</c:v>
                </c:pt>
                <c:pt idx="19">
                  <c:v>161.92500000000001</c:v>
                </c:pt>
                <c:pt idx="20">
                  <c:v>170.44800000000001</c:v>
                </c:pt>
                <c:pt idx="21">
                  <c:v>178.97</c:v>
                </c:pt>
                <c:pt idx="22">
                  <c:v>187.49199999999999</c:v>
                </c:pt>
                <c:pt idx="23">
                  <c:v>196.01499999999999</c:v>
                </c:pt>
                <c:pt idx="24">
                  <c:v>204.53700000000001</c:v>
                </c:pt>
                <c:pt idx="25">
                  <c:v>213.06</c:v>
                </c:pt>
                <c:pt idx="26">
                  <c:v>221.58199999999999</c:v>
                </c:pt>
                <c:pt idx="27">
                  <c:v>230.10400000000001</c:v>
                </c:pt>
                <c:pt idx="28">
                  <c:v>238.62700000000001</c:v>
                </c:pt>
                <c:pt idx="29">
                  <c:v>247.149</c:v>
                </c:pt>
                <c:pt idx="30">
                  <c:v>255.67099999999999</c:v>
                </c:pt>
                <c:pt idx="31">
                  <c:v>264.19400000000002</c:v>
                </c:pt>
                <c:pt idx="32">
                  <c:v>272.71600000000001</c:v>
                </c:pt>
                <c:pt idx="33">
                  <c:v>281.23899999999998</c:v>
                </c:pt>
                <c:pt idx="34">
                  <c:v>289.76100000000002</c:v>
                </c:pt>
                <c:pt idx="35">
                  <c:v>298.28300000000002</c:v>
                </c:pt>
                <c:pt idx="36">
                  <c:v>306.80599999999998</c:v>
                </c:pt>
                <c:pt idx="37">
                  <c:v>315.32799999999997</c:v>
                </c:pt>
                <c:pt idx="38">
                  <c:v>323.851</c:v>
                </c:pt>
                <c:pt idx="39">
                  <c:v>332.37299999999999</c:v>
                </c:pt>
                <c:pt idx="40">
                  <c:v>340.89499999999998</c:v>
                </c:pt>
                <c:pt idx="41">
                  <c:v>349.41800000000001</c:v>
                </c:pt>
                <c:pt idx="42">
                  <c:v>357.94</c:v>
                </c:pt>
                <c:pt idx="43">
                  <c:v>366.46199999999999</c:v>
                </c:pt>
                <c:pt idx="44">
                  <c:v>374.98500000000001</c:v>
                </c:pt>
                <c:pt idx="45">
                  <c:v>383.50700000000001</c:v>
                </c:pt>
                <c:pt idx="46">
                  <c:v>392.03</c:v>
                </c:pt>
                <c:pt idx="47">
                  <c:v>400.55200000000002</c:v>
                </c:pt>
                <c:pt idx="48">
                  <c:v>409.07400000000001</c:v>
                </c:pt>
                <c:pt idx="49">
                  <c:v>417.59699999999998</c:v>
                </c:pt>
                <c:pt idx="50">
                  <c:v>426.11900000000003</c:v>
                </c:pt>
                <c:pt idx="51">
                  <c:v>434.64100000000002</c:v>
                </c:pt>
                <c:pt idx="52">
                  <c:v>443.16399999999999</c:v>
                </c:pt>
                <c:pt idx="53">
                  <c:v>451.68599999999998</c:v>
                </c:pt>
                <c:pt idx="54">
                  <c:v>460.209</c:v>
                </c:pt>
                <c:pt idx="55">
                  <c:v>468.73099999999999</c:v>
                </c:pt>
                <c:pt idx="56">
                  <c:v>477.25299999999999</c:v>
                </c:pt>
                <c:pt idx="57">
                  <c:v>485.77600000000001</c:v>
                </c:pt>
                <c:pt idx="58">
                  <c:v>494.298</c:v>
                </c:pt>
                <c:pt idx="59">
                  <c:v>502.82100000000003</c:v>
                </c:pt>
                <c:pt idx="60">
                  <c:v>511.34300000000002</c:v>
                </c:pt>
                <c:pt idx="61">
                  <c:v>519.86500000000001</c:v>
                </c:pt>
                <c:pt idx="62">
                  <c:v>528.38800000000003</c:v>
                </c:pt>
                <c:pt idx="63">
                  <c:v>536.91</c:v>
                </c:pt>
                <c:pt idx="64">
                  <c:v>545.43200000000002</c:v>
                </c:pt>
                <c:pt idx="65">
                  <c:v>553.95500000000004</c:v>
                </c:pt>
                <c:pt idx="66">
                  <c:v>562.47699999999998</c:v>
                </c:pt>
                <c:pt idx="67">
                  <c:v>571</c:v>
                </c:pt>
                <c:pt idx="68">
                  <c:v>579.52200000000005</c:v>
                </c:pt>
                <c:pt idx="69">
                  <c:v>588.04399999999998</c:v>
                </c:pt>
                <c:pt idx="70">
                  <c:v>596.56700000000001</c:v>
                </c:pt>
                <c:pt idx="71">
                  <c:v>605.08900000000006</c:v>
                </c:pt>
                <c:pt idx="72">
                  <c:v>613.61199999999997</c:v>
                </c:pt>
                <c:pt idx="73">
                  <c:v>622.13400000000001</c:v>
                </c:pt>
                <c:pt idx="74">
                  <c:v>630.65599999999995</c:v>
                </c:pt>
                <c:pt idx="75">
                  <c:v>639.17899999999997</c:v>
                </c:pt>
                <c:pt idx="76">
                  <c:v>647.70100000000002</c:v>
                </c:pt>
                <c:pt idx="77">
                  <c:v>656.22299999999996</c:v>
                </c:pt>
                <c:pt idx="78">
                  <c:v>664.74599999999998</c:v>
                </c:pt>
                <c:pt idx="79">
                  <c:v>673.26800000000003</c:v>
                </c:pt>
                <c:pt idx="80">
                  <c:v>681.79100000000005</c:v>
                </c:pt>
                <c:pt idx="81">
                  <c:v>690.31299999999999</c:v>
                </c:pt>
                <c:pt idx="82">
                  <c:v>698.83500000000004</c:v>
                </c:pt>
                <c:pt idx="83">
                  <c:v>707.35799999999995</c:v>
                </c:pt>
                <c:pt idx="84">
                  <c:v>715.88</c:v>
                </c:pt>
                <c:pt idx="85">
                  <c:v>724.40200000000004</c:v>
                </c:pt>
                <c:pt idx="86">
                  <c:v>732.92499999999995</c:v>
                </c:pt>
                <c:pt idx="87">
                  <c:v>741.447</c:v>
                </c:pt>
                <c:pt idx="88">
                  <c:v>749.97</c:v>
                </c:pt>
                <c:pt idx="89">
                  <c:v>758.49199999999996</c:v>
                </c:pt>
                <c:pt idx="90">
                  <c:v>767.01400000000001</c:v>
                </c:pt>
                <c:pt idx="91">
                  <c:v>775.53700000000003</c:v>
                </c:pt>
                <c:pt idx="92">
                  <c:v>784.05899999999997</c:v>
                </c:pt>
                <c:pt idx="93">
                  <c:v>792.58199999999999</c:v>
                </c:pt>
                <c:pt idx="94">
                  <c:v>801.10400000000004</c:v>
                </c:pt>
                <c:pt idx="95">
                  <c:v>809.62599999999998</c:v>
                </c:pt>
                <c:pt idx="96">
                  <c:v>818.149</c:v>
                </c:pt>
                <c:pt idx="97">
                  <c:v>826.67100000000005</c:v>
                </c:pt>
                <c:pt idx="98">
                  <c:v>835.19299999999998</c:v>
                </c:pt>
                <c:pt idx="99">
                  <c:v>843.71600000000001</c:v>
                </c:pt>
                <c:pt idx="100">
                  <c:v>852.23800000000006</c:v>
                </c:pt>
                <c:pt idx="101">
                  <c:v>860.76099999999997</c:v>
                </c:pt>
                <c:pt idx="102">
                  <c:v>869.28300000000002</c:v>
                </c:pt>
                <c:pt idx="103">
                  <c:v>877.80499999999995</c:v>
                </c:pt>
                <c:pt idx="104">
                  <c:v>886.32799999999997</c:v>
                </c:pt>
                <c:pt idx="105">
                  <c:v>894.85</c:v>
                </c:pt>
                <c:pt idx="106">
                  <c:v>903.37300000000005</c:v>
                </c:pt>
                <c:pt idx="107">
                  <c:v>911.89499999999998</c:v>
                </c:pt>
                <c:pt idx="108">
                  <c:v>920.41700000000003</c:v>
                </c:pt>
                <c:pt idx="109">
                  <c:v>928.94</c:v>
                </c:pt>
                <c:pt idx="110">
                  <c:v>937.46199999999999</c:v>
                </c:pt>
                <c:pt idx="111">
                  <c:v>945.98400000000004</c:v>
                </c:pt>
                <c:pt idx="112">
                  <c:v>954.50699999999995</c:v>
                </c:pt>
                <c:pt idx="113">
                  <c:v>963.029</c:v>
                </c:pt>
                <c:pt idx="114">
                  <c:v>971.55200000000002</c:v>
                </c:pt>
                <c:pt idx="115">
                  <c:v>980.07399999999996</c:v>
                </c:pt>
                <c:pt idx="116">
                  <c:v>988.596</c:v>
                </c:pt>
                <c:pt idx="117">
                  <c:v>997.11900000000003</c:v>
                </c:pt>
                <c:pt idx="118">
                  <c:v>1005.641</c:v>
                </c:pt>
                <c:pt idx="119">
                  <c:v>1014.163</c:v>
                </c:pt>
                <c:pt idx="120">
                  <c:v>1022.686</c:v>
                </c:pt>
                <c:pt idx="121">
                  <c:v>1031.2080000000001</c:v>
                </c:pt>
                <c:pt idx="122">
                  <c:v>1039.731</c:v>
                </c:pt>
                <c:pt idx="123">
                  <c:v>1048.2529999999999</c:v>
                </c:pt>
                <c:pt idx="124">
                  <c:v>1056.7750000000001</c:v>
                </c:pt>
                <c:pt idx="125">
                  <c:v>1065.298</c:v>
                </c:pt>
                <c:pt idx="126">
                  <c:v>1073.82</c:v>
                </c:pt>
                <c:pt idx="127">
                  <c:v>1082.3430000000001</c:v>
                </c:pt>
                <c:pt idx="128">
                  <c:v>1090.865</c:v>
                </c:pt>
                <c:pt idx="129">
                  <c:v>1099.3869999999999</c:v>
                </c:pt>
                <c:pt idx="130">
                  <c:v>1107.9100000000001</c:v>
                </c:pt>
                <c:pt idx="131">
                  <c:v>1116.432</c:v>
                </c:pt>
                <c:pt idx="132">
                  <c:v>1124.954</c:v>
                </c:pt>
                <c:pt idx="133">
                  <c:v>1133.4770000000001</c:v>
                </c:pt>
                <c:pt idx="134">
                  <c:v>1141.999</c:v>
                </c:pt>
                <c:pt idx="135">
                  <c:v>1150.5219999999999</c:v>
                </c:pt>
                <c:pt idx="136">
                  <c:v>1159.0440000000001</c:v>
                </c:pt>
                <c:pt idx="137">
                  <c:v>1167.566</c:v>
                </c:pt>
                <c:pt idx="138">
                  <c:v>1176.0889999999999</c:v>
                </c:pt>
                <c:pt idx="139">
                  <c:v>1184.6110000000001</c:v>
                </c:pt>
                <c:pt idx="140">
                  <c:v>1193.134</c:v>
                </c:pt>
                <c:pt idx="141">
                  <c:v>1201.6559999999999</c:v>
                </c:pt>
                <c:pt idx="142">
                  <c:v>1210.1780000000001</c:v>
                </c:pt>
                <c:pt idx="143">
                  <c:v>1218.701</c:v>
                </c:pt>
                <c:pt idx="144">
                  <c:v>1227.223</c:v>
                </c:pt>
                <c:pt idx="145">
                  <c:v>1235.7449999999999</c:v>
                </c:pt>
                <c:pt idx="146">
                  <c:v>1244.268</c:v>
                </c:pt>
                <c:pt idx="147">
                  <c:v>1252.79</c:v>
                </c:pt>
                <c:pt idx="148">
                  <c:v>1261.3130000000001</c:v>
                </c:pt>
                <c:pt idx="149">
                  <c:v>1269.835</c:v>
                </c:pt>
                <c:pt idx="150">
                  <c:v>1278.357</c:v>
                </c:pt>
                <c:pt idx="151">
                  <c:v>1286.8800000000001</c:v>
                </c:pt>
                <c:pt idx="152">
                  <c:v>1295.402</c:v>
                </c:pt>
                <c:pt idx="153">
                  <c:v>1303.924</c:v>
                </c:pt>
                <c:pt idx="154">
                  <c:v>1312.4469999999999</c:v>
                </c:pt>
                <c:pt idx="155">
                  <c:v>1320.9690000000001</c:v>
                </c:pt>
                <c:pt idx="156">
                  <c:v>1329.492</c:v>
                </c:pt>
                <c:pt idx="157">
                  <c:v>1338.0139999999999</c:v>
                </c:pt>
                <c:pt idx="158">
                  <c:v>1346.5360000000001</c:v>
                </c:pt>
                <c:pt idx="159">
                  <c:v>1355.059</c:v>
                </c:pt>
                <c:pt idx="160">
                  <c:v>1363.5809999999999</c:v>
                </c:pt>
                <c:pt idx="161">
                  <c:v>1372.104</c:v>
                </c:pt>
                <c:pt idx="162">
                  <c:v>1380.626</c:v>
                </c:pt>
                <c:pt idx="163">
                  <c:v>1389.1479999999999</c:v>
                </c:pt>
                <c:pt idx="164">
                  <c:v>1397.671</c:v>
                </c:pt>
                <c:pt idx="165">
                  <c:v>1406.193</c:v>
                </c:pt>
                <c:pt idx="166">
                  <c:v>1414.7149999999999</c:v>
                </c:pt>
                <c:pt idx="167">
                  <c:v>1423.2380000000001</c:v>
                </c:pt>
                <c:pt idx="168">
                  <c:v>1431.76</c:v>
                </c:pt>
                <c:pt idx="169">
                  <c:v>1440.2829999999999</c:v>
                </c:pt>
                <c:pt idx="170">
                  <c:v>1448.8050000000001</c:v>
                </c:pt>
                <c:pt idx="171">
                  <c:v>1451.249</c:v>
                </c:pt>
                <c:pt idx="172">
                  <c:v>1457.327</c:v>
                </c:pt>
                <c:pt idx="173">
                  <c:v>1465.85</c:v>
                </c:pt>
                <c:pt idx="174">
                  <c:v>1474.3720000000001</c:v>
                </c:pt>
                <c:pt idx="175">
                  <c:v>1482.895</c:v>
                </c:pt>
                <c:pt idx="176">
                  <c:v>1486.6769999999999</c:v>
                </c:pt>
                <c:pt idx="177">
                  <c:v>1491.4169999999999</c:v>
                </c:pt>
                <c:pt idx="178">
                  <c:v>1499.9390000000001</c:v>
                </c:pt>
                <c:pt idx="179">
                  <c:v>1500</c:v>
                </c:pt>
                <c:pt idx="180">
                  <c:v>1508.462</c:v>
                </c:pt>
                <c:pt idx="181">
                  <c:v>1509.0260000000001</c:v>
                </c:pt>
                <c:pt idx="182">
                  <c:v>1512.5329999999999</c:v>
                </c:pt>
                <c:pt idx="183">
                  <c:v>1514.3820000000001</c:v>
                </c:pt>
                <c:pt idx="184">
                  <c:v>1516.9839999999999</c:v>
                </c:pt>
                <c:pt idx="185">
                  <c:v>1517.585</c:v>
                </c:pt>
                <c:pt idx="186">
                  <c:v>1518.3130000000001</c:v>
                </c:pt>
                <c:pt idx="187">
                  <c:v>1520.6479999999999</c:v>
                </c:pt>
                <c:pt idx="188">
                  <c:v>1522.9860000000001</c:v>
                </c:pt>
                <c:pt idx="189">
                  <c:v>1524.1890000000001</c:v>
                </c:pt>
                <c:pt idx="190">
                  <c:v>1525.5060000000001</c:v>
                </c:pt>
                <c:pt idx="191">
                  <c:v>1527.0509999999999</c:v>
                </c:pt>
                <c:pt idx="192">
                  <c:v>1528.876</c:v>
                </c:pt>
                <c:pt idx="193">
                  <c:v>1531.7950000000001</c:v>
                </c:pt>
                <c:pt idx="194">
                  <c:v>1534.029</c:v>
                </c:pt>
                <c:pt idx="195">
                  <c:v>1534.575</c:v>
                </c:pt>
                <c:pt idx="196">
                  <c:v>1535.3630000000001</c:v>
                </c:pt>
                <c:pt idx="197">
                  <c:v>1536.3579999999999</c:v>
                </c:pt>
                <c:pt idx="198">
                  <c:v>1538.394</c:v>
                </c:pt>
                <c:pt idx="199">
                  <c:v>1541.5409999999999</c:v>
                </c:pt>
                <c:pt idx="200">
                  <c:v>1542.5509999999999</c:v>
                </c:pt>
                <c:pt idx="201">
                  <c:v>1542.829</c:v>
                </c:pt>
                <c:pt idx="202">
                  <c:v>1543.577</c:v>
                </c:pt>
                <c:pt idx="203">
                  <c:v>1543.99</c:v>
                </c:pt>
                <c:pt idx="204">
                  <c:v>1545.56</c:v>
                </c:pt>
                <c:pt idx="205">
                  <c:v>1547.777</c:v>
                </c:pt>
                <c:pt idx="206">
                  <c:v>1549.662</c:v>
                </c:pt>
                <c:pt idx="207">
                  <c:v>1551.0740000000001</c:v>
                </c:pt>
                <c:pt idx="208">
                  <c:v>1551.2460000000001</c:v>
                </c:pt>
                <c:pt idx="209">
                  <c:v>1551.509</c:v>
                </c:pt>
                <c:pt idx="210">
                  <c:v>1552.4949999999999</c:v>
                </c:pt>
                <c:pt idx="211">
                  <c:v>1554.069</c:v>
                </c:pt>
                <c:pt idx="212">
                  <c:v>1554.473</c:v>
                </c:pt>
                <c:pt idx="213">
                  <c:v>1555.431</c:v>
                </c:pt>
                <c:pt idx="214">
                  <c:v>1556.2850000000001</c:v>
                </c:pt>
                <c:pt idx="215">
                  <c:v>1557.02</c:v>
                </c:pt>
                <c:pt idx="216">
                  <c:v>1557.7460000000001</c:v>
                </c:pt>
                <c:pt idx="217">
                  <c:v>1559.001</c:v>
                </c:pt>
                <c:pt idx="218">
                  <c:v>1559.596</c:v>
                </c:pt>
                <c:pt idx="219">
                  <c:v>1559.701</c:v>
                </c:pt>
                <c:pt idx="220">
                  <c:v>1559.9380000000001</c:v>
                </c:pt>
                <c:pt idx="221">
                  <c:v>1561.5630000000001</c:v>
                </c:pt>
                <c:pt idx="222">
                  <c:v>1563.4390000000001</c:v>
                </c:pt>
                <c:pt idx="223">
                  <c:v>1564.4739999999999</c:v>
                </c:pt>
                <c:pt idx="224">
                  <c:v>1565.0619999999999</c:v>
                </c:pt>
                <c:pt idx="225">
                  <c:v>1565.7560000000001</c:v>
                </c:pt>
                <c:pt idx="226">
                  <c:v>1566.0119999999999</c:v>
                </c:pt>
                <c:pt idx="227">
                  <c:v>1566.5930000000001</c:v>
                </c:pt>
                <c:pt idx="228">
                  <c:v>1567.894</c:v>
                </c:pt>
                <c:pt idx="229">
                  <c:v>1568.1179999999999</c:v>
                </c:pt>
                <c:pt idx="230">
                  <c:v>1568.682</c:v>
                </c:pt>
                <c:pt idx="231">
                  <c:v>1568.9069999999999</c:v>
                </c:pt>
                <c:pt idx="232">
                  <c:v>1569.068</c:v>
                </c:pt>
                <c:pt idx="233">
                  <c:v>1569.3630000000001</c:v>
                </c:pt>
                <c:pt idx="234">
                  <c:v>1569.8710000000001</c:v>
                </c:pt>
                <c:pt idx="235">
                  <c:v>1570.326</c:v>
                </c:pt>
                <c:pt idx="236">
                  <c:v>1571.7840000000001</c:v>
                </c:pt>
                <c:pt idx="237">
                  <c:v>1572.7249999999999</c:v>
                </c:pt>
                <c:pt idx="238">
                  <c:v>1573.9760000000001</c:v>
                </c:pt>
                <c:pt idx="239">
                  <c:v>1575.1869999999999</c:v>
                </c:pt>
                <c:pt idx="240">
                  <c:v>1575.616</c:v>
                </c:pt>
                <c:pt idx="241">
                  <c:v>1576.039</c:v>
                </c:pt>
                <c:pt idx="242">
                  <c:v>1576.568</c:v>
                </c:pt>
                <c:pt idx="243">
                  <c:v>1576.6410000000001</c:v>
                </c:pt>
                <c:pt idx="244">
                  <c:v>1577.5340000000001</c:v>
                </c:pt>
                <c:pt idx="245">
                  <c:v>1578.0250000000001</c:v>
                </c:pt>
                <c:pt idx="246">
                  <c:v>1578.9939999999999</c:v>
                </c:pt>
                <c:pt idx="247">
                  <c:v>1579.752</c:v>
                </c:pt>
                <c:pt idx="248">
                  <c:v>1579.9780000000001</c:v>
                </c:pt>
                <c:pt idx="249">
                  <c:v>1580.3</c:v>
                </c:pt>
                <c:pt idx="250">
                  <c:v>1581.2729999999999</c:v>
                </c:pt>
                <c:pt idx="251">
                  <c:v>1582.549</c:v>
                </c:pt>
                <c:pt idx="252">
                  <c:v>1582.703</c:v>
                </c:pt>
                <c:pt idx="253">
                  <c:v>1583.2090000000001</c:v>
                </c:pt>
                <c:pt idx="254">
                  <c:v>1583.5640000000001</c:v>
                </c:pt>
                <c:pt idx="255">
                  <c:v>1584.0160000000001</c:v>
                </c:pt>
                <c:pt idx="256">
                  <c:v>1584.7650000000001</c:v>
                </c:pt>
                <c:pt idx="257">
                  <c:v>1584.922</c:v>
                </c:pt>
                <c:pt idx="258">
                  <c:v>1585.163</c:v>
                </c:pt>
                <c:pt idx="259">
                  <c:v>1585.6669999999999</c:v>
                </c:pt>
                <c:pt idx="260">
                  <c:v>1587.6410000000001</c:v>
                </c:pt>
                <c:pt idx="261">
                  <c:v>1589.462</c:v>
                </c:pt>
                <c:pt idx="262">
                  <c:v>1589.6179999999999</c:v>
                </c:pt>
                <c:pt idx="263">
                  <c:v>1590.722</c:v>
                </c:pt>
                <c:pt idx="264">
                  <c:v>1592.1790000000001</c:v>
                </c:pt>
                <c:pt idx="265">
                  <c:v>1592.4449999999999</c:v>
                </c:pt>
                <c:pt idx="266">
                  <c:v>1592.7550000000001</c:v>
                </c:pt>
                <c:pt idx="267">
                  <c:v>1592.8779999999999</c:v>
                </c:pt>
                <c:pt idx="268">
                  <c:v>1593.471</c:v>
                </c:pt>
                <c:pt idx="269">
                  <c:v>1593.6849999999999</c:v>
                </c:pt>
                <c:pt idx="270">
                  <c:v>1593.981</c:v>
                </c:pt>
                <c:pt idx="271">
                  <c:v>1595.6189999999999</c:v>
                </c:pt>
                <c:pt idx="272">
                  <c:v>1596.1</c:v>
                </c:pt>
                <c:pt idx="273">
                  <c:v>1596.201</c:v>
                </c:pt>
                <c:pt idx="274">
                  <c:v>1596.5050000000001</c:v>
                </c:pt>
                <c:pt idx="275">
                  <c:v>1597.229</c:v>
                </c:pt>
                <c:pt idx="276">
                  <c:v>1597.4870000000001</c:v>
                </c:pt>
                <c:pt idx="277">
                  <c:v>1599.1489999999999</c:v>
                </c:pt>
                <c:pt idx="278">
                  <c:v>1599.95</c:v>
                </c:pt>
                <c:pt idx="279">
                  <c:v>1601.7719999999999</c:v>
                </c:pt>
                <c:pt idx="280">
                  <c:v>1601.8119999999999</c:v>
                </c:pt>
                <c:pt idx="281">
                  <c:v>1601.981</c:v>
                </c:pt>
                <c:pt idx="282">
                  <c:v>1602.2080000000001</c:v>
                </c:pt>
                <c:pt idx="283">
                  <c:v>1602.597</c:v>
                </c:pt>
                <c:pt idx="284">
                  <c:v>1603.4179999999999</c:v>
                </c:pt>
                <c:pt idx="285">
                  <c:v>1604.1120000000001</c:v>
                </c:pt>
                <c:pt idx="286">
                  <c:v>1604.386</c:v>
                </c:pt>
                <c:pt idx="287">
                  <c:v>1604.796</c:v>
                </c:pt>
                <c:pt idx="288">
                  <c:v>1605.1210000000001</c:v>
                </c:pt>
                <c:pt idx="289">
                  <c:v>1605.8689999999999</c:v>
                </c:pt>
                <c:pt idx="290">
                  <c:v>1606.329</c:v>
                </c:pt>
                <c:pt idx="291">
                  <c:v>1607.231</c:v>
                </c:pt>
                <c:pt idx="292">
                  <c:v>1607.3209999999999</c:v>
                </c:pt>
                <c:pt idx="293">
                  <c:v>1608.0029999999999</c:v>
                </c:pt>
                <c:pt idx="294">
                  <c:v>1608.345</c:v>
                </c:pt>
                <c:pt idx="295">
                  <c:v>1608.672</c:v>
                </c:pt>
                <c:pt idx="296">
                  <c:v>1609.307</c:v>
                </c:pt>
                <c:pt idx="297">
                  <c:v>1609.778</c:v>
                </c:pt>
                <c:pt idx="298">
                  <c:v>1610.0719999999999</c:v>
                </c:pt>
                <c:pt idx="299">
                  <c:v>1610.519</c:v>
                </c:pt>
                <c:pt idx="300">
                  <c:v>1610.73</c:v>
                </c:pt>
                <c:pt idx="301">
                  <c:v>1610.86</c:v>
                </c:pt>
                <c:pt idx="302">
                  <c:v>1611.55</c:v>
                </c:pt>
                <c:pt idx="303">
                  <c:v>1612.019</c:v>
                </c:pt>
                <c:pt idx="304">
                  <c:v>1613.95</c:v>
                </c:pt>
                <c:pt idx="305">
                  <c:v>1614.1790000000001</c:v>
                </c:pt>
                <c:pt idx="306">
                  <c:v>1614.829</c:v>
                </c:pt>
                <c:pt idx="307">
                  <c:v>1615.393</c:v>
                </c:pt>
                <c:pt idx="308">
                  <c:v>1615.7940000000001</c:v>
                </c:pt>
                <c:pt idx="309">
                  <c:v>1616.1110000000001</c:v>
                </c:pt>
                <c:pt idx="310">
                  <c:v>1616.748</c:v>
                </c:pt>
                <c:pt idx="311">
                  <c:v>1617.1289999999999</c:v>
                </c:pt>
                <c:pt idx="312">
                  <c:v>1617.356</c:v>
                </c:pt>
                <c:pt idx="313">
                  <c:v>1618.2349999999999</c:v>
                </c:pt>
                <c:pt idx="314">
                  <c:v>1618.7840000000001</c:v>
                </c:pt>
                <c:pt idx="315">
                  <c:v>1619.2529999999999</c:v>
                </c:pt>
                <c:pt idx="316">
                  <c:v>1619.31</c:v>
                </c:pt>
                <c:pt idx="317">
                  <c:v>1620.778</c:v>
                </c:pt>
                <c:pt idx="318">
                  <c:v>1621.6959999999999</c:v>
                </c:pt>
                <c:pt idx="319">
                  <c:v>1622.671</c:v>
                </c:pt>
                <c:pt idx="320">
                  <c:v>1624.039</c:v>
                </c:pt>
                <c:pt idx="321">
                  <c:v>1624.9639999999999</c:v>
                </c:pt>
                <c:pt idx="322">
                  <c:v>1626.261</c:v>
                </c:pt>
                <c:pt idx="323">
                  <c:v>1627.2080000000001</c:v>
                </c:pt>
                <c:pt idx="324">
                  <c:v>1627.7750000000001</c:v>
                </c:pt>
                <c:pt idx="325">
                  <c:v>1627.979</c:v>
                </c:pt>
                <c:pt idx="326">
                  <c:v>1628.559</c:v>
                </c:pt>
                <c:pt idx="327">
                  <c:v>1629.181</c:v>
                </c:pt>
                <c:pt idx="328">
                  <c:v>1629.8989999999999</c:v>
                </c:pt>
                <c:pt idx="329">
                  <c:v>1630.9770000000001</c:v>
                </c:pt>
                <c:pt idx="330">
                  <c:v>1631.441</c:v>
                </c:pt>
                <c:pt idx="331">
                  <c:v>1632.624</c:v>
                </c:pt>
                <c:pt idx="332">
                  <c:v>1632.973</c:v>
                </c:pt>
                <c:pt idx="333">
                  <c:v>1633.21</c:v>
                </c:pt>
                <c:pt idx="334">
                  <c:v>1634.2819999999999</c:v>
                </c:pt>
                <c:pt idx="335">
                  <c:v>1634.55</c:v>
                </c:pt>
                <c:pt idx="336">
                  <c:v>1635.3779999999999</c:v>
                </c:pt>
                <c:pt idx="337">
                  <c:v>1635.961</c:v>
                </c:pt>
                <c:pt idx="338">
                  <c:v>1636.297</c:v>
                </c:pt>
                <c:pt idx="339">
                  <c:v>1636.4670000000001</c:v>
                </c:pt>
                <c:pt idx="340">
                  <c:v>1636.854</c:v>
                </c:pt>
                <c:pt idx="341">
                  <c:v>1637.5360000000001</c:v>
                </c:pt>
                <c:pt idx="342">
                  <c:v>1638.231</c:v>
                </c:pt>
                <c:pt idx="343">
                  <c:v>1638.989</c:v>
                </c:pt>
                <c:pt idx="344">
                  <c:v>1639.4469999999999</c:v>
                </c:pt>
                <c:pt idx="345">
                  <c:v>1639.9970000000001</c:v>
                </c:pt>
                <c:pt idx="346">
                  <c:v>1640.5630000000001</c:v>
                </c:pt>
                <c:pt idx="347">
                  <c:v>1641.6489999999999</c:v>
                </c:pt>
                <c:pt idx="348">
                  <c:v>1642.104</c:v>
                </c:pt>
                <c:pt idx="349">
                  <c:v>1642.367</c:v>
                </c:pt>
                <c:pt idx="350">
                  <c:v>1642.5709999999999</c:v>
                </c:pt>
                <c:pt idx="351">
                  <c:v>1643.7370000000001</c:v>
                </c:pt>
                <c:pt idx="352">
                  <c:v>1644.49</c:v>
                </c:pt>
                <c:pt idx="353">
                  <c:v>1644.82</c:v>
                </c:pt>
                <c:pt idx="354">
                  <c:v>1644.8620000000001</c:v>
                </c:pt>
                <c:pt idx="355">
                  <c:v>1645.0940000000001</c:v>
                </c:pt>
                <c:pt idx="356">
                  <c:v>1645.7070000000001</c:v>
                </c:pt>
                <c:pt idx="357">
                  <c:v>1646.962</c:v>
                </c:pt>
                <c:pt idx="358">
                  <c:v>1648.018</c:v>
                </c:pt>
                <c:pt idx="359">
                  <c:v>1648.2159999999999</c:v>
                </c:pt>
                <c:pt idx="360">
                  <c:v>1648.403</c:v>
                </c:pt>
                <c:pt idx="361">
                  <c:v>1649.2449999999999</c:v>
                </c:pt>
                <c:pt idx="362">
                  <c:v>1649.828</c:v>
                </c:pt>
                <c:pt idx="363">
                  <c:v>1651.0260000000001</c:v>
                </c:pt>
                <c:pt idx="364">
                  <c:v>1651.5219999999999</c:v>
                </c:pt>
                <c:pt idx="365">
                  <c:v>1652.1610000000001</c:v>
                </c:pt>
                <c:pt idx="366">
                  <c:v>1652.4590000000001</c:v>
                </c:pt>
                <c:pt idx="367">
                  <c:v>1653.3420000000001</c:v>
                </c:pt>
                <c:pt idx="368">
                  <c:v>1653.5609999999999</c:v>
                </c:pt>
                <c:pt idx="369">
                  <c:v>1656.374</c:v>
                </c:pt>
                <c:pt idx="370">
                  <c:v>1657.6849999999999</c:v>
                </c:pt>
                <c:pt idx="371">
                  <c:v>1658.711</c:v>
                </c:pt>
                <c:pt idx="372">
                  <c:v>1659.6569999999999</c:v>
                </c:pt>
                <c:pt idx="373">
                  <c:v>1660.463</c:v>
                </c:pt>
                <c:pt idx="374">
                  <c:v>1661.865</c:v>
                </c:pt>
                <c:pt idx="375">
                  <c:v>1662.133</c:v>
                </c:pt>
                <c:pt idx="376">
                  <c:v>1664.07</c:v>
                </c:pt>
                <c:pt idx="377">
                  <c:v>1665.8510000000001</c:v>
                </c:pt>
                <c:pt idx="378">
                  <c:v>1666.42</c:v>
                </c:pt>
                <c:pt idx="379">
                  <c:v>1666.6679999999999</c:v>
                </c:pt>
                <c:pt idx="380">
                  <c:v>1667.5350000000001</c:v>
                </c:pt>
                <c:pt idx="381">
                  <c:v>1668.5429999999999</c:v>
                </c:pt>
                <c:pt idx="382">
                  <c:v>1669.049</c:v>
                </c:pt>
                <c:pt idx="383">
                  <c:v>1670.3869999999999</c:v>
                </c:pt>
                <c:pt idx="384">
                  <c:v>1671.1759999999999</c:v>
                </c:pt>
                <c:pt idx="385">
                  <c:v>1672.1869999999999</c:v>
                </c:pt>
                <c:pt idx="386">
                  <c:v>1673.732</c:v>
                </c:pt>
                <c:pt idx="387">
                  <c:v>1676.098</c:v>
                </c:pt>
                <c:pt idx="388">
                  <c:v>1677.2159999999999</c:v>
                </c:pt>
                <c:pt idx="389">
                  <c:v>1678.9090000000001</c:v>
                </c:pt>
                <c:pt idx="390">
                  <c:v>1678.9179999999999</c:v>
                </c:pt>
                <c:pt idx="391">
                  <c:v>1682.7750000000001</c:v>
                </c:pt>
                <c:pt idx="392">
                  <c:v>1684.617</c:v>
                </c:pt>
                <c:pt idx="393">
                  <c:v>1687.432</c:v>
                </c:pt>
                <c:pt idx="394">
                  <c:v>1687.99</c:v>
                </c:pt>
                <c:pt idx="395">
                  <c:v>1689.577</c:v>
                </c:pt>
                <c:pt idx="396">
                  <c:v>1692.2729999999999</c:v>
                </c:pt>
                <c:pt idx="397">
                  <c:v>1695.123</c:v>
                </c:pt>
                <c:pt idx="398">
                  <c:v>1695.954</c:v>
                </c:pt>
                <c:pt idx="399">
                  <c:v>1700.146</c:v>
                </c:pt>
                <c:pt idx="400">
                  <c:v>1704.4760000000001</c:v>
                </c:pt>
                <c:pt idx="401">
                  <c:v>1704.4760000000001</c:v>
                </c:pt>
              </c:numCache>
            </c:numRef>
          </c:xVal>
          <c:yVal>
            <c:numRef>
              <c:f>Foglio6!$L$5:$L$418</c:f>
              <c:numCache>
                <c:formatCode>General</c:formatCode>
                <c:ptCount val="414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100</c:v>
                </c:pt>
                <c:pt idx="162">
                  <c:v>100</c:v>
                </c:pt>
                <c:pt idx="163">
                  <c:v>100</c:v>
                </c:pt>
                <c:pt idx="164">
                  <c:v>100</c:v>
                </c:pt>
                <c:pt idx="165">
                  <c:v>100</c:v>
                </c:pt>
                <c:pt idx="166">
                  <c:v>100</c:v>
                </c:pt>
                <c:pt idx="167">
                  <c:v>100</c:v>
                </c:pt>
                <c:pt idx="168">
                  <c:v>100</c:v>
                </c:pt>
                <c:pt idx="169">
                  <c:v>100</c:v>
                </c:pt>
                <c:pt idx="170">
                  <c:v>100</c:v>
                </c:pt>
                <c:pt idx="171">
                  <c:v>100</c:v>
                </c:pt>
                <c:pt idx="172">
                  <c:v>99.981999999999999</c:v>
                </c:pt>
                <c:pt idx="173">
                  <c:v>99.858999999999995</c:v>
                </c:pt>
                <c:pt idx="174">
                  <c:v>99.632000000000005</c:v>
                </c:pt>
                <c:pt idx="175">
                  <c:v>99.53</c:v>
                </c:pt>
                <c:pt idx="176">
                  <c:v>99.5</c:v>
                </c:pt>
                <c:pt idx="177">
                  <c:v>99.343000000000004</c:v>
                </c:pt>
                <c:pt idx="178">
                  <c:v>99.003</c:v>
                </c:pt>
                <c:pt idx="179">
                  <c:v>99</c:v>
                </c:pt>
                <c:pt idx="180">
                  <c:v>98.52</c:v>
                </c:pt>
                <c:pt idx="181">
                  <c:v>98.5</c:v>
                </c:pt>
                <c:pt idx="182">
                  <c:v>98</c:v>
                </c:pt>
                <c:pt idx="183">
                  <c:v>97.5</c:v>
                </c:pt>
                <c:pt idx="184">
                  <c:v>97.224999999999994</c:v>
                </c:pt>
                <c:pt idx="185">
                  <c:v>97</c:v>
                </c:pt>
                <c:pt idx="186">
                  <c:v>96.5</c:v>
                </c:pt>
                <c:pt idx="187">
                  <c:v>96</c:v>
                </c:pt>
                <c:pt idx="188">
                  <c:v>95.5</c:v>
                </c:pt>
                <c:pt idx="189">
                  <c:v>95</c:v>
                </c:pt>
                <c:pt idx="190">
                  <c:v>94.763999999999996</c:v>
                </c:pt>
                <c:pt idx="191">
                  <c:v>94.5</c:v>
                </c:pt>
                <c:pt idx="192">
                  <c:v>94</c:v>
                </c:pt>
                <c:pt idx="193">
                  <c:v>93.5</c:v>
                </c:pt>
                <c:pt idx="194">
                  <c:v>93.302000000000007</c:v>
                </c:pt>
                <c:pt idx="195">
                  <c:v>93</c:v>
                </c:pt>
                <c:pt idx="196">
                  <c:v>92.5</c:v>
                </c:pt>
                <c:pt idx="197">
                  <c:v>92</c:v>
                </c:pt>
                <c:pt idx="198">
                  <c:v>91.5</c:v>
                </c:pt>
                <c:pt idx="199">
                  <c:v>91</c:v>
                </c:pt>
                <c:pt idx="200">
                  <c:v>90.6</c:v>
                </c:pt>
                <c:pt idx="201">
                  <c:v>90.5</c:v>
                </c:pt>
                <c:pt idx="202">
                  <c:v>90</c:v>
                </c:pt>
                <c:pt idx="203">
                  <c:v>89.5</c:v>
                </c:pt>
                <c:pt idx="204">
                  <c:v>89</c:v>
                </c:pt>
                <c:pt idx="205">
                  <c:v>88.5</c:v>
                </c:pt>
                <c:pt idx="206">
                  <c:v>88</c:v>
                </c:pt>
                <c:pt idx="207">
                  <c:v>87.570999999999998</c:v>
                </c:pt>
                <c:pt idx="208">
                  <c:v>87.5</c:v>
                </c:pt>
                <c:pt idx="209">
                  <c:v>87</c:v>
                </c:pt>
                <c:pt idx="210">
                  <c:v>86.5</c:v>
                </c:pt>
                <c:pt idx="211">
                  <c:v>86</c:v>
                </c:pt>
                <c:pt idx="212">
                  <c:v>85.5</c:v>
                </c:pt>
                <c:pt idx="213">
                  <c:v>85</c:v>
                </c:pt>
                <c:pt idx="214">
                  <c:v>84.5</c:v>
                </c:pt>
                <c:pt idx="215">
                  <c:v>84</c:v>
                </c:pt>
                <c:pt idx="216">
                  <c:v>83.5</c:v>
                </c:pt>
                <c:pt idx="217">
                  <c:v>83</c:v>
                </c:pt>
                <c:pt idx="218">
                  <c:v>82.616</c:v>
                </c:pt>
                <c:pt idx="219">
                  <c:v>82.5</c:v>
                </c:pt>
                <c:pt idx="220">
                  <c:v>82</c:v>
                </c:pt>
                <c:pt idx="221">
                  <c:v>81.5</c:v>
                </c:pt>
                <c:pt idx="222">
                  <c:v>81</c:v>
                </c:pt>
                <c:pt idx="223">
                  <c:v>80.5</c:v>
                </c:pt>
                <c:pt idx="224">
                  <c:v>80</c:v>
                </c:pt>
                <c:pt idx="225">
                  <c:v>79.5</c:v>
                </c:pt>
                <c:pt idx="226">
                  <c:v>79</c:v>
                </c:pt>
                <c:pt idx="227">
                  <c:v>78.5</c:v>
                </c:pt>
                <c:pt idx="228">
                  <c:v>78</c:v>
                </c:pt>
                <c:pt idx="229">
                  <c:v>77.852999999999994</c:v>
                </c:pt>
                <c:pt idx="230">
                  <c:v>77.5</c:v>
                </c:pt>
                <c:pt idx="231">
                  <c:v>77</c:v>
                </c:pt>
                <c:pt idx="232">
                  <c:v>76.5</c:v>
                </c:pt>
                <c:pt idx="233">
                  <c:v>76</c:v>
                </c:pt>
                <c:pt idx="234">
                  <c:v>75.5</c:v>
                </c:pt>
                <c:pt idx="235">
                  <c:v>75</c:v>
                </c:pt>
                <c:pt idx="236">
                  <c:v>74.5</c:v>
                </c:pt>
                <c:pt idx="237">
                  <c:v>74</c:v>
                </c:pt>
                <c:pt idx="238">
                  <c:v>73.5</c:v>
                </c:pt>
                <c:pt idx="239">
                  <c:v>73</c:v>
                </c:pt>
                <c:pt idx="240">
                  <c:v>72.5</c:v>
                </c:pt>
                <c:pt idx="241">
                  <c:v>72</c:v>
                </c:pt>
                <c:pt idx="242">
                  <c:v>71.5</c:v>
                </c:pt>
                <c:pt idx="243">
                  <c:v>71.462000000000003</c:v>
                </c:pt>
                <c:pt idx="244">
                  <c:v>71</c:v>
                </c:pt>
                <c:pt idx="245">
                  <c:v>70.5</c:v>
                </c:pt>
                <c:pt idx="246">
                  <c:v>70</c:v>
                </c:pt>
                <c:pt idx="247">
                  <c:v>69.5</c:v>
                </c:pt>
                <c:pt idx="248">
                  <c:v>69</c:v>
                </c:pt>
                <c:pt idx="249">
                  <c:v>68.5</c:v>
                </c:pt>
                <c:pt idx="250">
                  <c:v>68</c:v>
                </c:pt>
                <c:pt idx="251">
                  <c:v>67.5</c:v>
                </c:pt>
                <c:pt idx="252">
                  <c:v>67</c:v>
                </c:pt>
                <c:pt idx="253">
                  <c:v>66.5</c:v>
                </c:pt>
                <c:pt idx="254">
                  <c:v>66</c:v>
                </c:pt>
                <c:pt idx="255">
                  <c:v>65.5</c:v>
                </c:pt>
                <c:pt idx="256">
                  <c:v>65</c:v>
                </c:pt>
                <c:pt idx="257">
                  <c:v>64.5</c:v>
                </c:pt>
                <c:pt idx="258">
                  <c:v>64.234999999999999</c:v>
                </c:pt>
                <c:pt idx="259">
                  <c:v>64</c:v>
                </c:pt>
                <c:pt idx="260">
                  <c:v>63.5</c:v>
                </c:pt>
                <c:pt idx="261">
                  <c:v>63</c:v>
                </c:pt>
                <c:pt idx="262">
                  <c:v>62.5</c:v>
                </c:pt>
                <c:pt idx="263">
                  <c:v>62</c:v>
                </c:pt>
                <c:pt idx="264">
                  <c:v>61.5</c:v>
                </c:pt>
                <c:pt idx="265">
                  <c:v>61</c:v>
                </c:pt>
                <c:pt idx="266">
                  <c:v>60.5</c:v>
                </c:pt>
                <c:pt idx="267">
                  <c:v>60</c:v>
                </c:pt>
                <c:pt idx="268">
                  <c:v>59.5</c:v>
                </c:pt>
                <c:pt idx="269">
                  <c:v>59.363999999999997</c:v>
                </c:pt>
                <c:pt idx="270">
                  <c:v>59</c:v>
                </c:pt>
                <c:pt idx="271">
                  <c:v>58.5</c:v>
                </c:pt>
                <c:pt idx="272">
                  <c:v>58</c:v>
                </c:pt>
                <c:pt idx="273">
                  <c:v>57.5</c:v>
                </c:pt>
                <c:pt idx="274">
                  <c:v>57</c:v>
                </c:pt>
                <c:pt idx="275">
                  <c:v>56.5</c:v>
                </c:pt>
                <c:pt idx="276">
                  <c:v>56</c:v>
                </c:pt>
                <c:pt idx="277">
                  <c:v>55.5</c:v>
                </c:pt>
                <c:pt idx="278">
                  <c:v>55</c:v>
                </c:pt>
                <c:pt idx="279">
                  <c:v>54.5</c:v>
                </c:pt>
                <c:pt idx="280">
                  <c:v>54</c:v>
                </c:pt>
                <c:pt idx="281">
                  <c:v>53.5</c:v>
                </c:pt>
                <c:pt idx="282">
                  <c:v>53.35</c:v>
                </c:pt>
                <c:pt idx="283">
                  <c:v>53</c:v>
                </c:pt>
                <c:pt idx="284">
                  <c:v>52.5</c:v>
                </c:pt>
                <c:pt idx="285">
                  <c:v>52</c:v>
                </c:pt>
                <c:pt idx="286">
                  <c:v>51.5</c:v>
                </c:pt>
                <c:pt idx="287">
                  <c:v>51</c:v>
                </c:pt>
                <c:pt idx="288">
                  <c:v>50.5</c:v>
                </c:pt>
                <c:pt idx="289">
                  <c:v>50</c:v>
                </c:pt>
                <c:pt idx="290">
                  <c:v>49.5</c:v>
                </c:pt>
                <c:pt idx="291">
                  <c:v>49</c:v>
                </c:pt>
                <c:pt idx="292">
                  <c:v>48.5</c:v>
                </c:pt>
                <c:pt idx="293">
                  <c:v>48</c:v>
                </c:pt>
                <c:pt idx="294">
                  <c:v>47.5</c:v>
                </c:pt>
                <c:pt idx="295">
                  <c:v>47</c:v>
                </c:pt>
                <c:pt idx="296">
                  <c:v>46.5</c:v>
                </c:pt>
                <c:pt idx="297">
                  <c:v>46</c:v>
                </c:pt>
                <c:pt idx="298">
                  <c:v>45.5</c:v>
                </c:pt>
                <c:pt idx="299">
                  <c:v>45</c:v>
                </c:pt>
                <c:pt idx="300">
                  <c:v>44.643999999999998</c:v>
                </c:pt>
                <c:pt idx="301">
                  <c:v>44.5</c:v>
                </c:pt>
                <c:pt idx="302">
                  <c:v>44</c:v>
                </c:pt>
                <c:pt idx="303">
                  <c:v>43.5</c:v>
                </c:pt>
                <c:pt idx="304">
                  <c:v>43</c:v>
                </c:pt>
                <c:pt idx="305">
                  <c:v>42.5</c:v>
                </c:pt>
                <c:pt idx="306">
                  <c:v>42</c:v>
                </c:pt>
                <c:pt idx="307">
                  <c:v>41.5</c:v>
                </c:pt>
                <c:pt idx="308">
                  <c:v>41</c:v>
                </c:pt>
                <c:pt idx="309">
                  <c:v>40.5</c:v>
                </c:pt>
                <c:pt idx="310">
                  <c:v>40</c:v>
                </c:pt>
                <c:pt idx="311">
                  <c:v>39.5</c:v>
                </c:pt>
                <c:pt idx="312">
                  <c:v>39</c:v>
                </c:pt>
                <c:pt idx="313">
                  <c:v>38.5</c:v>
                </c:pt>
                <c:pt idx="314">
                  <c:v>38</c:v>
                </c:pt>
                <c:pt idx="315">
                  <c:v>37.512999999999998</c:v>
                </c:pt>
                <c:pt idx="316">
                  <c:v>37.5</c:v>
                </c:pt>
                <c:pt idx="317">
                  <c:v>37</c:v>
                </c:pt>
                <c:pt idx="318">
                  <c:v>36.5</c:v>
                </c:pt>
                <c:pt idx="319">
                  <c:v>36</c:v>
                </c:pt>
                <c:pt idx="320">
                  <c:v>35.5</c:v>
                </c:pt>
                <c:pt idx="321">
                  <c:v>35</c:v>
                </c:pt>
                <c:pt idx="322">
                  <c:v>34.5</c:v>
                </c:pt>
                <c:pt idx="323">
                  <c:v>34</c:v>
                </c:pt>
                <c:pt idx="324">
                  <c:v>33.649000000000001</c:v>
                </c:pt>
                <c:pt idx="325">
                  <c:v>33.5</c:v>
                </c:pt>
                <c:pt idx="326">
                  <c:v>33</c:v>
                </c:pt>
                <c:pt idx="327">
                  <c:v>32.5</c:v>
                </c:pt>
                <c:pt idx="328">
                  <c:v>32</c:v>
                </c:pt>
                <c:pt idx="329">
                  <c:v>31.5</c:v>
                </c:pt>
                <c:pt idx="330">
                  <c:v>31</c:v>
                </c:pt>
                <c:pt idx="331">
                  <c:v>30.5</c:v>
                </c:pt>
                <c:pt idx="332">
                  <c:v>30</c:v>
                </c:pt>
                <c:pt idx="333">
                  <c:v>29.5</c:v>
                </c:pt>
                <c:pt idx="334">
                  <c:v>29</c:v>
                </c:pt>
                <c:pt idx="335">
                  <c:v>28.5</c:v>
                </c:pt>
                <c:pt idx="336">
                  <c:v>28</c:v>
                </c:pt>
                <c:pt idx="337">
                  <c:v>27.5</c:v>
                </c:pt>
                <c:pt idx="338">
                  <c:v>27.114999999999998</c:v>
                </c:pt>
                <c:pt idx="339">
                  <c:v>27</c:v>
                </c:pt>
                <c:pt idx="340">
                  <c:v>26.5</c:v>
                </c:pt>
                <c:pt idx="341">
                  <c:v>26</c:v>
                </c:pt>
                <c:pt idx="342">
                  <c:v>25.5</c:v>
                </c:pt>
                <c:pt idx="343">
                  <c:v>25</c:v>
                </c:pt>
                <c:pt idx="344">
                  <c:v>24.5</c:v>
                </c:pt>
                <c:pt idx="345">
                  <c:v>24</c:v>
                </c:pt>
                <c:pt idx="346">
                  <c:v>23.5</c:v>
                </c:pt>
                <c:pt idx="347">
                  <c:v>23</c:v>
                </c:pt>
                <c:pt idx="348">
                  <c:v>22.5</c:v>
                </c:pt>
                <c:pt idx="349">
                  <c:v>22</c:v>
                </c:pt>
                <c:pt idx="350">
                  <c:v>21.5</c:v>
                </c:pt>
                <c:pt idx="351">
                  <c:v>21</c:v>
                </c:pt>
                <c:pt idx="352">
                  <c:v>20.5</c:v>
                </c:pt>
                <c:pt idx="353">
                  <c:v>20.056999999999999</c:v>
                </c:pt>
                <c:pt idx="354">
                  <c:v>20</c:v>
                </c:pt>
                <c:pt idx="355">
                  <c:v>19.5</c:v>
                </c:pt>
                <c:pt idx="356">
                  <c:v>19</c:v>
                </c:pt>
                <c:pt idx="357">
                  <c:v>18.5</c:v>
                </c:pt>
                <c:pt idx="358">
                  <c:v>18</c:v>
                </c:pt>
                <c:pt idx="359">
                  <c:v>17.5</c:v>
                </c:pt>
                <c:pt idx="360">
                  <c:v>17</c:v>
                </c:pt>
                <c:pt idx="361">
                  <c:v>16.5</c:v>
                </c:pt>
                <c:pt idx="362">
                  <c:v>16</c:v>
                </c:pt>
                <c:pt idx="363">
                  <c:v>15.5</c:v>
                </c:pt>
                <c:pt idx="364">
                  <c:v>15</c:v>
                </c:pt>
                <c:pt idx="365">
                  <c:v>14.5</c:v>
                </c:pt>
                <c:pt idx="366">
                  <c:v>14</c:v>
                </c:pt>
                <c:pt idx="367">
                  <c:v>13.522</c:v>
                </c:pt>
                <c:pt idx="368">
                  <c:v>13.5</c:v>
                </c:pt>
                <c:pt idx="369">
                  <c:v>13</c:v>
                </c:pt>
                <c:pt idx="370">
                  <c:v>12.5</c:v>
                </c:pt>
                <c:pt idx="371">
                  <c:v>12</c:v>
                </c:pt>
                <c:pt idx="372">
                  <c:v>11.5</c:v>
                </c:pt>
                <c:pt idx="373">
                  <c:v>11</c:v>
                </c:pt>
                <c:pt idx="374">
                  <c:v>10.862</c:v>
                </c:pt>
                <c:pt idx="375">
                  <c:v>10.5</c:v>
                </c:pt>
                <c:pt idx="376">
                  <c:v>10</c:v>
                </c:pt>
                <c:pt idx="377">
                  <c:v>9.5</c:v>
                </c:pt>
                <c:pt idx="378">
                  <c:v>9</c:v>
                </c:pt>
                <c:pt idx="379">
                  <c:v>8.5</c:v>
                </c:pt>
                <c:pt idx="380">
                  <c:v>8</c:v>
                </c:pt>
                <c:pt idx="381">
                  <c:v>7.5</c:v>
                </c:pt>
                <c:pt idx="382">
                  <c:v>7</c:v>
                </c:pt>
                <c:pt idx="383">
                  <c:v>6.6120000000000001</c:v>
                </c:pt>
                <c:pt idx="384">
                  <c:v>6.5</c:v>
                </c:pt>
                <c:pt idx="385">
                  <c:v>6</c:v>
                </c:pt>
                <c:pt idx="386">
                  <c:v>5.5</c:v>
                </c:pt>
                <c:pt idx="387">
                  <c:v>5</c:v>
                </c:pt>
                <c:pt idx="388">
                  <c:v>4.5</c:v>
                </c:pt>
                <c:pt idx="389">
                  <c:v>4.008</c:v>
                </c:pt>
                <c:pt idx="390">
                  <c:v>4</c:v>
                </c:pt>
                <c:pt idx="391">
                  <c:v>3.5</c:v>
                </c:pt>
                <c:pt idx="392">
                  <c:v>3</c:v>
                </c:pt>
                <c:pt idx="393">
                  <c:v>2.6</c:v>
                </c:pt>
                <c:pt idx="394">
                  <c:v>2.5</c:v>
                </c:pt>
                <c:pt idx="395">
                  <c:v>2</c:v>
                </c:pt>
                <c:pt idx="396">
                  <c:v>1.5</c:v>
                </c:pt>
                <c:pt idx="397">
                  <c:v>1</c:v>
                </c:pt>
                <c:pt idx="398">
                  <c:v>0.76200000000000001</c:v>
                </c:pt>
                <c:pt idx="399">
                  <c:v>0.5</c:v>
                </c:pt>
                <c:pt idx="400">
                  <c:v>0.14399999999999999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331-46BE-B50F-9AAB614B14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3823016"/>
        <c:axId val="513821376"/>
      </c:scatterChart>
      <c:valAx>
        <c:axId val="513823016"/>
        <c:scaling>
          <c:orientation val="minMax"/>
          <c:max val="1900"/>
          <c:min val="12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/>
                  <a:t>Dose [cGy(RBE)]</a:t>
                </a:r>
              </a:p>
            </c:rich>
          </c:tx>
          <c:layout>
            <c:manualLayout>
              <c:xMode val="edge"/>
              <c:yMode val="edge"/>
              <c:x val="0.40098055555555556"/>
              <c:y val="0.867602222222222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1376"/>
        <c:crosses val="autoZero"/>
        <c:crossBetween val="midCat"/>
      </c:valAx>
      <c:valAx>
        <c:axId val="513821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/>
                  <a:t>Volume [%]</a:t>
                </a:r>
              </a:p>
            </c:rich>
          </c:tx>
          <c:layout>
            <c:manualLayout>
              <c:xMode val="edge"/>
              <c:yMode val="edge"/>
              <c:x val="2.0158730158730157E-2"/>
              <c:y val="0.229866111111111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3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9618</cdr:x>
      <cdr:y>0.07895</cdr:y>
    </cdr:from>
    <cdr:to>
      <cdr:x>0.96823</cdr:x>
      <cdr:y>0.17458</cdr:y>
    </cdr:to>
    <cdr:sp macro="" textlink="">
      <cdr:nvSpPr>
        <cdr:cNvPr id="3" name="CasellaDiTesto 1">
          <a:extLst xmlns:a="http://schemas.openxmlformats.org/drawingml/2006/main">
            <a:ext uri="{FF2B5EF4-FFF2-40B4-BE49-F238E27FC236}">
              <a16:creationId xmlns:a16="http://schemas.microsoft.com/office/drawing/2014/main" id="{60376818-5515-4CD0-97A3-B8B2CC45C9E2}"/>
            </a:ext>
          </a:extLst>
        </cdr:cNvPr>
        <cdr:cNvSpPr txBox="1"/>
      </cdr:nvSpPr>
      <cdr:spPr>
        <a:xfrm xmlns:a="http://schemas.openxmlformats.org/drawingml/2006/main">
          <a:off x="624304" y="131615"/>
          <a:ext cx="1416613" cy="1594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000" b="1" dirty="0" err="1"/>
            <a:t>Healthy</a:t>
          </a:r>
          <a:r>
            <a:rPr lang="it-IT" sz="1000" b="1" dirty="0"/>
            <a:t> Brain </a:t>
          </a:r>
          <a:r>
            <a:rPr lang="it-IT" sz="1000" b="1" dirty="0" err="1"/>
            <a:t>Tissue</a:t>
          </a:r>
          <a:endParaRPr lang="it-IT" sz="10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131</cdr:x>
      <cdr:y>0.06285</cdr:y>
    </cdr:from>
    <cdr:to>
      <cdr:x>0.91187</cdr:x>
      <cdr:y>0.19857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63114E80-AD6B-4CAB-BDD3-A57789AF158F}"/>
            </a:ext>
          </a:extLst>
        </cdr:cNvPr>
        <cdr:cNvSpPr txBox="1"/>
      </cdr:nvSpPr>
      <cdr:spPr>
        <a:xfrm xmlns:a="http://schemas.openxmlformats.org/drawingml/2006/main">
          <a:off x="1503123" y="104771"/>
          <a:ext cx="418984" cy="2262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it-IT" sz="1000" b="1" dirty="0"/>
            <a:t>CTV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182477D-4BF5-4FF2-9F40-B48A4E020F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CBEE64AE-351F-4623-BEAE-56381F420E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EB88369-DEF8-49B1-9BA8-859CD9315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78D58ED-E98B-4788-B421-0C2307AF4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B7F512F-2817-40E5-80F8-5C4BC3661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8804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5F5B0E0-E189-47DE-800E-454910319F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4E6260E-ED70-4AD2-B42F-E8142CE2E1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7E1DA28-924E-4777-BEB7-B5E9EBB7A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0299774-1C1E-432A-B4B0-FA6921B36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C28BF5B-034C-4C6F-BE78-24133F6FD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8017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CFBCEEE-00C7-4F20-A751-5BBB07991F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91EC5DF-9EC9-42E9-A4E5-9E720835E4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367518F-B620-4D94-BDAE-BA6009B9B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CA28BF8-37FD-4115-A086-6C0436AF1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5349928-174F-4BF7-BFFB-D0D0354D8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5339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13BC709-F05D-4ABE-8C05-6DFCADDFB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ADF964F-6832-4E1E-B32E-AF817CCF5E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B3DD4D9-076B-44AB-A114-BD4E143A8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F7FB980-3283-4775-AB93-637401968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685B443-6ED4-4169-961A-B706649C8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8532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DD2C3B9-E7FC-49A1-8C4A-C496DE2165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0A57BED-5022-40A9-8541-2A203AF369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3A61B7-7CBE-40E6-8CB3-3070494F9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9B15E62-4376-4EEA-9735-22159DB2F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06279CC-68FB-42AC-A26E-43DFAAFE5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8338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B9A67A-52CA-4013-B099-FBCAB7606B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B375FBE-AAD2-4D2B-B014-E7875DBD98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FFD8378-ED1B-43DE-ABF4-F14AD209DD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F523E61-0FE1-4F9B-96B3-8ABCA1DE5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45E2FA6-F7F9-4182-B63A-00630573F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0858003-88D3-4C85-86C4-240F294613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217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000C191-478F-4BC1-A494-18C885491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B6F7333-04B4-49C0-A98E-64DF45A30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A244967-6F0D-4358-839C-2FEAACE0F0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8AC7592-C3E9-48E0-96D2-AAB928BDF7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29E83F8B-9430-4B23-BB4B-24F3D40F0B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52A42DFB-DE88-45F2-AA85-0DB45E439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948C423-2A4A-4009-9AC5-188F1B58C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65D335F-56E4-4AE4-A54C-D8E084DAD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1201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53C3654-C1C5-48C5-A2C4-430C1853B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DCCD7D4-9F30-482A-96B8-71BDB809F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E35B6C9-91EF-407B-BABB-4BABA8CDF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372D437-484E-4187-BBB0-BE088B764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0938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D937039-8215-4E6E-848B-C2791D8791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013FE68-CFB7-4A6F-8EA0-49BAC79C1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6F4B17E-CFA8-4097-A3C7-D907399D6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040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950791C-6FF6-4ADF-9336-7F98E6D09D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9ABB562-B203-43F6-AB6C-B6980607F4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82EA944-7D45-40A3-ABA4-7414CA01F2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B5C036C-AB46-471E-A3E7-8352330E0F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D0CABB0-D84A-4F93-B711-FEAA91421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817E6FA-F64A-4260-9991-C9D6A7CBC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1667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84F664F-8C8C-4E02-AF31-C207CEF3DB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7D365AD-7E36-4680-97AA-532D23AC00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99FF92D-E270-4EE3-A63A-907A60C3DA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2D4D5F9-EE0B-4DE6-8080-7417D03B3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AAD8179-5C23-4CB9-B01E-72F78BFF8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0D3FC91-5AC3-4988-9BD7-5E16B3932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9651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13A3FC2-0E22-45F6-B755-4A2466F42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4C851D2-67CD-4CDD-B902-A9C1AE62B4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A9DC02-3032-49C9-9644-5A758924F7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3050E11-4E0A-4D2B-8924-B30729918C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6FA689-C6EE-4ED5-B29A-4158F1739A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9165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DBD72B64-3861-4E55-BCE3-3DC8D258EF85}"/>
              </a:ext>
            </a:extLst>
          </p:cNvPr>
          <p:cNvGrpSpPr/>
          <p:nvPr/>
        </p:nvGrpSpPr>
        <p:grpSpPr>
          <a:xfrm>
            <a:off x="1079918" y="508872"/>
            <a:ext cx="4912509" cy="1923610"/>
            <a:chOff x="1079918" y="508872"/>
            <a:chExt cx="5872958" cy="2076999"/>
          </a:xfrm>
        </p:grpSpPr>
        <p:grpSp>
          <p:nvGrpSpPr>
            <p:cNvPr id="17" name="Gruppo 16">
              <a:extLst>
                <a:ext uri="{FF2B5EF4-FFF2-40B4-BE49-F238E27FC236}">
                  <a16:creationId xmlns:a16="http://schemas.microsoft.com/office/drawing/2014/main" id="{8971B746-3BCF-48AC-94F6-233A59AD41F2}"/>
                </a:ext>
              </a:extLst>
            </p:cNvPr>
            <p:cNvGrpSpPr/>
            <p:nvPr/>
          </p:nvGrpSpPr>
          <p:grpSpPr>
            <a:xfrm>
              <a:off x="1079918" y="508872"/>
              <a:ext cx="5872958" cy="1805669"/>
              <a:chOff x="304051" y="564290"/>
              <a:chExt cx="5872958" cy="1805669"/>
            </a:xfrm>
          </p:grpSpPr>
          <p:pic>
            <p:nvPicPr>
              <p:cNvPr id="15" name="Immagine 14">
                <a:extLst>
                  <a:ext uri="{FF2B5EF4-FFF2-40B4-BE49-F238E27FC236}">
                    <a16:creationId xmlns:a16="http://schemas.microsoft.com/office/drawing/2014/main" id="{2738302F-1675-4D9F-9C11-B371A78A8AA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1864"/>
              <a:stretch/>
            </p:blipFill>
            <p:spPr>
              <a:xfrm>
                <a:off x="5320133" y="571483"/>
                <a:ext cx="856876" cy="1798476"/>
              </a:xfrm>
              <a:prstGeom prst="rect">
                <a:avLst/>
              </a:prstGeom>
            </p:spPr>
          </p:pic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BA21D8C9-64F2-49F2-ACCD-47DCE260EBAD}"/>
                  </a:ext>
                </a:extLst>
              </p:cNvPr>
              <p:cNvSpPr txBox="1"/>
              <p:nvPr/>
            </p:nvSpPr>
            <p:spPr>
              <a:xfrm>
                <a:off x="304051" y="564290"/>
                <a:ext cx="252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/>
                  <a:t>Meningioma</a:t>
                </a:r>
              </a:p>
            </p:txBody>
          </p:sp>
        </p:grpSp>
        <p:graphicFrame>
          <p:nvGraphicFramePr>
            <p:cNvPr id="10" name="Grafico 9">
              <a:extLst>
                <a:ext uri="{FF2B5EF4-FFF2-40B4-BE49-F238E27FC236}">
                  <a16:creationId xmlns:a16="http://schemas.microsoft.com/office/drawing/2014/main" id="{4514A226-3B99-40B5-B291-7A434796A74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46465076"/>
                </p:ext>
              </p:extLst>
            </p:nvPr>
          </p:nvGraphicFramePr>
          <p:xfrm>
            <a:off x="3680537" y="785871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1" name="Grafico 10">
              <a:extLst>
                <a:ext uri="{FF2B5EF4-FFF2-40B4-BE49-F238E27FC236}">
                  <a16:creationId xmlns:a16="http://schemas.microsoft.com/office/drawing/2014/main" id="{BD83B56C-25FE-4CA7-AFE6-904BD4647CD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98582465"/>
                </p:ext>
              </p:extLst>
            </p:nvPr>
          </p:nvGraphicFramePr>
          <p:xfrm>
            <a:off x="1103836" y="785871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8" name="CasellaDiTesto 1">
            <a:extLst>
              <a:ext uri="{FF2B5EF4-FFF2-40B4-BE49-F238E27FC236}">
                <a16:creationId xmlns:a16="http://schemas.microsoft.com/office/drawing/2014/main" id="{6E923DE4-C839-4DE8-866C-19064E7D27A6}"/>
              </a:ext>
            </a:extLst>
          </p:cNvPr>
          <p:cNvSpPr txBox="1"/>
          <p:nvPr/>
        </p:nvSpPr>
        <p:spPr>
          <a:xfrm>
            <a:off x="1079918" y="2437732"/>
            <a:ext cx="50160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cs typeface="Times New Roman" panose="02020603050405020304" pitchFamily="18" charset="0"/>
              </a:rPr>
              <a:t>Fig. </a:t>
            </a:r>
            <a:r>
              <a:rPr lang="it-IT" sz="1100" b="1">
                <a:cs typeface="Times New Roman" panose="02020603050405020304" pitchFamily="18" charset="0"/>
              </a:rPr>
              <a:t>S2 </a:t>
            </a:r>
            <a:r>
              <a:rPr lang="it-IT" sz="1100" dirty="0">
                <a:cs typeface="Times New Roman" panose="02020603050405020304" pitchFamily="18" charset="0"/>
              </a:rPr>
              <a:t>Dose volume </a:t>
            </a:r>
            <a:r>
              <a:rPr lang="it-IT" sz="1100" dirty="0" err="1">
                <a:cs typeface="Times New Roman" panose="02020603050405020304" pitchFamily="18" charset="0"/>
              </a:rPr>
              <a:t>histograms</a:t>
            </a:r>
            <a:r>
              <a:rPr lang="it-IT" sz="1100" dirty="0">
                <a:cs typeface="Times New Roman" panose="02020603050405020304" pitchFamily="18" charset="0"/>
              </a:rPr>
              <a:t> for the meningioma </a:t>
            </a:r>
            <a:r>
              <a:rPr lang="it-IT" sz="1100" dirty="0" err="1">
                <a:cs typeface="Times New Roman" panose="02020603050405020304" pitchFamily="18" charset="0"/>
              </a:rPr>
              <a:t>patient</a:t>
            </a:r>
            <a:r>
              <a:rPr lang="it-IT" sz="1100" dirty="0">
                <a:cs typeface="Times New Roman" panose="02020603050405020304" pitchFamily="18" charset="0"/>
              </a:rPr>
              <a:t> # 8, for the </a:t>
            </a:r>
            <a:r>
              <a:rPr lang="it-IT" sz="1100" dirty="0" err="1">
                <a:cs typeface="Times New Roman" panose="02020603050405020304" pitchFamily="18" charset="0"/>
              </a:rPr>
              <a:t>nominal</a:t>
            </a:r>
            <a:r>
              <a:rPr lang="it-IT" sz="1100" dirty="0">
                <a:cs typeface="Times New Roman" panose="02020603050405020304" pitchFamily="18" charset="0"/>
              </a:rPr>
              <a:t> scenario. </a:t>
            </a:r>
          </a:p>
        </p:txBody>
      </p:sp>
    </p:spTree>
    <p:extLst>
      <p:ext uri="{BB962C8B-B14F-4D97-AF65-F5344CB8AC3E}">
        <p14:creationId xmlns:p14="http://schemas.microsoft.com/office/powerpoint/2010/main" val="353605542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57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ghetto Roberto</dc:creator>
  <cp:lastModifiedBy>Righetto Roberto</cp:lastModifiedBy>
  <cp:revision>9</cp:revision>
  <dcterms:created xsi:type="dcterms:W3CDTF">2021-08-17T11:29:33Z</dcterms:created>
  <dcterms:modified xsi:type="dcterms:W3CDTF">2021-08-19T13:44:08Z</dcterms:modified>
</cp:coreProperties>
</file>